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5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  <p:sldMasterId id="2147483684" r:id="rId2"/>
    <p:sldMasterId id="2147483696" r:id="rId3"/>
  </p:sldMasterIdLst>
  <p:notesMasterIdLst>
    <p:notesMasterId r:id="rId6"/>
  </p:notesMasterIdLst>
  <p:handoutMasterIdLst>
    <p:handoutMasterId r:id="rId7"/>
  </p:handoutMasterIdLst>
  <p:sldIdLst>
    <p:sldId id="287" r:id="rId4"/>
    <p:sldId id="286" r:id="rId5"/>
  </p:sldIdLst>
  <p:sldSz cx="9144000" cy="6858000" type="screen4x3"/>
  <p:notesSz cx="6805613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User" initials="IU" lastIdx="1" clrIdx="0">
    <p:extLst>
      <p:ext uri="{19B8F6BF-5375-455C-9EA6-DF929625EA0E}">
        <p15:presenceInfo xmlns:p15="http://schemas.microsoft.com/office/powerpoint/2012/main" userId="User" providerId="None"/>
      </p:ext>
    </p:extLst>
  </p:cmAuthor>
  <p:cmAuthor id="2" name="im3" initials="i" lastIdx="8" clrIdx="1">
    <p:extLst>
      <p:ext uri="{19B8F6BF-5375-455C-9EA6-DF929625EA0E}">
        <p15:presenceInfo xmlns:p15="http://schemas.microsoft.com/office/powerpoint/2012/main" userId="im3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CCFF"/>
    <a:srgbClr val="0066FF"/>
    <a:srgbClr val="FF3300"/>
    <a:srgbClr val="0000FF"/>
    <a:srgbClr val="FDEAD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569" autoAdjust="0"/>
    <p:restoredTop sz="96391" autoAdjust="0"/>
  </p:normalViewPr>
  <p:slideViewPr>
    <p:cSldViewPr snapToGrid="0">
      <p:cViewPr varScale="1">
        <p:scale>
          <a:sx n="99" d="100"/>
          <a:sy n="99" d="100"/>
        </p:scale>
        <p:origin x="998" y="77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Master" Target="slideMasters/slideMaster3.xml"/><Relationship Id="rId7" Type="http://schemas.openxmlformats.org/officeDocument/2006/relationships/handoutMaster" Target="handoutMasters/handoutMaster1.xml"/><Relationship Id="rId12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heme" Target="theme/theme1.xml"/><Relationship Id="rId5" Type="http://schemas.openxmlformats.org/officeDocument/2006/relationships/slide" Target="slides/slide2.xml"/><Relationship Id="rId10" Type="http://schemas.openxmlformats.org/officeDocument/2006/relationships/viewProps" Target="viewProps.xml"/><Relationship Id="rId4" Type="http://schemas.openxmlformats.org/officeDocument/2006/relationships/slide" Target="slides/slide1.xml"/><Relationship Id="rId9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5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2" y="2"/>
            <a:ext cx="2949687" cy="498965"/>
          </a:xfrm>
          <a:prstGeom prst="rect">
            <a:avLst/>
          </a:prstGeom>
        </p:spPr>
        <p:txBody>
          <a:bodyPr vert="horz" lIns="92228" tIns="46113" rIns="92228" bIns="46113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54322" y="2"/>
            <a:ext cx="2949686" cy="498965"/>
          </a:xfrm>
          <a:prstGeom prst="rect">
            <a:avLst/>
          </a:prstGeom>
        </p:spPr>
        <p:txBody>
          <a:bodyPr vert="horz" lIns="92228" tIns="46113" rIns="92228" bIns="46113" rtlCol="0"/>
          <a:lstStyle>
            <a:lvl1pPr algn="r">
              <a:defRPr sz="1200"/>
            </a:lvl1pPr>
          </a:lstStyle>
          <a:p>
            <a:fld id="{90380A36-6184-4BAE-B185-D1A6D4ACF31E}" type="datetimeFigureOut">
              <a:rPr kumimoji="1" lang="ja-JP" altLang="en-US" smtClean="0"/>
              <a:t>2020/7/2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2" y="9440374"/>
            <a:ext cx="2949687" cy="498965"/>
          </a:xfrm>
          <a:prstGeom prst="rect">
            <a:avLst/>
          </a:prstGeom>
        </p:spPr>
        <p:txBody>
          <a:bodyPr vert="horz" lIns="92228" tIns="46113" rIns="92228" bIns="46113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54322" y="9440374"/>
            <a:ext cx="2949686" cy="498965"/>
          </a:xfrm>
          <a:prstGeom prst="rect">
            <a:avLst/>
          </a:prstGeom>
        </p:spPr>
        <p:txBody>
          <a:bodyPr vert="horz" lIns="92228" tIns="46113" rIns="92228" bIns="46113" rtlCol="0" anchor="b"/>
          <a:lstStyle>
            <a:lvl1pPr algn="r">
              <a:defRPr sz="1200"/>
            </a:lvl1pPr>
          </a:lstStyle>
          <a:p>
            <a:fld id="{A9B981E6-4D0A-4440-B09A-69CC5A8591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011953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49099" cy="498693"/>
          </a:xfrm>
          <a:prstGeom prst="rect">
            <a:avLst/>
          </a:prstGeom>
        </p:spPr>
        <p:txBody>
          <a:bodyPr vert="horz" lIns="92228" tIns="46113" rIns="92228" bIns="46113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4940" y="1"/>
            <a:ext cx="2949099" cy="498693"/>
          </a:xfrm>
          <a:prstGeom prst="rect">
            <a:avLst/>
          </a:prstGeom>
        </p:spPr>
        <p:txBody>
          <a:bodyPr vert="horz" lIns="92228" tIns="46113" rIns="92228" bIns="46113" rtlCol="0"/>
          <a:lstStyle>
            <a:lvl1pPr algn="r">
              <a:defRPr sz="1200"/>
            </a:lvl1pPr>
          </a:lstStyle>
          <a:p>
            <a:fld id="{F618C0C1-33FB-40FC-A7BD-FEBAABDBB0FD}" type="datetimeFigureOut">
              <a:rPr kumimoji="1" lang="ja-JP" altLang="en-US" smtClean="0"/>
              <a:t>2020/7/2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8400" y="1243013"/>
            <a:ext cx="4468813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228" tIns="46113" rIns="92228" bIns="46113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562" y="4783308"/>
            <a:ext cx="5444490" cy="3913615"/>
          </a:xfrm>
          <a:prstGeom prst="rect">
            <a:avLst/>
          </a:prstGeom>
        </p:spPr>
        <p:txBody>
          <a:bodyPr vert="horz" lIns="92228" tIns="46113" rIns="92228" bIns="46113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440647"/>
            <a:ext cx="2949099" cy="498692"/>
          </a:xfrm>
          <a:prstGeom prst="rect">
            <a:avLst/>
          </a:prstGeom>
        </p:spPr>
        <p:txBody>
          <a:bodyPr vert="horz" lIns="92228" tIns="46113" rIns="92228" bIns="46113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4940" y="9440647"/>
            <a:ext cx="2949099" cy="498692"/>
          </a:xfrm>
          <a:prstGeom prst="rect">
            <a:avLst/>
          </a:prstGeom>
        </p:spPr>
        <p:txBody>
          <a:bodyPr vert="horz" lIns="92228" tIns="46113" rIns="92228" bIns="46113" rtlCol="0" anchor="b"/>
          <a:lstStyle>
            <a:lvl1pPr algn="r">
              <a:defRPr sz="1200"/>
            </a:lvl1pPr>
          </a:lstStyle>
          <a:p>
            <a:fld id="{2B24FCDE-8976-44FC-8A75-7BF58E195C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85059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2846E5AC-8362-449C-B173-68136EB9388C}" type="datetime1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Segoe UI"/>
                <a:ea typeface="Meiryo UI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/7/2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2DABCC2-1EEF-4DDF-B308-B50BC011052B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Segoe UI"/>
                <a:ea typeface="Meiryo UI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5479199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256F121-27DC-469E-9FCA-ED051DCD0049}" type="datetime1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Segoe UI"/>
                <a:ea typeface="Meiryo UI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/7/2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2DABCC2-1EEF-4DDF-B308-B50BC011052B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Segoe UI"/>
                <a:ea typeface="Meiryo UI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5816253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D541C25D-F2EF-44C8-A227-CA667C1E300A}" type="datetime1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Segoe UI"/>
                <a:ea typeface="Meiryo UI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/7/2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2DABCC2-1EEF-4DDF-B308-B50BC011052B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Segoe UI"/>
                <a:ea typeface="Meiryo UI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76443851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: タイトル スライド">
    <p:bg bwMode="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281237"/>
            <a:ext cx="7772400" cy="1749425"/>
          </a:xfrm>
        </p:spPr>
        <p:txBody>
          <a:bodyPr>
            <a:noAutofit/>
          </a:bodyPr>
          <a:lstStyle>
            <a:lvl1pPr algn="ctr">
              <a:defRPr sz="3600" baseline="0"/>
            </a:lvl1pPr>
          </a:lstStyle>
          <a:p>
            <a:r>
              <a:rPr kumimoji="1" lang="ja-JP" altLang="en-US"/>
              <a:t>マスター タイトルの書式設定</a:t>
            </a:r>
            <a:endParaRPr kumimoji="1" lang="ja-JP" altLang="en-US" dirty="0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724526" y="4095750"/>
            <a:ext cx="5694948" cy="1543050"/>
          </a:xfrm>
        </p:spPr>
        <p:txBody>
          <a:bodyPr anchor="ctr">
            <a:normAutofit/>
          </a:bodyPr>
          <a:lstStyle>
            <a:lvl1pPr marL="0" indent="0" algn="ctr">
              <a:buNone/>
              <a:defRPr baseline="0">
                <a:solidFill>
                  <a:schemeClr val="tx1"/>
                </a:solidFill>
                <a:latin typeface="+mj-lt"/>
                <a:ea typeface="+mj-ea"/>
              </a:defRPr>
            </a:lvl1pPr>
            <a:lvl2pPr marL="457200" indent="0" algn="ctr">
              <a:buNone/>
              <a:defRPr>
                <a:solidFill>
                  <a:schemeClr val="tx1"/>
                </a:solidFill>
              </a:defRPr>
            </a:lvl2pPr>
            <a:lvl3pPr marL="914400" indent="0" algn="ctr">
              <a:buNone/>
              <a:defRPr>
                <a:solidFill>
                  <a:schemeClr val="tx1"/>
                </a:solidFill>
              </a:defRPr>
            </a:lvl3pPr>
            <a:lvl4pPr marL="1371600" indent="0" algn="ctr">
              <a:buNone/>
              <a:defRPr>
                <a:solidFill>
                  <a:schemeClr val="tx1"/>
                </a:solidFill>
              </a:defRPr>
            </a:lvl4pPr>
            <a:lvl5pPr marL="1828800" indent="0" algn="ctr">
              <a:buNone/>
              <a:defRPr>
                <a:solidFill>
                  <a:schemeClr val="tx1"/>
                </a:solidFill>
              </a:defRPr>
            </a:lvl5pPr>
            <a:lvl6pPr marL="2286000" indent="0" algn="ctr">
              <a:buNone/>
              <a:defRPr sz="1800">
                <a:solidFill>
                  <a:schemeClr val="tx1"/>
                </a:solidFill>
              </a:defRPr>
            </a:lvl6pPr>
            <a:lvl7pPr marL="2743200" indent="0" algn="ctr">
              <a:buNone/>
              <a:defRPr sz="1800">
                <a:solidFill>
                  <a:schemeClr val="tx1"/>
                </a:solidFill>
              </a:defRPr>
            </a:lvl7pPr>
            <a:lvl8pPr marL="3200400" indent="0" algn="ctr">
              <a:buNone/>
              <a:defRPr sz="1800">
                <a:solidFill>
                  <a:schemeClr val="tx1"/>
                </a:solidFill>
              </a:defRPr>
            </a:lvl8pPr>
            <a:lvl9pPr marL="3657600" indent="0" algn="ctr">
              <a:buNone/>
              <a:defRPr sz="1800">
                <a:solidFill>
                  <a:schemeClr val="tx1"/>
                </a:solidFill>
              </a:defRPr>
            </a:lvl9pPr>
          </a:lstStyle>
          <a:p>
            <a:pPr lvl="0"/>
            <a:r>
              <a:rPr kumimoji="1" lang="ja-JP" altLang="en-US"/>
              <a:t>マスター サブタイトルの書式設定</a:t>
            </a:r>
            <a:endParaRPr kumimoji="1" lang="ja-JP" alt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kumimoji="1" lang="ja-JP" altLang="en-US"/>
          </a:p>
        </p:txBody>
      </p:sp>
      <p:pic>
        <p:nvPicPr>
          <p:cNvPr id="6" name="図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6232" y="632602"/>
            <a:ext cx="2308292" cy="1602000"/>
          </a:xfrm>
          <a:prstGeom prst="rect">
            <a:avLst/>
          </a:prstGeom>
        </p:spPr>
      </p:pic>
      <p:sp>
        <p:nvSpPr>
          <p:cNvPr id="7" name="フリーフォーム 6"/>
          <p:cNvSpPr/>
          <p:nvPr/>
        </p:nvSpPr>
        <p:spPr>
          <a:xfrm>
            <a:off x="-2904" y="4886752"/>
            <a:ext cx="9146904" cy="876879"/>
          </a:xfrm>
          <a:custGeom>
            <a:avLst/>
            <a:gdLst>
              <a:gd name="connsiteX0" fmla="*/ 0 w 9149286"/>
              <a:gd name="connsiteY0" fmla="*/ 872116 h 872116"/>
              <a:gd name="connsiteX1" fmla="*/ 6469513 w 9149286"/>
              <a:gd name="connsiteY1" fmla="*/ 872116 h 872116"/>
              <a:gd name="connsiteX2" fmla="*/ 9149286 w 9149286"/>
              <a:gd name="connsiteY2" fmla="*/ 576125 h 872116"/>
              <a:gd name="connsiteX3" fmla="*/ 9138715 w 9149286"/>
              <a:gd name="connsiteY3" fmla="*/ 0 h 872116"/>
              <a:gd name="connsiteX4" fmla="*/ 6152380 w 9149286"/>
              <a:gd name="connsiteY4" fmla="*/ 840402 h 872116"/>
              <a:gd name="connsiteX5" fmla="*/ 0 w 9149286"/>
              <a:gd name="connsiteY5" fmla="*/ 687121 h 872116"/>
              <a:gd name="connsiteX6" fmla="*/ 0 w 9149286"/>
              <a:gd name="connsiteY6" fmla="*/ 872116 h 872116"/>
              <a:gd name="connsiteX0" fmla="*/ 4762 w 9149286"/>
              <a:gd name="connsiteY0" fmla="*/ 874497 h 874497"/>
              <a:gd name="connsiteX1" fmla="*/ 6469513 w 9149286"/>
              <a:gd name="connsiteY1" fmla="*/ 872116 h 874497"/>
              <a:gd name="connsiteX2" fmla="*/ 9149286 w 9149286"/>
              <a:gd name="connsiteY2" fmla="*/ 576125 h 874497"/>
              <a:gd name="connsiteX3" fmla="*/ 9138715 w 9149286"/>
              <a:gd name="connsiteY3" fmla="*/ 0 h 874497"/>
              <a:gd name="connsiteX4" fmla="*/ 6152380 w 9149286"/>
              <a:gd name="connsiteY4" fmla="*/ 840402 h 874497"/>
              <a:gd name="connsiteX5" fmla="*/ 0 w 9149286"/>
              <a:gd name="connsiteY5" fmla="*/ 687121 h 874497"/>
              <a:gd name="connsiteX6" fmla="*/ 4762 w 9149286"/>
              <a:gd name="connsiteY6" fmla="*/ 874497 h 874497"/>
              <a:gd name="connsiteX0" fmla="*/ 2380 w 9146904"/>
              <a:gd name="connsiteY0" fmla="*/ 874497 h 874497"/>
              <a:gd name="connsiteX1" fmla="*/ 6467131 w 9146904"/>
              <a:gd name="connsiteY1" fmla="*/ 872116 h 874497"/>
              <a:gd name="connsiteX2" fmla="*/ 9146904 w 9146904"/>
              <a:gd name="connsiteY2" fmla="*/ 576125 h 874497"/>
              <a:gd name="connsiteX3" fmla="*/ 9136333 w 9146904"/>
              <a:gd name="connsiteY3" fmla="*/ 0 h 874497"/>
              <a:gd name="connsiteX4" fmla="*/ 6149998 w 9146904"/>
              <a:gd name="connsiteY4" fmla="*/ 840402 h 874497"/>
              <a:gd name="connsiteX5" fmla="*/ 0 w 9146904"/>
              <a:gd name="connsiteY5" fmla="*/ 846665 h 874497"/>
              <a:gd name="connsiteX6" fmla="*/ 2380 w 9146904"/>
              <a:gd name="connsiteY6" fmla="*/ 874497 h 874497"/>
              <a:gd name="connsiteX0" fmla="*/ 2380 w 9146904"/>
              <a:gd name="connsiteY0" fmla="*/ 874497 h 874497"/>
              <a:gd name="connsiteX1" fmla="*/ 6467131 w 9146904"/>
              <a:gd name="connsiteY1" fmla="*/ 872116 h 874497"/>
              <a:gd name="connsiteX2" fmla="*/ 9146904 w 9146904"/>
              <a:gd name="connsiteY2" fmla="*/ 576125 h 874497"/>
              <a:gd name="connsiteX3" fmla="*/ 9136333 w 9146904"/>
              <a:gd name="connsiteY3" fmla="*/ 0 h 874497"/>
              <a:gd name="connsiteX4" fmla="*/ 5895204 w 9146904"/>
              <a:gd name="connsiteY4" fmla="*/ 845165 h 874497"/>
              <a:gd name="connsiteX5" fmla="*/ 0 w 9146904"/>
              <a:gd name="connsiteY5" fmla="*/ 846665 h 874497"/>
              <a:gd name="connsiteX6" fmla="*/ 2380 w 9146904"/>
              <a:gd name="connsiteY6" fmla="*/ 874497 h 874497"/>
              <a:gd name="connsiteX0" fmla="*/ 2380 w 9146904"/>
              <a:gd name="connsiteY0" fmla="*/ 874497 h 874497"/>
              <a:gd name="connsiteX1" fmla="*/ 6467131 w 9146904"/>
              <a:gd name="connsiteY1" fmla="*/ 872116 h 874497"/>
              <a:gd name="connsiteX2" fmla="*/ 9146904 w 9146904"/>
              <a:gd name="connsiteY2" fmla="*/ 576125 h 874497"/>
              <a:gd name="connsiteX3" fmla="*/ 9136333 w 9146904"/>
              <a:gd name="connsiteY3" fmla="*/ 0 h 874497"/>
              <a:gd name="connsiteX4" fmla="*/ 5895204 w 9146904"/>
              <a:gd name="connsiteY4" fmla="*/ 845165 h 874497"/>
              <a:gd name="connsiteX5" fmla="*/ 0 w 9146904"/>
              <a:gd name="connsiteY5" fmla="*/ 846665 h 874497"/>
              <a:gd name="connsiteX6" fmla="*/ 2380 w 9146904"/>
              <a:gd name="connsiteY6" fmla="*/ 874497 h 874497"/>
              <a:gd name="connsiteX0" fmla="*/ 2380 w 9146904"/>
              <a:gd name="connsiteY0" fmla="*/ 874497 h 874497"/>
              <a:gd name="connsiteX1" fmla="*/ 6467131 w 9146904"/>
              <a:gd name="connsiteY1" fmla="*/ 872116 h 874497"/>
              <a:gd name="connsiteX2" fmla="*/ 9146904 w 9146904"/>
              <a:gd name="connsiteY2" fmla="*/ 576125 h 874497"/>
              <a:gd name="connsiteX3" fmla="*/ 9145858 w 9146904"/>
              <a:gd name="connsiteY3" fmla="*/ 0 h 874497"/>
              <a:gd name="connsiteX4" fmla="*/ 5895204 w 9146904"/>
              <a:gd name="connsiteY4" fmla="*/ 845165 h 874497"/>
              <a:gd name="connsiteX5" fmla="*/ 0 w 9146904"/>
              <a:gd name="connsiteY5" fmla="*/ 846665 h 874497"/>
              <a:gd name="connsiteX6" fmla="*/ 2380 w 9146904"/>
              <a:gd name="connsiteY6" fmla="*/ 874497 h 874497"/>
              <a:gd name="connsiteX0" fmla="*/ 2380 w 9146904"/>
              <a:gd name="connsiteY0" fmla="*/ 874497 h 874497"/>
              <a:gd name="connsiteX1" fmla="*/ 6467131 w 9146904"/>
              <a:gd name="connsiteY1" fmla="*/ 872116 h 874497"/>
              <a:gd name="connsiteX2" fmla="*/ 9146904 w 9146904"/>
              <a:gd name="connsiteY2" fmla="*/ 576125 h 874497"/>
              <a:gd name="connsiteX3" fmla="*/ 9145858 w 9146904"/>
              <a:gd name="connsiteY3" fmla="*/ 0 h 874497"/>
              <a:gd name="connsiteX4" fmla="*/ 5895204 w 9146904"/>
              <a:gd name="connsiteY4" fmla="*/ 845165 h 874497"/>
              <a:gd name="connsiteX5" fmla="*/ 0 w 9146904"/>
              <a:gd name="connsiteY5" fmla="*/ 846665 h 874497"/>
              <a:gd name="connsiteX6" fmla="*/ 2380 w 9146904"/>
              <a:gd name="connsiteY6" fmla="*/ 874497 h 874497"/>
              <a:gd name="connsiteX0" fmla="*/ 2380 w 9146904"/>
              <a:gd name="connsiteY0" fmla="*/ 874497 h 874497"/>
              <a:gd name="connsiteX1" fmla="*/ 6467131 w 9146904"/>
              <a:gd name="connsiteY1" fmla="*/ 872116 h 874497"/>
              <a:gd name="connsiteX2" fmla="*/ 9146904 w 9146904"/>
              <a:gd name="connsiteY2" fmla="*/ 576125 h 874497"/>
              <a:gd name="connsiteX3" fmla="*/ 9145858 w 9146904"/>
              <a:gd name="connsiteY3" fmla="*/ 0 h 874497"/>
              <a:gd name="connsiteX4" fmla="*/ 5895204 w 9146904"/>
              <a:gd name="connsiteY4" fmla="*/ 845165 h 874497"/>
              <a:gd name="connsiteX5" fmla="*/ 0 w 9146904"/>
              <a:gd name="connsiteY5" fmla="*/ 846665 h 874497"/>
              <a:gd name="connsiteX6" fmla="*/ 2380 w 9146904"/>
              <a:gd name="connsiteY6" fmla="*/ 874497 h 874497"/>
              <a:gd name="connsiteX0" fmla="*/ 2380 w 9146904"/>
              <a:gd name="connsiteY0" fmla="*/ 874497 h 874497"/>
              <a:gd name="connsiteX1" fmla="*/ 6467131 w 9146904"/>
              <a:gd name="connsiteY1" fmla="*/ 872116 h 874497"/>
              <a:gd name="connsiteX2" fmla="*/ 9146904 w 9146904"/>
              <a:gd name="connsiteY2" fmla="*/ 576125 h 874497"/>
              <a:gd name="connsiteX3" fmla="*/ 9145858 w 9146904"/>
              <a:gd name="connsiteY3" fmla="*/ 0 h 874497"/>
              <a:gd name="connsiteX4" fmla="*/ 5895204 w 9146904"/>
              <a:gd name="connsiteY4" fmla="*/ 845165 h 874497"/>
              <a:gd name="connsiteX5" fmla="*/ 0 w 9146904"/>
              <a:gd name="connsiteY5" fmla="*/ 846665 h 874497"/>
              <a:gd name="connsiteX6" fmla="*/ 2380 w 9146904"/>
              <a:gd name="connsiteY6" fmla="*/ 874497 h 874497"/>
              <a:gd name="connsiteX0" fmla="*/ 2380 w 9146904"/>
              <a:gd name="connsiteY0" fmla="*/ 874497 h 874497"/>
              <a:gd name="connsiteX1" fmla="*/ 6467131 w 9146904"/>
              <a:gd name="connsiteY1" fmla="*/ 872116 h 874497"/>
              <a:gd name="connsiteX2" fmla="*/ 9146904 w 9146904"/>
              <a:gd name="connsiteY2" fmla="*/ 576125 h 874497"/>
              <a:gd name="connsiteX3" fmla="*/ 9145858 w 9146904"/>
              <a:gd name="connsiteY3" fmla="*/ 0 h 874497"/>
              <a:gd name="connsiteX4" fmla="*/ 5895204 w 9146904"/>
              <a:gd name="connsiteY4" fmla="*/ 845165 h 874497"/>
              <a:gd name="connsiteX5" fmla="*/ 0 w 9146904"/>
              <a:gd name="connsiteY5" fmla="*/ 846665 h 874497"/>
              <a:gd name="connsiteX6" fmla="*/ 2380 w 9146904"/>
              <a:gd name="connsiteY6" fmla="*/ 874497 h 874497"/>
              <a:gd name="connsiteX0" fmla="*/ 2380 w 9146904"/>
              <a:gd name="connsiteY0" fmla="*/ 874497 h 874497"/>
              <a:gd name="connsiteX1" fmla="*/ 6467131 w 9146904"/>
              <a:gd name="connsiteY1" fmla="*/ 872116 h 874497"/>
              <a:gd name="connsiteX2" fmla="*/ 9146904 w 9146904"/>
              <a:gd name="connsiteY2" fmla="*/ 576125 h 874497"/>
              <a:gd name="connsiteX3" fmla="*/ 9145858 w 9146904"/>
              <a:gd name="connsiteY3" fmla="*/ 0 h 874497"/>
              <a:gd name="connsiteX4" fmla="*/ 5895204 w 9146904"/>
              <a:gd name="connsiteY4" fmla="*/ 845165 h 874497"/>
              <a:gd name="connsiteX5" fmla="*/ 0 w 9146904"/>
              <a:gd name="connsiteY5" fmla="*/ 846665 h 874497"/>
              <a:gd name="connsiteX6" fmla="*/ 2380 w 9146904"/>
              <a:gd name="connsiteY6" fmla="*/ 874497 h 874497"/>
              <a:gd name="connsiteX0" fmla="*/ 2380 w 9146904"/>
              <a:gd name="connsiteY0" fmla="*/ 874497 h 874497"/>
              <a:gd name="connsiteX1" fmla="*/ 6467131 w 9146904"/>
              <a:gd name="connsiteY1" fmla="*/ 872116 h 874497"/>
              <a:gd name="connsiteX2" fmla="*/ 9146904 w 9146904"/>
              <a:gd name="connsiteY2" fmla="*/ 576125 h 874497"/>
              <a:gd name="connsiteX3" fmla="*/ 9145858 w 9146904"/>
              <a:gd name="connsiteY3" fmla="*/ 0 h 874497"/>
              <a:gd name="connsiteX4" fmla="*/ 5895204 w 9146904"/>
              <a:gd name="connsiteY4" fmla="*/ 845165 h 874497"/>
              <a:gd name="connsiteX5" fmla="*/ 0 w 9146904"/>
              <a:gd name="connsiteY5" fmla="*/ 846665 h 874497"/>
              <a:gd name="connsiteX6" fmla="*/ 2380 w 9146904"/>
              <a:gd name="connsiteY6" fmla="*/ 874497 h 874497"/>
              <a:gd name="connsiteX0" fmla="*/ 2380 w 9146904"/>
              <a:gd name="connsiteY0" fmla="*/ 874497 h 874497"/>
              <a:gd name="connsiteX1" fmla="*/ 6467131 w 9146904"/>
              <a:gd name="connsiteY1" fmla="*/ 872116 h 874497"/>
              <a:gd name="connsiteX2" fmla="*/ 9146904 w 9146904"/>
              <a:gd name="connsiteY2" fmla="*/ 576125 h 874497"/>
              <a:gd name="connsiteX3" fmla="*/ 9145858 w 9146904"/>
              <a:gd name="connsiteY3" fmla="*/ 0 h 874497"/>
              <a:gd name="connsiteX4" fmla="*/ 5895204 w 9146904"/>
              <a:gd name="connsiteY4" fmla="*/ 845165 h 874497"/>
              <a:gd name="connsiteX5" fmla="*/ 0 w 9146904"/>
              <a:gd name="connsiteY5" fmla="*/ 846665 h 874497"/>
              <a:gd name="connsiteX6" fmla="*/ 2380 w 9146904"/>
              <a:gd name="connsiteY6" fmla="*/ 874497 h 874497"/>
              <a:gd name="connsiteX0" fmla="*/ 2380 w 9146904"/>
              <a:gd name="connsiteY0" fmla="*/ 874497 h 874497"/>
              <a:gd name="connsiteX1" fmla="*/ 6467131 w 9146904"/>
              <a:gd name="connsiteY1" fmla="*/ 872116 h 874497"/>
              <a:gd name="connsiteX2" fmla="*/ 9146904 w 9146904"/>
              <a:gd name="connsiteY2" fmla="*/ 576125 h 874497"/>
              <a:gd name="connsiteX3" fmla="*/ 9145858 w 9146904"/>
              <a:gd name="connsiteY3" fmla="*/ 0 h 874497"/>
              <a:gd name="connsiteX4" fmla="*/ 5895204 w 9146904"/>
              <a:gd name="connsiteY4" fmla="*/ 845165 h 874497"/>
              <a:gd name="connsiteX5" fmla="*/ 0 w 9146904"/>
              <a:gd name="connsiteY5" fmla="*/ 846665 h 874497"/>
              <a:gd name="connsiteX6" fmla="*/ 2380 w 9146904"/>
              <a:gd name="connsiteY6" fmla="*/ 874497 h 874497"/>
              <a:gd name="connsiteX0" fmla="*/ 2380 w 9146904"/>
              <a:gd name="connsiteY0" fmla="*/ 874497 h 874497"/>
              <a:gd name="connsiteX1" fmla="*/ 6467131 w 9146904"/>
              <a:gd name="connsiteY1" fmla="*/ 872116 h 874497"/>
              <a:gd name="connsiteX2" fmla="*/ 9146904 w 9146904"/>
              <a:gd name="connsiteY2" fmla="*/ 576125 h 874497"/>
              <a:gd name="connsiteX3" fmla="*/ 9145858 w 9146904"/>
              <a:gd name="connsiteY3" fmla="*/ 0 h 874497"/>
              <a:gd name="connsiteX4" fmla="*/ 5895204 w 9146904"/>
              <a:gd name="connsiteY4" fmla="*/ 845165 h 874497"/>
              <a:gd name="connsiteX5" fmla="*/ 0 w 9146904"/>
              <a:gd name="connsiteY5" fmla="*/ 846665 h 874497"/>
              <a:gd name="connsiteX6" fmla="*/ 2380 w 9146904"/>
              <a:gd name="connsiteY6" fmla="*/ 874497 h 874497"/>
              <a:gd name="connsiteX0" fmla="*/ 2380 w 9146904"/>
              <a:gd name="connsiteY0" fmla="*/ 874497 h 874497"/>
              <a:gd name="connsiteX1" fmla="*/ 6467131 w 9146904"/>
              <a:gd name="connsiteY1" fmla="*/ 872116 h 874497"/>
              <a:gd name="connsiteX2" fmla="*/ 9146904 w 9146904"/>
              <a:gd name="connsiteY2" fmla="*/ 576125 h 874497"/>
              <a:gd name="connsiteX3" fmla="*/ 9145858 w 9146904"/>
              <a:gd name="connsiteY3" fmla="*/ 0 h 874497"/>
              <a:gd name="connsiteX4" fmla="*/ 5895204 w 9146904"/>
              <a:gd name="connsiteY4" fmla="*/ 845165 h 874497"/>
              <a:gd name="connsiteX5" fmla="*/ 0 w 9146904"/>
              <a:gd name="connsiteY5" fmla="*/ 846665 h 874497"/>
              <a:gd name="connsiteX6" fmla="*/ 2380 w 9146904"/>
              <a:gd name="connsiteY6" fmla="*/ 874497 h 874497"/>
              <a:gd name="connsiteX0" fmla="*/ 2380 w 9146904"/>
              <a:gd name="connsiteY0" fmla="*/ 874497 h 874497"/>
              <a:gd name="connsiteX1" fmla="*/ 6464750 w 9146904"/>
              <a:gd name="connsiteY1" fmla="*/ 872116 h 874497"/>
              <a:gd name="connsiteX2" fmla="*/ 9146904 w 9146904"/>
              <a:gd name="connsiteY2" fmla="*/ 576125 h 874497"/>
              <a:gd name="connsiteX3" fmla="*/ 9145858 w 9146904"/>
              <a:gd name="connsiteY3" fmla="*/ 0 h 874497"/>
              <a:gd name="connsiteX4" fmla="*/ 5895204 w 9146904"/>
              <a:gd name="connsiteY4" fmla="*/ 845165 h 874497"/>
              <a:gd name="connsiteX5" fmla="*/ 0 w 9146904"/>
              <a:gd name="connsiteY5" fmla="*/ 846665 h 874497"/>
              <a:gd name="connsiteX6" fmla="*/ 2380 w 9146904"/>
              <a:gd name="connsiteY6" fmla="*/ 874497 h 874497"/>
              <a:gd name="connsiteX0" fmla="*/ 2380 w 9146904"/>
              <a:gd name="connsiteY0" fmla="*/ 874497 h 876879"/>
              <a:gd name="connsiteX1" fmla="*/ 6455225 w 9146904"/>
              <a:gd name="connsiteY1" fmla="*/ 876879 h 876879"/>
              <a:gd name="connsiteX2" fmla="*/ 9146904 w 9146904"/>
              <a:gd name="connsiteY2" fmla="*/ 576125 h 876879"/>
              <a:gd name="connsiteX3" fmla="*/ 9145858 w 9146904"/>
              <a:gd name="connsiteY3" fmla="*/ 0 h 876879"/>
              <a:gd name="connsiteX4" fmla="*/ 5895204 w 9146904"/>
              <a:gd name="connsiteY4" fmla="*/ 845165 h 876879"/>
              <a:gd name="connsiteX5" fmla="*/ 0 w 9146904"/>
              <a:gd name="connsiteY5" fmla="*/ 846665 h 876879"/>
              <a:gd name="connsiteX6" fmla="*/ 2380 w 9146904"/>
              <a:gd name="connsiteY6" fmla="*/ 874497 h 876879"/>
              <a:gd name="connsiteX0" fmla="*/ 2380 w 9146904"/>
              <a:gd name="connsiteY0" fmla="*/ 874497 h 876879"/>
              <a:gd name="connsiteX1" fmla="*/ 6455225 w 9146904"/>
              <a:gd name="connsiteY1" fmla="*/ 876879 h 876879"/>
              <a:gd name="connsiteX2" fmla="*/ 9146904 w 9146904"/>
              <a:gd name="connsiteY2" fmla="*/ 576125 h 876879"/>
              <a:gd name="connsiteX3" fmla="*/ 9145858 w 9146904"/>
              <a:gd name="connsiteY3" fmla="*/ 0 h 876879"/>
              <a:gd name="connsiteX4" fmla="*/ 5895204 w 9146904"/>
              <a:gd name="connsiteY4" fmla="*/ 845165 h 876879"/>
              <a:gd name="connsiteX5" fmla="*/ 0 w 9146904"/>
              <a:gd name="connsiteY5" fmla="*/ 846665 h 876879"/>
              <a:gd name="connsiteX6" fmla="*/ 2380 w 9146904"/>
              <a:gd name="connsiteY6" fmla="*/ 874497 h 876879"/>
              <a:gd name="connsiteX0" fmla="*/ 2380 w 9146904"/>
              <a:gd name="connsiteY0" fmla="*/ 874497 h 876879"/>
              <a:gd name="connsiteX1" fmla="*/ 6455225 w 9146904"/>
              <a:gd name="connsiteY1" fmla="*/ 876879 h 876879"/>
              <a:gd name="connsiteX2" fmla="*/ 9146904 w 9146904"/>
              <a:gd name="connsiteY2" fmla="*/ 576125 h 876879"/>
              <a:gd name="connsiteX3" fmla="*/ 9145858 w 9146904"/>
              <a:gd name="connsiteY3" fmla="*/ 0 h 876879"/>
              <a:gd name="connsiteX4" fmla="*/ 5895204 w 9146904"/>
              <a:gd name="connsiteY4" fmla="*/ 845165 h 876879"/>
              <a:gd name="connsiteX5" fmla="*/ 0 w 9146904"/>
              <a:gd name="connsiteY5" fmla="*/ 846665 h 876879"/>
              <a:gd name="connsiteX6" fmla="*/ 2380 w 9146904"/>
              <a:gd name="connsiteY6" fmla="*/ 874497 h 876879"/>
              <a:gd name="connsiteX0" fmla="*/ 2380 w 9146904"/>
              <a:gd name="connsiteY0" fmla="*/ 874497 h 876879"/>
              <a:gd name="connsiteX1" fmla="*/ 6386169 w 9146904"/>
              <a:gd name="connsiteY1" fmla="*/ 876879 h 876879"/>
              <a:gd name="connsiteX2" fmla="*/ 9146904 w 9146904"/>
              <a:gd name="connsiteY2" fmla="*/ 576125 h 876879"/>
              <a:gd name="connsiteX3" fmla="*/ 9145858 w 9146904"/>
              <a:gd name="connsiteY3" fmla="*/ 0 h 876879"/>
              <a:gd name="connsiteX4" fmla="*/ 5895204 w 9146904"/>
              <a:gd name="connsiteY4" fmla="*/ 845165 h 876879"/>
              <a:gd name="connsiteX5" fmla="*/ 0 w 9146904"/>
              <a:gd name="connsiteY5" fmla="*/ 846665 h 876879"/>
              <a:gd name="connsiteX6" fmla="*/ 2380 w 9146904"/>
              <a:gd name="connsiteY6" fmla="*/ 874497 h 876879"/>
              <a:gd name="connsiteX0" fmla="*/ 2380 w 9146904"/>
              <a:gd name="connsiteY0" fmla="*/ 874497 h 876879"/>
              <a:gd name="connsiteX1" fmla="*/ 6369500 w 9146904"/>
              <a:gd name="connsiteY1" fmla="*/ 876879 h 876879"/>
              <a:gd name="connsiteX2" fmla="*/ 9146904 w 9146904"/>
              <a:gd name="connsiteY2" fmla="*/ 576125 h 876879"/>
              <a:gd name="connsiteX3" fmla="*/ 9145858 w 9146904"/>
              <a:gd name="connsiteY3" fmla="*/ 0 h 876879"/>
              <a:gd name="connsiteX4" fmla="*/ 5895204 w 9146904"/>
              <a:gd name="connsiteY4" fmla="*/ 845165 h 876879"/>
              <a:gd name="connsiteX5" fmla="*/ 0 w 9146904"/>
              <a:gd name="connsiteY5" fmla="*/ 846665 h 876879"/>
              <a:gd name="connsiteX6" fmla="*/ 2380 w 9146904"/>
              <a:gd name="connsiteY6" fmla="*/ 874497 h 876879"/>
              <a:gd name="connsiteX0" fmla="*/ 2380 w 9146904"/>
              <a:gd name="connsiteY0" fmla="*/ 874497 h 876879"/>
              <a:gd name="connsiteX1" fmla="*/ 6336162 w 9146904"/>
              <a:gd name="connsiteY1" fmla="*/ 876879 h 876879"/>
              <a:gd name="connsiteX2" fmla="*/ 9146904 w 9146904"/>
              <a:gd name="connsiteY2" fmla="*/ 576125 h 876879"/>
              <a:gd name="connsiteX3" fmla="*/ 9145858 w 9146904"/>
              <a:gd name="connsiteY3" fmla="*/ 0 h 876879"/>
              <a:gd name="connsiteX4" fmla="*/ 5895204 w 9146904"/>
              <a:gd name="connsiteY4" fmla="*/ 845165 h 876879"/>
              <a:gd name="connsiteX5" fmla="*/ 0 w 9146904"/>
              <a:gd name="connsiteY5" fmla="*/ 846665 h 876879"/>
              <a:gd name="connsiteX6" fmla="*/ 2380 w 9146904"/>
              <a:gd name="connsiteY6" fmla="*/ 874497 h 876879"/>
              <a:gd name="connsiteX0" fmla="*/ 2380 w 9146904"/>
              <a:gd name="connsiteY0" fmla="*/ 874497 h 876879"/>
              <a:gd name="connsiteX1" fmla="*/ 6336162 w 9146904"/>
              <a:gd name="connsiteY1" fmla="*/ 876879 h 876879"/>
              <a:gd name="connsiteX2" fmla="*/ 9146904 w 9146904"/>
              <a:gd name="connsiteY2" fmla="*/ 576125 h 876879"/>
              <a:gd name="connsiteX3" fmla="*/ 9145858 w 9146904"/>
              <a:gd name="connsiteY3" fmla="*/ 0 h 876879"/>
              <a:gd name="connsiteX4" fmla="*/ 5904729 w 9146904"/>
              <a:gd name="connsiteY4" fmla="*/ 847546 h 876879"/>
              <a:gd name="connsiteX5" fmla="*/ 0 w 9146904"/>
              <a:gd name="connsiteY5" fmla="*/ 846665 h 876879"/>
              <a:gd name="connsiteX6" fmla="*/ 2380 w 9146904"/>
              <a:gd name="connsiteY6" fmla="*/ 874497 h 87687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9146904" h="876879">
                <a:moveTo>
                  <a:pt x="2380" y="874497"/>
                </a:moveTo>
                <a:lnTo>
                  <a:pt x="6336162" y="876879"/>
                </a:lnTo>
                <a:cubicBezTo>
                  <a:pt x="6907951" y="859178"/>
                  <a:pt x="8067909" y="831953"/>
                  <a:pt x="9146904" y="576125"/>
                </a:cubicBezTo>
                <a:cubicBezTo>
                  <a:pt x="9146555" y="384083"/>
                  <a:pt x="9146207" y="192042"/>
                  <a:pt x="9145858" y="0"/>
                </a:cubicBezTo>
                <a:cubicBezTo>
                  <a:pt x="8453626" y="481747"/>
                  <a:pt x="7580418" y="801568"/>
                  <a:pt x="5904729" y="847546"/>
                </a:cubicBezTo>
                <a:lnTo>
                  <a:pt x="0" y="846665"/>
                </a:lnTo>
                <a:lnTo>
                  <a:pt x="2380" y="874497"/>
                </a:lnTo>
                <a:close/>
              </a:path>
            </a:pathLst>
          </a:cu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254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8" name="図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6232" y="6058883"/>
            <a:ext cx="2869200" cy="5467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4078497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: 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35380" y="76966"/>
            <a:ext cx="856731" cy="594588"/>
          </a:xfrm>
          <a:prstGeom prst="rect">
            <a:avLst/>
          </a:prstGeom>
        </p:spPr>
      </p:pic>
      <p:sp>
        <p:nvSpPr>
          <p:cNvPr id="7" name="フリーフォーム 6"/>
          <p:cNvSpPr/>
          <p:nvPr/>
        </p:nvSpPr>
        <p:spPr>
          <a:xfrm>
            <a:off x="-1231" y="451262"/>
            <a:ext cx="9145230" cy="334860"/>
          </a:xfrm>
          <a:custGeom>
            <a:avLst/>
            <a:gdLst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5938 w 9149938"/>
              <a:gd name="connsiteY7" fmla="*/ 231569 h 344385"/>
              <a:gd name="connsiteX8" fmla="*/ 0 w 9149938"/>
              <a:gd name="connsiteY8" fmla="*/ 344385 h 344385"/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10700 w 9149938"/>
              <a:gd name="connsiteY7" fmla="*/ 300625 h 344385"/>
              <a:gd name="connsiteX8" fmla="*/ 0 w 9149938"/>
              <a:gd name="connsiteY8" fmla="*/ 344385 h 344385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25019 w 9139238"/>
              <a:gd name="connsiteY0" fmla="*/ 399154 h 399154"/>
              <a:gd name="connsiteX1" fmla="*/ 8230776 w 9139238"/>
              <a:gd name="connsiteY1" fmla="*/ 338447 h 399154"/>
              <a:gd name="connsiteX2" fmla="*/ 8771103 w 9139238"/>
              <a:gd name="connsiteY2" fmla="*/ 296883 h 399154"/>
              <a:gd name="connsiteX3" fmla="*/ 9139238 w 9139238"/>
              <a:gd name="connsiteY3" fmla="*/ 231569 h 399154"/>
              <a:gd name="connsiteX4" fmla="*/ 9139238 w 9139238"/>
              <a:gd name="connsiteY4" fmla="*/ 0 h 399154"/>
              <a:gd name="connsiteX5" fmla="*/ 8747352 w 9139238"/>
              <a:gd name="connsiteY5" fmla="*/ 201881 h 399154"/>
              <a:gd name="connsiteX6" fmla="*/ 8135773 w 9139238"/>
              <a:gd name="connsiteY6" fmla="*/ 302821 h 399154"/>
              <a:gd name="connsiteX7" fmla="*/ 0 w 9139238"/>
              <a:gd name="connsiteY7" fmla="*/ 300625 h 399154"/>
              <a:gd name="connsiteX8" fmla="*/ 25019 w 9139238"/>
              <a:gd name="connsiteY8" fmla="*/ 399154 h 39915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5937 w 9145175"/>
              <a:gd name="connsiteY7" fmla="*/ 300625 h 342004"/>
              <a:gd name="connsiteX8" fmla="*/ 0 w 9145175"/>
              <a:gd name="connsiteY8" fmla="*/ 342004 h 34200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120237 w 9145175"/>
              <a:gd name="connsiteY7" fmla="*/ 255381 h 342004"/>
              <a:gd name="connsiteX8" fmla="*/ 0 w 9145175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142917 w 9146382"/>
              <a:gd name="connsiteY6" fmla="*/ 302821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55 w 9145230"/>
              <a:gd name="connsiteY0" fmla="*/ 342004 h 342004"/>
              <a:gd name="connsiteX1" fmla="*/ 8236768 w 9145230"/>
              <a:gd name="connsiteY1" fmla="*/ 338447 h 342004"/>
              <a:gd name="connsiteX2" fmla="*/ 8777095 w 9145230"/>
              <a:gd name="connsiteY2" fmla="*/ 296883 h 342004"/>
              <a:gd name="connsiteX3" fmla="*/ 9145230 w 9145230"/>
              <a:gd name="connsiteY3" fmla="*/ 231569 h 342004"/>
              <a:gd name="connsiteX4" fmla="*/ 9145230 w 9145230"/>
              <a:gd name="connsiteY4" fmla="*/ 0 h 342004"/>
              <a:gd name="connsiteX5" fmla="*/ 8039370 w 9145230"/>
              <a:gd name="connsiteY5" fmla="*/ 302822 h 342004"/>
              <a:gd name="connsiteX6" fmla="*/ 1230 w 9145230"/>
              <a:gd name="connsiteY6" fmla="*/ 307768 h 342004"/>
              <a:gd name="connsiteX7" fmla="*/ 55 w 9145230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5387 h 342004"/>
              <a:gd name="connsiteX7" fmla="*/ 1207 w 9146382"/>
              <a:gd name="connsiteY7" fmla="*/ 342004 h 342004"/>
              <a:gd name="connsiteX0" fmla="*/ 1207 w 9146382"/>
              <a:gd name="connsiteY0" fmla="*/ 339622 h 339622"/>
              <a:gd name="connsiteX1" fmla="*/ 8237920 w 9146382"/>
              <a:gd name="connsiteY1" fmla="*/ 338447 h 339622"/>
              <a:gd name="connsiteX2" fmla="*/ 8778247 w 9146382"/>
              <a:gd name="connsiteY2" fmla="*/ 296883 h 339622"/>
              <a:gd name="connsiteX3" fmla="*/ 9146382 w 9146382"/>
              <a:gd name="connsiteY3" fmla="*/ 231569 h 339622"/>
              <a:gd name="connsiteX4" fmla="*/ 9146382 w 9146382"/>
              <a:gd name="connsiteY4" fmla="*/ 0 h 339622"/>
              <a:gd name="connsiteX5" fmla="*/ 8040522 w 9146382"/>
              <a:gd name="connsiteY5" fmla="*/ 302822 h 339622"/>
              <a:gd name="connsiteX6" fmla="*/ 0 w 9146382"/>
              <a:gd name="connsiteY6" fmla="*/ 305387 h 339622"/>
              <a:gd name="connsiteX7" fmla="*/ 1207 w 9146382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2822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3685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4860 h 334860"/>
              <a:gd name="connsiteX1" fmla="*/ 8236768 w 9145230"/>
              <a:gd name="connsiteY1" fmla="*/ 333685 h 334860"/>
              <a:gd name="connsiteX2" fmla="*/ 8777095 w 9145230"/>
              <a:gd name="connsiteY2" fmla="*/ 296883 h 334860"/>
              <a:gd name="connsiteX3" fmla="*/ 9145230 w 9145230"/>
              <a:gd name="connsiteY3" fmla="*/ 231569 h 334860"/>
              <a:gd name="connsiteX4" fmla="*/ 9145230 w 9145230"/>
              <a:gd name="connsiteY4" fmla="*/ 0 h 334860"/>
              <a:gd name="connsiteX5" fmla="*/ 8039370 w 9145230"/>
              <a:gd name="connsiteY5" fmla="*/ 305204 h 334860"/>
              <a:gd name="connsiteX6" fmla="*/ 1230 w 9145230"/>
              <a:gd name="connsiteY6" fmla="*/ 305387 h 334860"/>
              <a:gd name="connsiteX7" fmla="*/ 55 w 9145230"/>
              <a:gd name="connsiteY7" fmla="*/ 334860 h 3348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9145230" h="334860">
                <a:moveTo>
                  <a:pt x="55" y="334860"/>
                </a:moveTo>
                <a:lnTo>
                  <a:pt x="8236768" y="333685"/>
                </a:lnTo>
                <a:cubicBezTo>
                  <a:pt x="8424021" y="326974"/>
                  <a:pt x="8625685" y="313902"/>
                  <a:pt x="8777095" y="296883"/>
                </a:cubicBezTo>
                <a:cubicBezTo>
                  <a:pt x="8928505" y="279864"/>
                  <a:pt x="9017756" y="262865"/>
                  <a:pt x="9145230" y="231569"/>
                </a:cubicBezTo>
                <a:lnTo>
                  <a:pt x="9145230" y="0"/>
                </a:lnTo>
                <a:cubicBezTo>
                  <a:pt x="8875194" y="176182"/>
                  <a:pt x="8573165" y="285660"/>
                  <a:pt x="8039370" y="305204"/>
                </a:cubicBezTo>
                <a:lnTo>
                  <a:pt x="1230" y="305387"/>
                </a:lnTo>
                <a:cubicBezTo>
                  <a:pt x="1632" y="318386"/>
                  <a:pt x="-347" y="321861"/>
                  <a:pt x="55" y="334860"/>
                </a:cubicBezTo>
                <a:close/>
              </a:path>
            </a:pathLst>
          </a:cu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254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正方形/長方形 7"/>
          <p:cNvSpPr/>
          <p:nvPr/>
        </p:nvSpPr>
        <p:spPr>
          <a:xfrm>
            <a:off x="0" y="6321600"/>
            <a:ext cx="9144000" cy="25200"/>
          </a:xfrm>
          <a:prstGeom prst="rect">
            <a:avLst/>
          </a:pr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12700" dir="16200000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JP" alt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8914464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Section Header: 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フリーフォーム 11"/>
          <p:cNvSpPr/>
          <p:nvPr/>
        </p:nvSpPr>
        <p:spPr>
          <a:xfrm>
            <a:off x="-1230" y="3324729"/>
            <a:ext cx="9147611" cy="3539124"/>
          </a:xfrm>
          <a:custGeom>
            <a:avLst/>
            <a:gdLst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5938 w 9149938"/>
              <a:gd name="connsiteY7" fmla="*/ 231569 h 344385"/>
              <a:gd name="connsiteX8" fmla="*/ 0 w 9149938"/>
              <a:gd name="connsiteY8" fmla="*/ 344385 h 344385"/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10700 w 9149938"/>
              <a:gd name="connsiteY7" fmla="*/ 300625 h 344385"/>
              <a:gd name="connsiteX8" fmla="*/ 0 w 9149938"/>
              <a:gd name="connsiteY8" fmla="*/ 344385 h 344385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25019 w 9139238"/>
              <a:gd name="connsiteY0" fmla="*/ 399154 h 399154"/>
              <a:gd name="connsiteX1" fmla="*/ 8230776 w 9139238"/>
              <a:gd name="connsiteY1" fmla="*/ 338447 h 399154"/>
              <a:gd name="connsiteX2" fmla="*/ 8771103 w 9139238"/>
              <a:gd name="connsiteY2" fmla="*/ 296883 h 399154"/>
              <a:gd name="connsiteX3" fmla="*/ 9139238 w 9139238"/>
              <a:gd name="connsiteY3" fmla="*/ 231569 h 399154"/>
              <a:gd name="connsiteX4" fmla="*/ 9139238 w 9139238"/>
              <a:gd name="connsiteY4" fmla="*/ 0 h 399154"/>
              <a:gd name="connsiteX5" fmla="*/ 8747352 w 9139238"/>
              <a:gd name="connsiteY5" fmla="*/ 201881 h 399154"/>
              <a:gd name="connsiteX6" fmla="*/ 8135773 w 9139238"/>
              <a:gd name="connsiteY6" fmla="*/ 302821 h 399154"/>
              <a:gd name="connsiteX7" fmla="*/ 0 w 9139238"/>
              <a:gd name="connsiteY7" fmla="*/ 300625 h 399154"/>
              <a:gd name="connsiteX8" fmla="*/ 25019 w 9139238"/>
              <a:gd name="connsiteY8" fmla="*/ 399154 h 39915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5937 w 9145175"/>
              <a:gd name="connsiteY7" fmla="*/ 300625 h 342004"/>
              <a:gd name="connsiteX8" fmla="*/ 0 w 9145175"/>
              <a:gd name="connsiteY8" fmla="*/ 342004 h 34200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120237 w 9145175"/>
              <a:gd name="connsiteY7" fmla="*/ 255381 h 342004"/>
              <a:gd name="connsiteX8" fmla="*/ 0 w 9145175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142917 w 9146382"/>
              <a:gd name="connsiteY6" fmla="*/ 302821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55 w 9145230"/>
              <a:gd name="connsiteY0" fmla="*/ 342004 h 342004"/>
              <a:gd name="connsiteX1" fmla="*/ 8236768 w 9145230"/>
              <a:gd name="connsiteY1" fmla="*/ 338447 h 342004"/>
              <a:gd name="connsiteX2" fmla="*/ 8777095 w 9145230"/>
              <a:gd name="connsiteY2" fmla="*/ 296883 h 342004"/>
              <a:gd name="connsiteX3" fmla="*/ 9145230 w 9145230"/>
              <a:gd name="connsiteY3" fmla="*/ 231569 h 342004"/>
              <a:gd name="connsiteX4" fmla="*/ 9145230 w 9145230"/>
              <a:gd name="connsiteY4" fmla="*/ 0 h 342004"/>
              <a:gd name="connsiteX5" fmla="*/ 8039370 w 9145230"/>
              <a:gd name="connsiteY5" fmla="*/ 302822 h 342004"/>
              <a:gd name="connsiteX6" fmla="*/ 1230 w 9145230"/>
              <a:gd name="connsiteY6" fmla="*/ 307768 h 342004"/>
              <a:gd name="connsiteX7" fmla="*/ 55 w 9145230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5387 h 342004"/>
              <a:gd name="connsiteX7" fmla="*/ 1207 w 9146382"/>
              <a:gd name="connsiteY7" fmla="*/ 342004 h 342004"/>
              <a:gd name="connsiteX0" fmla="*/ 1207 w 9146382"/>
              <a:gd name="connsiteY0" fmla="*/ 339622 h 339622"/>
              <a:gd name="connsiteX1" fmla="*/ 8237920 w 9146382"/>
              <a:gd name="connsiteY1" fmla="*/ 338447 h 339622"/>
              <a:gd name="connsiteX2" fmla="*/ 8778247 w 9146382"/>
              <a:gd name="connsiteY2" fmla="*/ 296883 h 339622"/>
              <a:gd name="connsiteX3" fmla="*/ 9146382 w 9146382"/>
              <a:gd name="connsiteY3" fmla="*/ 231569 h 339622"/>
              <a:gd name="connsiteX4" fmla="*/ 9146382 w 9146382"/>
              <a:gd name="connsiteY4" fmla="*/ 0 h 339622"/>
              <a:gd name="connsiteX5" fmla="*/ 8040522 w 9146382"/>
              <a:gd name="connsiteY5" fmla="*/ 302822 h 339622"/>
              <a:gd name="connsiteX6" fmla="*/ 0 w 9146382"/>
              <a:gd name="connsiteY6" fmla="*/ 305387 h 339622"/>
              <a:gd name="connsiteX7" fmla="*/ 1207 w 9146382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2822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3685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4860 h 334860"/>
              <a:gd name="connsiteX1" fmla="*/ 8236768 w 9145230"/>
              <a:gd name="connsiteY1" fmla="*/ 333685 h 334860"/>
              <a:gd name="connsiteX2" fmla="*/ 8777095 w 9145230"/>
              <a:gd name="connsiteY2" fmla="*/ 296883 h 334860"/>
              <a:gd name="connsiteX3" fmla="*/ 9145230 w 9145230"/>
              <a:gd name="connsiteY3" fmla="*/ 231569 h 334860"/>
              <a:gd name="connsiteX4" fmla="*/ 9145230 w 9145230"/>
              <a:gd name="connsiteY4" fmla="*/ 0 h 334860"/>
              <a:gd name="connsiteX5" fmla="*/ 8039370 w 9145230"/>
              <a:gd name="connsiteY5" fmla="*/ 305204 h 334860"/>
              <a:gd name="connsiteX6" fmla="*/ 1230 w 9145230"/>
              <a:gd name="connsiteY6" fmla="*/ 305387 h 334860"/>
              <a:gd name="connsiteX7" fmla="*/ 55 w 9145230"/>
              <a:gd name="connsiteY7" fmla="*/ 334860 h 334860"/>
              <a:gd name="connsiteX0" fmla="*/ 27 w 9145202"/>
              <a:gd name="connsiteY0" fmla="*/ 334860 h 334860"/>
              <a:gd name="connsiteX1" fmla="*/ 8236740 w 9145202"/>
              <a:gd name="connsiteY1" fmla="*/ 333685 h 334860"/>
              <a:gd name="connsiteX2" fmla="*/ 8777067 w 9145202"/>
              <a:gd name="connsiteY2" fmla="*/ 296883 h 334860"/>
              <a:gd name="connsiteX3" fmla="*/ 9145202 w 9145202"/>
              <a:gd name="connsiteY3" fmla="*/ 231569 h 334860"/>
              <a:gd name="connsiteX4" fmla="*/ 9145202 w 9145202"/>
              <a:gd name="connsiteY4" fmla="*/ 0 h 334860"/>
              <a:gd name="connsiteX5" fmla="*/ 8039342 w 9145202"/>
              <a:gd name="connsiteY5" fmla="*/ 305204 h 334860"/>
              <a:gd name="connsiteX6" fmla="*/ 3584 w 9145202"/>
              <a:gd name="connsiteY6" fmla="*/ 300624 h 334860"/>
              <a:gd name="connsiteX7" fmla="*/ 27 w 9145202"/>
              <a:gd name="connsiteY7" fmla="*/ 334860 h 334860"/>
              <a:gd name="connsiteX0" fmla="*/ 27 w 9145202"/>
              <a:gd name="connsiteY0" fmla="*/ 334860 h 334860"/>
              <a:gd name="connsiteX1" fmla="*/ 8236740 w 9145202"/>
              <a:gd name="connsiteY1" fmla="*/ 333685 h 334860"/>
              <a:gd name="connsiteX2" fmla="*/ 8777067 w 9145202"/>
              <a:gd name="connsiteY2" fmla="*/ 296883 h 334860"/>
              <a:gd name="connsiteX3" fmla="*/ 9145202 w 9145202"/>
              <a:gd name="connsiteY3" fmla="*/ 231569 h 334860"/>
              <a:gd name="connsiteX4" fmla="*/ 9145202 w 9145202"/>
              <a:gd name="connsiteY4" fmla="*/ 0 h 334860"/>
              <a:gd name="connsiteX5" fmla="*/ 8039342 w 9145202"/>
              <a:gd name="connsiteY5" fmla="*/ 305204 h 334860"/>
              <a:gd name="connsiteX6" fmla="*/ 3584 w 9145202"/>
              <a:gd name="connsiteY6" fmla="*/ 305387 h 334860"/>
              <a:gd name="connsiteX7" fmla="*/ 27 w 9145202"/>
              <a:gd name="connsiteY7" fmla="*/ 334860 h 334860"/>
              <a:gd name="connsiteX0" fmla="*/ 4 w 9145179"/>
              <a:gd name="connsiteY0" fmla="*/ 334860 h 334860"/>
              <a:gd name="connsiteX1" fmla="*/ 8236717 w 9145179"/>
              <a:gd name="connsiteY1" fmla="*/ 333685 h 334860"/>
              <a:gd name="connsiteX2" fmla="*/ 8777044 w 9145179"/>
              <a:gd name="connsiteY2" fmla="*/ 296883 h 334860"/>
              <a:gd name="connsiteX3" fmla="*/ 9145179 w 9145179"/>
              <a:gd name="connsiteY3" fmla="*/ 231569 h 334860"/>
              <a:gd name="connsiteX4" fmla="*/ 9145179 w 9145179"/>
              <a:gd name="connsiteY4" fmla="*/ 0 h 334860"/>
              <a:gd name="connsiteX5" fmla="*/ 8039319 w 9145179"/>
              <a:gd name="connsiteY5" fmla="*/ 305204 h 334860"/>
              <a:gd name="connsiteX6" fmla="*/ 32137 w 9145179"/>
              <a:gd name="connsiteY6" fmla="*/ 288718 h 334860"/>
              <a:gd name="connsiteX7" fmla="*/ 4 w 9145179"/>
              <a:gd name="connsiteY7" fmla="*/ 334860 h 334860"/>
              <a:gd name="connsiteX0" fmla="*/ 54 w 9145229"/>
              <a:gd name="connsiteY0" fmla="*/ 334860 h 334860"/>
              <a:gd name="connsiteX1" fmla="*/ 8236767 w 9145229"/>
              <a:gd name="connsiteY1" fmla="*/ 333685 h 334860"/>
              <a:gd name="connsiteX2" fmla="*/ 8777094 w 9145229"/>
              <a:gd name="connsiteY2" fmla="*/ 296883 h 334860"/>
              <a:gd name="connsiteX3" fmla="*/ 9145229 w 9145229"/>
              <a:gd name="connsiteY3" fmla="*/ 231569 h 334860"/>
              <a:gd name="connsiteX4" fmla="*/ 9145229 w 9145229"/>
              <a:gd name="connsiteY4" fmla="*/ 0 h 334860"/>
              <a:gd name="connsiteX5" fmla="*/ 8039369 w 9145229"/>
              <a:gd name="connsiteY5" fmla="*/ 305204 h 334860"/>
              <a:gd name="connsiteX6" fmla="*/ 1231 w 9145229"/>
              <a:gd name="connsiteY6" fmla="*/ 303006 h 334860"/>
              <a:gd name="connsiteX7" fmla="*/ 54 w 9145229"/>
              <a:gd name="connsiteY7" fmla="*/ 334860 h 334860"/>
              <a:gd name="connsiteX0" fmla="*/ 54 w 9145229"/>
              <a:gd name="connsiteY0" fmla="*/ 334860 h 334860"/>
              <a:gd name="connsiteX1" fmla="*/ 8236767 w 9145229"/>
              <a:gd name="connsiteY1" fmla="*/ 333685 h 334860"/>
              <a:gd name="connsiteX2" fmla="*/ 8777094 w 9145229"/>
              <a:gd name="connsiteY2" fmla="*/ 296883 h 334860"/>
              <a:gd name="connsiteX3" fmla="*/ 9145229 w 9145229"/>
              <a:gd name="connsiteY3" fmla="*/ 231569 h 334860"/>
              <a:gd name="connsiteX4" fmla="*/ 9145229 w 9145229"/>
              <a:gd name="connsiteY4" fmla="*/ 0 h 334860"/>
              <a:gd name="connsiteX5" fmla="*/ 6055787 w 9145229"/>
              <a:gd name="connsiteY5" fmla="*/ 305204 h 334860"/>
              <a:gd name="connsiteX6" fmla="*/ 1231 w 9145229"/>
              <a:gd name="connsiteY6" fmla="*/ 303006 h 334860"/>
              <a:gd name="connsiteX7" fmla="*/ 54 w 9145229"/>
              <a:gd name="connsiteY7" fmla="*/ 334860 h 334860"/>
              <a:gd name="connsiteX0" fmla="*/ 54 w 9145229"/>
              <a:gd name="connsiteY0" fmla="*/ 334860 h 336066"/>
              <a:gd name="connsiteX1" fmla="*/ 6198417 w 9145229"/>
              <a:gd name="connsiteY1" fmla="*/ 336066 h 336066"/>
              <a:gd name="connsiteX2" fmla="*/ 8777094 w 9145229"/>
              <a:gd name="connsiteY2" fmla="*/ 296883 h 336066"/>
              <a:gd name="connsiteX3" fmla="*/ 9145229 w 9145229"/>
              <a:gd name="connsiteY3" fmla="*/ 231569 h 336066"/>
              <a:gd name="connsiteX4" fmla="*/ 9145229 w 9145229"/>
              <a:gd name="connsiteY4" fmla="*/ 0 h 336066"/>
              <a:gd name="connsiteX5" fmla="*/ 6055787 w 9145229"/>
              <a:gd name="connsiteY5" fmla="*/ 305204 h 336066"/>
              <a:gd name="connsiteX6" fmla="*/ 1231 w 9145229"/>
              <a:gd name="connsiteY6" fmla="*/ 303006 h 336066"/>
              <a:gd name="connsiteX7" fmla="*/ 54 w 9145229"/>
              <a:gd name="connsiteY7" fmla="*/ 334860 h 336066"/>
              <a:gd name="connsiteX0" fmla="*/ 54 w 9145229"/>
              <a:gd name="connsiteY0" fmla="*/ 873022 h 874228"/>
              <a:gd name="connsiteX1" fmla="*/ 6198417 w 9145229"/>
              <a:gd name="connsiteY1" fmla="*/ 874228 h 874228"/>
              <a:gd name="connsiteX2" fmla="*/ 8777094 w 9145229"/>
              <a:gd name="connsiteY2" fmla="*/ 835045 h 874228"/>
              <a:gd name="connsiteX3" fmla="*/ 9145229 w 9145229"/>
              <a:gd name="connsiteY3" fmla="*/ 769731 h 874228"/>
              <a:gd name="connsiteX4" fmla="*/ 9142848 w 9145229"/>
              <a:gd name="connsiteY4" fmla="*/ 0 h 874228"/>
              <a:gd name="connsiteX5" fmla="*/ 6055787 w 9145229"/>
              <a:gd name="connsiteY5" fmla="*/ 843366 h 874228"/>
              <a:gd name="connsiteX6" fmla="*/ 1231 w 9145229"/>
              <a:gd name="connsiteY6" fmla="*/ 841168 h 874228"/>
              <a:gd name="connsiteX7" fmla="*/ 54 w 9145229"/>
              <a:gd name="connsiteY7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8777094 w 9147610"/>
              <a:gd name="connsiteY2" fmla="*/ 835045 h 874228"/>
              <a:gd name="connsiteX3" fmla="*/ 9147610 w 9147610"/>
              <a:gd name="connsiteY3" fmla="*/ 576849 h 874228"/>
              <a:gd name="connsiteX4" fmla="*/ 9142848 w 9147610"/>
              <a:gd name="connsiteY4" fmla="*/ 0 h 874228"/>
              <a:gd name="connsiteX5" fmla="*/ 6055787 w 9147610"/>
              <a:gd name="connsiteY5" fmla="*/ 843366 h 874228"/>
              <a:gd name="connsiteX6" fmla="*/ 1231 w 9147610"/>
              <a:gd name="connsiteY6" fmla="*/ 841168 h 874228"/>
              <a:gd name="connsiteX7" fmla="*/ 54 w 9147610"/>
              <a:gd name="connsiteY7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7907938 w 9147610"/>
              <a:gd name="connsiteY2" fmla="*/ 804089 h 874228"/>
              <a:gd name="connsiteX3" fmla="*/ 9147610 w 9147610"/>
              <a:gd name="connsiteY3" fmla="*/ 576849 h 874228"/>
              <a:gd name="connsiteX4" fmla="*/ 9142848 w 9147610"/>
              <a:gd name="connsiteY4" fmla="*/ 0 h 874228"/>
              <a:gd name="connsiteX5" fmla="*/ 6055787 w 9147610"/>
              <a:gd name="connsiteY5" fmla="*/ 843366 h 874228"/>
              <a:gd name="connsiteX6" fmla="*/ 1231 w 9147610"/>
              <a:gd name="connsiteY6" fmla="*/ 841168 h 874228"/>
              <a:gd name="connsiteX7" fmla="*/ 54 w 9147610"/>
              <a:gd name="connsiteY7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9147610 w 9147610"/>
              <a:gd name="connsiteY2" fmla="*/ 576849 h 874228"/>
              <a:gd name="connsiteX3" fmla="*/ 9142848 w 9147610"/>
              <a:gd name="connsiteY3" fmla="*/ 0 h 874228"/>
              <a:gd name="connsiteX4" fmla="*/ 6055787 w 9147610"/>
              <a:gd name="connsiteY4" fmla="*/ 843366 h 874228"/>
              <a:gd name="connsiteX5" fmla="*/ 1231 w 9147610"/>
              <a:gd name="connsiteY5" fmla="*/ 841168 h 874228"/>
              <a:gd name="connsiteX6" fmla="*/ 54 w 9147610"/>
              <a:gd name="connsiteY6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9147610 w 9147610"/>
              <a:gd name="connsiteY2" fmla="*/ 576849 h 874228"/>
              <a:gd name="connsiteX3" fmla="*/ 9142848 w 9147610"/>
              <a:gd name="connsiteY3" fmla="*/ 0 h 874228"/>
              <a:gd name="connsiteX4" fmla="*/ 6055787 w 9147610"/>
              <a:gd name="connsiteY4" fmla="*/ 843366 h 874228"/>
              <a:gd name="connsiteX5" fmla="*/ 1231 w 9147610"/>
              <a:gd name="connsiteY5" fmla="*/ 841168 h 874228"/>
              <a:gd name="connsiteX6" fmla="*/ 54 w 9147610"/>
              <a:gd name="connsiteY6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9147610 w 9147610"/>
              <a:gd name="connsiteY2" fmla="*/ 576849 h 874228"/>
              <a:gd name="connsiteX3" fmla="*/ 9142848 w 9147610"/>
              <a:gd name="connsiteY3" fmla="*/ 0 h 874228"/>
              <a:gd name="connsiteX4" fmla="*/ 6055787 w 9147610"/>
              <a:gd name="connsiteY4" fmla="*/ 843366 h 874228"/>
              <a:gd name="connsiteX5" fmla="*/ 1231 w 9147610"/>
              <a:gd name="connsiteY5" fmla="*/ 841168 h 874228"/>
              <a:gd name="connsiteX6" fmla="*/ 54 w 9147610"/>
              <a:gd name="connsiteY6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9147610 w 9147610"/>
              <a:gd name="connsiteY2" fmla="*/ 576849 h 874228"/>
              <a:gd name="connsiteX3" fmla="*/ 9142848 w 9147610"/>
              <a:gd name="connsiteY3" fmla="*/ 0 h 874228"/>
              <a:gd name="connsiteX4" fmla="*/ 6055787 w 9147610"/>
              <a:gd name="connsiteY4" fmla="*/ 843366 h 874228"/>
              <a:gd name="connsiteX5" fmla="*/ 1231 w 9147610"/>
              <a:gd name="connsiteY5" fmla="*/ 841168 h 874228"/>
              <a:gd name="connsiteX6" fmla="*/ 54 w 9147610"/>
              <a:gd name="connsiteY6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9147610 w 9147610"/>
              <a:gd name="connsiteY2" fmla="*/ 576849 h 874228"/>
              <a:gd name="connsiteX3" fmla="*/ 9142848 w 9147610"/>
              <a:gd name="connsiteY3" fmla="*/ 0 h 874228"/>
              <a:gd name="connsiteX4" fmla="*/ 6055787 w 9147610"/>
              <a:gd name="connsiteY4" fmla="*/ 843366 h 874228"/>
              <a:gd name="connsiteX5" fmla="*/ 1231 w 9147610"/>
              <a:gd name="connsiteY5" fmla="*/ 841168 h 874228"/>
              <a:gd name="connsiteX6" fmla="*/ 54 w 9147610"/>
              <a:gd name="connsiteY6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9147610 w 9147610"/>
              <a:gd name="connsiteY2" fmla="*/ 576849 h 874228"/>
              <a:gd name="connsiteX3" fmla="*/ 9142848 w 9147610"/>
              <a:gd name="connsiteY3" fmla="*/ 0 h 874228"/>
              <a:gd name="connsiteX4" fmla="*/ 6055787 w 9147610"/>
              <a:gd name="connsiteY4" fmla="*/ 843366 h 874228"/>
              <a:gd name="connsiteX5" fmla="*/ 1231 w 9147610"/>
              <a:gd name="connsiteY5" fmla="*/ 841168 h 874228"/>
              <a:gd name="connsiteX6" fmla="*/ 54 w 9147610"/>
              <a:gd name="connsiteY6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9147610 w 9147610"/>
              <a:gd name="connsiteY2" fmla="*/ 576849 h 874228"/>
              <a:gd name="connsiteX3" fmla="*/ 9142848 w 9147610"/>
              <a:gd name="connsiteY3" fmla="*/ 0 h 874228"/>
              <a:gd name="connsiteX4" fmla="*/ 6055787 w 9147610"/>
              <a:gd name="connsiteY4" fmla="*/ 843366 h 874228"/>
              <a:gd name="connsiteX5" fmla="*/ 1231 w 9147610"/>
              <a:gd name="connsiteY5" fmla="*/ 841168 h 874228"/>
              <a:gd name="connsiteX6" fmla="*/ 54 w 9147610"/>
              <a:gd name="connsiteY6" fmla="*/ 873022 h 874228"/>
              <a:gd name="connsiteX0" fmla="*/ 54 w 9147610"/>
              <a:gd name="connsiteY0" fmla="*/ 868259 h 869465"/>
              <a:gd name="connsiteX1" fmla="*/ 6198417 w 9147610"/>
              <a:gd name="connsiteY1" fmla="*/ 869465 h 869465"/>
              <a:gd name="connsiteX2" fmla="*/ 9147610 w 9147610"/>
              <a:gd name="connsiteY2" fmla="*/ 572086 h 869465"/>
              <a:gd name="connsiteX3" fmla="*/ 9145229 w 9147610"/>
              <a:gd name="connsiteY3" fmla="*/ 0 h 869465"/>
              <a:gd name="connsiteX4" fmla="*/ 6055787 w 9147610"/>
              <a:gd name="connsiteY4" fmla="*/ 838603 h 869465"/>
              <a:gd name="connsiteX5" fmla="*/ 1231 w 9147610"/>
              <a:gd name="connsiteY5" fmla="*/ 836405 h 869465"/>
              <a:gd name="connsiteX6" fmla="*/ 54 w 9147610"/>
              <a:gd name="connsiteY6" fmla="*/ 868259 h 869465"/>
              <a:gd name="connsiteX0" fmla="*/ 54 w 9147610"/>
              <a:gd name="connsiteY0" fmla="*/ 868259 h 869465"/>
              <a:gd name="connsiteX1" fmla="*/ 6198417 w 9147610"/>
              <a:gd name="connsiteY1" fmla="*/ 869465 h 869465"/>
              <a:gd name="connsiteX2" fmla="*/ 9147610 w 9147610"/>
              <a:gd name="connsiteY2" fmla="*/ 572086 h 869465"/>
              <a:gd name="connsiteX3" fmla="*/ 9145229 w 9147610"/>
              <a:gd name="connsiteY3" fmla="*/ 0 h 869465"/>
              <a:gd name="connsiteX4" fmla="*/ 6055787 w 9147610"/>
              <a:gd name="connsiteY4" fmla="*/ 838603 h 869465"/>
              <a:gd name="connsiteX5" fmla="*/ 1231 w 9147610"/>
              <a:gd name="connsiteY5" fmla="*/ 836405 h 869465"/>
              <a:gd name="connsiteX6" fmla="*/ 54 w 9147610"/>
              <a:gd name="connsiteY6" fmla="*/ 868259 h 869465"/>
              <a:gd name="connsiteX0" fmla="*/ 54 w 9147610"/>
              <a:gd name="connsiteY0" fmla="*/ 1508816 h 1508816"/>
              <a:gd name="connsiteX1" fmla="*/ 6198417 w 9147610"/>
              <a:gd name="connsiteY1" fmla="*/ 869465 h 1508816"/>
              <a:gd name="connsiteX2" fmla="*/ 9147610 w 9147610"/>
              <a:gd name="connsiteY2" fmla="*/ 572086 h 1508816"/>
              <a:gd name="connsiteX3" fmla="*/ 9145229 w 9147610"/>
              <a:gd name="connsiteY3" fmla="*/ 0 h 1508816"/>
              <a:gd name="connsiteX4" fmla="*/ 6055787 w 9147610"/>
              <a:gd name="connsiteY4" fmla="*/ 838603 h 1508816"/>
              <a:gd name="connsiteX5" fmla="*/ 1231 w 9147610"/>
              <a:gd name="connsiteY5" fmla="*/ 836405 h 1508816"/>
              <a:gd name="connsiteX6" fmla="*/ 54 w 9147610"/>
              <a:gd name="connsiteY6" fmla="*/ 1508816 h 1508816"/>
              <a:gd name="connsiteX0" fmla="*/ 54 w 9147610"/>
              <a:gd name="connsiteY0" fmla="*/ 3535259 h 3535259"/>
              <a:gd name="connsiteX1" fmla="*/ 6198417 w 9147610"/>
              <a:gd name="connsiteY1" fmla="*/ 869465 h 3535259"/>
              <a:gd name="connsiteX2" fmla="*/ 9147610 w 9147610"/>
              <a:gd name="connsiteY2" fmla="*/ 572086 h 3535259"/>
              <a:gd name="connsiteX3" fmla="*/ 9145229 w 9147610"/>
              <a:gd name="connsiteY3" fmla="*/ 0 h 3535259"/>
              <a:gd name="connsiteX4" fmla="*/ 6055787 w 9147610"/>
              <a:gd name="connsiteY4" fmla="*/ 838603 h 3535259"/>
              <a:gd name="connsiteX5" fmla="*/ 1231 w 9147610"/>
              <a:gd name="connsiteY5" fmla="*/ 836405 h 3535259"/>
              <a:gd name="connsiteX6" fmla="*/ 54 w 9147610"/>
              <a:gd name="connsiteY6" fmla="*/ 3535259 h 3535259"/>
              <a:gd name="connsiteX0" fmla="*/ 54 w 9147610"/>
              <a:gd name="connsiteY0" fmla="*/ 3535259 h 3535259"/>
              <a:gd name="connsiteX1" fmla="*/ 9147610 w 9147610"/>
              <a:gd name="connsiteY1" fmla="*/ 572086 h 3535259"/>
              <a:gd name="connsiteX2" fmla="*/ 9145229 w 9147610"/>
              <a:gd name="connsiteY2" fmla="*/ 0 h 3535259"/>
              <a:gd name="connsiteX3" fmla="*/ 6055787 w 9147610"/>
              <a:gd name="connsiteY3" fmla="*/ 838603 h 3535259"/>
              <a:gd name="connsiteX4" fmla="*/ 1231 w 9147610"/>
              <a:gd name="connsiteY4" fmla="*/ 836405 h 3535259"/>
              <a:gd name="connsiteX5" fmla="*/ 54 w 9147610"/>
              <a:gd name="connsiteY5" fmla="*/ 3535259 h 3535259"/>
              <a:gd name="connsiteX0" fmla="*/ 54 w 9147610"/>
              <a:gd name="connsiteY0" fmla="*/ 3535259 h 3535259"/>
              <a:gd name="connsiteX1" fmla="*/ 9147610 w 9147610"/>
              <a:gd name="connsiteY1" fmla="*/ 1415049 h 3535259"/>
              <a:gd name="connsiteX2" fmla="*/ 9145229 w 9147610"/>
              <a:gd name="connsiteY2" fmla="*/ 0 h 3535259"/>
              <a:gd name="connsiteX3" fmla="*/ 6055787 w 9147610"/>
              <a:gd name="connsiteY3" fmla="*/ 838603 h 3535259"/>
              <a:gd name="connsiteX4" fmla="*/ 1231 w 9147610"/>
              <a:gd name="connsiteY4" fmla="*/ 836405 h 3535259"/>
              <a:gd name="connsiteX5" fmla="*/ 54 w 9147610"/>
              <a:gd name="connsiteY5" fmla="*/ 3535259 h 3535259"/>
              <a:gd name="connsiteX0" fmla="*/ 54 w 9145280"/>
              <a:gd name="connsiteY0" fmla="*/ 3535259 h 3535259"/>
              <a:gd name="connsiteX1" fmla="*/ 9138085 w 9145280"/>
              <a:gd name="connsiteY1" fmla="*/ 1588880 h 3535259"/>
              <a:gd name="connsiteX2" fmla="*/ 9145229 w 9145280"/>
              <a:gd name="connsiteY2" fmla="*/ 0 h 3535259"/>
              <a:gd name="connsiteX3" fmla="*/ 6055787 w 9145280"/>
              <a:gd name="connsiteY3" fmla="*/ 838603 h 3535259"/>
              <a:gd name="connsiteX4" fmla="*/ 1231 w 9145280"/>
              <a:gd name="connsiteY4" fmla="*/ 836405 h 3535259"/>
              <a:gd name="connsiteX5" fmla="*/ 54 w 9145280"/>
              <a:gd name="connsiteY5" fmla="*/ 3535259 h 3535259"/>
              <a:gd name="connsiteX0" fmla="*/ 54 w 9145458"/>
              <a:gd name="connsiteY0" fmla="*/ 3535259 h 3535259"/>
              <a:gd name="connsiteX1" fmla="*/ 9145229 w 9145458"/>
              <a:gd name="connsiteY1" fmla="*/ 3531980 h 3535259"/>
              <a:gd name="connsiteX2" fmla="*/ 9145229 w 9145458"/>
              <a:gd name="connsiteY2" fmla="*/ 0 h 3535259"/>
              <a:gd name="connsiteX3" fmla="*/ 6055787 w 9145458"/>
              <a:gd name="connsiteY3" fmla="*/ 838603 h 3535259"/>
              <a:gd name="connsiteX4" fmla="*/ 1231 w 9145458"/>
              <a:gd name="connsiteY4" fmla="*/ 836405 h 3535259"/>
              <a:gd name="connsiteX5" fmla="*/ 54 w 9145458"/>
              <a:gd name="connsiteY5" fmla="*/ 3535259 h 3535259"/>
              <a:gd name="connsiteX0" fmla="*/ 54 w 9147610"/>
              <a:gd name="connsiteY0" fmla="*/ 3535259 h 3535259"/>
              <a:gd name="connsiteX1" fmla="*/ 9147610 w 9147610"/>
              <a:gd name="connsiteY1" fmla="*/ 3529598 h 3535259"/>
              <a:gd name="connsiteX2" fmla="*/ 9145229 w 9147610"/>
              <a:gd name="connsiteY2" fmla="*/ 0 h 3535259"/>
              <a:gd name="connsiteX3" fmla="*/ 6055787 w 9147610"/>
              <a:gd name="connsiteY3" fmla="*/ 838603 h 3535259"/>
              <a:gd name="connsiteX4" fmla="*/ 1231 w 9147610"/>
              <a:gd name="connsiteY4" fmla="*/ 836405 h 3535259"/>
              <a:gd name="connsiteX5" fmla="*/ 54 w 9147610"/>
              <a:gd name="connsiteY5" fmla="*/ 3535259 h 3535259"/>
              <a:gd name="connsiteX0" fmla="*/ 54 w 9154754"/>
              <a:gd name="connsiteY0" fmla="*/ 3535259 h 3553411"/>
              <a:gd name="connsiteX1" fmla="*/ 9154754 w 9154754"/>
              <a:gd name="connsiteY1" fmla="*/ 3553411 h 3553411"/>
              <a:gd name="connsiteX2" fmla="*/ 9145229 w 9154754"/>
              <a:gd name="connsiteY2" fmla="*/ 0 h 3553411"/>
              <a:gd name="connsiteX3" fmla="*/ 6055787 w 9154754"/>
              <a:gd name="connsiteY3" fmla="*/ 838603 h 3553411"/>
              <a:gd name="connsiteX4" fmla="*/ 1231 w 9154754"/>
              <a:gd name="connsiteY4" fmla="*/ 836405 h 3553411"/>
              <a:gd name="connsiteX5" fmla="*/ 54 w 9154754"/>
              <a:gd name="connsiteY5" fmla="*/ 3535259 h 3553411"/>
              <a:gd name="connsiteX0" fmla="*/ 54 w 9147611"/>
              <a:gd name="connsiteY0" fmla="*/ 3535259 h 3539124"/>
              <a:gd name="connsiteX1" fmla="*/ 9147611 w 9147611"/>
              <a:gd name="connsiteY1" fmla="*/ 3539124 h 3539124"/>
              <a:gd name="connsiteX2" fmla="*/ 9145229 w 9147611"/>
              <a:gd name="connsiteY2" fmla="*/ 0 h 3539124"/>
              <a:gd name="connsiteX3" fmla="*/ 6055787 w 9147611"/>
              <a:gd name="connsiteY3" fmla="*/ 838603 h 3539124"/>
              <a:gd name="connsiteX4" fmla="*/ 1231 w 9147611"/>
              <a:gd name="connsiteY4" fmla="*/ 836405 h 3539124"/>
              <a:gd name="connsiteX5" fmla="*/ 54 w 9147611"/>
              <a:gd name="connsiteY5" fmla="*/ 3535259 h 353912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9147611" h="3539124">
                <a:moveTo>
                  <a:pt x="54" y="3535259"/>
                </a:moveTo>
                <a:lnTo>
                  <a:pt x="9147611" y="3539124"/>
                </a:lnTo>
                <a:cubicBezTo>
                  <a:pt x="9146817" y="3282547"/>
                  <a:pt x="9146023" y="256577"/>
                  <a:pt x="9145229" y="0"/>
                </a:cubicBezTo>
                <a:cubicBezTo>
                  <a:pt x="8508481" y="485745"/>
                  <a:pt x="7318244" y="819060"/>
                  <a:pt x="6055787" y="838603"/>
                </a:cubicBezTo>
                <a:lnTo>
                  <a:pt x="1231" y="836405"/>
                </a:lnTo>
                <a:cubicBezTo>
                  <a:pt x="1633" y="849404"/>
                  <a:pt x="-348" y="3522260"/>
                  <a:pt x="54" y="3535259"/>
                </a:cubicBezTo>
                <a:close/>
              </a:path>
            </a:pathLst>
          </a:custGeom>
          <a:solidFill>
            <a:schemeClr val="bg2"/>
          </a:solidFill>
          <a:ln w="3175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フリーフォーム 6"/>
          <p:cNvSpPr/>
          <p:nvPr/>
        </p:nvSpPr>
        <p:spPr>
          <a:xfrm>
            <a:off x="-1229" y="3302898"/>
            <a:ext cx="9147610" cy="869465"/>
          </a:xfrm>
          <a:custGeom>
            <a:avLst/>
            <a:gdLst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5938 w 9149938"/>
              <a:gd name="connsiteY7" fmla="*/ 231569 h 344385"/>
              <a:gd name="connsiteX8" fmla="*/ 0 w 9149938"/>
              <a:gd name="connsiteY8" fmla="*/ 344385 h 344385"/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10700 w 9149938"/>
              <a:gd name="connsiteY7" fmla="*/ 300625 h 344385"/>
              <a:gd name="connsiteX8" fmla="*/ 0 w 9149938"/>
              <a:gd name="connsiteY8" fmla="*/ 344385 h 344385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25019 w 9139238"/>
              <a:gd name="connsiteY0" fmla="*/ 399154 h 399154"/>
              <a:gd name="connsiteX1" fmla="*/ 8230776 w 9139238"/>
              <a:gd name="connsiteY1" fmla="*/ 338447 h 399154"/>
              <a:gd name="connsiteX2" fmla="*/ 8771103 w 9139238"/>
              <a:gd name="connsiteY2" fmla="*/ 296883 h 399154"/>
              <a:gd name="connsiteX3" fmla="*/ 9139238 w 9139238"/>
              <a:gd name="connsiteY3" fmla="*/ 231569 h 399154"/>
              <a:gd name="connsiteX4" fmla="*/ 9139238 w 9139238"/>
              <a:gd name="connsiteY4" fmla="*/ 0 h 399154"/>
              <a:gd name="connsiteX5" fmla="*/ 8747352 w 9139238"/>
              <a:gd name="connsiteY5" fmla="*/ 201881 h 399154"/>
              <a:gd name="connsiteX6" fmla="*/ 8135773 w 9139238"/>
              <a:gd name="connsiteY6" fmla="*/ 302821 h 399154"/>
              <a:gd name="connsiteX7" fmla="*/ 0 w 9139238"/>
              <a:gd name="connsiteY7" fmla="*/ 300625 h 399154"/>
              <a:gd name="connsiteX8" fmla="*/ 25019 w 9139238"/>
              <a:gd name="connsiteY8" fmla="*/ 399154 h 39915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5937 w 9145175"/>
              <a:gd name="connsiteY7" fmla="*/ 300625 h 342004"/>
              <a:gd name="connsiteX8" fmla="*/ 0 w 9145175"/>
              <a:gd name="connsiteY8" fmla="*/ 342004 h 34200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120237 w 9145175"/>
              <a:gd name="connsiteY7" fmla="*/ 255381 h 342004"/>
              <a:gd name="connsiteX8" fmla="*/ 0 w 9145175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142917 w 9146382"/>
              <a:gd name="connsiteY6" fmla="*/ 302821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55 w 9145230"/>
              <a:gd name="connsiteY0" fmla="*/ 342004 h 342004"/>
              <a:gd name="connsiteX1" fmla="*/ 8236768 w 9145230"/>
              <a:gd name="connsiteY1" fmla="*/ 338447 h 342004"/>
              <a:gd name="connsiteX2" fmla="*/ 8777095 w 9145230"/>
              <a:gd name="connsiteY2" fmla="*/ 296883 h 342004"/>
              <a:gd name="connsiteX3" fmla="*/ 9145230 w 9145230"/>
              <a:gd name="connsiteY3" fmla="*/ 231569 h 342004"/>
              <a:gd name="connsiteX4" fmla="*/ 9145230 w 9145230"/>
              <a:gd name="connsiteY4" fmla="*/ 0 h 342004"/>
              <a:gd name="connsiteX5" fmla="*/ 8039370 w 9145230"/>
              <a:gd name="connsiteY5" fmla="*/ 302822 h 342004"/>
              <a:gd name="connsiteX6" fmla="*/ 1230 w 9145230"/>
              <a:gd name="connsiteY6" fmla="*/ 307768 h 342004"/>
              <a:gd name="connsiteX7" fmla="*/ 55 w 9145230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5387 h 342004"/>
              <a:gd name="connsiteX7" fmla="*/ 1207 w 9146382"/>
              <a:gd name="connsiteY7" fmla="*/ 342004 h 342004"/>
              <a:gd name="connsiteX0" fmla="*/ 1207 w 9146382"/>
              <a:gd name="connsiteY0" fmla="*/ 339622 h 339622"/>
              <a:gd name="connsiteX1" fmla="*/ 8237920 w 9146382"/>
              <a:gd name="connsiteY1" fmla="*/ 338447 h 339622"/>
              <a:gd name="connsiteX2" fmla="*/ 8778247 w 9146382"/>
              <a:gd name="connsiteY2" fmla="*/ 296883 h 339622"/>
              <a:gd name="connsiteX3" fmla="*/ 9146382 w 9146382"/>
              <a:gd name="connsiteY3" fmla="*/ 231569 h 339622"/>
              <a:gd name="connsiteX4" fmla="*/ 9146382 w 9146382"/>
              <a:gd name="connsiteY4" fmla="*/ 0 h 339622"/>
              <a:gd name="connsiteX5" fmla="*/ 8040522 w 9146382"/>
              <a:gd name="connsiteY5" fmla="*/ 302822 h 339622"/>
              <a:gd name="connsiteX6" fmla="*/ 0 w 9146382"/>
              <a:gd name="connsiteY6" fmla="*/ 305387 h 339622"/>
              <a:gd name="connsiteX7" fmla="*/ 1207 w 9146382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2822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3685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4860 h 334860"/>
              <a:gd name="connsiteX1" fmla="*/ 8236768 w 9145230"/>
              <a:gd name="connsiteY1" fmla="*/ 333685 h 334860"/>
              <a:gd name="connsiteX2" fmla="*/ 8777095 w 9145230"/>
              <a:gd name="connsiteY2" fmla="*/ 296883 h 334860"/>
              <a:gd name="connsiteX3" fmla="*/ 9145230 w 9145230"/>
              <a:gd name="connsiteY3" fmla="*/ 231569 h 334860"/>
              <a:gd name="connsiteX4" fmla="*/ 9145230 w 9145230"/>
              <a:gd name="connsiteY4" fmla="*/ 0 h 334860"/>
              <a:gd name="connsiteX5" fmla="*/ 8039370 w 9145230"/>
              <a:gd name="connsiteY5" fmla="*/ 305204 h 334860"/>
              <a:gd name="connsiteX6" fmla="*/ 1230 w 9145230"/>
              <a:gd name="connsiteY6" fmla="*/ 305387 h 334860"/>
              <a:gd name="connsiteX7" fmla="*/ 55 w 9145230"/>
              <a:gd name="connsiteY7" fmla="*/ 334860 h 334860"/>
              <a:gd name="connsiteX0" fmla="*/ 27 w 9145202"/>
              <a:gd name="connsiteY0" fmla="*/ 334860 h 334860"/>
              <a:gd name="connsiteX1" fmla="*/ 8236740 w 9145202"/>
              <a:gd name="connsiteY1" fmla="*/ 333685 h 334860"/>
              <a:gd name="connsiteX2" fmla="*/ 8777067 w 9145202"/>
              <a:gd name="connsiteY2" fmla="*/ 296883 h 334860"/>
              <a:gd name="connsiteX3" fmla="*/ 9145202 w 9145202"/>
              <a:gd name="connsiteY3" fmla="*/ 231569 h 334860"/>
              <a:gd name="connsiteX4" fmla="*/ 9145202 w 9145202"/>
              <a:gd name="connsiteY4" fmla="*/ 0 h 334860"/>
              <a:gd name="connsiteX5" fmla="*/ 8039342 w 9145202"/>
              <a:gd name="connsiteY5" fmla="*/ 305204 h 334860"/>
              <a:gd name="connsiteX6" fmla="*/ 3584 w 9145202"/>
              <a:gd name="connsiteY6" fmla="*/ 300624 h 334860"/>
              <a:gd name="connsiteX7" fmla="*/ 27 w 9145202"/>
              <a:gd name="connsiteY7" fmla="*/ 334860 h 334860"/>
              <a:gd name="connsiteX0" fmla="*/ 27 w 9145202"/>
              <a:gd name="connsiteY0" fmla="*/ 334860 h 334860"/>
              <a:gd name="connsiteX1" fmla="*/ 8236740 w 9145202"/>
              <a:gd name="connsiteY1" fmla="*/ 333685 h 334860"/>
              <a:gd name="connsiteX2" fmla="*/ 8777067 w 9145202"/>
              <a:gd name="connsiteY2" fmla="*/ 296883 h 334860"/>
              <a:gd name="connsiteX3" fmla="*/ 9145202 w 9145202"/>
              <a:gd name="connsiteY3" fmla="*/ 231569 h 334860"/>
              <a:gd name="connsiteX4" fmla="*/ 9145202 w 9145202"/>
              <a:gd name="connsiteY4" fmla="*/ 0 h 334860"/>
              <a:gd name="connsiteX5" fmla="*/ 8039342 w 9145202"/>
              <a:gd name="connsiteY5" fmla="*/ 305204 h 334860"/>
              <a:gd name="connsiteX6" fmla="*/ 3584 w 9145202"/>
              <a:gd name="connsiteY6" fmla="*/ 305387 h 334860"/>
              <a:gd name="connsiteX7" fmla="*/ 27 w 9145202"/>
              <a:gd name="connsiteY7" fmla="*/ 334860 h 334860"/>
              <a:gd name="connsiteX0" fmla="*/ 4 w 9145179"/>
              <a:gd name="connsiteY0" fmla="*/ 334860 h 334860"/>
              <a:gd name="connsiteX1" fmla="*/ 8236717 w 9145179"/>
              <a:gd name="connsiteY1" fmla="*/ 333685 h 334860"/>
              <a:gd name="connsiteX2" fmla="*/ 8777044 w 9145179"/>
              <a:gd name="connsiteY2" fmla="*/ 296883 h 334860"/>
              <a:gd name="connsiteX3" fmla="*/ 9145179 w 9145179"/>
              <a:gd name="connsiteY3" fmla="*/ 231569 h 334860"/>
              <a:gd name="connsiteX4" fmla="*/ 9145179 w 9145179"/>
              <a:gd name="connsiteY4" fmla="*/ 0 h 334860"/>
              <a:gd name="connsiteX5" fmla="*/ 8039319 w 9145179"/>
              <a:gd name="connsiteY5" fmla="*/ 305204 h 334860"/>
              <a:gd name="connsiteX6" fmla="*/ 32137 w 9145179"/>
              <a:gd name="connsiteY6" fmla="*/ 288718 h 334860"/>
              <a:gd name="connsiteX7" fmla="*/ 4 w 9145179"/>
              <a:gd name="connsiteY7" fmla="*/ 334860 h 334860"/>
              <a:gd name="connsiteX0" fmla="*/ 54 w 9145229"/>
              <a:gd name="connsiteY0" fmla="*/ 334860 h 334860"/>
              <a:gd name="connsiteX1" fmla="*/ 8236767 w 9145229"/>
              <a:gd name="connsiteY1" fmla="*/ 333685 h 334860"/>
              <a:gd name="connsiteX2" fmla="*/ 8777094 w 9145229"/>
              <a:gd name="connsiteY2" fmla="*/ 296883 h 334860"/>
              <a:gd name="connsiteX3" fmla="*/ 9145229 w 9145229"/>
              <a:gd name="connsiteY3" fmla="*/ 231569 h 334860"/>
              <a:gd name="connsiteX4" fmla="*/ 9145229 w 9145229"/>
              <a:gd name="connsiteY4" fmla="*/ 0 h 334860"/>
              <a:gd name="connsiteX5" fmla="*/ 8039369 w 9145229"/>
              <a:gd name="connsiteY5" fmla="*/ 305204 h 334860"/>
              <a:gd name="connsiteX6" fmla="*/ 1231 w 9145229"/>
              <a:gd name="connsiteY6" fmla="*/ 303006 h 334860"/>
              <a:gd name="connsiteX7" fmla="*/ 54 w 9145229"/>
              <a:gd name="connsiteY7" fmla="*/ 334860 h 334860"/>
              <a:gd name="connsiteX0" fmla="*/ 54 w 9145229"/>
              <a:gd name="connsiteY0" fmla="*/ 334860 h 334860"/>
              <a:gd name="connsiteX1" fmla="*/ 8236767 w 9145229"/>
              <a:gd name="connsiteY1" fmla="*/ 333685 h 334860"/>
              <a:gd name="connsiteX2" fmla="*/ 8777094 w 9145229"/>
              <a:gd name="connsiteY2" fmla="*/ 296883 h 334860"/>
              <a:gd name="connsiteX3" fmla="*/ 9145229 w 9145229"/>
              <a:gd name="connsiteY3" fmla="*/ 231569 h 334860"/>
              <a:gd name="connsiteX4" fmla="*/ 9145229 w 9145229"/>
              <a:gd name="connsiteY4" fmla="*/ 0 h 334860"/>
              <a:gd name="connsiteX5" fmla="*/ 6055787 w 9145229"/>
              <a:gd name="connsiteY5" fmla="*/ 305204 h 334860"/>
              <a:gd name="connsiteX6" fmla="*/ 1231 w 9145229"/>
              <a:gd name="connsiteY6" fmla="*/ 303006 h 334860"/>
              <a:gd name="connsiteX7" fmla="*/ 54 w 9145229"/>
              <a:gd name="connsiteY7" fmla="*/ 334860 h 334860"/>
              <a:gd name="connsiteX0" fmla="*/ 54 w 9145229"/>
              <a:gd name="connsiteY0" fmla="*/ 334860 h 336066"/>
              <a:gd name="connsiteX1" fmla="*/ 6198417 w 9145229"/>
              <a:gd name="connsiteY1" fmla="*/ 336066 h 336066"/>
              <a:gd name="connsiteX2" fmla="*/ 8777094 w 9145229"/>
              <a:gd name="connsiteY2" fmla="*/ 296883 h 336066"/>
              <a:gd name="connsiteX3" fmla="*/ 9145229 w 9145229"/>
              <a:gd name="connsiteY3" fmla="*/ 231569 h 336066"/>
              <a:gd name="connsiteX4" fmla="*/ 9145229 w 9145229"/>
              <a:gd name="connsiteY4" fmla="*/ 0 h 336066"/>
              <a:gd name="connsiteX5" fmla="*/ 6055787 w 9145229"/>
              <a:gd name="connsiteY5" fmla="*/ 305204 h 336066"/>
              <a:gd name="connsiteX6" fmla="*/ 1231 w 9145229"/>
              <a:gd name="connsiteY6" fmla="*/ 303006 h 336066"/>
              <a:gd name="connsiteX7" fmla="*/ 54 w 9145229"/>
              <a:gd name="connsiteY7" fmla="*/ 334860 h 336066"/>
              <a:gd name="connsiteX0" fmla="*/ 54 w 9145229"/>
              <a:gd name="connsiteY0" fmla="*/ 873022 h 874228"/>
              <a:gd name="connsiteX1" fmla="*/ 6198417 w 9145229"/>
              <a:gd name="connsiteY1" fmla="*/ 874228 h 874228"/>
              <a:gd name="connsiteX2" fmla="*/ 8777094 w 9145229"/>
              <a:gd name="connsiteY2" fmla="*/ 835045 h 874228"/>
              <a:gd name="connsiteX3" fmla="*/ 9145229 w 9145229"/>
              <a:gd name="connsiteY3" fmla="*/ 769731 h 874228"/>
              <a:gd name="connsiteX4" fmla="*/ 9142848 w 9145229"/>
              <a:gd name="connsiteY4" fmla="*/ 0 h 874228"/>
              <a:gd name="connsiteX5" fmla="*/ 6055787 w 9145229"/>
              <a:gd name="connsiteY5" fmla="*/ 843366 h 874228"/>
              <a:gd name="connsiteX6" fmla="*/ 1231 w 9145229"/>
              <a:gd name="connsiteY6" fmla="*/ 841168 h 874228"/>
              <a:gd name="connsiteX7" fmla="*/ 54 w 9145229"/>
              <a:gd name="connsiteY7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8777094 w 9147610"/>
              <a:gd name="connsiteY2" fmla="*/ 835045 h 874228"/>
              <a:gd name="connsiteX3" fmla="*/ 9147610 w 9147610"/>
              <a:gd name="connsiteY3" fmla="*/ 576849 h 874228"/>
              <a:gd name="connsiteX4" fmla="*/ 9142848 w 9147610"/>
              <a:gd name="connsiteY4" fmla="*/ 0 h 874228"/>
              <a:gd name="connsiteX5" fmla="*/ 6055787 w 9147610"/>
              <a:gd name="connsiteY5" fmla="*/ 843366 h 874228"/>
              <a:gd name="connsiteX6" fmla="*/ 1231 w 9147610"/>
              <a:gd name="connsiteY6" fmla="*/ 841168 h 874228"/>
              <a:gd name="connsiteX7" fmla="*/ 54 w 9147610"/>
              <a:gd name="connsiteY7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7907938 w 9147610"/>
              <a:gd name="connsiteY2" fmla="*/ 804089 h 874228"/>
              <a:gd name="connsiteX3" fmla="*/ 9147610 w 9147610"/>
              <a:gd name="connsiteY3" fmla="*/ 576849 h 874228"/>
              <a:gd name="connsiteX4" fmla="*/ 9142848 w 9147610"/>
              <a:gd name="connsiteY4" fmla="*/ 0 h 874228"/>
              <a:gd name="connsiteX5" fmla="*/ 6055787 w 9147610"/>
              <a:gd name="connsiteY5" fmla="*/ 843366 h 874228"/>
              <a:gd name="connsiteX6" fmla="*/ 1231 w 9147610"/>
              <a:gd name="connsiteY6" fmla="*/ 841168 h 874228"/>
              <a:gd name="connsiteX7" fmla="*/ 54 w 9147610"/>
              <a:gd name="connsiteY7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9147610 w 9147610"/>
              <a:gd name="connsiteY2" fmla="*/ 576849 h 874228"/>
              <a:gd name="connsiteX3" fmla="*/ 9142848 w 9147610"/>
              <a:gd name="connsiteY3" fmla="*/ 0 h 874228"/>
              <a:gd name="connsiteX4" fmla="*/ 6055787 w 9147610"/>
              <a:gd name="connsiteY4" fmla="*/ 843366 h 874228"/>
              <a:gd name="connsiteX5" fmla="*/ 1231 w 9147610"/>
              <a:gd name="connsiteY5" fmla="*/ 841168 h 874228"/>
              <a:gd name="connsiteX6" fmla="*/ 54 w 9147610"/>
              <a:gd name="connsiteY6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9147610 w 9147610"/>
              <a:gd name="connsiteY2" fmla="*/ 576849 h 874228"/>
              <a:gd name="connsiteX3" fmla="*/ 9142848 w 9147610"/>
              <a:gd name="connsiteY3" fmla="*/ 0 h 874228"/>
              <a:gd name="connsiteX4" fmla="*/ 6055787 w 9147610"/>
              <a:gd name="connsiteY4" fmla="*/ 843366 h 874228"/>
              <a:gd name="connsiteX5" fmla="*/ 1231 w 9147610"/>
              <a:gd name="connsiteY5" fmla="*/ 841168 h 874228"/>
              <a:gd name="connsiteX6" fmla="*/ 54 w 9147610"/>
              <a:gd name="connsiteY6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9147610 w 9147610"/>
              <a:gd name="connsiteY2" fmla="*/ 576849 h 874228"/>
              <a:gd name="connsiteX3" fmla="*/ 9142848 w 9147610"/>
              <a:gd name="connsiteY3" fmla="*/ 0 h 874228"/>
              <a:gd name="connsiteX4" fmla="*/ 6055787 w 9147610"/>
              <a:gd name="connsiteY4" fmla="*/ 843366 h 874228"/>
              <a:gd name="connsiteX5" fmla="*/ 1231 w 9147610"/>
              <a:gd name="connsiteY5" fmla="*/ 841168 h 874228"/>
              <a:gd name="connsiteX6" fmla="*/ 54 w 9147610"/>
              <a:gd name="connsiteY6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9147610 w 9147610"/>
              <a:gd name="connsiteY2" fmla="*/ 576849 h 874228"/>
              <a:gd name="connsiteX3" fmla="*/ 9142848 w 9147610"/>
              <a:gd name="connsiteY3" fmla="*/ 0 h 874228"/>
              <a:gd name="connsiteX4" fmla="*/ 6055787 w 9147610"/>
              <a:gd name="connsiteY4" fmla="*/ 843366 h 874228"/>
              <a:gd name="connsiteX5" fmla="*/ 1231 w 9147610"/>
              <a:gd name="connsiteY5" fmla="*/ 841168 h 874228"/>
              <a:gd name="connsiteX6" fmla="*/ 54 w 9147610"/>
              <a:gd name="connsiteY6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9147610 w 9147610"/>
              <a:gd name="connsiteY2" fmla="*/ 576849 h 874228"/>
              <a:gd name="connsiteX3" fmla="*/ 9142848 w 9147610"/>
              <a:gd name="connsiteY3" fmla="*/ 0 h 874228"/>
              <a:gd name="connsiteX4" fmla="*/ 6055787 w 9147610"/>
              <a:gd name="connsiteY4" fmla="*/ 843366 h 874228"/>
              <a:gd name="connsiteX5" fmla="*/ 1231 w 9147610"/>
              <a:gd name="connsiteY5" fmla="*/ 841168 h 874228"/>
              <a:gd name="connsiteX6" fmla="*/ 54 w 9147610"/>
              <a:gd name="connsiteY6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9147610 w 9147610"/>
              <a:gd name="connsiteY2" fmla="*/ 576849 h 874228"/>
              <a:gd name="connsiteX3" fmla="*/ 9142848 w 9147610"/>
              <a:gd name="connsiteY3" fmla="*/ 0 h 874228"/>
              <a:gd name="connsiteX4" fmla="*/ 6055787 w 9147610"/>
              <a:gd name="connsiteY4" fmla="*/ 843366 h 874228"/>
              <a:gd name="connsiteX5" fmla="*/ 1231 w 9147610"/>
              <a:gd name="connsiteY5" fmla="*/ 841168 h 874228"/>
              <a:gd name="connsiteX6" fmla="*/ 54 w 9147610"/>
              <a:gd name="connsiteY6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9147610 w 9147610"/>
              <a:gd name="connsiteY2" fmla="*/ 576849 h 874228"/>
              <a:gd name="connsiteX3" fmla="*/ 9142848 w 9147610"/>
              <a:gd name="connsiteY3" fmla="*/ 0 h 874228"/>
              <a:gd name="connsiteX4" fmla="*/ 6055787 w 9147610"/>
              <a:gd name="connsiteY4" fmla="*/ 843366 h 874228"/>
              <a:gd name="connsiteX5" fmla="*/ 1231 w 9147610"/>
              <a:gd name="connsiteY5" fmla="*/ 841168 h 874228"/>
              <a:gd name="connsiteX6" fmla="*/ 54 w 9147610"/>
              <a:gd name="connsiteY6" fmla="*/ 873022 h 874228"/>
              <a:gd name="connsiteX0" fmla="*/ 54 w 9147610"/>
              <a:gd name="connsiteY0" fmla="*/ 868259 h 869465"/>
              <a:gd name="connsiteX1" fmla="*/ 6198417 w 9147610"/>
              <a:gd name="connsiteY1" fmla="*/ 869465 h 869465"/>
              <a:gd name="connsiteX2" fmla="*/ 9147610 w 9147610"/>
              <a:gd name="connsiteY2" fmla="*/ 572086 h 869465"/>
              <a:gd name="connsiteX3" fmla="*/ 9145229 w 9147610"/>
              <a:gd name="connsiteY3" fmla="*/ 0 h 869465"/>
              <a:gd name="connsiteX4" fmla="*/ 6055787 w 9147610"/>
              <a:gd name="connsiteY4" fmla="*/ 838603 h 869465"/>
              <a:gd name="connsiteX5" fmla="*/ 1231 w 9147610"/>
              <a:gd name="connsiteY5" fmla="*/ 836405 h 869465"/>
              <a:gd name="connsiteX6" fmla="*/ 54 w 9147610"/>
              <a:gd name="connsiteY6" fmla="*/ 868259 h 869465"/>
              <a:gd name="connsiteX0" fmla="*/ 54 w 9147610"/>
              <a:gd name="connsiteY0" fmla="*/ 868259 h 869465"/>
              <a:gd name="connsiteX1" fmla="*/ 6198417 w 9147610"/>
              <a:gd name="connsiteY1" fmla="*/ 869465 h 869465"/>
              <a:gd name="connsiteX2" fmla="*/ 9147610 w 9147610"/>
              <a:gd name="connsiteY2" fmla="*/ 572086 h 869465"/>
              <a:gd name="connsiteX3" fmla="*/ 9145229 w 9147610"/>
              <a:gd name="connsiteY3" fmla="*/ 0 h 869465"/>
              <a:gd name="connsiteX4" fmla="*/ 6055787 w 9147610"/>
              <a:gd name="connsiteY4" fmla="*/ 838603 h 869465"/>
              <a:gd name="connsiteX5" fmla="*/ 1231 w 9147610"/>
              <a:gd name="connsiteY5" fmla="*/ 836405 h 869465"/>
              <a:gd name="connsiteX6" fmla="*/ 54 w 9147610"/>
              <a:gd name="connsiteY6" fmla="*/ 868259 h 86946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9147610" h="869465">
                <a:moveTo>
                  <a:pt x="54" y="868259"/>
                </a:moveTo>
                <a:lnTo>
                  <a:pt x="6198417" y="869465"/>
                </a:lnTo>
                <a:cubicBezTo>
                  <a:pt x="7765872" y="853441"/>
                  <a:pt x="8513997" y="720173"/>
                  <a:pt x="9147610" y="572086"/>
                </a:cubicBezTo>
                <a:cubicBezTo>
                  <a:pt x="9146816" y="315509"/>
                  <a:pt x="9146023" y="256577"/>
                  <a:pt x="9145229" y="0"/>
                </a:cubicBezTo>
                <a:cubicBezTo>
                  <a:pt x="8508481" y="485745"/>
                  <a:pt x="7318244" y="819060"/>
                  <a:pt x="6055787" y="838603"/>
                </a:cubicBezTo>
                <a:lnTo>
                  <a:pt x="1231" y="836405"/>
                </a:lnTo>
                <a:cubicBezTo>
                  <a:pt x="1633" y="849404"/>
                  <a:pt x="-348" y="855260"/>
                  <a:pt x="54" y="868259"/>
                </a:cubicBezTo>
                <a:close/>
              </a:path>
            </a:pathLst>
          </a:cu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254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10" name="図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767" y="6478651"/>
            <a:ext cx="1270800" cy="242144"/>
          </a:xfrm>
          <a:prstGeom prst="rect">
            <a:avLst/>
          </a:prstGeom>
        </p:spPr>
      </p:pic>
      <p:pic>
        <p:nvPicPr>
          <p:cNvPr id="11" name="図 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55731" y="317430"/>
            <a:ext cx="856731" cy="594588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8312" y="1700213"/>
            <a:ext cx="8224837" cy="1728788"/>
          </a:xfrm>
        </p:spPr>
        <p:txBody>
          <a:bodyPr anchor="b">
            <a:noAutofit/>
          </a:bodyPr>
          <a:lstStyle>
            <a:lvl1pPr algn="l">
              <a:defRPr sz="3600" b="1" cap="none" baseline="0"/>
            </a:lvl1pPr>
          </a:lstStyle>
          <a:p>
            <a:r>
              <a:rPr kumimoji="1" lang="ja-JP" altLang="en-US"/>
              <a:t>マスター タイトルの書式設定</a:t>
            </a:r>
            <a:endParaRPr kumimoji="1" lang="ja-JP" altLang="en-US" dirty="0"/>
          </a:p>
        </p:txBody>
      </p:sp>
      <p:sp>
        <p:nvSpPr>
          <p:cNvPr id="8" name="サブタイトル 2"/>
          <p:cNvSpPr>
            <a:spLocks noGrp="1"/>
          </p:cNvSpPr>
          <p:nvPr>
            <p:ph type="subTitle" idx="10"/>
          </p:nvPr>
        </p:nvSpPr>
        <p:spPr>
          <a:xfrm>
            <a:off x="468313" y="4307304"/>
            <a:ext cx="8224837" cy="1831559"/>
          </a:xfrm>
        </p:spPr>
        <p:txBody>
          <a:bodyPr anchor="t">
            <a:normAutofit/>
          </a:bodyPr>
          <a:lstStyle>
            <a:lvl1pPr marL="0" indent="0" algn="l">
              <a:buNone/>
              <a:defRPr sz="2000" baseline="0">
                <a:solidFill>
                  <a:schemeClr val="tx1"/>
                </a:solidFill>
                <a:latin typeface="+mj-lt"/>
                <a:ea typeface="+mj-ea"/>
              </a:defRPr>
            </a:lvl1pPr>
            <a:lvl2pPr marL="457200" indent="0" algn="l">
              <a:buNone/>
              <a:defRPr sz="1800">
                <a:solidFill>
                  <a:schemeClr val="tx1"/>
                </a:solidFill>
              </a:defRPr>
            </a:lvl2pPr>
            <a:lvl3pPr marL="914400" indent="0" algn="l">
              <a:buNone/>
              <a:defRPr sz="1600">
                <a:solidFill>
                  <a:schemeClr val="tx1"/>
                </a:solidFill>
              </a:defRPr>
            </a:lvl3pPr>
            <a:lvl4pPr marL="1371600" indent="0" algn="l">
              <a:buNone/>
              <a:defRPr sz="1400">
                <a:solidFill>
                  <a:schemeClr val="tx1"/>
                </a:solidFill>
              </a:defRPr>
            </a:lvl4pPr>
            <a:lvl5pPr marL="1828800" indent="0" algn="l">
              <a:buNone/>
              <a:defRPr sz="1400">
                <a:solidFill>
                  <a:schemeClr val="tx1"/>
                </a:solidFill>
              </a:defRPr>
            </a:lvl5pPr>
            <a:lvl6pPr marL="2286000" indent="0" algn="l">
              <a:buNone/>
              <a:defRPr sz="1400">
                <a:solidFill>
                  <a:schemeClr val="tx1"/>
                </a:solidFill>
              </a:defRPr>
            </a:lvl6pPr>
            <a:lvl7pPr marL="2743200" indent="0" algn="l">
              <a:buNone/>
              <a:defRPr sz="1400">
                <a:solidFill>
                  <a:schemeClr val="tx1"/>
                </a:solidFill>
              </a:defRPr>
            </a:lvl7pPr>
            <a:lvl8pPr marL="3200400" indent="0" algn="l">
              <a:buNone/>
              <a:defRPr sz="1400">
                <a:solidFill>
                  <a:schemeClr val="tx1"/>
                </a:solidFill>
              </a:defRPr>
            </a:lvl8pPr>
            <a:lvl9pPr marL="3657600" indent="0" algn="l">
              <a:buNone/>
              <a:defRPr sz="1400">
                <a:solidFill>
                  <a:schemeClr val="tx1"/>
                </a:solidFill>
              </a:defRPr>
            </a:lvl9pPr>
          </a:lstStyle>
          <a:p>
            <a:pPr lvl="0"/>
            <a:r>
              <a:rPr kumimoji="1" lang="ja-JP" altLang="en-US"/>
              <a:t>マスター サブタイトルの書式設定</a:t>
            </a:r>
            <a:endParaRPr kumimoji="1" lang="ja-JP" altLang="en-US" dirty="0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8000064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: 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図 1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35380" y="76966"/>
            <a:ext cx="856731" cy="594588"/>
          </a:xfrm>
          <a:prstGeom prst="rect">
            <a:avLst/>
          </a:prstGeom>
        </p:spPr>
      </p:pic>
      <p:sp>
        <p:nvSpPr>
          <p:cNvPr id="13" name="フリーフォーム 12"/>
          <p:cNvSpPr/>
          <p:nvPr/>
        </p:nvSpPr>
        <p:spPr>
          <a:xfrm>
            <a:off x="-1231" y="451262"/>
            <a:ext cx="9145230" cy="334860"/>
          </a:xfrm>
          <a:custGeom>
            <a:avLst/>
            <a:gdLst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5938 w 9149938"/>
              <a:gd name="connsiteY7" fmla="*/ 231569 h 344385"/>
              <a:gd name="connsiteX8" fmla="*/ 0 w 9149938"/>
              <a:gd name="connsiteY8" fmla="*/ 344385 h 344385"/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10700 w 9149938"/>
              <a:gd name="connsiteY7" fmla="*/ 300625 h 344385"/>
              <a:gd name="connsiteX8" fmla="*/ 0 w 9149938"/>
              <a:gd name="connsiteY8" fmla="*/ 344385 h 344385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25019 w 9139238"/>
              <a:gd name="connsiteY0" fmla="*/ 399154 h 399154"/>
              <a:gd name="connsiteX1" fmla="*/ 8230776 w 9139238"/>
              <a:gd name="connsiteY1" fmla="*/ 338447 h 399154"/>
              <a:gd name="connsiteX2" fmla="*/ 8771103 w 9139238"/>
              <a:gd name="connsiteY2" fmla="*/ 296883 h 399154"/>
              <a:gd name="connsiteX3" fmla="*/ 9139238 w 9139238"/>
              <a:gd name="connsiteY3" fmla="*/ 231569 h 399154"/>
              <a:gd name="connsiteX4" fmla="*/ 9139238 w 9139238"/>
              <a:gd name="connsiteY4" fmla="*/ 0 h 399154"/>
              <a:gd name="connsiteX5" fmla="*/ 8747352 w 9139238"/>
              <a:gd name="connsiteY5" fmla="*/ 201881 h 399154"/>
              <a:gd name="connsiteX6" fmla="*/ 8135773 w 9139238"/>
              <a:gd name="connsiteY6" fmla="*/ 302821 h 399154"/>
              <a:gd name="connsiteX7" fmla="*/ 0 w 9139238"/>
              <a:gd name="connsiteY7" fmla="*/ 300625 h 399154"/>
              <a:gd name="connsiteX8" fmla="*/ 25019 w 9139238"/>
              <a:gd name="connsiteY8" fmla="*/ 399154 h 39915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5937 w 9145175"/>
              <a:gd name="connsiteY7" fmla="*/ 300625 h 342004"/>
              <a:gd name="connsiteX8" fmla="*/ 0 w 9145175"/>
              <a:gd name="connsiteY8" fmla="*/ 342004 h 34200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120237 w 9145175"/>
              <a:gd name="connsiteY7" fmla="*/ 255381 h 342004"/>
              <a:gd name="connsiteX8" fmla="*/ 0 w 9145175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142917 w 9146382"/>
              <a:gd name="connsiteY6" fmla="*/ 302821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55 w 9145230"/>
              <a:gd name="connsiteY0" fmla="*/ 342004 h 342004"/>
              <a:gd name="connsiteX1" fmla="*/ 8236768 w 9145230"/>
              <a:gd name="connsiteY1" fmla="*/ 338447 h 342004"/>
              <a:gd name="connsiteX2" fmla="*/ 8777095 w 9145230"/>
              <a:gd name="connsiteY2" fmla="*/ 296883 h 342004"/>
              <a:gd name="connsiteX3" fmla="*/ 9145230 w 9145230"/>
              <a:gd name="connsiteY3" fmla="*/ 231569 h 342004"/>
              <a:gd name="connsiteX4" fmla="*/ 9145230 w 9145230"/>
              <a:gd name="connsiteY4" fmla="*/ 0 h 342004"/>
              <a:gd name="connsiteX5" fmla="*/ 8039370 w 9145230"/>
              <a:gd name="connsiteY5" fmla="*/ 302822 h 342004"/>
              <a:gd name="connsiteX6" fmla="*/ 1230 w 9145230"/>
              <a:gd name="connsiteY6" fmla="*/ 307768 h 342004"/>
              <a:gd name="connsiteX7" fmla="*/ 55 w 9145230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5387 h 342004"/>
              <a:gd name="connsiteX7" fmla="*/ 1207 w 9146382"/>
              <a:gd name="connsiteY7" fmla="*/ 342004 h 342004"/>
              <a:gd name="connsiteX0" fmla="*/ 1207 w 9146382"/>
              <a:gd name="connsiteY0" fmla="*/ 339622 h 339622"/>
              <a:gd name="connsiteX1" fmla="*/ 8237920 w 9146382"/>
              <a:gd name="connsiteY1" fmla="*/ 338447 h 339622"/>
              <a:gd name="connsiteX2" fmla="*/ 8778247 w 9146382"/>
              <a:gd name="connsiteY2" fmla="*/ 296883 h 339622"/>
              <a:gd name="connsiteX3" fmla="*/ 9146382 w 9146382"/>
              <a:gd name="connsiteY3" fmla="*/ 231569 h 339622"/>
              <a:gd name="connsiteX4" fmla="*/ 9146382 w 9146382"/>
              <a:gd name="connsiteY4" fmla="*/ 0 h 339622"/>
              <a:gd name="connsiteX5" fmla="*/ 8040522 w 9146382"/>
              <a:gd name="connsiteY5" fmla="*/ 302822 h 339622"/>
              <a:gd name="connsiteX6" fmla="*/ 0 w 9146382"/>
              <a:gd name="connsiteY6" fmla="*/ 305387 h 339622"/>
              <a:gd name="connsiteX7" fmla="*/ 1207 w 9146382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2822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3685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4860 h 334860"/>
              <a:gd name="connsiteX1" fmla="*/ 8236768 w 9145230"/>
              <a:gd name="connsiteY1" fmla="*/ 333685 h 334860"/>
              <a:gd name="connsiteX2" fmla="*/ 8777095 w 9145230"/>
              <a:gd name="connsiteY2" fmla="*/ 296883 h 334860"/>
              <a:gd name="connsiteX3" fmla="*/ 9145230 w 9145230"/>
              <a:gd name="connsiteY3" fmla="*/ 231569 h 334860"/>
              <a:gd name="connsiteX4" fmla="*/ 9145230 w 9145230"/>
              <a:gd name="connsiteY4" fmla="*/ 0 h 334860"/>
              <a:gd name="connsiteX5" fmla="*/ 8039370 w 9145230"/>
              <a:gd name="connsiteY5" fmla="*/ 305204 h 334860"/>
              <a:gd name="connsiteX6" fmla="*/ 1230 w 9145230"/>
              <a:gd name="connsiteY6" fmla="*/ 305387 h 334860"/>
              <a:gd name="connsiteX7" fmla="*/ 55 w 9145230"/>
              <a:gd name="connsiteY7" fmla="*/ 334860 h 3348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9145230" h="334860">
                <a:moveTo>
                  <a:pt x="55" y="334860"/>
                </a:moveTo>
                <a:lnTo>
                  <a:pt x="8236768" y="333685"/>
                </a:lnTo>
                <a:cubicBezTo>
                  <a:pt x="8424021" y="326974"/>
                  <a:pt x="8625685" y="313902"/>
                  <a:pt x="8777095" y="296883"/>
                </a:cubicBezTo>
                <a:cubicBezTo>
                  <a:pt x="8928505" y="279864"/>
                  <a:pt x="9017756" y="262865"/>
                  <a:pt x="9145230" y="231569"/>
                </a:cubicBezTo>
                <a:lnTo>
                  <a:pt x="9145230" y="0"/>
                </a:lnTo>
                <a:cubicBezTo>
                  <a:pt x="8875194" y="176182"/>
                  <a:pt x="8573165" y="285660"/>
                  <a:pt x="8039370" y="305204"/>
                </a:cubicBezTo>
                <a:lnTo>
                  <a:pt x="1230" y="305387"/>
                </a:lnTo>
                <a:cubicBezTo>
                  <a:pt x="1632" y="318386"/>
                  <a:pt x="-347" y="321861"/>
                  <a:pt x="55" y="334860"/>
                </a:cubicBezTo>
                <a:close/>
              </a:path>
            </a:pathLst>
          </a:cu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254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正方形/長方形 13"/>
          <p:cNvSpPr/>
          <p:nvPr/>
        </p:nvSpPr>
        <p:spPr>
          <a:xfrm>
            <a:off x="0" y="6321600"/>
            <a:ext cx="9144000" cy="25200"/>
          </a:xfrm>
          <a:prstGeom prst="rect">
            <a:avLst/>
          </a:pr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12700" dir="16200000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014414"/>
            <a:ext cx="4038600" cy="5111750"/>
          </a:xfrm>
        </p:spPr>
        <p:txBody>
          <a:bodyPr>
            <a:normAutofit/>
          </a:bodyPr>
          <a:lstStyle>
            <a:lvl1pPr>
              <a:defRPr sz="2400" baseline="0"/>
            </a:lvl1pPr>
            <a:lvl2pPr>
              <a:defRPr sz="2000" baseline="0"/>
            </a:lvl2pPr>
            <a:lvl3pPr>
              <a:defRPr sz="1800" baseline="0"/>
            </a:lvl3pPr>
            <a:lvl4pPr>
              <a:defRPr sz="1600" baseline="0"/>
            </a:lvl4pPr>
            <a:lvl5pPr>
              <a:defRPr sz="1600" baseline="0"/>
            </a:lvl5pPr>
            <a:lvl6pPr>
              <a:defRPr sz="1400"/>
            </a:lvl6pPr>
            <a:lvl7pPr marL="2297113" indent="-228600">
              <a:defRPr sz="1400"/>
            </a:lvl7pPr>
            <a:lvl8pPr marL="2601913" indent="-228600">
              <a:defRPr sz="1400"/>
            </a:lvl8pPr>
            <a:lvl9pPr marL="2874963" indent="-228600">
              <a:defRPr sz="14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en-US" altLang="ja-JP" dirty="0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014414"/>
            <a:ext cx="4038600" cy="5111749"/>
          </a:xfrm>
        </p:spPr>
        <p:txBody>
          <a:bodyPr>
            <a:normAutofit/>
          </a:bodyPr>
          <a:lstStyle>
            <a:lvl1pPr>
              <a:defRPr sz="2400" baseline="0"/>
            </a:lvl1pPr>
            <a:lvl2pPr>
              <a:defRPr sz="2000" baseline="0"/>
            </a:lvl2pPr>
            <a:lvl3pPr>
              <a:defRPr sz="1800" baseline="0"/>
            </a:lvl3pPr>
            <a:lvl4pPr>
              <a:defRPr sz="1600" baseline="0"/>
            </a:lvl4pPr>
            <a:lvl5pPr>
              <a:defRPr sz="1600" baseline="0"/>
            </a:lvl5pPr>
            <a:lvl6pPr>
              <a:defRPr sz="1400"/>
            </a:lvl6pPr>
            <a:lvl7pPr marL="2297113" indent="-228600">
              <a:defRPr sz="1400"/>
            </a:lvl7pPr>
            <a:lvl8pPr marL="2601913" indent="-228600">
              <a:defRPr sz="1400"/>
            </a:lvl8pPr>
            <a:lvl9pPr marL="2874963" indent="-228600">
              <a:defRPr sz="14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en-US" altLang="ja-JP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378198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: 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図 1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35380" y="76966"/>
            <a:ext cx="856731" cy="594588"/>
          </a:xfrm>
          <a:prstGeom prst="rect">
            <a:avLst/>
          </a:prstGeom>
        </p:spPr>
      </p:pic>
      <p:sp>
        <p:nvSpPr>
          <p:cNvPr id="15" name="フリーフォーム 14"/>
          <p:cNvSpPr/>
          <p:nvPr/>
        </p:nvSpPr>
        <p:spPr>
          <a:xfrm>
            <a:off x="-1231" y="451262"/>
            <a:ext cx="9145230" cy="334860"/>
          </a:xfrm>
          <a:custGeom>
            <a:avLst/>
            <a:gdLst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5938 w 9149938"/>
              <a:gd name="connsiteY7" fmla="*/ 231569 h 344385"/>
              <a:gd name="connsiteX8" fmla="*/ 0 w 9149938"/>
              <a:gd name="connsiteY8" fmla="*/ 344385 h 344385"/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10700 w 9149938"/>
              <a:gd name="connsiteY7" fmla="*/ 300625 h 344385"/>
              <a:gd name="connsiteX8" fmla="*/ 0 w 9149938"/>
              <a:gd name="connsiteY8" fmla="*/ 344385 h 344385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25019 w 9139238"/>
              <a:gd name="connsiteY0" fmla="*/ 399154 h 399154"/>
              <a:gd name="connsiteX1" fmla="*/ 8230776 w 9139238"/>
              <a:gd name="connsiteY1" fmla="*/ 338447 h 399154"/>
              <a:gd name="connsiteX2" fmla="*/ 8771103 w 9139238"/>
              <a:gd name="connsiteY2" fmla="*/ 296883 h 399154"/>
              <a:gd name="connsiteX3" fmla="*/ 9139238 w 9139238"/>
              <a:gd name="connsiteY3" fmla="*/ 231569 h 399154"/>
              <a:gd name="connsiteX4" fmla="*/ 9139238 w 9139238"/>
              <a:gd name="connsiteY4" fmla="*/ 0 h 399154"/>
              <a:gd name="connsiteX5" fmla="*/ 8747352 w 9139238"/>
              <a:gd name="connsiteY5" fmla="*/ 201881 h 399154"/>
              <a:gd name="connsiteX6" fmla="*/ 8135773 w 9139238"/>
              <a:gd name="connsiteY6" fmla="*/ 302821 h 399154"/>
              <a:gd name="connsiteX7" fmla="*/ 0 w 9139238"/>
              <a:gd name="connsiteY7" fmla="*/ 300625 h 399154"/>
              <a:gd name="connsiteX8" fmla="*/ 25019 w 9139238"/>
              <a:gd name="connsiteY8" fmla="*/ 399154 h 39915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5937 w 9145175"/>
              <a:gd name="connsiteY7" fmla="*/ 300625 h 342004"/>
              <a:gd name="connsiteX8" fmla="*/ 0 w 9145175"/>
              <a:gd name="connsiteY8" fmla="*/ 342004 h 34200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120237 w 9145175"/>
              <a:gd name="connsiteY7" fmla="*/ 255381 h 342004"/>
              <a:gd name="connsiteX8" fmla="*/ 0 w 9145175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142917 w 9146382"/>
              <a:gd name="connsiteY6" fmla="*/ 302821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55 w 9145230"/>
              <a:gd name="connsiteY0" fmla="*/ 342004 h 342004"/>
              <a:gd name="connsiteX1" fmla="*/ 8236768 w 9145230"/>
              <a:gd name="connsiteY1" fmla="*/ 338447 h 342004"/>
              <a:gd name="connsiteX2" fmla="*/ 8777095 w 9145230"/>
              <a:gd name="connsiteY2" fmla="*/ 296883 h 342004"/>
              <a:gd name="connsiteX3" fmla="*/ 9145230 w 9145230"/>
              <a:gd name="connsiteY3" fmla="*/ 231569 h 342004"/>
              <a:gd name="connsiteX4" fmla="*/ 9145230 w 9145230"/>
              <a:gd name="connsiteY4" fmla="*/ 0 h 342004"/>
              <a:gd name="connsiteX5" fmla="*/ 8039370 w 9145230"/>
              <a:gd name="connsiteY5" fmla="*/ 302822 h 342004"/>
              <a:gd name="connsiteX6" fmla="*/ 1230 w 9145230"/>
              <a:gd name="connsiteY6" fmla="*/ 307768 h 342004"/>
              <a:gd name="connsiteX7" fmla="*/ 55 w 9145230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5387 h 342004"/>
              <a:gd name="connsiteX7" fmla="*/ 1207 w 9146382"/>
              <a:gd name="connsiteY7" fmla="*/ 342004 h 342004"/>
              <a:gd name="connsiteX0" fmla="*/ 1207 w 9146382"/>
              <a:gd name="connsiteY0" fmla="*/ 339622 h 339622"/>
              <a:gd name="connsiteX1" fmla="*/ 8237920 w 9146382"/>
              <a:gd name="connsiteY1" fmla="*/ 338447 h 339622"/>
              <a:gd name="connsiteX2" fmla="*/ 8778247 w 9146382"/>
              <a:gd name="connsiteY2" fmla="*/ 296883 h 339622"/>
              <a:gd name="connsiteX3" fmla="*/ 9146382 w 9146382"/>
              <a:gd name="connsiteY3" fmla="*/ 231569 h 339622"/>
              <a:gd name="connsiteX4" fmla="*/ 9146382 w 9146382"/>
              <a:gd name="connsiteY4" fmla="*/ 0 h 339622"/>
              <a:gd name="connsiteX5" fmla="*/ 8040522 w 9146382"/>
              <a:gd name="connsiteY5" fmla="*/ 302822 h 339622"/>
              <a:gd name="connsiteX6" fmla="*/ 0 w 9146382"/>
              <a:gd name="connsiteY6" fmla="*/ 305387 h 339622"/>
              <a:gd name="connsiteX7" fmla="*/ 1207 w 9146382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2822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3685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4860 h 334860"/>
              <a:gd name="connsiteX1" fmla="*/ 8236768 w 9145230"/>
              <a:gd name="connsiteY1" fmla="*/ 333685 h 334860"/>
              <a:gd name="connsiteX2" fmla="*/ 8777095 w 9145230"/>
              <a:gd name="connsiteY2" fmla="*/ 296883 h 334860"/>
              <a:gd name="connsiteX3" fmla="*/ 9145230 w 9145230"/>
              <a:gd name="connsiteY3" fmla="*/ 231569 h 334860"/>
              <a:gd name="connsiteX4" fmla="*/ 9145230 w 9145230"/>
              <a:gd name="connsiteY4" fmla="*/ 0 h 334860"/>
              <a:gd name="connsiteX5" fmla="*/ 8039370 w 9145230"/>
              <a:gd name="connsiteY5" fmla="*/ 305204 h 334860"/>
              <a:gd name="connsiteX6" fmla="*/ 1230 w 9145230"/>
              <a:gd name="connsiteY6" fmla="*/ 305387 h 334860"/>
              <a:gd name="connsiteX7" fmla="*/ 55 w 9145230"/>
              <a:gd name="connsiteY7" fmla="*/ 334860 h 3348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9145230" h="334860">
                <a:moveTo>
                  <a:pt x="55" y="334860"/>
                </a:moveTo>
                <a:lnTo>
                  <a:pt x="8236768" y="333685"/>
                </a:lnTo>
                <a:cubicBezTo>
                  <a:pt x="8424021" y="326974"/>
                  <a:pt x="8625685" y="313902"/>
                  <a:pt x="8777095" y="296883"/>
                </a:cubicBezTo>
                <a:cubicBezTo>
                  <a:pt x="8928505" y="279864"/>
                  <a:pt x="9017756" y="262865"/>
                  <a:pt x="9145230" y="231569"/>
                </a:cubicBezTo>
                <a:lnTo>
                  <a:pt x="9145230" y="0"/>
                </a:lnTo>
                <a:cubicBezTo>
                  <a:pt x="8875194" y="176182"/>
                  <a:pt x="8573165" y="285660"/>
                  <a:pt x="8039370" y="305204"/>
                </a:cubicBezTo>
                <a:lnTo>
                  <a:pt x="1230" y="305387"/>
                </a:lnTo>
                <a:cubicBezTo>
                  <a:pt x="1632" y="318386"/>
                  <a:pt x="-347" y="321861"/>
                  <a:pt x="55" y="334860"/>
                </a:cubicBezTo>
                <a:close/>
              </a:path>
            </a:pathLst>
          </a:cu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254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正方形/長方形 15"/>
          <p:cNvSpPr/>
          <p:nvPr/>
        </p:nvSpPr>
        <p:spPr>
          <a:xfrm>
            <a:off x="0" y="6321600"/>
            <a:ext cx="9144000" cy="25200"/>
          </a:xfrm>
          <a:prstGeom prst="rect">
            <a:avLst/>
          </a:pr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12700" dir="16200000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014413"/>
            <a:ext cx="4040188" cy="685800"/>
          </a:xfrm>
        </p:spPr>
        <p:txBody>
          <a:bodyPr anchor="ctr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1700213"/>
            <a:ext cx="4040188" cy="442595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 marL="1976438" indent="-228600">
              <a:defRPr sz="1200"/>
            </a:lvl6pPr>
            <a:lvl7pPr marL="2297113" indent="-228600">
              <a:defRPr sz="1200"/>
            </a:lvl7pPr>
            <a:lvl8pPr marL="2601913" indent="-228600">
              <a:defRPr sz="1200"/>
            </a:lvl8pPr>
            <a:lvl9pPr marL="2874963" indent="-228600">
              <a:defRPr sz="12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en-US" altLang="ja-JP" dirty="0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014413"/>
            <a:ext cx="4041775" cy="685800"/>
          </a:xfrm>
        </p:spPr>
        <p:txBody>
          <a:bodyPr anchor="ctr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1700213"/>
            <a:ext cx="4041775" cy="442595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 marL="1887538" indent="-228600">
              <a:defRPr sz="1200"/>
            </a:lvl6pPr>
            <a:lvl7pPr marL="2297113" indent="-228600">
              <a:defRPr sz="1200"/>
            </a:lvl7pPr>
            <a:lvl8pPr marL="2601913" indent="-228600">
              <a:defRPr sz="1200"/>
            </a:lvl8pPr>
            <a:lvl9pPr marL="2874963" indent="-228600">
              <a:defRPr sz="12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en-US" altLang="ja-JP" dirty="0"/>
          </a:p>
        </p:txBody>
      </p:sp>
      <p:sp>
        <p:nvSpPr>
          <p:cNvPr id="7" name="フッター プレースホルダー 6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0770930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: 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35380" y="76966"/>
            <a:ext cx="856731" cy="594588"/>
          </a:xfrm>
          <a:prstGeom prst="rect">
            <a:avLst/>
          </a:prstGeom>
        </p:spPr>
      </p:pic>
      <p:sp>
        <p:nvSpPr>
          <p:cNvPr id="11" name="フリーフォーム 10"/>
          <p:cNvSpPr/>
          <p:nvPr/>
        </p:nvSpPr>
        <p:spPr>
          <a:xfrm>
            <a:off x="-1231" y="451262"/>
            <a:ext cx="9145230" cy="334860"/>
          </a:xfrm>
          <a:custGeom>
            <a:avLst/>
            <a:gdLst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5938 w 9149938"/>
              <a:gd name="connsiteY7" fmla="*/ 231569 h 344385"/>
              <a:gd name="connsiteX8" fmla="*/ 0 w 9149938"/>
              <a:gd name="connsiteY8" fmla="*/ 344385 h 344385"/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10700 w 9149938"/>
              <a:gd name="connsiteY7" fmla="*/ 300625 h 344385"/>
              <a:gd name="connsiteX8" fmla="*/ 0 w 9149938"/>
              <a:gd name="connsiteY8" fmla="*/ 344385 h 344385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25019 w 9139238"/>
              <a:gd name="connsiteY0" fmla="*/ 399154 h 399154"/>
              <a:gd name="connsiteX1" fmla="*/ 8230776 w 9139238"/>
              <a:gd name="connsiteY1" fmla="*/ 338447 h 399154"/>
              <a:gd name="connsiteX2" fmla="*/ 8771103 w 9139238"/>
              <a:gd name="connsiteY2" fmla="*/ 296883 h 399154"/>
              <a:gd name="connsiteX3" fmla="*/ 9139238 w 9139238"/>
              <a:gd name="connsiteY3" fmla="*/ 231569 h 399154"/>
              <a:gd name="connsiteX4" fmla="*/ 9139238 w 9139238"/>
              <a:gd name="connsiteY4" fmla="*/ 0 h 399154"/>
              <a:gd name="connsiteX5" fmla="*/ 8747352 w 9139238"/>
              <a:gd name="connsiteY5" fmla="*/ 201881 h 399154"/>
              <a:gd name="connsiteX6" fmla="*/ 8135773 w 9139238"/>
              <a:gd name="connsiteY6" fmla="*/ 302821 h 399154"/>
              <a:gd name="connsiteX7" fmla="*/ 0 w 9139238"/>
              <a:gd name="connsiteY7" fmla="*/ 300625 h 399154"/>
              <a:gd name="connsiteX8" fmla="*/ 25019 w 9139238"/>
              <a:gd name="connsiteY8" fmla="*/ 399154 h 39915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5937 w 9145175"/>
              <a:gd name="connsiteY7" fmla="*/ 300625 h 342004"/>
              <a:gd name="connsiteX8" fmla="*/ 0 w 9145175"/>
              <a:gd name="connsiteY8" fmla="*/ 342004 h 34200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120237 w 9145175"/>
              <a:gd name="connsiteY7" fmla="*/ 255381 h 342004"/>
              <a:gd name="connsiteX8" fmla="*/ 0 w 9145175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142917 w 9146382"/>
              <a:gd name="connsiteY6" fmla="*/ 302821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55 w 9145230"/>
              <a:gd name="connsiteY0" fmla="*/ 342004 h 342004"/>
              <a:gd name="connsiteX1" fmla="*/ 8236768 w 9145230"/>
              <a:gd name="connsiteY1" fmla="*/ 338447 h 342004"/>
              <a:gd name="connsiteX2" fmla="*/ 8777095 w 9145230"/>
              <a:gd name="connsiteY2" fmla="*/ 296883 h 342004"/>
              <a:gd name="connsiteX3" fmla="*/ 9145230 w 9145230"/>
              <a:gd name="connsiteY3" fmla="*/ 231569 h 342004"/>
              <a:gd name="connsiteX4" fmla="*/ 9145230 w 9145230"/>
              <a:gd name="connsiteY4" fmla="*/ 0 h 342004"/>
              <a:gd name="connsiteX5" fmla="*/ 8039370 w 9145230"/>
              <a:gd name="connsiteY5" fmla="*/ 302822 h 342004"/>
              <a:gd name="connsiteX6" fmla="*/ 1230 w 9145230"/>
              <a:gd name="connsiteY6" fmla="*/ 307768 h 342004"/>
              <a:gd name="connsiteX7" fmla="*/ 55 w 9145230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5387 h 342004"/>
              <a:gd name="connsiteX7" fmla="*/ 1207 w 9146382"/>
              <a:gd name="connsiteY7" fmla="*/ 342004 h 342004"/>
              <a:gd name="connsiteX0" fmla="*/ 1207 w 9146382"/>
              <a:gd name="connsiteY0" fmla="*/ 339622 h 339622"/>
              <a:gd name="connsiteX1" fmla="*/ 8237920 w 9146382"/>
              <a:gd name="connsiteY1" fmla="*/ 338447 h 339622"/>
              <a:gd name="connsiteX2" fmla="*/ 8778247 w 9146382"/>
              <a:gd name="connsiteY2" fmla="*/ 296883 h 339622"/>
              <a:gd name="connsiteX3" fmla="*/ 9146382 w 9146382"/>
              <a:gd name="connsiteY3" fmla="*/ 231569 h 339622"/>
              <a:gd name="connsiteX4" fmla="*/ 9146382 w 9146382"/>
              <a:gd name="connsiteY4" fmla="*/ 0 h 339622"/>
              <a:gd name="connsiteX5" fmla="*/ 8040522 w 9146382"/>
              <a:gd name="connsiteY5" fmla="*/ 302822 h 339622"/>
              <a:gd name="connsiteX6" fmla="*/ 0 w 9146382"/>
              <a:gd name="connsiteY6" fmla="*/ 305387 h 339622"/>
              <a:gd name="connsiteX7" fmla="*/ 1207 w 9146382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2822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3685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4860 h 334860"/>
              <a:gd name="connsiteX1" fmla="*/ 8236768 w 9145230"/>
              <a:gd name="connsiteY1" fmla="*/ 333685 h 334860"/>
              <a:gd name="connsiteX2" fmla="*/ 8777095 w 9145230"/>
              <a:gd name="connsiteY2" fmla="*/ 296883 h 334860"/>
              <a:gd name="connsiteX3" fmla="*/ 9145230 w 9145230"/>
              <a:gd name="connsiteY3" fmla="*/ 231569 h 334860"/>
              <a:gd name="connsiteX4" fmla="*/ 9145230 w 9145230"/>
              <a:gd name="connsiteY4" fmla="*/ 0 h 334860"/>
              <a:gd name="connsiteX5" fmla="*/ 8039370 w 9145230"/>
              <a:gd name="connsiteY5" fmla="*/ 305204 h 334860"/>
              <a:gd name="connsiteX6" fmla="*/ 1230 w 9145230"/>
              <a:gd name="connsiteY6" fmla="*/ 305387 h 334860"/>
              <a:gd name="connsiteX7" fmla="*/ 55 w 9145230"/>
              <a:gd name="connsiteY7" fmla="*/ 334860 h 3348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9145230" h="334860">
                <a:moveTo>
                  <a:pt x="55" y="334860"/>
                </a:moveTo>
                <a:lnTo>
                  <a:pt x="8236768" y="333685"/>
                </a:lnTo>
                <a:cubicBezTo>
                  <a:pt x="8424021" y="326974"/>
                  <a:pt x="8625685" y="313902"/>
                  <a:pt x="8777095" y="296883"/>
                </a:cubicBezTo>
                <a:cubicBezTo>
                  <a:pt x="8928505" y="279864"/>
                  <a:pt x="9017756" y="262865"/>
                  <a:pt x="9145230" y="231569"/>
                </a:cubicBezTo>
                <a:lnTo>
                  <a:pt x="9145230" y="0"/>
                </a:lnTo>
                <a:cubicBezTo>
                  <a:pt x="8875194" y="176182"/>
                  <a:pt x="8573165" y="285660"/>
                  <a:pt x="8039370" y="305204"/>
                </a:cubicBezTo>
                <a:lnTo>
                  <a:pt x="1230" y="305387"/>
                </a:lnTo>
                <a:cubicBezTo>
                  <a:pt x="1632" y="318386"/>
                  <a:pt x="-347" y="321861"/>
                  <a:pt x="55" y="334860"/>
                </a:cubicBezTo>
                <a:close/>
              </a:path>
            </a:pathLst>
          </a:cu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254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正方形/長方形 11"/>
          <p:cNvSpPr/>
          <p:nvPr/>
        </p:nvSpPr>
        <p:spPr>
          <a:xfrm>
            <a:off x="0" y="6321600"/>
            <a:ext cx="9144000" cy="25200"/>
          </a:xfrm>
          <a:prstGeom prst="rect">
            <a:avLst/>
          </a:pr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12700" dir="16200000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5114215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: 白紙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フッター プレースホルダー 1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4748233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with Caption: タイトル付きの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図 1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35380" y="76966"/>
            <a:ext cx="856731" cy="594588"/>
          </a:xfrm>
          <a:prstGeom prst="rect">
            <a:avLst/>
          </a:prstGeom>
        </p:spPr>
      </p:pic>
      <p:sp>
        <p:nvSpPr>
          <p:cNvPr id="15" name="フリーフォーム 14"/>
          <p:cNvSpPr/>
          <p:nvPr/>
        </p:nvSpPr>
        <p:spPr>
          <a:xfrm>
            <a:off x="-1231" y="451262"/>
            <a:ext cx="9145230" cy="334860"/>
          </a:xfrm>
          <a:custGeom>
            <a:avLst/>
            <a:gdLst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5938 w 9149938"/>
              <a:gd name="connsiteY7" fmla="*/ 231569 h 344385"/>
              <a:gd name="connsiteX8" fmla="*/ 0 w 9149938"/>
              <a:gd name="connsiteY8" fmla="*/ 344385 h 344385"/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10700 w 9149938"/>
              <a:gd name="connsiteY7" fmla="*/ 300625 h 344385"/>
              <a:gd name="connsiteX8" fmla="*/ 0 w 9149938"/>
              <a:gd name="connsiteY8" fmla="*/ 344385 h 344385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25019 w 9139238"/>
              <a:gd name="connsiteY0" fmla="*/ 399154 h 399154"/>
              <a:gd name="connsiteX1" fmla="*/ 8230776 w 9139238"/>
              <a:gd name="connsiteY1" fmla="*/ 338447 h 399154"/>
              <a:gd name="connsiteX2" fmla="*/ 8771103 w 9139238"/>
              <a:gd name="connsiteY2" fmla="*/ 296883 h 399154"/>
              <a:gd name="connsiteX3" fmla="*/ 9139238 w 9139238"/>
              <a:gd name="connsiteY3" fmla="*/ 231569 h 399154"/>
              <a:gd name="connsiteX4" fmla="*/ 9139238 w 9139238"/>
              <a:gd name="connsiteY4" fmla="*/ 0 h 399154"/>
              <a:gd name="connsiteX5" fmla="*/ 8747352 w 9139238"/>
              <a:gd name="connsiteY5" fmla="*/ 201881 h 399154"/>
              <a:gd name="connsiteX6" fmla="*/ 8135773 w 9139238"/>
              <a:gd name="connsiteY6" fmla="*/ 302821 h 399154"/>
              <a:gd name="connsiteX7" fmla="*/ 0 w 9139238"/>
              <a:gd name="connsiteY7" fmla="*/ 300625 h 399154"/>
              <a:gd name="connsiteX8" fmla="*/ 25019 w 9139238"/>
              <a:gd name="connsiteY8" fmla="*/ 399154 h 39915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5937 w 9145175"/>
              <a:gd name="connsiteY7" fmla="*/ 300625 h 342004"/>
              <a:gd name="connsiteX8" fmla="*/ 0 w 9145175"/>
              <a:gd name="connsiteY8" fmla="*/ 342004 h 34200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120237 w 9145175"/>
              <a:gd name="connsiteY7" fmla="*/ 255381 h 342004"/>
              <a:gd name="connsiteX8" fmla="*/ 0 w 9145175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142917 w 9146382"/>
              <a:gd name="connsiteY6" fmla="*/ 302821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55 w 9145230"/>
              <a:gd name="connsiteY0" fmla="*/ 342004 h 342004"/>
              <a:gd name="connsiteX1" fmla="*/ 8236768 w 9145230"/>
              <a:gd name="connsiteY1" fmla="*/ 338447 h 342004"/>
              <a:gd name="connsiteX2" fmla="*/ 8777095 w 9145230"/>
              <a:gd name="connsiteY2" fmla="*/ 296883 h 342004"/>
              <a:gd name="connsiteX3" fmla="*/ 9145230 w 9145230"/>
              <a:gd name="connsiteY3" fmla="*/ 231569 h 342004"/>
              <a:gd name="connsiteX4" fmla="*/ 9145230 w 9145230"/>
              <a:gd name="connsiteY4" fmla="*/ 0 h 342004"/>
              <a:gd name="connsiteX5" fmla="*/ 8039370 w 9145230"/>
              <a:gd name="connsiteY5" fmla="*/ 302822 h 342004"/>
              <a:gd name="connsiteX6" fmla="*/ 1230 w 9145230"/>
              <a:gd name="connsiteY6" fmla="*/ 307768 h 342004"/>
              <a:gd name="connsiteX7" fmla="*/ 55 w 9145230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5387 h 342004"/>
              <a:gd name="connsiteX7" fmla="*/ 1207 w 9146382"/>
              <a:gd name="connsiteY7" fmla="*/ 342004 h 342004"/>
              <a:gd name="connsiteX0" fmla="*/ 1207 w 9146382"/>
              <a:gd name="connsiteY0" fmla="*/ 339622 h 339622"/>
              <a:gd name="connsiteX1" fmla="*/ 8237920 w 9146382"/>
              <a:gd name="connsiteY1" fmla="*/ 338447 h 339622"/>
              <a:gd name="connsiteX2" fmla="*/ 8778247 w 9146382"/>
              <a:gd name="connsiteY2" fmla="*/ 296883 h 339622"/>
              <a:gd name="connsiteX3" fmla="*/ 9146382 w 9146382"/>
              <a:gd name="connsiteY3" fmla="*/ 231569 h 339622"/>
              <a:gd name="connsiteX4" fmla="*/ 9146382 w 9146382"/>
              <a:gd name="connsiteY4" fmla="*/ 0 h 339622"/>
              <a:gd name="connsiteX5" fmla="*/ 8040522 w 9146382"/>
              <a:gd name="connsiteY5" fmla="*/ 302822 h 339622"/>
              <a:gd name="connsiteX6" fmla="*/ 0 w 9146382"/>
              <a:gd name="connsiteY6" fmla="*/ 305387 h 339622"/>
              <a:gd name="connsiteX7" fmla="*/ 1207 w 9146382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2822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3685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4860 h 334860"/>
              <a:gd name="connsiteX1" fmla="*/ 8236768 w 9145230"/>
              <a:gd name="connsiteY1" fmla="*/ 333685 h 334860"/>
              <a:gd name="connsiteX2" fmla="*/ 8777095 w 9145230"/>
              <a:gd name="connsiteY2" fmla="*/ 296883 h 334860"/>
              <a:gd name="connsiteX3" fmla="*/ 9145230 w 9145230"/>
              <a:gd name="connsiteY3" fmla="*/ 231569 h 334860"/>
              <a:gd name="connsiteX4" fmla="*/ 9145230 w 9145230"/>
              <a:gd name="connsiteY4" fmla="*/ 0 h 334860"/>
              <a:gd name="connsiteX5" fmla="*/ 8039370 w 9145230"/>
              <a:gd name="connsiteY5" fmla="*/ 305204 h 334860"/>
              <a:gd name="connsiteX6" fmla="*/ 1230 w 9145230"/>
              <a:gd name="connsiteY6" fmla="*/ 305387 h 334860"/>
              <a:gd name="connsiteX7" fmla="*/ 55 w 9145230"/>
              <a:gd name="connsiteY7" fmla="*/ 334860 h 3348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9145230" h="334860">
                <a:moveTo>
                  <a:pt x="55" y="334860"/>
                </a:moveTo>
                <a:lnTo>
                  <a:pt x="8236768" y="333685"/>
                </a:lnTo>
                <a:cubicBezTo>
                  <a:pt x="8424021" y="326974"/>
                  <a:pt x="8625685" y="313902"/>
                  <a:pt x="8777095" y="296883"/>
                </a:cubicBezTo>
                <a:cubicBezTo>
                  <a:pt x="8928505" y="279864"/>
                  <a:pt x="9017756" y="262865"/>
                  <a:pt x="9145230" y="231569"/>
                </a:cubicBezTo>
                <a:lnTo>
                  <a:pt x="9145230" y="0"/>
                </a:lnTo>
                <a:cubicBezTo>
                  <a:pt x="8875194" y="176182"/>
                  <a:pt x="8573165" y="285660"/>
                  <a:pt x="8039370" y="305204"/>
                </a:cubicBezTo>
                <a:lnTo>
                  <a:pt x="1230" y="305387"/>
                </a:lnTo>
                <a:cubicBezTo>
                  <a:pt x="1632" y="318386"/>
                  <a:pt x="-347" y="321861"/>
                  <a:pt x="55" y="334860"/>
                </a:cubicBezTo>
                <a:close/>
              </a:path>
            </a:pathLst>
          </a:cu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254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正方形/長方形 15"/>
          <p:cNvSpPr/>
          <p:nvPr/>
        </p:nvSpPr>
        <p:spPr>
          <a:xfrm>
            <a:off x="0" y="6321600"/>
            <a:ext cx="9144000" cy="25200"/>
          </a:xfrm>
          <a:prstGeom prst="rect">
            <a:avLst/>
          </a:pr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12700" dir="16200000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187325"/>
            <a:ext cx="7355159" cy="544513"/>
          </a:xfrm>
        </p:spPr>
        <p:txBody>
          <a:bodyPr anchor="ctr">
            <a:normAutofit/>
          </a:bodyPr>
          <a:lstStyle>
            <a:lvl1pPr algn="l">
              <a:defRPr sz="3200" b="1" baseline="0"/>
            </a:lvl1pPr>
          </a:lstStyle>
          <a:p>
            <a:r>
              <a:rPr kumimoji="1" lang="ja-JP" altLang="en-US"/>
              <a:t>マスター タイトルの書式設定</a:t>
            </a:r>
            <a:endParaRPr kumimoji="1" lang="ja-JP" altLang="en-US" dirty="0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1014413"/>
            <a:ext cx="5111750" cy="5111750"/>
          </a:xfrm>
        </p:spPr>
        <p:txBody>
          <a:bodyPr>
            <a:normAutofit/>
          </a:bodyPr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JP" altLang="en-US" dirty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700213"/>
            <a:ext cx="3008313" cy="44259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8" name="テキスト プレースホルダー 7"/>
          <p:cNvSpPr>
            <a:spLocks noGrp="1"/>
          </p:cNvSpPr>
          <p:nvPr>
            <p:ph type="body" sz="quarter" idx="11"/>
          </p:nvPr>
        </p:nvSpPr>
        <p:spPr>
          <a:xfrm>
            <a:off x="457199" y="1014413"/>
            <a:ext cx="3008314" cy="685799"/>
          </a:xfrm>
        </p:spPr>
        <p:txBody>
          <a:bodyPr vert="horz" lIns="91440" tIns="45720" rIns="91440" bIns="45720" rtlCol="0" anchor="ctr">
            <a:normAutofit lnSpcReduction="10000"/>
          </a:bodyPr>
          <a:lstStyle>
            <a:lvl1pPr marL="0" indent="0">
              <a:buNone/>
              <a:defRPr lang="ja-JP" altLang="en-US" sz="2000" b="1" baseline="0" dirty="0" smtClean="0">
                <a:latin typeface="+mn-lt"/>
                <a:ea typeface="+mn-ea"/>
                <a:cs typeface="+mj-cs"/>
              </a:defRPr>
            </a:lvl1pPr>
            <a:lvl2pPr marL="171450" indent="0">
              <a:buNone/>
              <a:defRPr lang="ja-JP" altLang="en-US" sz="1800" dirty="0" smtClean="0"/>
            </a:lvl2pPr>
            <a:lvl3pPr marL="685800" indent="0">
              <a:buNone/>
              <a:defRPr lang="ja-JP" altLang="en-US" sz="1800" dirty="0" smtClean="0"/>
            </a:lvl3pPr>
            <a:lvl4pPr marL="1143000" indent="0">
              <a:buNone/>
              <a:defRPr lang="ja-JP" altLang="en-US" dirty="0" smtClean="0"/>
            </a:lvl4pPr>
            <a:lvl5pPr marL="1600200" indent="0">
              <a:buNone/>
              <a:defRPr lang="ja-JP" altLang="en-US" dirty="0"/>
            </a:lvl5pPr>
          </a:lstStyle>
          <a:p>
            <a:pPr marL="0" lvl="0">
              <a:lnSpc>
                <a:spcPct val="100000"/>
              </a:lnSpc>
              <a:spcBef>
                <a:spcPct val="0"/>
              </a:spcBef>
            </a:pPr>
            <a:r>
              <a:rPr kumimoji="1" lang="ja-JP" altLang="en-US"/>
              <a:t>マスター テキスト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23988984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F9ACDFD-25CA-403C-AB5C-1E2DF6C68562}" type="datetime1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Segoe UI"/>
                <a:ea typeface="Meiryo UI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/7/2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2DABCC2-1EEF-4DDF-B308-B50BC011052B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Segoe UI"/>
                <a:ea typeface="Meiryo UI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824636368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icture with Caption: 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図 1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35380" y="76966"/>
            <a:ext cx="856731" cy="594588"/>
          </a:xfrm>
          <a:prstGeom prst="rect">
            <a:avLst/>
          </a:prstGeom>
        </p:spPr>
      </p:pic>
      <p:sp>
        <p:nvSpPr>
          <p:cNvPr id="15" name="フリーフォーム 14"/>
          <p:cNvSpPr/>
          <p:nvPr/>
        </p:nvSpPr>
        <p:spPr>
          <a:xfrm>
            <a:off x="-1231" y="451262"/>
            <a:ext cx="9145230" cy="334860"/>
          </a:xfrm>
          <a:custGeom>
            <a:avLst/>
            <a:gdLst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5938 w 9149938"/>
              <a:gd name="connsiteY7" fmla="*/ 231569 h 344385"/>
              <a:gd name="connsiteX8" fmla="*/ 0 w 9149938"/>
              <a:gd name="connsiteY8" fmla="*/ 344385 h 344385"/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10700 w 9149938"/>
              <a:gd name="connsiteY7" fmla="*/ 300625 h 344385"/>
              <a:gd name="connsiteX8" fmla="*/ 0 w 9149938"/>
              <a:gd name="connsiteY8" fmla="*/ 344385 h 344385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25019 w 9139238"/>
              <a:gd name="connsiteY0" fmla="*/ 399154 h 399154"/>
              <a:gd name="connsiteX1" fmla="*/ 8230776 w 9139238"/>
              <a:gd name="connsiteY1" fmla="*/ 338447 h 399154"/>
              <a:gd name="connsiteX2" fmla="*/ 8771103 w 9139238"/>
              <a:gd name="connsiteY2" fmla="*/ 296883 h 399154"/>
              <a:gd name="connsiteX3" fmla="*/ 9139238 w 9139238"/>
              <a:gd name="connsiteY3" fmla="*/ 231569 h 399154"/>
              <a:gd name="connsiteX4" fmla="*/ 9139238 w 9139238"/>
              <a:gd name="connsiteY4" fmla="*/ 0 h 399154"/>
              <a:gd name="connsiteX5" fmla="*/ 8747352 w 9139238"/>
              <a:gd name="connsiteY5" fmla="*/ 201881 h 399154"/>
              <a:gd name="connsiteX6" fmla="*/ 8135773 w 9139238"/>
              <a:gd name="connsiteY6" fmla="*/ 302821 h 399154"/>
              <a:gd name="connsiteX7" fmla="*/ 0 w 9139238"/>
              <a:gd name="connsiteY7" fmla="*/ 300625 h 399154"/>
              <a:gd name="connsiteX8" fmla="*/ 25019 w 9139238"/>
              <a:gd name="connsiteY8" fmla="*/ 399154 h 39915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5937 w 9145175"/>
              <a:gd name="connsiteY7" fmla="*/ 300625 h 342004"/>
              <a:gd name="connsiteX8" fmla="*/ 0 w 9145175"/>
              <a:gd name="connsiteY8" fmla="*/ 342004 h 34200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120237 w 9145175"/>
              <a:gd name="connsiteY7" fmla="*/ 255381 h 342004"/>
              <a:gd name="connsiteX8" fmla="*/ 0 w 9145175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142917 w 9146382"/>
              <a:gd name="connsiteY6" fmla="*/ 302821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55 w 9145230"/>
              <a:gd name="connsiteY0" fmla="*/ 342004 h 342004"/>
              <a:gd name="connsiteX1" fmla="*/ 8236768 w 9145230"/>
              <a:gd name="connsiteY1" fmla="*/ 338447 h 342004"/>
              <a:gd name="connsiteX2" fmla="*/ 8777095 w 9145230"/>
              <a:gd name="connsiteY2" fmla="*/ 296883 h 342004"/>
              <a:gd name="connsiteX3" fmla="*/ 9145230 w 9145230"/>
              <a:gd name="connsiteY3" fmla="*/ 231569 h 342004"/>
              <a:gd name="connsiteX4" fmla="*/ 9145230 w 9145230"/>
              <a:gd name="connsiteY4" fmla="*/ 0 h 342004"/>
              <a:gd name="connsiteX5" fmla="*/ 8039370 w 9145230"/>
              <a:gd name="connsiteY5" fmla="*/ 302822 h 342004"/>
              <a:gd name="connsiteX6" fmla="*/ 1230 w 9145230"/>
              <a:gd name="connsiteY6" fmla="*/ 307768 h 342004"/>
              <a:gd name="connsiteX7" fmla="*/ 55 w 9145230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5387 h 342004"/>
              <a:gd name="connsiteX7" fmla="*/ 1207 w 9146382"/>
              <a:gd name="connsiteY7" fmla="*/ 342004 h 342004"/>
              <a:gd name="connsiteX0" fmla="*/ 1207 w 9146382"/>
              <a:gd name="connsiteY0" fmla="*/ 339622 h 339622"/>
              <a:gd name="connsiteX1" fmla="*/ 8237920 w 9146382"/>
              <a:gd name="connsiteY1" fmla="*/ 338447 h 339622"/>
              <a:gd name="connsiteX2" fmla="*/ 8778247 w 9146382"/>
              <a:gd name="connsiteY2" fmla="*/ 296883 h 339622"/>
              <a:gd name="connsiteX3" fmla="*/ 9146382 w 9146382"/>
              <a:gd name="connsiteY3" fmla="*/ 231569 h 339622"/>
              <a:gd name="connsiteX4" fmla="*/ 9146382 w 9146382"/>
              <a:gd name="connsiteY4" fmla="*/ 0 h 339622"/>
              <a:gd name="connsiteX5" fmla="*/ 8040522 w 9146382"/>
              <a:gd name="connsiteY5" fmla="*/ 302822 h 339622"/>
              <a:gd name="connsiteX6" fmla="*/ 0 w 9146382"/>
              <a:gd name="connsiteY6" fmla="*/ 305387 h 339622"/>
              <a:gd name="connsiteX7" fmla="*/ 1207 w 9146382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2822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3685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4860 h 334860"/>
              <a:gd name="connsiteX1" fmla="*/ 8236768 w 9145230"/>
              <a:gd name="connsiteY1" fmla="*/ 333685 h 334860"/>
              <a:gd name="connsiteX2" fmla="*/ 8777095 w 9145230"/>
              <a:gd name="connsiteY2" fmla="*/ 296883 h 334860"/>
              <a:gd name="connsiteX3" fmla="*/ 9145230 w 9145230"/>
              <a:gd name="connsiteY3" fmla="*/ 231569 h 334860"/>
              <a:gd name="connsiteX4" fmla="*/ 9145230 w 9145230"/>
              <a:gd name="connsiteY4" fmla="*/ 0 h 334860"/>
              <a:gd name="connsiteX5" fmla="*/ 8039370 w 9145230"/>
              <a:gd name="connsiteY5" fmla="*/ 305204 h 334860"/>
              <a:gd name="connsiteX6" fmla="*/ 1230 w 9145230"/>
              <a:gd name="connsiteY6" fmla="*/ 305387 h 334860"/>
              <a:gd name="connsiteX7" fmla="*/ 55 w 9145230"/>
              <a:gd name="connsiteY7" fmla="*/ 334860 h 3348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9145230" h="334860">
                <a:moveTo>
                  <a:pt x="55" y="334860"/>
                </a:moveTo>
                <a:lnTo>
                  <a:pt x="8236768" y="333685"/>
                </a:lnTo>
                <a:cubicBezTo>
                  <a:pt x="8424021" y="326974"/>
                  <a:pt x="8625685" y="313902"/>
                  <a:pt x="8777095" y="296883"/>
                </a:cubicBezTo>
                <a:cubicBezTo>
                  <a:pt x="8928505" y="279864"/>
                  <a:pt x="9017756" y="262865"/>
                  <a:pt x="9145230" y="231569"/>
                </a:cubicBezTo>
                <a:lnTo>
                  <a:pt x="9145230" y="0"/>
                </a:lnTo>
                <a:cubicBezTo>
                  <a:pt x="8875194" y="176182"/>
                  <a:pt x="8573165" y="285660"/>
                  <a:pt x="8039370" y="305204"/>
                </a:cubicBezTo>
                <a:lnTo>
                  <a:pt x="1230" y="305387"/>
                </a:lnTo>
                <a:cubicBezTo>
                  <a:pt x="1632" y="318386"/>
                  <a:pt x="-347" y="321861"/>
                  <a:pt x="55" y="334860"/>
                </a:cubicBezTo>
                <a:close/>
              </a:path>
            </a:pathLst>
          </a:cu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254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正方形/長方形 15"/>
          <p:cNvSpPr/>
          <p:nvPr/>
        </p:nvSpPr>
        <p:spPr>
          <a:xfrm>
            <a:off x="0" y="6321600"/>
            <a:ext cx="9144000" cy="25200"/>
          </a:xfrm>
          <a:prstGeom prst="rect">
            <a:avLst/>
          </a:pr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12700" dir="16200000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187325"/>
            <a:ext cx="7355160" cy="544513"/>
          </a:xfrm>
        </p:spPr>
        <p:txBody>
          <a:bodyPr anchor="ctr">
            <a:normAutofit/>
          </a:bodyPr>
          <a:lstStyle>
            <a:lvl1pPr algn="l">
              <a:defRPr sz="3200" b="1"/>
            </a:lvl1pPr>
          </a:lstStyle>
          <a:p>
            <a:r>
              <a:rPr kumimoji="1" lang="ja-JP" altLang="en-US"/>
              <a:t>マスター タイトルの書式設定</a:t>
            </a:r>
            <a:endParaRPr kumimoji="1" lang="ja-JP" altLang="en-US" dirty="0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1014412"/>
            <a:ext cx="5486400" cy="3709987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kumimoji="1" lang="ja-JP" altLang="en-US"/>
              <a:t>アイコンをクリックして図を追加</a:t>
            </a:r>
            <a:endParaRPr kumimoji="1" lang="ja-JP" altLang="en-US" dirty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771525"/>
          </a:xfrm>
        </p:spPr>
        <p:txBody>
          <a:bodyPr/>
          <a:lstStyle>
            <a:lvl1pPr marL="0" indent="0">
              <a:buNone/>
              <a:defRPr sz="1400" baseline="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テキスト プレースホルダー 6"/>
          <p:cNvSpPr>
            <a:spLocks noGrp="1"/>
          </p:cNvSpPr>
          <p:nvPr>
            <p:ph type="body" sz="quarter" idx="11"/>
          </p:nvPr>
        </p:nvSpPr>
        <p:spPr>
          <a:xfrm>
            <a:off x="1792288" y="4791338"/>
            <a:ext cx="5486400" cy="576000"/>
          </a:xfrm>
        </p:spPr>
        <p:txBody>
          <a:bodyPr vert="horz" lIns="91440" tIns="45720" rIns="91440" bIns="45720" rtlCol="0" anchor="ctr">
            <a:normAutofit/>
          </a:bodyPr>
          <a:lstStyle>
            <a:lvl1pPr marL="342900" indent="-342900">
              <a:buNone/>
              <a:defRPr lang="ja-JP" altLang="en-US" sz="2000" b="1" smtClean="0"/>
            </a:lvl1pPr>
            <a:lvl2pPr>
              <a:defRPr lang="ja-JP" altLang="en-US" sz="1200" smtClean="0"/>
            </a:lvl2pPr>
            <a:lvl3pPr>
              <a:defRPr lang="ja-JP" altLang="en-US" sz="1000" smtClean="0"/>
            </a:lvl3pPr>
            <a:lvl4pPr>
              <a:defRPr lang="ja-JP" altLang="en-US" sz="900" smtClean="0"/>
            </a:lvl4pPr>
            <a:lvl5pPr>
              <a:defRPr lang="ja-JP" altLang="en-US" sz="900"/>
            </a:lvl5pPr>
          </a:lstStyle>
          <a:p>
            <a:pPr marL="0" lvl="0" indent="0"/>
            <a:r>
              <a:rPr kumimoji="1" lang="ja-JP" altLang="en-US"/>
              <a:t>マスター テキスト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1954706291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35380" y="76966"/>
            <a:ext cx="856731" cy="594588"/>
          </a:xfrm>
          <a:prstGeom prst="rect">
            <a:avLst/>
          </a:prstGeom>
        </p:spPr>
      </p:pic>
      <p:sp>
        <p:nvSpPr>
          <p:cNvPr id="12" name="フリーフォーム 11"/>
          <p:cNvSpPr/>
          <p:nvPr/>
        </p:nvSpPr>
        <p:spPr>
          <a:xfrm>
            <a:off x="-1231" y="451262"/>
            <a:ext cx="9145230" cy="334860"/>
          </a:xfrm>
          <a:custGeom>
            <a:avLst/>
            <a:gdLst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5938 w 9149938"/>
              <a:gd name="connsiteY7" fmla="*/ 231569 h 344385"/>
              <a:gd name="connsiteX8" fmla="*/ 0 w 9149938"/>
              <a:gd name="connsiteY8" fmla="*/ 344385 h 344385"/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10700 w 9149938"/>
              <a:gd name="connsiteY7" fmla="*/ 300625 h 344385"/>
              <a:gd name="connsiteX8" fmla="*/ 0 w 9149938"/>
              <a:gd name="connsiteY8" fmla="*/ 344385 h 344385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25019 w 9139238"/>
              <a:gd name="connsiteY0" fmla="*/ 399154 h 399154"/>
              <a:gd name="connsiteX1" fmla="*/ 8230776 w 9139238"/>
              <a:gd name="connsiteY1" fmla="*/ 338447 h 399154"/>
              <a:gd name="connsiteX2" fmla="*/ 8771103 w 9139238"/>
              <a:gd name="connsiteY2" fmla="*/ 296883 h 399154"/>
              <a:gd name="connsiteX3" fmla="*/ 9139238 w 9139238"/>
              <a:gd name="connsiteY3" fmla="*/ 231569 h 399154"/>
              <a:gd name="connsiteX4" fmla="*/ 9139238 w 9139238"/>
              <a:gd name="connsiteY4" fmla="*/ 0 h 399154"/>
              <a:gd name="connsiteX5" fmla="*/ 8747352 w 9139238"/>
              <a:gd name="connsiteY5" fmla="*/ 201881 h 399154"/>
              <a:gd name="connsiteX6" fmla="*/ 8135773 w 9139238"/>
              <a:gd name="connsiteY6" fmla="*/ 302821 h 399154"/>
              <a:gd name="connsiteX7" fmla="*/ 0 w 9139238"/>
              <a:gd name="connsiteY7" fmla="*/ 300625 h 399154"/>
              <a:gd name="connsiteX8" fmla="*/ 25019 w 9139238"/>
              <a:gd name="connsiteY8" fmla="*/ 399154 h 39915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5937 w 9145175"/>
              <a:gd name="connsiteY7" fmla="*/ 300625 h 342004"/>
              <a:gd name="connsiteX8" fmla="*/ 0 w 9145175"/>
              <a:gd name="connsiteY8" fmla="*/ 342004 h 34200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120237 w 9145175"/>
              <a:gd name="connsiteY7" fmla="*/ 255381 h 342004"/>
              <a:gd name="connsiteX8" fmla="*/ 0 w 9145175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142917 w 9146382"/>
              <a:gd name="connsiteY6" fmla="*/ 302821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55 w 9145230"/>
              <a:gd name="connsiteY0" fmla="*/ 342004 h 342004"/>
              <a:gd name="connsiteX1" fmla="*/ 8236768 w 9145230"/>
              <a:gd name="connsiteY1" fmla="*/ 338447 h 342004"/>
              <a:gd name="connsiteX2" fmla="*/ 8777095 w 9145230"/>
              <a:gd name="connsiteY2" fmla="*/ 296883 h 342004"/>
              <a:gd name="connsiteX3" fmla="*/ 9145230 w 9145230"/>
              <a:gd name="connsiteY3" fmla="*/ 231569 h 342004"/>
              <a:gd name="connsiteX4" fmla="*/ 9145230 w 9145230"/>
              <a:gd name="connsiteY4" fmla="*/ 0 h 342004"/>
              <a:gd name="connsiteX5" fmla="*/ 8039370 w 9145230"/>
              <a:gd name="connsiteY5" fmla="*/ 302822 h 342004"/>
              <a:gd name="connsiteX6" fmla="*/ 1230 w 9145230"/>
              <a:gd name="connsiteY6" fmla="*/ 307768 h 342004"/>
              <a:gd name="connsiteX7" fmla="*/ 55 w 9145230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5387 h 342004"/>
              <a:gd name="connsiteX7" fmla="*/ 1207 w 9146382"/>
              <a:gd name="connsiteY7" fmla="*/ 342004 h 342004"/>
              <a:gd name="connsiteX0" fmla="*/ 1207 w 9146382"/>
              <a:gd name="connsiteY0" fmla="*/ 339622 h 339622"/>
              <a:gd name="connsiteX1" fmla="*/ 8237920 w 9146382"/>
              <a:gd name="connsiteY1" fmla="*/ 338447 h 339622"/>
              <a:gd name="connsiteX2" fmla="*/ 8778247 w 9146382"/>
              <a:gd name="connsiteY2" fmla="*/ 296883 h 339622"/>
              <a:gd name="connsiteX3" fmla="*/ 9146382 w 9146382"/>
              <a:gd name="connsiteY3" fmla="*/ 231569 h 339622"/>
              <a:gd name="connsiteX4" fmla="*/ 9146382 w 9146382"/>
              <a:gd name="connsiteY4" fmla="*/ 0 h 339622"/>
              <a:gd name="connsiteX5" fmla="*/ 8040522 w 9146382"/>
              <a:gd name="connsiteY5" fmla="*/ 302822 h 339622"/>
              <a:gd name="connsiteX6" fmla="*/ 0 w 9146382"/>
              <a:gd name="connsiteY6" fmla="*/ 305387 h 339622"/>
              <a:gd name="connsiteX7" fmla="*/ 1207 w 9146382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2822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3685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4860 h 334860"/>
              <a:gd name="connsiteX1" fmla="*/ 8236768 w 9145230"/>
              <a:gd name="connsiteY1" fmla="*/ 333685 h 334860"/>
              <a:gd name="connsiteX2" fmla="*/ 8777095 w 9145230"/>
              <a:gd name="connsiteY2" fmla="*/ 296883 h 334860"/>
              <a:gd name="connsiteX3" fmla="*/ 9145230 w 9145230"/>
              <a:gd name="connsiteY3" fmla="*/ 231569 h 334860"/>
              <a:gd name="connsiteX4" fmla="*/ 9145230 w 9145230"/>
              <a:gd name="connsiteY4" fmla="*/ 0 h 334860"/>
              <a:gd name="connsiteX5" fmla="*/ 8039370 w 9145230"/>
              <a:gd name="connsiteY5" fmla="*/ 305204 h 334860"/>
              <a:gd name="connsiteX6" fmla="*/ 1230 w 9145230"/>
              <a:gd name="connsiteY6" fmla="*/ 305387 h 334860"/>
              <a:gd name="connsiteX7" fmla="*/ 55 w 9145230"/>
              <a:gd name="connsiteY7" fmla="*/ 334860 h 3348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9145230" h="334860">
                <a:moveTo>
                  <a:pt x="55" y="334860"/>
                </a:moveTo>
                <a:lnTo>
                  <a:pt x="8236768" y="333685"/>
                </a:lnTo>
                <a:cubicBezTo>
                  <a:pt x="8424021" y="326974"/>
                  <a:pt x="8625685" y="313902"/>
                  <a:pt x="8777095" y="296883"/>
                </a:cubicBezTo>
                <a:cubicBezTo>
                  <a:pt x="8928505" y="279864"/>
                  <a:pt x="9017756" y="262865"/>
                  <a:pt x="9145230" y="231569"/>
                </a:cubicBezTo>
                <a:lnTo>
                  <a:pt x="9145230" y="0"/>
                </a:lnTo>
                <a:cubicBezTo>
                  <a:pt x="8875194" y="176182"/>
                  <a:pt x="8573165" y="285660"/>
                  <a:pt x="8039370" y="305204"/>
                </a:cubicBezTo>
                <a:lnTo>
                  <a:pt x="1230" y="305387"/>
                </a:lnTo>
                <a:cubicBezTo>
                  <a:pt x="1632" y="318386"/>
                  <a:pt x="-347" y="321861"/>
                  <a:pt x="55" y="334860"/>
                </a:cubicBezTo>
                <a:close/>
              </a:path>
            </a:pathLst>
          </a:cu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254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正方形/長方形 12"/>
          <p:cNvSpPr/>
          <p:nvPr/>
        </p:nvSpPr>
        <p:spPr>
          <a:xfrm>
            <a:off x="0" y="6321600"/>
            <a:ext cx="9144000" cy="25200"/>
          </a:xfrm>
          <a:prstGeom prst="rect">
            <a:avLst/>
          </a:pr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12700" dir="16200000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>
            <a:lvl1pPr>
              <a:defRPr baseline="0">
                <a:latin typeface="メイリオ" panose="020B0604030504040204" pitchFamily="50" charset="-128"/>
                <a:ea typeface="メイリオ" panose="020B0604030504040204" pitchFamily="50" charset="-128"/>
              </a:defRPr>
            </a:lvl1pPr>
            <a:lvl2pPr>
              <a:defRPr baseline="0">
                <a:latin typeface="メイリオ" panose="020B0604030504040204" pitchFamily="50" charset="-128"/>
                <a:ea typeface="メイリオ" panose="020B0604030504040204" pitchFamily="50" charset="-128"/>
              </a:defRPr>
            </a:lvl2pPr>
            <a:lvl3pPr>
              <a:defRPr baseline="0">
                <a:latin typeface="メイリオ" panose="020B0604030504040204" pitchFamily="50" charset="-128"/>
                <a:ea typeface="メイリオ" panose="020B0604030504040204" pitchFamily="50" charset="-128"/>
              </a:defRPr>
            </a:lvl3pPr>
            <a:lvl4pPr>
              <a:defRPr baseline="0">
                <a:latin typeface="メイリオ" panose="020B0604030504040204" pitchFamily="50" charset="-128"/>
                <a:ea typeface="メイリオ" panose="020B0604030504040204" pitchFamily="50" charset="-128"/>
              </a:defRPr>
            </a:lvl4pPr>
            <a:lvl5pPr>
              <a:defRPr baseline="0">
                <a:latin typeface="メイリオ" panose="020B0604030504040204" pitchFamily="50" charset="-128"/>
                <a:ea typeface="メイリオ" panose="020B0604030504040204" pitchFamily="50" charset="-128"/>
              </a:defRPr>
            </a:lvl5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JP" alt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270676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図 1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35380" y="76966"/>
            <a:ext cx="856731" cy="594588"/>
          </a:xfrm>
          <a:prstGeom prst="rect">
            <a:avLst/>
          </a:prstGeom>
        </p:spPr>
      </p:pic>
      <p:sp>
        <p:nvSpPr>
          <p:cNvPr id="14" name="フリーフォーム 13"/>
          <p:cNvSpPr/>
          <p:nvPr/>
        </p:nvSpPr>
        <p:spPr>
          <a:xfrm>
            <a:off x="-1231" y="451262"/>
            <a:ext cx="9145230" cy="334860"/>
          </a:xfrm>
          <a:custGeom>
            <a:avLst/>
            <a:gdLst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5938 w 9149938"/>
              <a:gd name="connsiteY7" fmla="*/ 231569 h 344385"/>
              <a:gd name="connsiteX8" fmla="*/ 0 w 9149938"/>
              <a:gd name="connsiteY8" fmla="*/ 344385 h 344385"/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10700 w 9149938"/>
              <a:gd name="connsiteY7" fmla="*/ 300625 h 344385"/>
              <a:gd name="connsiteX8" fmla="*/ 0 w 9149938"/>
              <a:gd name="connsiteY8" fmla="*/ 344385 h 344385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25019 w 9139238"/>
              <a:gd name="connsiteY0" fmla="*/ 399154 h 399154"/>
              <a:gd name="connsiteX1" fmla="*/ 8230776 w 9139238"/>
              <a:gd name="connsiteY1" fmla="*/ 338447 h 399154"/>
              <a:gd name="connsiteX2" fmla="*/ 8771103 w 9139238"/>
              <a:gd name="connsiteY2" fmla="*/ 296883 h 399154"/>
              <a:gd name="connsiteX3" fmla="*/ 9139238 w 9139238"/>
              <a:gd name="connsiteY3" fmla="*/ 231569 h 399154"/>
              <a:gd name="connsiteX4" fmla="*/ 9139238 w 9139238"/>
              <a:gd name="connsiteY4" fmla="*/ 0 h 399154"/>
              <a:gd name="connsiteX5" fmla="*/ 8747352 w 9139238"/>
              <a:gd name="connsiteY5" fmla="*/ 201881 h 399154"/>
              <a:gd name="connsiteX6" fmla="*/ 8135773 w 9139238"/>
              <a:gd name="connsiteY6" fmla="*/ 302821 h 399154"/>
              <a:gd name="connsiteX7" fmla="*/ 0 w 9139238"/>
              <a:gd name="connsiteY7" fmla="*/ 300625 h 399154"/>
              <a:gd name="connsiteX8" fmla="*/ 25019 w 9139238"/>
              <a:gd name="connsiteY8" fmla="*/ 399154 h 39915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5937 w 9145175"/>
              <a:gd name="connsiteY7" fmla="*/ 300625 h 342004"/>
              <a:gd name="connsiteX8" fmla="*/ 0 w 9145175"/>
              <a:gd name="connsiteY8" fmla="*/ 342004 h 34200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120237 w 9145175"/>
              <a:gd name="connsiteY7" fmla="*/ 255381 h 342004"/>
              <a:gd name="connsiteX8" fmla="*/ 0 w 9145175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142917 w 9146382"/>
              <a:gd name="connsiteY6" fmla="*/ 302821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55 w 9145230"/>
              <a:gd name="connsiteY0" fmla="*/ 342004 h 342004"/>
              <a:gd name="connsiteX1" fmla="*/ 8236768 w 9145230"/>
              <a:gd name="connsiteY1" fmla="*/ 338447 h 342004"/>
              <a:gd name="connsiteX2" fmla="*/ 8777095 w 9145230"/>
              <a:gd name="connsiteY2" fmla="*/ 296883 h 342004"/>
              <a:gd name="connsiteX3" fmla="*/ 9145230 w 9145230"/>
              <a:gd name="connsiteY3" fmla="*/ 231569 h 342004"/>
              <a:gd name="connsiteX4" fmla="*/ 9145230 w 9145230"/>
              <a:gd name="connsiteY4" fmla="*/ 0 h 342004"/>
              <a:gd name="connsiteX5" fmla="*/ 8039370 w 9145230"/>
              <a:gd name="connsiteY5" fmla="*/ 302822 h 342004"/>
              <a:gd name="connsiteX6" fmla="*/ 1230 w 9145230"/>
              <a:gd name="connsiteY6" fmla="*/ 307768 h 342004"/>
              <a:gd name="connsiteX7" fmla="*/ 55 w 9145230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5387 h 342004"/>
              <a:gd name="connsiteX7" fmla="*/ 1207 w 9146382"/>
              <a:gd name="connsiteY7" fmla="*/ 342004 h 342004"/>
              <a:gd name="connsiteX0" fmla="*/ 1207 w 9146382"/>
              <a:gd name="connsiteY0" fmla="*/ 339622 h 339622"/>
              <a:gd name="connsiteX1" fmla="*/ 8237920 w 9146382"/>
              <a:gd name="connsiteY1" fmla="*/ 338447 h 339622"/>
              <a:gd name="connsiteX2" fmla="*/ 8778247 w 9146382"/>
              <a:gd name="connsiteY2" fmla="*/ 296883 h 339622"/>
              <a:gd name="connsiteX3" fmla="*/ 9146382 w 9146382"/>
              <a:gd name="connsiteY3" fmla="*/ 231569 h 339622"/>
              <a:gd name="connsiteX4" fmla="*/ 9146382 w 9146382"/>
              <a:gd name="connsiteY4" fmla="*/ 0 h 339622"/>
              <a:gd name="connsiteX5" fmla="*/ 8040522 w 9146382"/>
              <a:gd name="connsiteY5" fmla="*/ 302822 h 339622"/>
              <a:gd name="connsiteX6" fmla="*/ 0 w 9146382"/>
              <a:gd name="connsiteY6" fmla="*/ 305387 h 339622"/>
              <a:gd name="connsiteX7" fmla="*/ 1207 w 9146382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2822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3685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4860 h 334860"/>
              <a:gd name="connsiteX1" fmla="*/ 8236768 w 9145230"/>
              <a:gd name="connsiteY1" fmla="*/ 333685 h 334860"/>
              <a:gd name="connsiteX2" fmla="*/ 8777095 w 9145230"/>
              <a:gd name="connsiteY2" fmla="*/ 296883 h 334860"/>
              <a:gd name="connsiteX3" fmla="*/ 9145230 w 9145230"/>
              <a:gd name="connsiteY3" fmla="*/ 231569 h 334860"/>
              <a:gd name="connsiteX4" fmla="*/ 9145230 w 9145230"/>
              <a:gd name="connsiteY4" fmla="*/ 0 h 334860"/>
              <a:gd name="connsiteX5" fmla="*/ 8039370 w 9145230"/>
              <a:gd name="connsiteY5" fmla="*/ 305204 h 334860"/>
              <a:gd name="connsiteX6" fmla="*/ 1230 w 9145230"/>
              <a:gd name="connsiteY6" fmla="*/ 305387 h 334860"/>
              <a:gd name="connsiteX7" fmla="*/ 55 w 9145230"/>
              <a:gd name="connsiteY7" fmla="*/ 334860 h 3348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9145230" h="334860">
                <a:moveTo>
                  <a:pt x="55" y="334860"/>
                </a:moveTo>
                <a:lnTo>
                  <a:pt x="8236768" y="333685"/>
                </a:lnTo>
                <a:cubicBezTo>
                  <a:pt x="8424021" y="326974"/>
                  <a:pt x="8625685" y="313902"/>
                  <a:pt x="8777095" y="296883"/>
                </a:cubicBezTo>
                <a:cubicBezTo>
                  <a:pt x="8928505" y="279864"/>
                  <a:pt x="9017756" y="262865"/>
                  <a:pt x="9145230" y="231569"/>
                </a:cubicBezTo>
                <a:lnTo>
                  <a:pt x="9145230" y="0"/>
                </a:lnTo>
                <a:cubicBezTo>
                  <a:pt x="8875194" y="176182"/>
                  <a:pt x="8573165" y="285660"/>
                  <a:pt x="8039370" y="305204"/>
                </a:cubicBezTo>
                <a:lnTo>
                  <a:pt x="1230" y="305387"/>
                </a:lnTo>
                <a:cubicBezTo>
                  <a:pt x="1632" y="318386"/>
                  <a:pt x="-347" y="321861"/>
                  <a:pt x="55" y="334860"/>
                </a:cubicBezTo>
                <a:close/>
              </a:path>
            </a:pathLst>
          </a:cu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254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正方形/長方形 14"/>
          <p:cNvSpPr/>
          <p:nvPr/>
        </p:nvSpPr>
        <p:spPr>
          <a:xfrm>
            <a:off x="0" y="6321600"/>
            <a:ext cx="9144000" cy="25200"/>
          </a:xfrm>
          <a:prstGeom prst="rect">
            <a:avLst/>
          </a:pr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12700" dir="16200000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57200" y="187325"/>
            <a:ext cx="7355160" cy="544514"/>
          </a:xfrm>
        </p:spPr>
        <p:txBody>
          <a:bodyPr vert="horz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199" y="1014413"/>
            <a:ext cx="6930189" cy="5111750"/>
          </a:xfrm>
        </p:spPr>
        <p:txBody>
          <a:bodyPr vert="eaVert"/>
          <a:lstStyle>
            <a:lvl1pPr>
              <a:defRPr baseline="0">
                <a:latin typeface="メイリオ" panose="020B0604030504040204" pitchFamily="50" charset="-128"/>
                <a:ea typeface="メイリオ" panose="020B0604030504040204" pitchFamily="50" charset="-128"/>
              </a:defRPr>
            </a:lvl1pPr>
            <a:lvl2pPr>
              <a:defRPr baseline="0">
                <a:latin typeface="メイリオ" panose="020B0604030504040204" pitchFamily="50" charset="-128"/>
                <a:ea typeface="メイリオ" panose="020B0604030504040204" pitchFamily="50" charset="-128"/>
              </a:defRPr>
            </a:lvl2pPr>
            <a:lvl3pPr>
              <a:defRPr baseline="0">
                <a:latin typeface="メイリオ" panose="020B0604030504040204" pitchFamily="50" charset="-128"/>
                <a:ea typeface="メイリオ" panose="020B0604030504040204" pitchFamily="50" charset="-128"/>
              </a:defRPr>
            </a:lvl3pPr>
            <a:lvl4pPr>
              <a:defRPr baseline="0">
                <a:latin typeface="メイリオ" panose="020B0604030504040204" pitchFamily="50" charset="-128"/>
                <a:ea typeface="メイリオ" panose="020B0604030504040204" pitchFamily="50" charset="-128"/>
              </a:defRPr>
            </a:lvl4pPr>
            <a:lvl5pPr>
              <a:defRPr baseline="0">
                <a:latin typeface="メイリオ" panose="020B0604030504040204" pitchFamily="50" charset="-128"/>
                <a:ea typeface="メイリオ" panose="020B0604030504040204" pitchFamily="50" charset="-128"/>
              </a:defRPr>
            </a:lvl5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縦書きテキスト プレースホルダー 6"/>
          <p:cNvSpPr>
            <a:spLocks noGrp="1"/>
          </p:cNvSpPr>
          <p:nvPr>
            <p:ph type="body" orient="vert" sz="quarter" idx="11"/>
          </p:nvPr>
        </p:nvSpPr>
        <p:spPr>
          <a:xfrm>
            <a:off x="7452320" y="1014413"/>
            <a:ext cx="1240830" cy="5111750"/>
          </a:xfrm>
        </p:spPr>
        <p:txBody>
          <a:bodyPr vert="eaVert" lIns="91440" tIns="45720" rIns="91440" bIns="45720" rtlCol="0" anchor="ctr">
            <a:noAutofit/>
          </a:bodyPr>
          <a:lstStyle>
            <a:lvl1pPr marL="0" indent="0">
              <a:buNone/>
              <a:defRPr lang="ja-JP" altLang="en-US" sz="3200" b="1" baseline="0" smtClean="0">
                <a:latin typeface="メイリオ" panose="020B0604030504040204" pitchFamily="50" charset="-128"/>
                <a:ea typeface="メイリオ" panose="020B0604030504040204" pitchFamily="50" charset="-128"/>
                <a:cs typeface="+mj-cs"/>
              </a:defRPr>
            </a:lvl1pPr>
            <a:lvl2pPr marL="171450" indent="0">
              <a:buNone/>
              <a:defRPr lang="ja-JP" altLang="en-US" sz="1800" smtClean="0"/>
            </a:lvl2pPr>
            <a:lvl3pPr marL="685800" indent="0">
              <a:buNone/>
              <a:defRPr lang="ja-JP" altLang="en-US" sz="1800" smtClean="0"/>
            </a:lvl3pPr>
            <a:lvl4pPr marL="1143000" indent="0">
              <a:buNone/>
              <a:defRPr lang="ja-JP" altLang="en-US" smtClean="0"/>
            </a:lvl4pPr>
            <a:lvl5pPr marL="1600200" indent="0">
              <a:buNone/>
              <a:defRPr lang="ja-JP" altLang="en-US"/>
            </a:lvl5pPr>
          </a:lstStyle>
          <a:p>
            <a:pPr marL="0" lvl="0">
              <a:lnSpc>
                <a:spcPct val="100000"/>
              </a:lnSpc>
              <a:spcBef>
                <a:spcPct val="0"/>
              </a:spcBef>
            </a:pPr>
            <a:r>
              <a:rPr kumimoji="1" lang="ja-JP" altLang="en-US"/>
              <a:t>マスター テキスト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2298330376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: 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281237"/>
            <a:ext cx="7772400" cy="1749425"/>
          </a:xfrm>
        </p:spPr>
        <p:txBody>
          <a:bodyPr>
            <a:noAutofit/>
          </a:bodyPr>
          <a:lstStyle>
            <a:lvl1pPr algn="ctr">
              <a:defRPr sz="3600" baseline="0"/>
            </a:lvl1pPr>
          </a:lstStyle>
          <a:p>
            <a:r>
              <a:rPr kumimoji="1" lang="ja-JP" altLang="en-US"/>
              <a:t>マスター タイトルの書式設定</a:t>
            </a:r>
            <a:endParaRPr kumimoji="1" lang="ja-JP" altLang="en-US" dirty="0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724526" y="4095750"/>
            <a:ext cx="5694948" cy="1543050"/>
          </a:xfrm>
        </p:spPr>
        <p:txBody>
          <a:bodyPr anchor="ctr">
            <a:normAutofit/>
          </a:bodyPr>
          <a:lstStyle>
            <a:lvl1pPr marL="0" indent="0" algn="ctr">
              <a:buNone/>
              <a:defRPr baseline="0">
                <a:solidFill>
                  <a:schemeClr val="tx1"/>
                </a:solidFill>
                <a:latin typeface="+mj-lt"/>
                <a:ea typeface="+mj-ea"/>
              </a:defRPr>
            </a:lvl1pPr>
            <a:lvl2pPr marL="457200" indent="0" algn="ctr">
              <a:buNone/>
              <a:defRPr>
                <a:solidFill>
                  <a:schemeClr val="tx1"/>
                </a:solidFill>
              </a:defRPr>
            </a:lvl2pPr>
            <a:lvl3pPr marL="914400" indent="0" algn="ctr">
              <a:buNone/>
              <a:defRPr>
                <a:solidFill>
                  <a:schemeClr val="tx1"/>
                </a:solidFill>
              </a:defRPr>
            </a:lvl3pPr>
            <a:lvl4pPr marL="1371600" indent="0" algn="ctr">
              <a:buNone/>
              <a:defRPr>
                <a:solidFill>
                  <a:schemeClr val="tx1"/>
                </a:solidFill>
              </a:defRPr>
            </a:lvl4pPr>
            <a:lvl5pPr marL="1828800" indent="0" algn="ctr">
              <a:buNone/>
              <a:defRPr>
                <a:solidFill>
                  <a:schemeClr val="tx1"/>
                </a:solidFill>
              </a:defRPr>
            </a:lvl5pPr>
            <a:lvl6pPr marL="2286000" indent="0" algn="ctr">
              <a:buNone/>
              <a:defRPr sz="1800">
                <a:solidFill>
                  <a:schemeClr val="tx1"/>
                </a:solidFill>
              </a:defRPr>
            </a:lvl6pPr>
            <a:lvl7pPr marL="2743200" indent="0" algn="ctr">
              <a:buNone/>
              <a:defRPr sz="1800">
                <a:solidFill>
                  <a:schemeClr val="tx1"/>
                </a:solidFill>
              </a:defRPr>
            </a:lvl7pPr>
            <a:lvl8pPr marL="3200400" indent="0" algn="ctr">
              <a:buNone/>
              <a:defRPr sz="1800">
                <a:solidFill>
                  <a:schemeClr val="tx1"/>
                </a:solidFill>
              </a:defRPr>
            </a:lvl8pPr>
            <a:lvl9pPr marL="3657600" indent="0" algn="ctr">
              <a:buNone/>
              <a:defRPr sz="1800">
                <a:solidFill>
                  <a:schemeClr val="tx1"/>
                </a:solidFill>
              </a:defRPr>
            </a:lvl9pPr>
          </a:lstStyle>
          <a:p>
            <a:pPr lvl="0"/>
            <a:r>
              <a:rPr kumimoji="1" lang="ja-JP" altLang="en-US"/>
              <a:t>マスター サブタイトルの書式設定</a:t>
            </a:r>
            <a:endParaRPr kumimoji="1" lang="ja-JP" alt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kumimoji="1" lang="ja-JP" altLang="en-US"/>
          </a:p>
        </p:txBody>
      </p:sp>
      <p:pic>
        <p:nvPicPr>
          <p:cNvPr id="6" name="図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6232" y="632602"/>
            <a:ext cx="2308292" cy="1602000"/>
          </a:xfrm>
          <a:prstGeom prst="rect">
            <a:avLst/>
          </a:prstGeom>
        </p:spPr>
      </p:pic>
      <p:sp>
        <p:nvSpPr>
          <p:cNvPr id="7" name="フリーフォーム 6"/>
          <p:cNvSpPr/>
          <p:nvPr/>
        </p:nvSpPr>
        <p:spPr>
          <a:xfrm>
            <a:off x="-2904" y="4886752"/>
            <a:ext cx="9146904" cy="876879"/>
          </a:xfrm>
          <a:custGeom>
            <a:avLst/>
            <a:gdLst>
              <a:gd name="connsiteX0" fmla="*/ 0 w 9149286"/>
              <a:gd name="connsiteY0" fmla="*/ 872116 h 872116"/>
              <a:gd name="connsiteX1" fmla="*/ 6469513 w 9149286"/>
              <a:gd name="connsiteY1" fmla="*/ 872116 h 872116"/>
              <a:gd name="connsiteX2" fmla="*/ 9149286 w 9149286"/>
              <a:gd name="connsiteY2" fmla="*/ 576125 h 872116"/>
              <a:gd name="connsiteX3" fmla="*/ 9138715 w 9149286"/>
              <a:gd name="connsiteY3" fmla="*/ 0 h 872116"/>
              <a:gd name="connsiteX4" fmla="*/ 6152380 w 9149286"/>
              <a:gd name="connsiteY4" fmla="*/ 840402 h 872116"/>
              <a:gd name="connsiteX5" fmla="*/ 0 w 9149286"/>
              <a:gd name="connsiteY5" fmla="*/ 687121 h 872116"/>
              <a:gd name="connsiteX6" fmla="*/ 0 w 9149286"/>
              <a:gd name="connsiteY6" fmla="*/ 872116 h 872116"/>
              <a:gd name="connsiteX0" fmla="*/ 4762 w 9149286"/>
              <a:gd name="connsiteY0" fmla="*/ 874497 h 874497"/>
              <a:gd name="connsiteX1" fmla="*/ 6469513 w 9149286"/>
              <a:gd name="connsiteY1" fmla="*/ 872116 h 874497"/>
              <a:gd name="connsiteX2" fmla="*/ 9149286 w 9149286"/>
              <a:gd name="connsiteY2" fmla="*/ 576125 h 874497"/>
              <a:gd name="connsiteX3" fmla="*/ 9138715 w 9149286"/>
              <a:gd name="connsiteY3" fmla="*/ 0 h 874497"/>
              <a:gd name="connsiteX4" fmla="*/ 6152380 w 9149286"/>
              <a:gd name="connsiteY4" fmla="*/ 840402 h 874497"/>
              <a:gd name="connsiteX5" fmla="*/ 0 w 9149286"/>
              <a:gd name="connsiteY5" fmla="*/ 687121 h 874497"/>
              <a:gd name="connsiteX6" fmla="*/ 4762 w 9149286"/>
              <a:gd name="connsiteY6" fmla="*/ 874497 h 874497"/>
              <a:gd name="connsiteX0" fmla="*/ 2380 w 9146904"/>
              <a:gd name="connsiteY0" fmla="*/ 874497 h 874497"/>
              <a:gd name="connsiteX1" fmla="*/ 6467131 w 9146904"/>
              <a:gd name="connsiteY1" fmla="*/ 872116 h 874497"/>
              <a:gd name="connsiteX2" fmla="*/ 9146904 w 9146904"/>
              <a:gd name="connsiteY2" fmla="*/ 576125 h 874497"/>
              <a:gd name="connsiteX3" fmla="*/ 9136333 w 9146904"/>
              <a:gd name="connsiteY3" fmla="*/ 0 h 874497"/>
              <a:gd name="connsiteX4" fmla="*/ 6149998 w 9146904"/>
              <a:gd name="connsiteY4" fmla="*/ 840402 h 874497"/>
              <a:gd name="connsiteX5" fmla="*/ 0 w 9146904"/>
              <a:gd name="connsiteY5" fmla="*/ 846665 h 874497"/>
              <a:gd name="connsiteX6" fmla="*/ 2380 w 9146904"/>
              <a:gd name="connsiteY6" fmla="*/ 874497 h 874497"/>
              <a:gd name="connsiteX0" fmla="*/ 2380 w 9146904"/>
              <a:gd name="connsiteY0" fmla="*/ 874497 h 874497"/>
              <a:gd name="connsiteX1" fmla="*/ 6467131 w 9146904"/>
              <a:gd name="connsiteY1" fmla="*/ 872116 h 874497"/>
              <a:gd name="connsiteX2" fmla="*/ 9146904 w 9146904"/>
              <a:gd name="connsiteY2" fmla="*/ 576125 h 874497"/>
              <a:gd name="connsiteX3" fmla="*/ 9136333 w 9146904"/>
              <a:gd name="connsiteY3" fmla="*/ 0 h 874497"/>
              <a:gd name="connsiteX4" fmla="*/ 5895204 w 9146904"/>
              <a:gd name="connsiteY4" fmla="*/ 845165 h 874497"/>
              <a:gd name="connsiteX5" fmla="*/ 0 w 9146904"/>
              <a:gd name="connsiteY5" fmla="*/ 846665 h 874497"/>
              <a:gd name="connsiteX6" fmla="*/ 2380 w 9146904"/>
              <a:gd name="connsiteY6" fmla="*/ 874497 h 874497"/>
              <a:gd name="connsiteX0" fmla="*/ 2380 w 9146904"/>
              <a:gd name="connsiteY0" fmla="*/ 874497 h 874497"/>
              <a:gd name="connsiteX1" fmla="*/ 6467131 w 9146904"/>
              <a:gd name="connsiteY1" fmla="*/ 872116 h 874497"/>
              <a:gd name="connsiteX2" fmla="*/ 9146904 w 9146904"/>
              <a:gd name="connsiteY2" fmla="*/ 576125 h 874497"/>
              <a:gd name="connsiteX3" fmla="*/ 9136333 w 9146904"/>
              <a:gd name="connsiteY3" fmla="*/ 0 h 874497"/>
              <a:gd name="connsiteX4" fmla="*/ 5895204 w 9146904"/>
              <a:gd name="connsiteY4" fmla="*/ 845165 h 874497"/>
              <a:gd name="connsiteX5" fmla="*/ 0 w 9146904"/>
              <a:gd name="connsiteY5" fmla="*/ 846665 h 874497"/>
              <a:gd name="connsiteX6" fmla="*/ 2380 w 9146904"/>
              <a:gd name="connsiteY6" fmla="*/ 874497 h 874497"/>
              <a:gd name="connsiteX0" fmla="*/ 2380 w 9146904"/>
              <a:gd name="connsiteY0" fmla="*/ 874497 h 874497"/>
              <a:gd name="connsiteX1" fmla="*/ 6467131 w 9146904"/>
              <a:gd name="connsiteY1" fmla="*/ 872116 h 874497"/>
              <a:gd name="connsiteX2" fmla="*/ 9146904 w 9146904"/>
              <a:gd name="connsiteY2" fmla="*/ 576125 h 874497"/>
              <a:gd name="connsiteX3" fmla="*/ 9145858 w 9146904"/>
              <a:gd name="connsiteY3" fmla="*/ 0 h 874497"/>
              <a:gd name="connsiteX4" fmla="*/ 5895204 w 9146904"/>
              <a:gd name="connsiteY4" fmla="*/ 845165 h 874497"/>
              <a:gd name="connsiteX5" fmla="*/ 0 w 9146904"/>
              <a:gd name="connsiteY5" fmla="*/ 846665 h 874497"/>
              <a:gd name="connsiteX6" fmla="*/ 2380 w 9146904"/>
              <a:gd name="connsiteY6" fmla="*/ 874497 h 874497"/>
              <a:gd name="connsiteX0" fmla="*/ 2380 w 9146904"/>
              <a:gd name="connsiteY0" fmla="*/ 874497 h 874497"/>
              <a:gd name="connsiteX1" fmla="*/ 6467131 w 9146904"/>
              <a:gd name="connsiteY1" fmla="*/ 872116 h 874497"/>
              <a:gd name="connsiteX2" fmla="*/ 9146904 w 9146904"/>
              <a:gd name="connsiteY2" fmla="*/ 576125 h 874497"/>
              <a:gd name="connsiteX3" fmla="*/ 9145858 w 9146904"/>
              <a:gd name="connsiteY3" fmla="*/ 0 h 874497"/>
              <a:gd name="connsiteX4" fmla="*/ 5895204 w 9146904"/>
              <a:gd name="connsiteY4" fmla="*/ 845165 h 874497"/>
              <a:gd name="connsiteX5" fmla="*/ 0 w 9146904"/>
              <a:gd name="connsiteY5" fmla="*/ 846665 h 874497"/>
              <a:gd name="connsiteX6" fmla="*/ 2380 w 9146904"/>
              <a:gd name="connsiteY6" fmla="*/ 874497 h 874497"/>
              <a:gd name="connsiteX0" fmla="*/ 2380 w 9146904"/>
              <a:gd name="connsiteY0" fmla="*/ 874497 h 874497"/>
              <a:gd name="connsiteX1" fmla="*/ 6467131 w 9146904"/>
              <a:gd name="connsiteY1" fmla="*/ 872116 h 874497"/>
              <a:gd name="connsiteX2" fmla="*/ 9146904 w 9146904"/>
              <a:gd name="connsiteY2" fmla="*/ 576125 h 874497"/>
              <a:gd name="connsiteX3" fmla="*/ 9145858 w 9146904"/>
              <a:gd name="connsiteY3" fmla="*/ 0 h 874497"/>
              <a:gd name="connsiteX4" fmla="*/ 5895204 w 9146904"/>
              <a:gd name="connsiteY4" fmla="*/ 845165 h 874497"/>
              <a:gd name="connsiteX5" fmla="*/ 0 w 9146904"/>
              <a:gd name="connsiteY5" fmla="*/ 846665 h 874497"/>
              <a:gd name="connsiteX6" fmla="*/ 2380 w 9146904"/>
              <a:gd name="connsiteY6" fmla="*/ 874497 h 874497"/>
              <a:gd name="connsiteX0" fmla="*/ 2380 w 9146904"/>
              <a:gd name="connsiteY0" fmla="*/ 874497 h 874497"/>
              <a:gd name="connsiteX1" fmla="*/ 6467131 w 9146904"/>
              <a:gd name="connsiteY1" fmla="*/ 872116 h 874497"/>
              <a:gd name="connsiteX2" fmla="*/ 9146904 w 9146904"/>
              <a:gd name="connsiteY2" fmla="*/ 576125 h 874497"/>
              <a:gd name="connsiteX3" fmla="*/ 9145858 w 9146904"/>
              <a:gd name="connsiteY3" fmla="*/ 0 h 874497"/>
              <a:gd name="connsiteX4" fmla="*/ 5895204 w 9146904"/>
              <a:gd name="connsiteY4" fmla="*/ 845165 h 874497"/>
              <a:gd name="connsiteX5" fmla="*/ 0 w 9146904"/>
              <a:gd name="connsiteY5" fmla="*/ 846665 h 874497"/>
              <a:gd name="connsiteX6" fmla="*/ 2380 w 9146904"/>
              <a:gd name="connsiteY6" fmla="*/ 874497 h 874497"/>
              <a:gd name="connsiteX0" fmla="*/ 2380 w 9146904"/>
              <a:gd name="connsiteY0" fmla="*/ 874497 h 874497"/>
              <a:gd name="connsiteX1" fmla="*/ 6467131 w 9146904"/>
              <a:gd name="connsiteY1" fmla="*/ 872116 h 874497"/>
              <a:gd name="connsiteX2" fmla="*/ 9146904 w 9146904"/>
              <a:gd name="connsiteY2" fmla="*/ 576125 h 874497"/>
              <a:gd name="connsiteX3" fmla="*/ 9145858 w 9146904"/>
              <a:gd name="connsiteY3" fmla="*/ 0 h 874497"/>
              <a:gd name="connsiteX4" fmla="*/ 5895204 w 9146904"/>
              <a:gd name="connsiteY4" fmla="*/ 845165 h 874497"/>
              <a:gd name="connsiteX5" fmla="*/ 0 w 9146904"/>
              <a:gd name="connsiteY5" fmla="*/ 846665 h 874497"/>
              <a:gd name="connsiteX6" fmla="*/ 2380 w 9146904"/>
              <a:gd name="connsiteY6" fmla="*/ 874497 h 874497"/>
              <a:gd name="connsiteX0" fmla="*/ 2380 w 9146904"/>
              <a:gd name="connsiteY0" fmla="*/ 874497 h 874497"/>
              <a:gd name="connsiteX1" fmla="*/ 6467131 w 9146904"/>
              <a:gd name="connsiteY1" fmla="*/ 872116 h 874497"/>
              <a:gd name="connsiteX2" fmla="*/ 9146904 w 9146904"/>
              <a:gd name="connsiteY2" fmla="*/ 576125 h 874497"/>
              <a:gd name="connsiteX3" fmla="*/ 9145858 w 9146904"/>
              <a:gd name="connsiteY3" fmla="*/ 0 h 874497"/>
              <a:gd name="connsiteX4" fmla="*/ 5895204 w 9146904"/>
              <a:gd name="connsiteY4" fmla="*/ 845165 h 874497"/>
              <a:gd name="connsiteX5" fmla="*/ 0 w 9146904"/>
              <a:gd name="connsiteY5" fmla="*/ 846665 h 874497"/>
              <a:gd name="connsiteX6" fmla="*/ 2380 w 9146904"/>
              <a:gd name="connsiteY6" fmla="*/ 874497 h 874497"/>
              <a:gd name="connsiteX0" fmla="*/ 2380 w 9146904"/>
              <a:gd name="connsiteY0" fmla="*/ 874497 h 874497"/>
              <a:gd name="connsiteX1" fmla="*/ 6467131 w 9146904"/>
              <a:gd name="connsiteY1" fmla="*/ 872116 h 874497"/>
              <a:gd name="connsiteX2" fmla="*/ 9146904 w 9146904"/>
              <a:gd name="connsiteY2" fmla="*/ 576125 h 874497"/>
              <a:gd name="connsiteX3" fmla="*/ 9145858 w 9146904"/>
              <a:gd name="connsiteY3" fmla="*/ 0 h 874497"/>
              <a:gd name="connsiteX4" fmla="*/ 5895204 w 9146904"/>
              <a:gd name="connsiteY4" fmla="*/ 845165 h 874497"/>
              <a:gd name="connsiteX5" fmla="*/ 0 w 9146904"/>
              <a:gd name="connsiteY5" fmla="*/ 846665 h 874497"/>
              <a:gd name="connsiteX6" fmla="*/ 2380 w 9146904"/>
              <a:gd name="connsiteY6" fmla="*/ 874497 h 874497"/>
              <a:gd name="connsiteX0" fmla="*/ 2380 w 9146904"/>
              <a:gd name="connsiteY0" fmla="*/ 874497 h 874497"/>
              <a:gd name="connsiteX1" fmla="*/ 6467131 w 9146904"/>
              <a:gd name="connsiteY1" fmla="*/ 872116 h 874497"/>
              <a:gd name="connsiteX2" fmla="*/ 9146904 w 9146904"/>
              <a:gd name="connsiteY2" fmla="*/ 576125 h 874497"/>
              <a:gd name="connsiteX3" fmla="*/ 9145858 w 9146904"/>
              <a:gd name="connsiteY3" fmla="*/ 0 h 874497"/>
              <a:gd name="connsiteX4" fmla="*/ 5895204 w 9146904"/>
              <a:gd name="connsiteY4" fmla="*/ 845165 h 874497"/>
              <a:gd name="connsiteX5" fmla="*/ 0 w 9146904"/>
              <a:gd name="connsiteY5" fmla="*/ 846665 h 874497"/>
              <a:gd name="connsiteX6" fmla="*/ 2380 w 9146904"/>
              <a:gd name="connsiteY6" fmla="*/ 874497 h 874497"/>
              <a:gd name="connsiteX0" fmla="*/ 2380 w 9146904"/>
              <a:gd name="connsiteY0" fmla="*/ 874497 h 874497"/>
              <a:gd name="connsiteX1" fmla="*/ 6467131 w 9146904"/>
              <a:gd name="connsiteY1" fmla="*/ 872116 h 874497"/>
              <a:gd name="connsiteX2" fmla="*/ 9146904 w 9146904"/>
              <a:gd name="connsiteY2" fmla="*/ 576125 h 874497"/>
              <a:gd name="connsiteX3" fmla="*/ 9145858 w 9146904"/>
              <a:gd name="connsiteY3" fmla="*/ 0 h 874497"/>
              <a:gd name="connsiteX4" fmla="*/ 5895204 w 9146904"/>
              <a:gd name="connsiteY4" fmla="*/ 845165 h 874497"/>
              <a:gd name="connsiteX5" fmla="*/ 0 w 9146904"/>
              <a:gd name="connsiteY5" fmla="*/ 846665 h 874497"/>
              <a:gd name="connsiteX6" fmla="*/ 2380 w 9146904"/>
              <a:gd name="connsiteY6" fmla="*/ 874497 h 874497"/>
              <a:gd name="connsiteX0" fmla="*/ 2380 w 9146904"/>
              <a:gd name="connsiteY0" fmla="*/ 874497 h 874497"/>
              <a:gd name="connsiteX1" fmla="*/ 6467131 w 9146904"/>
              <a:gd name="connsiteY1" fmla="*/ 872116 h 874497"/>
              <a:gd name="connsiteX2" fmla="*/ 9146904 w 9146904"/>
              <a:gd name="connsiteY2" fmla="*/ 576125 h 874497"/>
              <a:gd name="connsiteX3" fmla="*/ 9145858 w 9146904"/>
              <a:gd name="connsiteY3" fmla="*/ 0 h 874497"/>
              <a:gd name="connsiteX4" fmla="*/ 5895204 w 9146904"/>
              <a:gd name="connsiteY4" fmla="*/ 845165 h 874497"/>
              <a:gd name="connsiteX5" fmla="*/ 0 w 9146904"/>
              <a:gd name="connsiteY5" fmla="*/ 846665 h 874497"/>
              <a:gd name="connsiteX6" fmla="*/ 2380 w 9146904"/>
              <a:gd name="connsiteY6" fmla="*/ 874497 h 874497"/>
              <a:gd name="connsiteX0" fmla="*/ 2380 w 9146904"/>
              <a:gd name="connsiteY0" fmla="*/ 874497 h 874497"/>
              <a:gd name="connsiteX1" fmla="*/ 6467131 w 9146904"/>
              <a:gd name="connsiteY1" fmla="*/ 872116 h 874497"/>
              <a:gd name="connsiteX2" fmla="*/ 9146904 w 9146904"/>
              <a:gd name="connsiteY2" fmla="*/ 576125 h 874497"/>
              <a:gd name="connsiteX3" fmla="*/ 9145858 w 9146904"/>
              <a:gd name="connsiteY3" fmla="*/ 0 h 874497"/>
              <a:gd name="connsiteX4" fmla="*/ 5895204 w 9146904"/>
              <a:gd name="connsiteY4" fmla="*/ 845165 h 874497"/>
              <a:gd name="connsiteX5" fmla="*/ 0 w 9146904"/>
              <a:gd name="connsiteY5" fmla="*/ 846665 h 874497"/>
              <a:gd name="connsiteX6" fmla="*/ 2380 w 9146904"/>
              <a:gd name="connsiteY6" fmla="*/ 874497 h 874497"/>
              <a:gd name="connsiteX0" fmla="*/ 2380 w 9146904"/>
              <a:gd name="connsiteY0" fmla="*/ 874497 h 874497"/>
              <a:gd name="connsiteX1" fmla="*/ 6464750 w 9146904"/>
              <a:gd name="connsiteY1" fmla="*/ 872116 h 874497"/>
              <a:gd name="connsiteX2" fmla="*/ 9146904 w 9146904"/>
              <a:gd name="connsiteY2" fmla="*/ 576125 h 874497"/>
              <a:gd name="connsiteX3" fmla="*/ 9145858 w 9146904"/>
              <a:gd name="connsiteY3" fmla="*/ 0 h 874497"/>
              <a:gd name="connsiteX4" fmla="*/ 5895204 w 9146904"/>
              <a:gd name="connsiteY4" fmla="*/ 845165 h 874497"/>
              <a:gd name="connsiteX5" fmla="*/ 0 w 9146904"/>
              <a:gd name="connsiteY5" fmla="*/ 846665 h 874497"/>
              <a:gd name="connsiteX6" fmla="*/ 2380 w 9146904"/>
              <a:gd name="connsiteY6" fmla="*/ 874497 h 874497"/>
              <a:gd name="connsiteX0" fmla="*/ 2380 w 9146904"/>
              <a:gd name="connsiteY0" fmla="*/ 874497 h 876879"/>
              <a:gd name="connsiteX1" fmla="*/ 6455225 w 9146904"/>
              <a:gd name="connsiteY1" fmla="*/ 876879 h 876879"/>
              <a:gd name="connsiteX2" fmla="*/ 9146904 w 9146904"/>
              <a:gd name="connsiteY2" fmla="*/ 576125 h 876879"/>
              <a:gd name="connsiteX3" fmla="*/ 9145858 w 9146904"/>
              <a:gd name="connsiteY3" fmla="*/ 0 h 876879"/>
              <a:gd name="connsiteX4" fmla="*/ 5895204 w 9146904"/>
              <a:gd name="connsiteY4" fmla="*/ 845165 h 876879"/>
              <a:gd name="connsiteX5" fmla="*/ 0 w 9146904"/>
              <a:gd name="connsiteY5" fmla="*/ 846665 h 876879"/>
              <a:gd name="connsiteX6" fmla="*/ 2380 w 9146904"/>
              <a:gd name="connsiteY6" fmla="*/ 874497 h 876879"/>
              <a:gd name="connsiteX0" fmla="*/ 2380 w 9146904"/>
              <a:gd name="connsiteY0" fmla="*/ 874497 h 876879"/>
              <a:gd name="connsiteX1" fmla="*/ 6455225 w 9146904"/>
              <a:gd name="connsiteY1" fmla="*/ 876879 h 876879"/>
              <a:gd name="connsiteX2" fmla="*/ 9146904 w 9146904"/>
              <a:gd name="connsiteY2" fmla="*/ 576125 h 876879"/>
              <a:gd name="connsiteX3" fmla="*/ 9145858 w 9146904"/>
              <a:gd name="connsiteY3" fmla="*/ 0 h 876879"/>
              <a:gd name="connsiteX4" fmla="*/ 5895204 w 9146904"/>
              <a:gd name="connsiteY4" fmla="*/ 845165 h 876879"/>
              <a:gd name="connsiteX5" fmla="*/ 0 w 9146904"/>
              <a:gd name="connsiteY5" fmla="*/ 846665 h 876879"/>
              <a:gd name="connsiteX6" fmla="*/ 2380 w 9146904"/>
              <a:gd name="connsiteY6" fmla="*/ 874497 h 876879"/>
              <a:gd name="connsiteX0" fmla="*/ 2380 w 9146904"/>
              <a:gd name="connsiteY0" fmla="*/ 874497 h 876879"/>
              <a:gd name="connsiteX1" fmla="*/ 6455225 w 9146904"/>
              <a:gd name="connsiteY1" fmla="*/ 876879 h 876879"/>
              <a:gd name="connsiteX2" fmla="*/ 9146904 w 9146904"/>
              <a:gd name="connsiteY2" fmla="*/ 576125 h 876879"/>
              <a:gd name="connsiteX3" fmla="*/ 9145858 w 9146904"/>
              <a:gd name="connsiteY3" fmla="*/ 0 h 876879"/>
              <a:gd name="connsiteX4" fmla="*/ 5895204 w 9146904"/>
              <a:gd name="connsiteY4" fmla="*/ 845165 h 876879"/>
              <a:gd name="connsiteX5" fmla="*/ 0 w 9146904"/>
              <a:gd name="connsiteY5" fmla="*/ 846665 h 876879"/>
              <a:gd name="connsiteX6" fmla="*/ 2380 w 9146904"/>
              <a:gd name="connsiteY6" fmla="*/ 874497 h 876879"/>
              <a:gd name="connsiteX0" fmla="*/ 2380 w 9146904"/>
              <a:gd name="connsiteY0" fmla="*/ 874497 h 876879"/>
              <a:gd name="connsiteX1" fmla="*/ 6386169 w 9146904"/>
              <a:gd name="connsiteY1" fmla="*/ 876879 h 876879"/>
              <a:gd name="connsiteX2" fmla="*/ 9146904 w 9146904"/>
              <a:gd name="connsiteY2" fmla="*/ 576125 h 876879"/>
              <a:gd name="connsiteX3" fmla="*/ 9145858 w 9146904"/>
              <a:gd name="connsiteY3" fmla="*/ 0 h 876879"/>
              <a:gd name="connsiteX4" fmla="*/ 5895204 w 9146904"/>
              <a:gd name="connsiteY4" fmla="*/ 845165 h 876879"/>
              <a:gd name="connsiteX5" fmla="*/ 0 w 9146904"/>
              <a:gd name="connsiteY5" fmla="*/ 846665 h 876879"/>
              <a:gd name="connsiteX6" fmla="*/ 2380 w 9146904"/>
              <a:gd name="connsiteY6" fmla="*/ 874497 h 876879"/>
              <a:gd name="connsiteX0" fmla="*/ 2380 w 9146904"/>
              <a:gd name="connsiteY0" fmla="*/ 874497 h 876879"/>
              <a:gd name="connsiteX1" fmla="*/ 6369500 w 9146904"/>
              <a:gd name="connsiteY1" fmla="*/ 876879 h 876879"/>
              <a:gd name="connsiteX2" fmla="*/ 9146904 w 9146904"/>
              <a:gd name="connsiteY2" fmla="*/ 576125 h 876879"/>
              <a:gd name="connsiteX3" fmla="*/ 9145858 w 9146904"/>
              <a:gd name="connsiteY3" fmla="*/ 0 h 876879"/>
              <a:gd name="connsiteX4" fmla="*/ 5895204 w 9146904"/>
              <a:gd name="connsiteY4" fmla="*/ 845165 h 876879"/>
              <a:gd name="connsiteX5" fmla="*/ 0 w 9146904"/>
              <a:gd name="connsiteY5" fmla="*/ 846665 h 876879"/>
              <a:gd name="connsiteX6" fmla="*/ 2380 w 9146904"/>
              <a:gd name="connsiteY6" fmla="*/ 874497 h 876879"/>
              <a:gd name="connsiteX0" fmla="*/ 2380 w 9146904"/>
              <a:gd name="connsiteY0" fmla="*/ 874497 h 876879"/>
              <a:gd name="connsiteX1" fmla="*/ 6336162 w 9146904"/>
              <a:gd name="connsiteY1" fmla="*/ 876879 h 876879"/>
              <a:gd name="connsiteX2" fmla="*/ 9146904 w 9146904"/>
              <a:gd name="connsiteY2" fmla="*/ 576125 h 876879"/>
              <a:gd name="connsiteX3" fmla="*/ 9145858 w 9146904"/>
              <a:gd name="connsiteY3" fmla="*/ 0 h 876879"/>
              <a:gd name="connsiteX4" fmla="*/ 5895204 w 9146904"/>
              <a:gd name="connsiteY4" fmla="*/ 845165 h 876879"/>
              <a:gd name="connsiteX5" fmla="*/ 0 w 9146904"/>
              <a:gd name="connsiteY5" fmla="*/ 846665 h 876879"/>
              <a:gd name="connsiteX6" fmla="*/ 2380 w 9146904"/>
              <a:gd name="connsiteY6" fmla="*/ 874497 h 876879"/>
              <a:gd name="connsiteX0" fmla="*/ 2380 w 9146904"/>
              <a:gd name="connsiteY0" fmla="*/ 874497 h 876879"/>
              <a:gd name="connsiteX1" fmla="*/ 6336162 w 9146904"/>
              <a:gd name="connsiteY1" fmla="*/ 876879 h 876879"/>
              <a:gd name="connsiteX2" fmla="*/ 9146904 w 9146904"/>
              <a:gd name="connsiteY2" fmla="*/ 576125 h 876879"/>
              <a:gd name="connsiteX3" fmla="*/ 9145858 w 9146904"/>
              <a:gd name="connsiteY3" fmla="*/ 0 h 876879"/>
              <a:gd name="connsiteX4" fmla="*/ 5904729 w 9146904"/>
              <a:gd name="connsiteY4" fmla="*/ 847546 h 876879"/>
              <a:gd name="connsiteX5" fmla="*/ 0 w 9146904"/>
              <a:gd name="connsiteY5" fmla="*/ 846665 h 876879"/>
              <a:gd name="connsiteX6" fmla="*/ 2380 w 9146904"/>
              <a:gd name="connsiteY6" fmla="*/ 874497 h 87687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9146904" h="876879">
                <a:moveTo>
                  <a:pt x="2380" y="874497"/>
                </a:moveTo>
                <a:lnTo>
                  <a:pt x="6336162" y="876879"/>
                </a:lnTo>
                <a:cubicBezTo>
                  <a:pt x="6907951" y="859178"/>
                  <a:pt x="8067909" y="831953"/>
                  <a:pt x="9146904" y="576125"/>
                </a:cubicBezTo>
                <a:cubicBezTo>
                  <a:pt x="9146555" y="384083"/>
                  <a:pt x="9146207" y="192042"/>
                  <a:pt x="9145858" y="0"/>
                </a:cubicBezTo>
                <a:cubicBezTo>
                  <a:pt x="8453626" y="481747"/>
                  <a:pt x="7580418" y="801568"/>
                  <a:pt x="5904729" y="847546"/>
                </a:cubicBezTo>
                <a:lnTo>
                  <a:pt x="0" y="846665"/>
                </a:lnTo>
                <a:lnTo>
                  <a:pt x="2380" y="874497"/>
                </a:lnTo>
                <a:close/>
              </a:path>
            </a:pathLst>
          </a:cu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254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8" name="図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6232" y="6058883"/>
            <a:ext cx="2869200" cy="5467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08120348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and Content: 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35380" y="76966"/>
            <a:ext cx="856731" cy="594588"/>
          </a:xfrm>
          <a:prstGeom prst="rect">
            <a:avLst/>
          </a:prstGeom>
        </p:spPr>
      </p:pic>
      <p:sp>
        <p:nvSpPr>
          <p:cNvPr id="7" name="フリーフォーム 6"/>
          <p:cNvSpPr/>
          <p:nvPr/>
        </p:nvSpPr>
        <p:spPr>
          <a:xfrm>
            <a:off x="-1231" y="451262"/>
            <a:ext cx="9145230" cy="334860"/>
          </a:xfrm>
          <a:custGeom>
            <a:avLst/>
            <a:gdLst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5938 w 9149938"/>
              <a:gd name="connsiteY7" fmla="*/ 231569 h 344385"/>
              <a:gd name="connsiteX8" fmla="*/ 0 w 9149938"/>
              <a:gd name="connsiteY8" fmla="*/ 344385 h 344385"/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10700 w 9149938"/>
              <a:gd name="connsiteY7" fmla="*/ 300625 h 344385"/>
              <a:gd name="connsiteX8" fmla="*/ 0 w 9149938"/>
              <a:gd name="connsiteY8" fmla="*/ 344385 h 344385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25019 w 9139238"/>
              <a:gd name="connsiteY0" fmla="*/ 399154 h 399154"/>
              <a:gd name="connsiteX1" fmla="*/ 8230776 w 9139238"/>
              <a:gd name="connsiteY1" fmla="*/ 338447 h 399154"/>
              <a:gd name="connsiteX2" fmla="*/ 8771103 w 9139238"/>
              <a:gd name="connsiteY2" fmla="*/ 296883 h 399154"/>
              <a:gd name="connsiteX3" fmla="*/ 9139238 w 9139238"/>
              <a:gd name="connsiteY3" fmla="*/ 231569 h 399154"/>
              <a:gd name="connsiteX4" fmla="*/ 9139238 w 9139238"/>
              <a:gd name="connsiteY4" fmla="*/ 0 h 399154"/>
              <a:gd name="connsiteX5" fmla="*/ 8747352 w 9139238"/>
              <a:gd name="connsiteY5" fmla="*/ 201881 h 399154"/>
              <a:gd name="connsiteX6" fmla="*/ 8135773 w 9139238"/>
              <a:gd name="connsiteY6" fmla="*/ 302821 h 399154"/>
              <a:gd name="connsiteX7" fmla="*/ 0 w 9139238"/>
              <a:gd name="connsiteY7" fmla="*/ 300625 h 399154"/>
              <a:gd name="connsiteX8" fmla="*/ 25019 w 9139238"/>
              <a:gd name="connsiteY8" fmla="*/ 399154 h 39915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5937 w 9145175"/>
              <a:gd name="connsiteY7" fmla="*/ 300625 h 342004"/>
              <a:gd name="connsiteX8" fmla="*/ 0 w 9145175"/>
              <a:gd name="connsiteY8" fmla="*/ 342004 h 34200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120237 w 9145175"/>
              <a:gd name="connsiteY7" fmla="*/ 255381 h 342004"/>
              <a:gd name="connsiteX8" fmla="*/ 0 w 9145175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142917 w 9146382"/>
              <a:gd name="connsiteY6" fmla="*/ 302821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55 w 9145230"/>
              <a:gd name="connsiteY0" fmla="*/ 342004 h 342004"/>
              <a:gd name="connsiteX1" fmla="*/ 8236768 w 9145230"/>
              <a:gd name="connsiteY1" fmla="*/ 338447 h 342004"/>
              <a:gd name="connsiteX2" fmla="*/ 8777095 w 9145230"/>
              <a:gd name="connsiteY2" fmla="*/ 296883 h 342004"/>
              <a:gd name="connsiteX3" fmla="*/ 9145230 w 9145230"/>
              <a:gd name="connsiteY3" fmla="*/ 231569 h 342004"/>
              <a:gd name="connsiteX4" fmla="*/ 9145230 w 9145230"/>
              <a:gd name="connsiteY4" fmla="*/ 0 h 342004"/>
              <a:gd name="connsiteX5" fmla="*/ 8039370 w 9145230"/>
              <a:gd name="connsiteY5" fmla="*/ 302822 h 342004"/>
              <a:gd name="connsiteX6" fmla="*/ 1230 w 9145230"/>
              <a:gd name="connsiteY6" fmla="*/ 307768 h 342004"/>
              <a:gd name="connsiteX7" fmla="*/ 55 w 9145230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5387 h 342004"/>
              <a:gd name="connsiteX7" fmla="*/ 1207 w 9146382"/>
              <a:gd name="connsiteY7" fmla="*/ 342004 h 342004"/>
              <a:gd name="connsiteX0" fmla="*/ 1207 w 9146382"/>
              <a:gd name="connsiteY0" fmla="*/ 339622 h 339622"/>
              <a:gd name="connsiteX1" fmla="*/ 8237920 w 9146382"/>
              <a:gd name="connsiteY1" fmla="*/ 338447 h 339622"/>
              <a:gd name="connsiteX2" fmla="*/ 8778247 w 9146382"/>
              <a:gd name="connsiteY2" fmla="*/ 296883 h 339622"/>
              <a:gd name="connsiteX3" fmla="*/ 9146382 w 9146382"/>
              <a:gd name="connsiteY3" fmla="*/ 231569 h 339622"/>
              <a:gd name="connsiteX4" fmla="*/ 9146382 w 9146382"/>
              <a:gd name="connsiteY4" fmla="*/ 0 h 339622"/>
              <a:gd name="connsiteX5" fmla="*/ 8040522 w 9146382"/>
              <a:gd name="connsiteY5" fmla="*/ 302822 h 339622"/>
              <a:gd name="connsiteX6" fmla="*/ 0 w 9146382"/>
              <a:gd name="connsiteY6" fmla="*/ 305387 h 339622"/>
              <a:gd name="connsiteX7" fmla="*/ 1207 w 9146382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2822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3685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4860 h 334860"/>
              <a:gd name="connsiteX1" fmla="*/ 8236768 w 9145230"/>
              <a:gd name="connsiteY1" fmla="*/ 333685 h 334860"/>
              <a:gd name="connsiteX2" fmla="*/ 8777095 w 9145230"/>
              <a:gd name="connsiteY2" fmla="*/ 296883 h 334860"/>
              <a:gd name="connsiteX3" fmla="*/ 9145230 w 9145230"/>
              <a:gd name="connsiteY3" fmla="*/ 231569 h 334860"/>
              <a:gd name="connsiteX4" fmla="*/ 9145230 w 9145230"/>
              <a:gd name="connsiteY4" fmla="*/ 0 h 334860"/>
              <a:gd name="connsiteX5" fmla="*/ 8039370 w 9145230"/>
              <a:gd name="connsiteY5" fmla="*/ 305204 h 334860"/>
              <a:gd name="connsiteX6" fmla="*/ 1230 w 9145230"/>
              <a:gd name="connsiteY6" fmla="*/ 305387 h 334860"/>
              <a:gd name="connsiteX7" fmla="*/ 55 w 9145230"/>
              <a:gd name="connsiteY7" fmla="*/ 334860 h 3348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9145230" h="334860">
                <a:moveTo>
                  <a:pt x="55" y="334860"/>
                </a:moveTo>
                <a:lnTo>
                  <a:pt x="8236768" y="333685"/>
                </a:lnTo>
                <a:cubicBezTo>
                  <a:pt x="8424021" y="326974"/>
                  <a:pt x="8625685" y="313902"/>
                  <a:pt x="8777095" y="296883"/>
                </a:cubicBezTo>
                <a:cubicBezTo>
                  <a:pt x="8928505" y="279864"/>
                  <a:pt x="9017756" y="262865"/>
                  <a:pt x="9145230" y="231569"/>
                </a:cubicBezTo>
                <a:lnTo>
                  <a:pt x="9145230" y="0"/>
                </a:lnTo>
                <a:cubicBezTo>
                  <a:pt x="8875194" y="176182"/>
                  <a:pt x="8573165" y="285660"/>
                  <a:pt x="8039370" y="305204"/>
                </a:cubicBezTo>
                <a:lnTo>
                  <a:pt x="1230" y="305387"/>
                </a:lnTo>
                <a:cubicBezTo>
                  <a:pt x="1632" y="318386"/>
                  <a:pt x="-347" y="321861"/>
                  <a:pt x="55" y="334860"/>
                </a:cubicBezTo>
                <a:close/>
              </a:path>
            </a:pathLst>
          </a:cu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254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正方形/長方形 7"/>
          <p:cNvSpPr/>
          <p:nvPr/>
        </p:nvSpPr>
        <p:spPr>
          <a:xfrm>
            <a:off x="0" y="6321600"/>
            <a:ext cx="9144000" cy="25200"/>
          </a:xfrm>
          <a:prstGeom prst="rect">
            <a:avLst/>
          </a:pr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12700" dir="16200000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JP" alt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4415929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Section Header: 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フリーフォーム 11"/>
          <p:cNvSpPr/>
          <p:nvPr/>
        </p:nvSpPr>
        <p:spPr>
          <a:xfrm>
            <a:off x="-1230" y="3324729"/>
            <a:ext cx="9147611" cy="3539124"/>
          </a:xfrm>
          <a:custGeom>
            <a:avLst/>
            <a:gdLst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5938 w 9149938"/>
              <a:gd name="connsiteY7" fmla="*/ 231569 h 344385"/>
              <a:gd name="connsiteX8" fmla="*/ 0 w 9149938"/>
              <a:gd name="connsiteY8" fmla="*/ 344385 h 344385"/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10700 w 9149938"/>
              <a:gd name="connsiteY7" fmla="*/ 300625 h 344385"/>
              <a:gd name="connsiteX8" fmla="*/ 0 w 9149938"/>
              <a:gd name="connsiteY8" fmla="*/ 344385 h 344385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25019 w 9139238"/>
              <a:gd name="connsiteY0" fmla="*/ 399154 h 399154"/>
              <a:gd name="connsiteX1" fmla="*/ 8230776 w 9139238"/>
              <a:gd name="connsiteY1" fmla="*/ 338447 h 399154"/>
              <a:gd name="connsiteX2" fmla="*/ 8771103 w 9139238"/>
              <a:gd name="connsiteY2" fmla="*/ 296883 h 399154"/>
              <a:gd name="connsiteX3" fmla="*/ 9139238 w 9139238"/>
              <a:gd name="connsiteY3" fmla="*/ 231569 h 399154"/>
              <a:gd name="connsiteX4" fmla="*/ 9139238 w 9139238"/>
              <a:gd name="connsiteY4" fmla="*/ 0 h 399154"/>
              <a:gd name="connsiteX5" fmla="*/ 8747352 w 9139238"/>
              <a:gd name="connsiteY5" fmla="*/ 201881 h 399154"/>
              <a:gd name="connsiteX6" fmla="*/ 8135773 w 9139238"/>
              <a:gd name="connsiteY6" fmla="*/ 302821 h 399154"/>
              <a:gd name="connsiteX7" fmla="*/ 0 w 9139238"/>
              <a:gd name="connsiteY7" fmla="*/ 300625 h 399154"/>
              <a:gd name="connsiteX8" fmla="*/ 25019 w 9139238"/>
              <a:gd name="connsiteY8" fmla="*/ 399154 h 39915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5937 w 9145175"/>
              <a:gd name="connsiteY7" fmla="*/ 300625 h 342004"/>
              <a:gd name="connsiteX8" fmla="*/ 0 w 9145175"/>
              <a:gd name="connsiteY8" fmla="*/ 342004 h 34200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120237 w 9145175"/>
              <a:gd name="connsiteY7" fmla="*/ 255381 h 342004"/>
              <a:gd name="connsiteX8" fmla="*/ 0 w 9145175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142917 w 9146382"/>
              <a:gd name="connsiteY6" fmla="*/ 302821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55 w 9145230"/>
              <a:gd name="connsiteY0" fmla="*/ 342004 h 342004"/>
              <a:gd name="connsiteX1" fmla="*/ 8236768 w 9145230"/>
              <a:gd name="connsiteY1" fmla="*/ 338447 h 342004"/>
              <a:gd name="connsiteX2" fmla="*/ 8777095 w 9145230"/>
              <a:gd name="connsiteY2" fmla="*/ 296883 h 342004"/>
              <a:gd name="connsiteX3" fmla="*/ 9145230 w 9145230"/>
              <a:gd name="connsiteY3" fmla="*/ 231569 h 342004"/>
              <a:gd name="connsiteX4" fmla="*/ 9145230 w 9145230"/>
              <a:gd name="connsiteY4" fmla="*/ 0 h 342004"/>
              <a:gd name="connsiteX5" fmla="*/ 8039370 w 9145230"/>
              <a:gd name="connsiteY5" fmla="*/ 302822 h 342004"/>
              <a:gd name="connsiteX6" fmla="*/ 1230 w 9145230"/>
              <a:gd name="connsiteY6" fmla="*/ 307768 h 342004"/>
              <a:gd name="connsiteX7" fmla="*/ 55 w 9145230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5387 h 342004"/>
              <a:gd name="connsiteX7" fmla="*/ 1207 w 9146382"/>
              <a:gd name="connsiteY7" fmla="*/ 342004 h 342004"/>
              <a:gd name="connsiteX0" fmla="*/ 1207 w 9146382"/>
              <a:gd name="connsiteY0" fmla="*/ 339622 h 339622"/>
              <a:gd name="connsiteX1" fmla="*/ 8237920 w 9146382"/>
              <a:gd name="connsiteY1" fmla="*/ 338447 h 339622"/>
              <a:gd name="connsiteX2" fmla="*/ 8778247 w 9146382"/>
              <a:gd name="connsiteY2" fmla="*/ 296883 h 339622"/>
              <a:gd name="connsiteX3" fmla="*/ 9146382 w 9146382"/>
              <a:gd name="connsiteY3" fmla="*/ 231569 h 339622"/>
              <a:gd name="connsiteX4" fmla="*/ 9146382 w 9146382"/>
              <a:gd name="connsiteY4" fmla="*/ 0 h 339622"/>
              <a:gd name="connsiteX5" fmla="*/ 8040522 w 9146382"/>
              <a:gd name="connsiteY5" fmla="*/ 302822 h 339622"/>
              <a:gd name="connsiteX6" fmla="*/ 0 w 9146382"/>
              <a:gd name="connsiteY6" fmla="*/ 305387 h 339622"/>
              <a:gd name="connsiteX7" fmla="*/ 1207 w 9146382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2822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3685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4860 h 334860"/>
              <a:gd name="connsiteX1" fmla="*/ 8236768 w 9145230"/>
              <a:gd name="connsiteY1" fmla="*/ 333685 h 334860"/>
              <a:gd name="connsiteX2" fmla="*/ 8777095 w 9145230"/>
              <a:gd name="connsiteY2" fmla="*/ 296883 h 334860"/>
              <a:gd name="connsiteX3" fmla="*/ 9145230 w 9145230"/>
              <a:gd name="connsiteY3" fmla="*/ 231569 h 334860"/>
              <a:gd name="connsiteX4" fmla="*/ 9145230 w 9145230"/>
              <a:gd name="connsiteY4" fmla="*/ 0 h 334860"/>
              <a:gd name="connsiteX5" fmla="*/ 8039370 w 9145230"/>
              <a:gd name="connsiteY5" fmla="*/ 305204 h 334860"/>
              <a:gd name="connsiteX6" fmla="*/ 1230 w 9145230"/>
              <a:gd name="connsiteY6" fmla="*/ 305387 h 334860"/>
              <a:gd name="connsiteX7" fmla="*/ 55 w 9145230"/>
              <a:gd name="connsiteY7" fmla="*/ 334860 h 334860"/>
              <a:gd name="connsiteX0" fmla="*/ 27 w 9145202"/>
              <a:gd name="connsiteY0" fmla="*/ 334860 h 334860"/>
              <a:gd name="connsiteX1" fmla="*/ 8236740 w 9145202"/>
              <a:gd name="connsiteY1" fmla="*/ 333685 h 334860"/>
              <a:gd name="connsiteX2" fmla="*/ 8777067 w 9145202"/>
              <a:gd name="connsiteY2" fmla="*/ 296883 h 334860"/>
              <a:gd name="connsiteX3" fmla="*/ 9145202 w 9145202"/>
              <a:gd name="connsiteY3" fmla="*/ 231569 h 334860"/>
              <a:gd name="connsiteX4" fmla="*/ 9145202 w 9145202"/>
              <a:gd name="connsiteY4" fmla="*/ 0 h 334860"/>
              <a:gd name="connsiteX5" fmla="*/ 8039342 w 9145202"/>
              <a:gd name="connsiteY5" fmla="*/ 305204 h 334860"/>
              <a:gd name="connsiteX6" fmla="*/ 3584 w 9145202"/>
              <a:gd name="connsiteY6" fmla="*/ 300624 h 334860"/>
              <a:gd name="connsiteX7" fmla="*/ 27 w 9145202"/>
              <a:gd name="connsiteY7" fmla="*/ 334860 h 334860"/>
              <a:gd name="connsiteX0" fmla="*/ 27 w 9145202"/>
              <a:gd name="connsiteY0" fmla="*/ 334860 h 334860"/>
              <a:gd name="connsiteX1" fmla="*/ 8236740 w 9145202"/>
              <a:gd name="connsiteY1" fmla="*/ 333685 h 334860"/>
              <a:gd name="connsiteX2" fmla="*/ 8777067 w 9145202"/>
              <a:gd name="connsiteY2" fmla="*/ 296883 h 334860"/>
              <a:gd name="connsiteX3" fmla="*/ 9145202 w 9145202"/>
              <a:gd name="connsiteY3" fmla="*/ 231569 h 334860"/>
              <a:gd name="connsiteX4" fmla="*/ 9145202 w 9145202"/>
              <a:gd name="connsiteY4" fmla="*/ 0 h 334860"/>
              <a:gd name="connsiteX5" fmla="*/ 8039342 w 9145202"/>
              <a:gd name="connsiteY5" fmla="*/ 305204 h 334860"/>
              <a:gd name="connsiteX6" fmla="*/ 3584 w 9145202"/>
              <a:gd name="connsiteY6" fmla="*/ 305387 h 334860"/>
              <a:gd name="connsiteX7" fmla="*/ 27 w 9145202"/>
              <a:gd name="connsiteY7" fmla="*/ 334860 h 334860"/>
              <a:gd name="connsiteX0" fmla="*/ 4 w 9145179"/>
              <a:gd name="connsiteY0" fmla="*/ 334860 h 334860"/>
              <a:gd name="connsiteX1" fmla="*/ 8236717 w 9145179"/>
              <a:gd name="connsiteY1" fmla="*/ 333685 h 334860"/>
              <a:gd name="connsiteX2" fmla="*/ 8777044 w 9145179"/>
              <a:gd name="connsiteY2" fmla="*/ 296883 h 334860"/>
              <a:gd name="connsiteX3" fmla="*/ 9145179 w 9145179"/>
              <a:gd name="connsiteY3" fmla="*/ 231569 h 334860"/>
              <a:gd name="connsiteX4" fmla="*/ 9145179 w 9145179"/>
              <a:gd name="connsiteY4" fmla="*/ 0 h 334860"/>
              <a:gd name="connsiteX5" fmla="*/ 8039319 w 9145179"/>
              <a:gd name="connsiteY5" fmla="*/ 305204 h 334860"/>
              <a:gd name="connsiteX6" fmla="*/ 32137 w 9145179"/>
              <a:gd name="connsiteY6" fmla="*/ 288718 h 334860"/>
              <a:gd name="connsiteX7" fmla="*/ 4 w 9145179"/>
              <a:gd name="connsiteY7" fmla="*/ 334860 h 334860"/>
              <a:gd name="connsiteX0" fmla="*/ 54 w 9145229"/>
              <a:gd name="connsiteY0" fmla="*/ 334860 h 334860"/>
              <a:gd name="connsiteX1" fmla="*/ 8236767 w 9145229"/>
              <a:gd name="connsiteY1" fmla="*/ 333685 h 334860"/>
              <a:gd name="connsiteX2" fmla="*/ 8777094 w 9145229"/>
              <a:gd name="connsiteY2" fmla="*/ 296883 h 334860"/>
              <a:gd name="connsiteX3" fmla="*/ 9145229 w 9145229"/>
              <a:gd name="connsiteY3" fmla="*/ 231569 h 334860"/>
              <a:gd name="connsiteX4" fmla="*/ 9145229 w 9145229"/>
              <a:gd name="connsiteY4" fmla="*/ 0 h 334860"/>
              <a:gd name="connsiteX5" fmla="*/ 8039369 w 9145229"/>
              <a:gd name="connsiteY5" fmla="*/ 305204 h 334860"/>
              <a:gd name="connsiteX6" fmla="*/ 1231 w 9145229"/>
              <a:gd name="connsiteY6" fmla="*/ 303006 h 334860"/>
              <a:gd name="connsiteX7" fmla="*/ 54 w 9145229"/>
              <a:gd name="connsiteY7" fmla="*/ 334860 h 334860"/>
              <a:gd name="connsiteX0" fmla="*/ 54 w 9145229"/>
              <a:gd name="connsiteY0" fmla="*/ 334860 h 334860"/>
              <a:gd name="connsiteX1" fmla="*/ 8236767 w 9145229"/>
              <a:gd name="connsiteY1" fmla="*/ 333685 h 334860"/>
              <a:gd name="connsiteX2" fmla="*/ 8777094 w 9145229"/>
              <a:gd name="connsiteY2" fmla="*/ 296883 h 334860"/>
              <a:gd name="connsiteX3" fmla="*/ 9145229 w 9145229"/>
              <a:gd name="connsiteY3" fmla="*/ 231569 h 334860"/>
              <a:gd name="connsiteX4" fmla="*/ 9145229 w 9145229"/>
              <a:gd name="connsiteY4" fmla="*/ 0 h 334860"/>
              <a:gd name="connsiteX5" fmla="*/ 6055787 w 9145229"/>
              <a:gd name="connsiteY5" fmla="*/ 305204 h 334860"/>
              <a:gd name="connsiteX6" fmla="*/ 1231 w 9145229"/>
              <a:gd name="connsiteY6" fmla="*/ 303006 h 334860"/>
              <a:gd name="connsiteX7" fmla="*/ 54 w 9145229"/>
              <a:gd name="connsiteY7" fmla="*/ 334860 h 334860"/>
              <a:gd name="connsiteX0" fmla="*/ 54 w 9145229"/>
              <a:gd name="connsiteY0" fmla="*/ 334860 h 336066"/>
              <a:gd name="connsiteX1" fmla="*/ 6198417 w 9145229"/>
              <a:gd name="connsiteY1" fmla="*/ 336066 h 336066"/>
              <a:gd name="connsiteX2" fmla="*/ 8777094 w 9145229"/>
              <a:gd name="connsiteY2" fmla="*/ 296883 h 336066"/>
              <a:gd name="connsiteX3" fmla="*/ 9145229 w 9145229"/>
              <a:gd name="connsiteY3" fmla="*/ 231569 h 336066"/>
              <a:gd name="connsiteX4" fmla="*/ 9145229 w 9145229"/>
              <a:gd name="connsiteY4" fmla="*/ 0 h 336066"/>
              <a:gd name="connsiteX5" fmla="*/ 6055787 w 9145229"/>
              <a:gd name="connsiteY5" fmla="*/ 305204 h 336066"/>
              <a:gd name="connsiteX6" fmla="*/ 1231 w 9145229"/>
              <a:gd name="connsiteY6" fmla="*/ 303006 h 336066"/>
              <a:gd name="connsiteX7" fmla="*/ 54 w 9145229"/>
              <a:gd name="connsiteY7" fmla="*/ 334860 h 336066"/>
              <a:gd name="connsiteX0" fmla="*/ 54 w 9145229"/>
              <a:gd name="connsiteY0" fmla="*/ 873022 h 874228"/>
              <a:gd name="connsiteX1" fmla="*/ 6198417 w 9145229"/>
              <a:gd name="connsiteY1" fmla="*/ 874228 h 874228"/>
              <a:gd name="connsiteX2" fmla="*/ 8777094 w 9145229"/>
              <a:gd name="connsiteY2" fmla="*/ 835045 h 874228"/>
              <a:gd name="connsiteX3" fmla="*/ 9145229 w 9145229"/>
              <a:gd name="connsiteY3" fmla="*/ 769731 h 874228"/>
              <a:gd name="connsiteX4" fmla="*/ 9142848 w 9145229"/>
              <a:gd name="connsiteY4" fmla="*/ 0 h 874228"/>
              <a:gd name="connsiteX5" fmla="*/ 6055787 w 9145229"/>
              <a:gd name="connsiteY5" fmla="*/ 843366 h 874228"/>
              <a:gd name="connsiteX6" fmla="*/ 1231 w 9145229"/>
              <a:gd name="connsiteY6" fmla="*/ 841168 h 874228"/>
              <a:gd name="connsiteX7" fmla="*/ 54 w 9145229"/>
              <a:gd name="connsiteY7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8777094 w 9147610"/>
              <a:gd name="connsiteY2" fmla="*/ 835045 h 874228"/>
              <a:gd name="connsiteX3" fmla="*/ 9147610 w 9147610"/>
              <a:gd name="connsiteY3" fmla="*/ 576849 h 874228"/>
              <a:gd name="connsiteX4" fmla="*/ 9142848 w 9147610"/>
              <a:gd name="connsiteY4" fmla="*/ 0 h 874228"/>
              <a:gd name="connsiteX5" fmla="*/ 6055787 w 9147610"/>
              <a:gd name="connsiteY5" fmla="*/ 843366 h 874228"/>
              <a:gd name="connsiteX6" fmla="*/ 1231 w 9147610"/>
              <a:gd name="connsiteY6" fmla="*/ 841168 h 874228"/>
              <a:gd name="connsiteX7" fmla="*/ 54 w 9147610"/>
              <a:gd name="connsiteY7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7907938 w 9147610"/>
              <a:gd name="connsiteY2" fmla="*/ 804089 h 874228"/>
              <a:gd name="connsiteX3" fmla="*/ 9147610 w 9147610"/>
              <a:gd name="connsiteY3" fmla="*/ 576849 h 874228"/>
              <a:gd name="connsiteX4" fmla="*/ 9142848 w 9147610"/>
              <a:gd name="connsiteY4" fmla="*/ 0 h 874228"/>
              <a:gd name="connsiteX5" fmla="*/ 6055787 w 9147610"/>
              <a:gd name="connsiteY5" fmla="*/ 843366 h 874228"/>
              <a:gd name="connsiteX6" fmla="*/ 1231 w 9147610"/>
              <a:gd name="connsiteY6" fmla="*/ 841168 h 874228"/>
              <a:gd name="connsiteX7" fmla="*/ 54 w 9147610"/>
              <a:gd name="connsiteY7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9147610 w 9147610"/>
              <a:gd name="connsiteY2" fmla="*/ 576849 h 874228"/>
              <a:gd name="connsiteX3" fmla="*/ 9142848 w 9147610"/>
              <a:gd name="connsiteY3" fmla="*/ 0 h 874228"/>
              <a:gd name="connsiteX4" fmla="*/ 6055787 w 9147610"/>
              <a:gd name="connsiteY4" fmla="*/ 843366 h 874228"/>
              <a:gd name="connsiteX5" fmla="*/ 1231 w 9147610"/>
              <a:gd name="connsiteY5" fmla="*/ 841168 h 874228"/>
              <a:gd name="connsiteX6" fmla="*/ 54 w 9147610"/>
              <a:gd name="connsiteY6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9147610 w 9147610"/>
              <a:gd name="connsiteY2" fmla="*/ 576849 h 874228"/>
              <a:gd name="connsiteX3" fmla="*/ 9142848 w 9147610"/>
              <a:gd name="connsiteY3" fmla="*/ 0 h 874228"/>
              <a:gd name="connsiteX4" fmla="*/ 6055787 w 9147610"/>
              <a:gd name="connsiteY4" fmla="*/ 843366 h 874228"/>
              <a:gd name="connsiteX5" fmla="*/ 1231 w 9147610"/>
              <a:gd name="connsiteY5" fmla="*/ 841168 h 874228"/>
              <a:gd name="connsiteX6" fmla="*/ 54 w 9147610"/>
              <a:gd name="connsiteY6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9147610 w 9147610"/>
              <a:gd name="connsiteY2" fmla="*/ 576849 h 874228"/>
              <a:gd name="connsiteX3" fmla="*/ 9142848 w 9147610"/>
              <a:gd name="connsiteY3" fmla="*/ 0 h 874228"/>
              <a:gd name="connsiteX4" fmla="*/ 6055787 w 9147610"/>
              <a:gd name="connsiteY4" fmla="*/ 843366 h 874228"/>
              <a:gd name="connsiteX5" fmla="*/ 1231 w 9147610"/>
              <a:gd name="connsiteY5" fmla="*/ 841168 h 874228"/>
              <a:gd name="connsiteX6" fmla="*/ 54 w 9147610"/>
              <a:gd name="connsiteY6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9147610 w 9147610"/>
              <a:gd name="connsiteY2" fmla="*/ 576849 h 874228"/>
              <a:gd name="connsiteX3" fmla="*/ 9142848 w 9147610"/>
              <a:gd name="connsiteY3" fmla="*/ 0 h 874228"/>
              <a:gd name="connsiteX4" fmla="*/ 6055787 w 9147610"/>
              <a:gd name="connsiteY4" fmla="*/ 843366 h 874228"/>
              <a:gd name="connsiteX5" fmla="*/ 1231 w 9147610"/>
              <a:gd name="connsiteY5" fmla="*/ 841168 h 874228"/>
              <a:gd name="connsiteX6" fmla="*/ 54 w 9147610"/>
              <a:gd name="connsiteY6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9147610 w 9147610"/>
              <a:gd name="connsiteY2" fmla="*/ 576849 h 874228"/>
              <a:gd name="connsiteX3" fmla="*/ 9142848 w 9147610"/>
              <a:gd name="connsiteY3" fmla="*/ 0 h 874228"/>
              <a:gd name="connsiteX4" fmla="*/ 6055787 w 9147610"/>
              <a:gd name="connsiteY4" fmla="*/ 843366 h 874228"/>
              <a:gd name="connsiteX5" fmla="*/ 1231 w 9147610"/>
              <a:gd name="connsiteY5" fmla="*/ 841168 h 874228"/>
              <a:gd name="connsiteX6" fmla="*/ 54 w 9147610"/>
              <a:gd name="connsiteY6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9147610 w 9147610"/>
              <a:gd name="connsiteY2" fmla="*/ 576849 h 874228"/>
              <a:gd name="connsiteX3" fmla="*/ 9142848 w 9147610"/>
              <a:gd name="connsiteY3" fmla="*/ 0 h 874228"/>
              <a:gd name="connsiteX4" fmla="*/ 6055787 w 9147610"/>
              <a:gd name="connsiteY4" fmla="*/ 843366 h 874228"/>
              <a:gd name="connsiteX5" fmla="*/ 1231 w 9147610"/>
              <a:gd name="connsiteY5" fmla="*/ 841168 h 874228"/>
              <a:gd name="connsiteX6" fmla="*/ 54 w 9147610"/>
              <a:gd name="connsiteY6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9147610 w 9147610"/>
              <a:gd name="connsiteY2" fmla="*/ 576849 h 874228"/>
              <a:gd name="connsiteX3" fmla="*/ 9142848 w 9147610"/>
              <a:gd name="connsiteY3" fmla="*/ 0 h 874228"/>
              <a:gd name="connsiteX4" fmla="*/ 6055787 w 9147610"/>
              <a:gd name="connsiteY4" fmla="*/ 843366 h 874228"/>
              <a:gd name="connsiteX5" fmla="*/ 1231 w 9147610"/>
              <a:gd name="connsiteY5" fmla="*/ 841168 h 874228"/>
              <a:gd name="connsiteX6" fmla="*/ 54 w 9147610"/>
              <a:gd name="connsiteY6" fmla="*/ 873022 h 874228"/>
              <a:gd name="connsiteX0" fmla="*/ 54 w 9147610"/>
              <a:gd name="connsiteY0" fmla="*/ 868259 h 869465"/>
              <a:gd name="connsiteX1" fmla="*/ 6198417 w 9147610"/>
              <a:gd name="connsiteY1" fmla="*/ 869465 h 869465"/>
              <a:gd name="connsiteX2" fmla="*/ 9147610 w 9147610"/>
              <a:gd name="connsiteY2" fmla="*/ 572086 h 869465"/>
              <a:gd name="connsiteX3" fmla="*/ 9145229 w 9147610"/>
              <a:gd name="connsiteY3" fmla="*/ 0 h 869465"/>
              <a:gd name="connsiteX4" fmla="*/ 6055787 w 9147610"/>
              <a:gd name="connsiteY4" fmla="*/ 838603 h 869465"/>
              <a:gd name="connsiteX5" fmla="*/ 1231 w 9147610"/>
              <a:gd name="connsiteY5" fmla="*/ 836405 h 869465"/>
              <a:gd name="connsiteX6" fmla="*/ 54 w 9147610"/>
              <a:gd name="connsiteY6" fmla="*/ 868259 h 869465"/>
              <a:gd name="connsiteX0" fmla="*/ 54 w 9147610"/>
              <a:gd name="connsiteY0" fmla="*/ 868259 h 869465"/>
              <a:gd name="connsiteX1" fmla="*/ 6198417 w 9147610"/>
              <a:gd name="connsiteY1" fmla="*/ 869465 h 869465"/>
              <a:gd name="connsiteX2" fmla="*/ 9147610 w 9147610"/>
              <a:gd name="connsiteY2" fmla="*/ 572086 h 869465"/>
              <a:gd name="connsiteX3" fmla="*/ 9145229 w 9147610"/>
              <a:gd name="connsiteY3" fmla="*/ 0 h 869465"/>
              <a:gd name="connsiteX4" fmla="*/ 6055787 w 9147610"/>
              <a:gd name="connsiteY4" fmla="*/ 838603 h 869465"/>
              <a:gd name="connsiteX5" fmla="*/ 1231 w 9147610"/>
              <a:gd name="connsiteY5" fmla="*/ 836405 h 869465"/>
              <a:gd name="connsiteX6" fmla="*/ 54 w 9147610"/>
              <a:gd name="connsiteY6" fmla="*/ 868259 h 869465"/>
              <a:gd name="connsiteX0" fmla="*/ 54 w 9147610"/>
              <a:gd name="connsiteY0" fmla="*/ 1508816 h 1508816"/>
              <a:gd name="connsiteX1" fmla="*/ 6198417 w 9147610"/>
              <a:gd name="connsiteY1" fmla="*/ 869465 h 1508816"/>
              <a:gd name="connsiteX2" fmla="*/ 9147610 w 9147610"/>
              <a:gd name="connsiteY2" fmla="*/ 572086 h 1508816"/>
              <a:gd name="connsiteX3" fmla="*/ 9145229 w 9147610"/>
              <a:gd name="connsiteY3" fmla="*/ 0 h 1508816"/>
              <a:gd name="connsiteX4" fmla="*/ 6055787 w 9147610"/>
              <a:gd name="connsiteY4" fmla="*/ 838603 h 1508816"/>
              <a:gd name="connsiteX5" fmla="*/ 1231 w 9147610"/>
              <a:gd name="connsiteY5" fmla="*/ 836405 h 1508816"/>
              <a:gd name="connsiteX6" fmla="*/ 54 w 9147610"/>
              <a:gd name="connsiteY6" fmla="*/ 1508816 h 1508816"/>
              <a:gd name="connsiteX0" fmla="*/ 54 w 9147610"/>
              <a:gd name="connsiteY0" fmla="*/ 3535259 h 3535259"/>
              <a:gd name="connsiteX1" fmla="*/ 6198417 w 9147610"/>
              <a:gd name="connsiteY1" fmla="*/ 869465 h 3535259"/>
              <a:gd name="connsiteX2" fmla="*/ 9147610 w 9147610"/>
              <a:gd name="connsiteY2" fmla="*/ 572086 h 3535259"/>
              <a:gd name="connsiteX3" fmla="*/ 9145229 w 9147610"/>
              <a:gd name="connsiteY3" fmla="*/ 0 h 3535259"/>
              <a:gd name="connsiteX4" fmla="*/ 6055787 w 9147610"/>
              <a:gd name="connsiteY4" fmla="*/ 838603 h 3535259"/>
              <a:gd name="connsiteX5" fmla="*/ 1231 w 9147610"/>
              <a:gd name="connsiteY5" fmla="*/ 836405 h 3535259"/>
              <a:gd name="connsiteX6" fmla="*/ 54 w 9147610"/>
              <a:gd name="connsiteY6" fmla="*/ 3535259 h 3535259"/>
              <a:gd name="connsiteX0" fmla="*/ 54 w 9147610"/>
              <a:gd name="connsiteY0" fmla="*/ 3535259 h 3535259"/>
              <a:gd name="connsiteX1" fmla="*/ 9147610 w 9147610"/>
              <a:gd name="connsiteY1" fmla="*/ 572086 h 3535259"/>
              <a:gd name="connsiteX2" fmla="*/ 9145229 w 9147610"/>
              <a:gd name="connsiteY2" fmla="*/ 0 h 3535259"/>
              <a:gd name="connsiteX3" fmla="*/ 6055787 w 9147610"/>
              <a:gd name="connsiteY3" fmla="*/ 838603 h 3535259"/>
              <a:gd name="connsiteX4" fmla="*/ 1231 w 9147610"/>
              <a:gd name="connsiteY4" fmla="*/ 836405 h 3535259"/>
              <a:gd name="connsiteX5" fmla="*/ 54 w 9147610"/>
              <a:gd name="connsiteY5" fmla="*/ 3535259 h 3535259"/>
              <a:gd name="connsiteX0" fmla="*/ 54 w 9147610"/>
              <a:gd name="connsiteY0" fmla="*/ 3535259 h 3535259"/>
              <a:gd name="connsiteX1" fmla="*/ 9147610 w 9147610"/>
              <a:gd name="connsiteY1" fmla="*/ 1415049 h 3535259"/>
              <a:gd name="connsiteX2" fmla="*/ 9145229 w 9147610"/>
              <a:gd name="connsiteY2" fmla="*/ 0 h 3535259"/>
              <a:gd name="connsiteX3" fmla="*/ 6055787 w 9147610"/>
              <a:gd name="connsiteY3" fmla="*/ 838603 h 3535259"/>
              <a:gd name="connsiteX4" fmla="*/ 1231 w 9147610"/>
              <a:gd name="connsiteY4" fmla="*/ 836405 h 3535259"/>
              <a:gd name="connsiteX5" fmla="*/ 54 w 9147610"/>
              <a:gd name="connsiteY5" fmla="*/ 3535259 h 3535259"/>
              <a:gd name="connsiteX0" fmla="*/ 54 w 9145280"/>
              <a:gd name="connsiteY0" fmla="*/ 3535259 h 3535259"/>
              <a:gd name="connsiteX1" fmla="*/ 9138085 w 9145280"/>
              <a:gd name="connsiteY1" fmla="*/ 1588880 h 3535259"/>
              <a:gd name="connsiteX2" fmla="*/ 9145229 w 9145280"/>
              <a:gd name="connsiteY2" fmla="*/ 0 h 3535259"/>
              <a:gd name="connsiteX3" fmla="*/ 6055787 w 9145280"/>
              <a:gd name="connsiteY3" fmla="*/ 838603 h 3535259"/>
              <a:gd name="connsiteX4" fmla="*/ 1231 w 9145280"/>
              <a:gd name="connsiteY4" fmla="*/ 836405 h 3535259"/>
              <a:gd name="connsiteX5" fmla="*/ 54 w 9145280"/>
              <a:gd name="connsiteY5" fmla="*/ 3535259 h 3535259"/>
              <a:gd name="connsiteX0" fmla="*/ 54 w 9145458"/>
              <a:gd name="connsiteY0" fmla="*/ 3535259 h 3535259"/>
              <a:gd name="connsiteX1" fmla="*/ 9145229 w 9145458"/>
              <a:gd name="connsiteY1" fmla="*/ 3531980 h 3535259"/>
              <a:gd name="connsiteX2" fmla="*/ 9145229 w 9145458"/>
              <a:gd name="connsiteY2" fmla="*/ 0 h 3535259"/>
              <a:gd name="connsiteX3" fmla="*/ 6055787 w 9145458"/>
              <a:gd name="connsiteY3" fmla="*/ 838603 h 3535259"/>
              <a:gd name="connsiteX4" fmla="*/ 1231 w 9145458"/>
              <a:gd name="connsiteY4" fmla="*/ 836405 h 3535259"/>
              <a:gd name="connsiteX5" fmla="*/ 54 w 9145458"/>
              <a:gd name="connsiteY5" fmla="*/ 3535259 h 3535259"/>
              <a:gd name="connsiteX0" fmla="*/ 54 w 9147610"/>
              <a:gd name="connsiteY0" fmla="*/ 3535259 h 3535259"/>
              <a:gd name="connsiteX1" fmla="*/ 9147610 w 9147610"/>
              <a:gd name="connsiteY1" fmla="*/ 3529598 h 3535259"/>
              <a:gd name="connsiteX2" fmla="*/ 9145229 w 9147610"/>
              <a:gd name="connsiteY2" fmla="*/ 0 h 3535259"/>
              <a:gd name="connsiteX3" fmla="*/ 6055787 w 9147610"/>
              <a:gd name="connsiteY3" fmla="*/ 838603 h 3535259"/>
              <a:gd name="connsiteX4" fmla="*/ 1231 w 9147610"/>
              <a:gd name="connsiteY4" fmla="*/ 836405 h 3535259"/>
              <a:gd name="connsiteX5" fmla="*/ 54 w 9147610"/>
              <a:gd name="connsiteY5" fmla="*/ 3535259 h 3535259"/>
              <a:gd name="connsiteX0" fmla="*/ 54 w 9154754"/>
              <a:gd name="connsiteY0" fmla="*/ 3535259 h 3553411"/>
              <a:gd name="connsiteX1" fmla="*/ 9154754 w 9154754"/>
              <a:gd name="connsiteY1" fmla="*/ 3553411 h 3553411"/>
              <a:gd name="connsiteX2" fmla="*/ 9145229 w 9154754"/>
              <a:gd name="connsiteY2" fmla="*/ 0 h 3553411"/>
              <a:gd name="connsiteX3" fmla="*/ 6055787 w 9154754"/>
              <a:gd name="connsiteY3" fmla="*/ 838603 h 3553411"/>
              <a:gd name="connsiteX4" fmla="*/ 1231 w 9154754"/>
              <a:gd name="connsiteY4" fmla="*/ 836405 h 3553411"/>
              <a:gd name="connsiteX5" fmla="*/ 54 w 9154754"/>
              <a:gd name="connsiteY5" fmla="*/ 3535259 h 3553411"/>
              <a:gd name="connsiteX0" fmla="*/ 54 w 9147611"/>
              <a:gd name="connsiteY0" fmla="*/ 3535259 h 3539124"/>
              <a:gd name="connsiteX1" fmla="*/ 9147611 w 9147611"/>
              <a:gd name="connsiteY1" fmla="*/ 3539124 h 3539124"/>
              <a:gd name="connsiteX2" fmla="*/ 9145229 w 9147611"/>
              <a:gd name="connsiteY2" fmla="*/ 0 h 3539124"/>
              <a:gd name="connsiteX3" fmla="*/ 6055787 w 9147611"/>
              <a:gd name="connsiteY3" fmla="*/ 838603 h 3539124"/>
              <a:gd name="connsiteX4" fmla="*/ 1231 w 9147611"/>
              <a:gd name="connsiteY4" fmla="*/ 836405 h 3539124"/>
              <a:gd name="connsiteX5" fmla="*/ 54 w 9147611"/>
              <a:gd name="connsiteY5" fmla="*/ 3535259 h 353912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9147611" h="3539124">
                <a:moveTo>
                  <a:pt x="54" y="3535259"/>
                </a:moveTo>
                <a:lnTo>
                  <a:pt x="9147611" y="3539124"/>
                </a:lnTo>
                <a:cubicBezTo>
                  <a:pt x="9146817" y="3282547"/>
                  <a:pt x="9146023" y="256577"/>
                  <a:pt x="9145229" y="0"/>
                </a:cubicBezTo>
                <a:cubicBezTo>
                  <a:pt x="8508481" y="485745"/>
                  <a:pt x="7318244" y="819060"/>
                  <a:pt x="6055787" y="838603"/>
                </a:cubicBezTo>
                <a:lnTo>
                  <a:pt x="1231" y="836405"/>
                </a:lnTo>
                <a:cubicBezTo>
                  <a:pt x="1633" y="849404"/>
                  <a:pt x="-348" y="3522260"/>
                  <a:pt x="54" y="3535259"/>
                </a:cubicBezTo>
                <a:close/>
              </a:path>
            </a:pathLst>
          </a:custGeom>
          <a:solidFill>
            <a:schemeClr val="bg2"/>
          </a:solidFill>
          <a:ln w="3175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フリーフォーム 6"/>
          <p:cNvSpPr/>
          <p:nvPr/>
        </p:nvSpPr>
        <p:spPr>
          <a:xfrm>
            <a:off x="-1229" y="3302898"/>
            <a:ext cx="9147610" cy="869465"/>
          </a:xfrm>
          <a:custGeom>
            <a:avLst/>
            <a:gdLst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5938 w 9149938"/>
              <a:gd name="connsiteY7" fmla="*/ 231569 h 344385"/>
              <a:gd name="connsiteX8" fmla="*/ 0 w 9149938"/>
              <a:gd name="connsiteY8" fmla="*/ 344385 h 344385"/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10700 w 9149938"/>
              <a:gd name="connsiteY7" fmla="*/ 300625 h 344385"/>
              <a:gd name="connsiteX8" fmla="*/ 0 w 9149938"/>
              <a:gd name="connsiteY8" fmla="*/ 344385 h 344385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25019 w 9139238"/>
              <a:gd name="connsiteY0" fmla="*/ 399154 h 399154"/>
              <a:gd name="connsiteX1" fmla="*/ 8230776 w 9139238"/>
              <a:gd name="connsiteY1" fmla="*/ 338447 h 399154"/>
              <a:gd name="connsiteX2" fmla="*/ 8771103 w 9139238"/>
              <a:gd name="connsiteY2" fmla="*/ 296883 h 399154"/>
              <a:gd name="connsiteX3" fmla="*/ 9139238 w 9139238"/>
              <a:gd name="connsiteY3" fmla="*/ 231569 h 399154"/>
              <a:gd name="connsiteX4" fmla="*/ 9139238 w 9139238"/>
              <a:gd name="connsiteY4" fmla="*/ 0 h 399154"/>
              <a:gd name="connsiteX5" fmla="*/ 8747352 w 9139238"/>
              <a:gd name="connsiteY5" fmla="*/ 201881 h 399154"/>
              <a:gd name="connsiteX6" fmla="*/ 8135773 w 9139238"/>
              <a:gd name="connsiteY6" fmla="*/ 302821 h 399154"/>
              <a:gd name="connsiteX7" fmla="*/ 0 w 9139238"/>
              <a:gd name="connsiteY7" fmla="*/ 300625 h 399154"/>
              <a:gd name="connsiteX8" fmla="*/ 25019 w 9139238"/>
              <a:gd name="connsiteY8" fmla="*/ 399154 h 39915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5937 w 9145175"/>
              <a:gd name="connsiteY7" fmla="*/ 300625 h 342004"/>
              <a:gd name="connsiteX8" fmla="*/ 0 w 9145175"/>
              <a:gd name="connsiteY8" fmla="*/ 342004 h 34200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120237 w 9145175"/>
              <a:gd name="connsiteY7" fmla="*/ 255381 h 342004"/>
              <a:gd name="connsiteX8" fmla="*/ 0 w 9145175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142917 w 9146382"/>
              <a:gd name="connsiteY6" fmla="*/ 302821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55 w 9145230"/>
              <a:gd name="connsiteY0" fmla="*/ 342004 h 342004"/>
              <a:gd name="connsiteX1" fmla="*/ 8236768 w 9145230"/>
              <a:gd name="connsiteY1" fmla="*/ 338447 h 342004"/>
              <a:gd name="connsiteX2" fmla="*/ 8777095 w 9145230"/>
              <a:gd name="connsiteY2" fmla="*/ 296883 h 342004"/>
              <a:gd name="connsiteX3" fmla="*/ 9145230 w 9145230"/>
              <a:gd name="connsiteY3" fmla="*/ 231569 h 342004"/>
              <a:gd name="connsiteX4" fmla="*/ 9145230 w 9145230"/>
              <a:gd name="connsiteY4" fmla="*/ 0 h 342004"/>
              <a:gd name="connsiteX5" fmla="*/ 8039370 w 9145230"/>
              <a:gd name="connsiteY5" fmla="*/ 302822 h 342004"/>
              <a:gd name="connsiteX6" fmla="*/ 1230 w 9145230"/>
              <a:gd name="connsiteY6" fmla="*/ 307768 h 342004"/>
              <a:gd name="connsiteX7" fmla="*/ 55 w 9145230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5387 h 342004"/>
              <a:gd name="connsiteX7" fmla="*/ 1207 w 9146382"/>
              <a:gd name="connsiteY7" fmla="*/ 342004 h 342004"/>
              <a:gd name="connsiteX0" fmla="*/ 1207 w 9146382"/>
              <a:gd name="connsiteY0" fmla="*/ 339622 h 339622"/>
              <a:gd name="connsiteX1" fmla="*/ 8237920 w 9146382"/>
              <a:gd name="connsiteY1" fmla="*/ 338447 h 339622"/>
              <a:gd name="connsiteX2" fmla="*/ 8778247 w 9146382"/>
              <a:gd name="connsiteY2" fmla="*/ 296883 h 339622"/>
              <a:gd name="connsiteX3" fmla="*/ 9146382 w 9146382"/>
              <a:gd name="connsiteY3" fmla="*/ 231569 h 339622"/>
              <a:gd name="connsiteX4" fmla="*/ 9146382 w 9146382"/>
              <a:gd name="connsiteY4" fmla="*/ 0 h 339622"/>
              <a:gd name="connsiteX5" fmla="*/ 8040522 w 9146382"/>
              <a:gd name="connsiteY5" fmla="*/ 302822 h 339622"/>
              <a:gd name="connsiteX6" fmla="*/ 0 w 9146382"/>
              <a:gd name="connsiteY6" fmla="*/ 305387 h 339622"/>
              <a:gd name="connsiteX7" fmla="*/ 1207 w 9146382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2822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3685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4860 h 334860"/>
              <a:gd name="connsiteX1" fmla="*/ 8236768 w 9145230"/>
              <a:gd name="connsiteY1" fmla="*/ 333685 h 334860"/>
              <a:gd name="connsiteX2" fmla="*/ 8777095 w 9145230"/>
              <a:gd name="connsiteY2" fmla="*/ 296883 h 334860"/>
              <a:gd name="connsiteX3" fmla="*/ 9145230 w 9145230"/>
              <a:gd name="connsiteY3" fmla="*/ 231569 h 334860"/>
              <a:gd name="connsiteX4" fmla="*/ 9145230 w 9145230"/>
              <a:gd name="connsiteY4" fmla="*/ 0 h 334860"/>
              <a:gd name="connsiteX5" fmla="*/ 8039370 w 9145230"/>
              <a:gd name="connsiteY5" fmla="*/ 305204 h 334860"/>
              <a:gd name="connsiteX6" fmla="*/ 1230 w 9145230"/>
              <a:gd name="connsiteY6" fmla="*/ 305387 h 334860"/>
              <a:gd name="connsiteX7" fmla="*/ 55 w 9145230"/>
              <a:gd name="connsiteY7" fmla="*/ 334860 h 334860"/>
              <a:gd name="connsiteX0" fmla="*/ 27 w 9145202"/>
              <a:gd name="connsiteY0" fmla="*/ 334860 h 334860"/>
              <a:gd name="connsiteX1" fmla="*/ 8236740 w 9145202"/>
              <a:gd name="connsiteY1" fmla="*/ 333685 h 334860"/>
              <a:gd name="connsiteX2" fmla="*/ 8777067 w 9145202"/>
              <a:gd name="connsiteY2" fmla="*/ 296883 h 334860"/>
              <a:gd name="connsiteX3" fmla="*/ 9145202 w 9145202"/>
              <a:gd name="connsiteY3" fmla="*/ 231569 h 334860"/>
              <a:gd name="connsiteX4" fmla="*/ 9145202 w 9145202"/>
              <a:gd name="connsiteY4" fmla="*/ 0 h 334860"/>
              <a:gd name="connsiteX5" fmla="*/ 8039342 w 9145202"/>
              <a:gd name="connsiteY5" fmla="*/ 305204 h 334860"/>
              <a:gd name="connsiteX6" fmla="*/ 3584 w 9145202"/>
              <a:gd name="connsiteY6" fmla="*/ 300624 h 334860"/>
              <a:gd name="connsiteX7" fmla="*/ 27 w 9145202"/>
              <a:gd name="connsiteY7" fmla="*/ 334860 h 334860"/>
              <a:gd name="connsiteX0" fmla="*/ 27 w 9145202"/>
              <a:gd name="connsiteY0" fmla="*/ 334860 h 334860"/>
              <a:gd name="connsiteX1" fmla="*/ 8236740 w 9145202"/>
              <a:gd name="connsiteY1" fmla="*/ 333685 h 334860"/>
              <a:gd name="connsiteX2" fmla="*/ 8777067 w 9145202"/>
              <a:gd name="connsiteY2" fmla="*/ 296883 h 334860"/>
              <a:gd name="connsiteX3" fmla="*/ 9145202 w 9145202"/>
              <a:gd name="connsiteY3" fmla="*/ 231569 h 334860"/>
              <a:gd name="connsiteX4" fmla="*/ 9145202 w 9145202"/>
              <a:gd name="connsiteY4" fmla="*/ 0 h 334860"/>
              <a:gd name="connsiteX5" fmla="*/ 8039342 w 9145202"/>
              <a:gd name="connsiteY5" fmla="*/ 305204 h 334860"/>
              <a:gd name="connsiteX6" fmla="*/ 3584 w 9145202"/>
              <a:gd name="connsiteY6" fmla="*/ 305387 h 334860"/>
              <a:gd name="connsiteX7" fmla="*/ 27 w 9145202"/>
              <a:gd name="connsiteY7" fmla="*/ 334860 h 334860"/>
              <a:gd name="connsiteX0" fmla="*/ 4 w 9145179"/>
              <a:gd name="connsiteY0" fmla="*/ 334860 h 334860"/>
              <a:gd name="connsiteX1" fmla="*/ 8236717 w 9145179"/>
              <a:gd name="connsiteY1" fmla="*/ 333685 h 334860"/>
              <a:gd name="connsiteX2" fmla="*/ 8777044 w 9145179"/>
              <a:gd name="connsiteY2" fmla="*/ 296883 h 334860"/>
              <a:gd name="connsiteX3" fmla="*/ 9145179 w 9145179"/>
              <a:gd name="connsiteY3" fmla="*/ 231569 h 334860"/>
              <a:gd name="connsiteX4" fmla="*/ 9145179 w 9145179"/>
              <a:gd name="connsiteY4" fmla="*/ 0 h 334860"/>
              <a:gd name="connsiteX5" fmla="*/ 8039319 w 9145179"/>
              <a:gd name="connsiteY5" fmla="*/ 305204 h 334860"/>
              <a:gd name="connsiteX6" fmla="*/ 32137 w 9145179"/>
              <a:gd name="connsiteY6" fmla="*/ 288718 h 334860"/>
              <a:gd name="connsiteX7" fmla="*/ 4 w 9145179"/>
              <a:gd name="connsiteY7" fmla="*/ 334860 h 334860"/>
              <a:gd name="connsiteX0" fmla="*/ 54 w 9145229"/>
              <a:gd name="connsiteY0" fmla="*/ 334860 h 334860"/>
              <a:gd name="connsiteX1" fmla="*/ 8236767 w 9145229"/>
              <a:gd name="connsiteY1" fmla="*/ 333685 h 334860"/>
              <a:gd name="connsiteX2" fmla="*/ 8777094 w 9145229"/>
              <a:gd name="connsiteY2" fmla="*/ 296883 h 334860"/>
              <a:gd name="connsiteX3" fmla="*/ 9145229 w 9145229"/>
              <a:gd name="connsiteY3" fmla="*/ 231569 h 334860"/>
              <a:gd name="connsiteX4" fmla="*/ 9145229 w 9145229"/>
              <a:gd name="connsiteY4" fmla="*/ 0 h 334860"/>
              <a:gd name="connsiteX5" fmla="*/ 8039369 w 9145229"/>
              <a:gd name="connsiteY5" fmla="*/ 305204 h 334860"/>
              <a:gd name="connsiteX6" fmla="*/ 1231 w 9145229"/>
              <a:gd name="connsiteY6" fmla="*/ 303006 h 334860"/>
              <a:gd name="connsiteX7" fmla="*/ 54 w 9145229"/>
              <a:gd name="connsiteY7" fmla="*/ 334860 h 334860"/>
              <a:gd name="connsiteX0" fmla="*/ 54 w 9145229"/>
              <a:gd name="connsiteY0" fmla="*/ 334860 h 334860"/>
              <a:gd name="connsiteX1" fmla="*/ 8236767 w 9145229"/>
              <a:gd name="connsiteY1" fmla="*/ 333685 h 334860"/>
              <a:gd name="connsiteX2" fmla="*/ 8777094 w 9145229"/>
              <a:gd name="connsiteY2" fmla="*/ 296883 h 334860"/>
              <a:gd name="connsiteX3" fmla="*/ 9145229 w 9145229"/>
              <a:gd name="connsiteY3" fmla="*/ 231569 h 334860"/>
              <a:gd name="connsiteX4" fmla="*/ 9145229 w 9145229"/>
              <a:gd name="connsiteY4" fmla="*/ 0 h 334860"/>
              <a:gd name="connsiteX5" fmla="*/ 6055787 w 9145229"/>
              <a:gd name="connsiteY5" fmla="*/ 305204 h 334860"/>
              <a:gd name="connsiteX6" fmla="*/ 1231 w 9145229"/>
              <a:gd name="connsiteY6" fmla="*/ 303006 h 334860"/>
              <a:gd name="connsiteX7" fmla="*/ 54 w 9145229"/>
              <a:gd name="connsiteY7" fmla="*/ 334860 h 334860"/>
              <a:gd name="connsiteX0" fmla="*/ 54 w 9145229"/>
              <a:gd name="connsiteY0" fmla="*/ 334860 h 336066"/>
              <a:gd name="connsiteX1" fmla="*/ 6198417 w 9145229"/>
              <a:gd name="connsiteY1" fmla="*/ 336066 h 336066"/>
              <a:gd name="connsiteX2" fmla="*/ 8777094 w 9145229"/>
              <a:gd name="connsiteY2" fmla="*/ 296883 h 336066"/>
              <a:gd name="connsiteX3" fmla="*/ 9145229 w 9145229"/>
              <a:gd name="connsiteY3" fmla="*/ 231569 h 336066"/>
              <a:gd name="connsiteX4" fmla="*/ 9145229 w 9145229"/>
              <a:gd name="connsiteY4" fmla="*/ 0 h 336066"/>
              <a:gd name="connsiteX5" fmla="*/ 6055787 w 9145229"/>
              <a:gd name="connsiteY5" fmla="*/ 305204 h 336066"/>
              <a:gd name="connsiteX6" fmla="*/ 1231 w 9145229"/>
              <a:gd name="connsiteY6" fmla="*/ 303006 h 336066"/>
              <a:gd name="connsiteX7" fmla="*/ 54 w 9145229"/>
              <a:gd name="connsiteY7" fmla="*/ 334860 h 336066"/>
              <a:gd name="connsiteX0" fmla="*/ 54 w 9145229"/>
              <a:gd name="connsiteY0" fmla="*/ 873022 h 874228"/>
              <a:gd name="connsiteX1" fmla="*/ 6198417 w 9145229"/>
              <a:gd name="connsiteY1" fmla="*/ 874228 h 874228"/>
              <a:gd name="connsiteX2" fmla="*/ 8777094 w 9145229"/>
              <a:gd name="connsiteY2" fmla="*/ 835045 h 874228"/>
              <a:gd name="connsiteX3" fmla="*/ 9145229 w 9145229"/>
              <a:gd name="connsiteY3" fmla="*/ 769731 h 874228"/>
              <a:gd name="connsiteX4" fmla="*/ 9142848 w 9145229"/>
              <a:gd name="connsiteY4" fmla="*/ 0 h 874228"/>
              <a:gd name="connsiteX5" fmla="*/ 6055787 w 9145229"/>
              <a:gd name="connsiteY5" fmla="*/ 843366 h 874228"/>
              <a:gd name="connsiteX6" fmla="*/ 1231 w 9145229"/>
              <a:gd name="connsiteY6" fmla="*/ 841168 h 874228"/>
              <a:gd name="connsiteX7" fmla="*/ 54 w 9145229"/>
              <a:gd name="connsiteY7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8777094 w 9147610"/>
              <a:gd name="connsiteY2" fmla="*/ 835045 h 874228"/>
              <a:gd name="connsiteX3" fmla="*/ 9147610 w 9147610"/>
              <a:gd name="connsiteY3" fmla="*/ 576849 h 874228"/>
              <a:gd name="connsiteX4" fmla="*/ 9142848 w 9147610"/>
              <a:gd name="connsiteY4" fmla="*/ 0 h 874228"/>
              <a:gd name="connsiteX5" fmla="*/ 6055787 w 9147610"/>
              <a:gd name="connsiteY5" fmla="*/ 843366 h 874228"/>
              <a:gd name="connsiteX6" fmla="*/ 1231 w 9147610"/>
              <a:gd name="connsiteY6" fmla="*/ 841168 h 874228"/>
              <a:gd name="connsiteX7" fmla="*/ 54 w 9147610"/>
              <a:gd name="connsiteY7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7907938 w 9147610"/>
              <a:gd name="connsiteY2" fmla="*/ 804089 h 874228"/>
              <a:gd name="connsiteX3" fmla="*/ 9147610 w 9147610"/>
              <a:gd name="connsiteY3" fmla="*/ 576849 h 874228"/>
              <a:gd name="connsiteX4" fmla="*/ 9142848 w 9147610"/>
              <a:gd name="connsiteY4" fmla="*/ 0 h 874228"/>
              <a:gd name="connsiteX5" fmla="*/ 6055787 w 9147610"/>
              <a:gd name="connsiteY5" fmla="*/ 843366 h 874228"/>
              <a:gd name="connsiteX6" fmla="*/ 1231 w 9147610"/>
              <a:gd name="connsiteY6" fmla="*/ 841168 h 874228"/>
              <a:gd name="connsiteX7" fmla="*/ 54 w 9147610"/>
              <a:gd name="connsiteY7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9147610 w 9147610"/>
              <a:gd name="connsiteY2" fmla="*/ 576849 h 874228"/>
              <a:gd name="connsiteX3" fmla="*/ 9142848 w 9147610"/>
              <a:gd name="connsiteY3" fmla="*/ 0 h 874228"/>
              <a:gd name="connsiteX4" fmla="*/ 6055787 w 9147610"/>
              <a:gd name="connsiteY4" fmla="*/ 843366 h 874228"/>
              <a:gd name="connsiteX5" fmla="*/ 1231 w 9147610"/>
              <a:gd name="connsiteY5" fmla="*/ 841168 h 874228"/>
              <a:gd name="connsiteX6" fmla="*/ 54 w 9147610"/>
              <a:gd name="connsiteY6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9147610 w 9147610"/>
              <a:gd name="connsiteY2" fmla="*/ 576849 h 874228"/>
              <a:gd name="connsiteX3" fmla="*/ 9142848 w 9147610"/>
              <a:gd name="connsiteY3" fmla="*/ 0 h 874228"/>
              <a:gd name="connsiteX4" fmla="*/ 6055787 w 9147610"/>
              <a:gd name="connsiteY4" fmla="*/ 843366 h 874228"/>
              <a:gd name="connsiteX5" fmla="*/ 1231 w 9147610"/>
              <a:gd name="connsiteY5" fmla="*/ 841168 h 874228"/>
              <a:gd name="connsiteX6" fmla="*/ 54 w 9147610"/>
              <a:gd name="connsiteY6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9147610 w 9147610"/>
              <a:gd name="connsiteY2" fmla="*/ 576849 h 874228"/>
              <a:gd name="connsiteX3" fmla="*/ 9142848 w 9147610"/>
              <a:gd name="connsiteY3" fmla="*/ 0 h 874228"/>
              <a:gd name="connsiteX4" fmla="*/ 6055787 w 9147610"/>
              <a:gd name="connsiteY4" fmla="*/ 843366 h 874228"/>
              <a:gd name="connsiteX5" fmla="*/ 1231 w 9147610"/>
              <a:gd name="connsiteY5" fmla="*/ 841168 h 874228"/>
              <a:gd name="connsiteX6" fmla="*/ 54 w 9147610"/>
              <a:gd name="connsiteY6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9147610 w 9147610"/>
              <a:gd name="connsiteY2" fmla="*/ 576849 h 874228"/>
              <a:gd name="connsiteX3" fmla="*/ 9142848 w 9147610"/>
              <a:gd name="connsiteY3" fmla="*/ 0 h 874228"/>
              <a:gd name="connsiteX4" fmla="*/ 6055787 w 9147610"/>
              <a:gd name="connsiteY4" fmla="*/ 843366 h 874228"/>
              <a:gd name="connsiteX5" fmla="*/ 1231 w 9147610"/>
              <a:gd name="connsiteY5" fmla="*/ 841168 h 874228"/>
              <a:gd name="connsiteX6" fmla="*/ 54 w 9147610"/>
              <a:gd name="connsiteY6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9147610 w 9147610"/>
              <a:gd name="connsiteY2" fmla="*/ 576849 h 874228"/>
              <a:gd name="connsiteX3" fmla="*/ 9142848 w 9147610"/>
              <a:gd name="connsiteY3" fmla="*/ 0 h 874228"/>
              <a:gd name="connsiteX4" fmla="*/ 6055787 w 9147610"/>
              <a:gd name="connsiteY4" fmla="*/ 843366 h 874228"/>
              <a:gd name="connsiteX5" fmla="*/ 1231 w 9147610"/>
              <a:gd name="connsiteY5" fmla="*/ 841168 h 874228"/>
              <a:gd name="connsiteX6" fmla="*/ 54 w 9147610"/>
              <a:gd name="connsiteY6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9147610 w 9147610"/>
              <a:gd name="connsiteY2" fmla="*/ 576849 h 874228"/>
              <a:gd name="connsiteX3" fmla="*/ 9142848 w 9147610"/>
              <a:gd name="connsiteY3" fmla="*/ 0 h 874228"/>
              <a:gd name="connsiteX4" fmla="*/ 6055787 w 9147610"/>
              <a:gd name="connsiteY4" fmla="*/ 843366 h 874228"/>
              <a:gd name="connsiteX5" fmla="*/ 1231 w 9147610"/>
              <a:gd name="connsiteY5" fmla="*/ 841168 h 874228"/>
              <a:gd name="connsiteX6" fmla="*/ 54 w 9147610"/>
              <a:gd name="connsiteY6" fmla="*/ 873022 h 874228"/>
              <a:gd name="connsiteX0" fmla="*/ 54 w 9147610"/>
              <a:gd name="connsiteY0" fmla="*/ 873022 h 874228"/>
              <a:gd name="connsiteX1" fmla="*/ 6198417 w 9147610"/>
              <a:gd name="connsiteY1" fmla="*/ 874228 h 874228"/>
              <a:gd name="connsiteX2" fmla="*/ 9147610 w 9147610"/>
              <a:gd name="connsiteY2" fmla="*/ 576849 h 874228"/>
              <a:gd name="connsiteX3" fmla="*/ 9142848 w 9147610"/>
              <a:gd name="connsiteY3" fmla="*/ 0 h 874228"/>
              <a:gd name="connsiteX4" fmla="*/ 6055787 w 9147610"/>
              <a:gd name="connsiteY4" fmla="*/ 843366 h 874228"/>
              <a:gd name="connsiteX5" fmla="*/ 1231 w 9147610"/>
              <a:gd name="connsiteY5" fmla="*/ 841168 h 874228"/>
              <a:gd name="connsiteX6" fmla="*/ 54 w 9147610"/>
              <a:gd name="connsiteY6" fmla="*/ 873022 h 874228"/>
              <a:gd name="connsiteX0" fmla="*/ 54 w 9147610"/>
              <a:gd name="connsiteY0" fmla="*/ 868259 h 869465"/>
              <a:gd name="connsiteX1" fmla="*/ 6198417 w 9147610"/>
              <a:gd name="connsiteY1" fmla="*/ 869465 h 869465"/>
              <a:gd name="connsiteX2" fmla="*/ 9147610 w 9147610"/>
              <a:gd name="connsiteY2" fmla="*/ 572086 h 869465"/>
              <a:gd name="connsiteX3" fmla="*/ 9145229 w 9147610"/>
              <a:gd name="connsiteY3" fmla="*/ 0 h 869465"/>
              <a:gd name="connsiteX4" fmla="*/ 6055787 w 9147610"/>
              <a:gd name="connsiteY4" fmla="*/ 838603 h 869465"/>
              <a:gd name="connsiteX5" fmla="*/ 1231 w 9147610"/>
              <a:gd name="connsiteY5" fmla="*/ 836405 h 869465"/>
              <a:gd name="connsiteX6" fmla="*/ 54 w 9147610"/>
              <a:gd name="connsiteY6" fmla="*/ 868259 h 869465"/>
              <a:gd name="connsiteX0" fmla="*/ 54 w 9147610"/>
              <a:gd name="connsiteY0" fmla="*/ 868259 h 869465"/>
              <a:gd name="connsiteX1" fmla="*/ 6198417 w 9147610"/>
              <a:gd name="connsiteY1" fmla="*/ 869465 h 869465"/>
              <a:gd name="connsiteX2" fmla="*/ 9147610 w 9147610"/>
              <a:gd name="connsiteY2" fmla="*/ 572086 h 869465"/>
              <a:gd name="connsiteX3" fmla="*/ 9145229 w 9147610"/>
              <a:gd name="connsiteY3" fmla="*/ 0 h 869465"/>
              <a:gd name="connsiteX4" fmla="*/ 6055787 w 9147610"/>
              <a:gd name="connsiteY4" fmla="*/ 838603 h 869465"/>
              <a:gd name="connsiteX5" fmla="*/ 1231 w 9147610"/>
              <a:gd name="connsiteY5" fmla="*/ 836405 h 869465"/>
              <a:gd name="connsiteX6" fmla="*/ 54 w 9147610"/>
              <a:gd name="connsiteY6" fmla="*/ 868259 h 86946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9147610" h="869465">
                <a:moveTo>
                  <a:pt x="54" y="868259"/>
                </a:moveTo>
                <a:lnTo>
                  <a:pt x="6198417" y="869465"/>
                </a:lnTo>
                <a:cubicBezTo>
                  <a:pt x="7765872" y="853441"/>
                  <a:pt x="8513997" y="720173"/>
                  <a:pt x="9147610" y="572086"/>
                </a:cubicBezTo>
                <a:cubicBezTo>
                  <a:pt x="9146816" y="315509"/>
                  <a:pt x="9146023" y="256577"/>
                  <a:pt x="9145229" y="0"/>
                </a:cubicBezTo>
                <a:cubicBezTo>
                  <a:pt x="8508481" y="485745"/>
                  <a:pt x="7318244" y="819060"/>
                  <a:pt x="6055787" y="838603"/>
                </a:cubicBezTo>
                <a:lnTo>
                  <a:pt x="1231" y="836405"/>
                </a:lnTo>
                <a:cubicBezTo>
                  <a:pt x="1633" y="849404"/>
                  <a:pt x="-348" y="855260"/>
                  <a:pt x="54" y="868259"/>
                </a:cubicBezTo>
                <a:close/>
              </a:path>
            </a:pathLst>
          </a:cu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254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10" name="図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767" y="6478651"/>
            <a:ext cx="1270800" cy="242144"/>
          </a:xfrm>
          <a:prstGeom prst="rect">
            <a:avLst/>
          </a:prstGeom>
        </p:spPr>
      </p:pic>
      <p:pic>
        <p:nvPicPr>
          <p:cNvPr id="11" name="図 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55731" y="317430"/>
            <a:ext cx="856731" cy="594588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8312" y="1700213"/>
            <a:ext cx="8224837" cy="1728788"/>
          </a:xfrm>
        </p:spPr>
        <p:txBody>
          <a:bodyPr anchor="b">
            <a:noAutofit/>
          </a:bodyPr>
          <a:lstStyle>
            <a:lvl1pPr algn="l">
              <a:defRPr sz="3600" b="1" cap="none" baseline="0"/>
            </a:lvl1pPr>
          </a:lstStyle>
          <a:p>
            <a:r>
              <a:rPr kumimoji="1" lang="ja-JP" altLang="en-US"/>
              <a:t>マスター タイトルの書式設定</a:t>
            </a:r>
            <a:endParaRPr kumimoji="1" lang="ja-JP" altLang="en-US" dirty="0"/>
          </a:p>
        </p:txBody>
      </p:sp>
      <p:sp>
        <p:nvSpPr>
          <p:cNvPr id="8" name="サブタイトル 2"/>
          <p:cNvSpPr>
            <a:spLocks noGrp="1"/>
          </p:cNvSpPr>
          <p:nvPr>
            <p:ph type="subTitle" idx="10"/>
          </p:nvPr>
        </p:nvSpPr>
        <p:spPr>
          <a:xfrm>
            <a:off x="468313" y="4307304"/>
            <a:ext cx="8224837" cy="1831559"/>
          </a:xfrm>
        </p:spPr>
        <p:txBody>
          <a:bodyPr anchor="t">
            <a:normAutofit/>
          </a:bodyPr>
          <a:lstStyle>
            <a:lvl1pPr marL="0" indent="0" algn="l">
              <a:buNone/>
              <a:defRPr sz="2000" baseline="0">
                <a:solidFill>
                  <a:schemeClr val="tx1"/>
                </a:solidFill>
                <a:latin typeface="+mj-lt"/>
                <a:ea typeface="+mj-ea"/>
              </a:defRPr>
            </a:lvl1pPr>
            <a:lvl2pPr marL="457200" indent="0" algn="l">
              <a:buNone/>
              <a:defRPr sz="1800">
                <a:solidFill>
                  <a:schemeClr val="tx1"/>
                </a:solidFill>
              </a:defRPr>
            </a:lvl2pPr>
            <a:lvl3pPr marL="914400" indent="0" algn="l">
              <a:buNone/>
              <a:defRPr sz="1600">
                <a:solidFill>
                  <a:schemeClr val="tx1"/>
                </a:solidFill>
              </a:defRPr>
            </a:lvl3pPr>
            <a:lvl4pPr marL="1371600" indent="0" algn="l">
              <a:buNone/>
              <a:defRPr sz="1400">
                <a:solidFill>
                  <a:schemeClr val="tx1"/>
                </a:solidFill>
              </a:defRPr>
            </a:lvl4pPr>
            <a:lvl5pPr marL="1828800" indent="0" algn="l">
              <a:buNone/>
              <a:defRPr sz="1400">
                <a:solidFill>
                  <a:schemeClr val="tx1"/>
                </a:solidFill>
              </a:defRPr>
            </a:lvl5pPr>
            <a:lvl6pPr marL="2286000" indent="0" algn="l">
              <a:buNone/>
              <a:defRPr sz="1400">
                <a:solidFill>
                  <a:schemeClr val="tx1"/>
                </a:solidFill>
              </a:defRPr>
            </a:lvl6pPr>
            <a:lvl7pPr marL="2743200" indent="0" algn="l">
              <a:buNone/>
              <a:defRPr sz="1400">
                <a:solidFill>
                  <a:schemeClr val="tx1"/>
                </a:solidFill>
              </a:defRPr>
            </a:lvl7pPr>
            <a:lvl8pPr marL="3200400" indent="0" algn="l">
              <a:buNone/>
              <a:defRPr sz="1400">
                <a:solidFill>
                  <a:schemeClr val="tx1"/>
                </a:solidFill>
              </a:defRPr>
            </a:lvl8pPr>
            <a:lvl9pPr marL="3657600" indent="0" algn="l">
              <a:buNone/>
              <a:defRPr sz="1400">
                <a:solidFill>
                  <a:schemeClr val="tx1"/>
                </a:solidFill>
              </a:defRPr>
            </a:lvl9pPr>
          </a:lstStyle>
          <a:p>
            <a:pPr lvl="0"/>
            <a:r>
              <a:rPr kumimoji="1" lang="ja-JP" altLang="en-US"/>
              <a:t>マスター サブタイトルの書式設定</a:t>
            </a:r>
            <a:endParaRPr kumimoji="1" lang="ja-JP" altLang="en-US" dirty="0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191888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Obj" preserve="1">
  <p:cSld name="Two Content: 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図 1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35380" y="76966"/>
            <a:ext cx="856731" cy="594588"/>
          </a:xfrm>
          <a:prstGeom prst="rect">
            <a:avLst/>
          </a:prstGeom>
        </p:spPr>
      </p:pic>
      <p:sp>
        <p:nvSpPr>
          <p:cNvPr id="13" name="フリーフォーム 12"/>
          <p:cNvSpPr/>
          <p:nvPr/>
        </p:nvSpPr>
        <p:spPr>
          <a:xfrm>
            <a:off x="-1231" y="451262"/>
            <a:ext cx="9145230" cy="334860"/>
          </a:xfrm>
          <a:custGeom>
            <a:avLst/>
            <a:gdLst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5938 w 9149938"/>
              <a:gd name="connsiteY7" fmla="*/ 231569 h 344385"/>
              <a:gd name="connsiteX8" fmla="*/ 0 w 9149938"/>
              <a:gd name="connsiteY8" fmla="*/ 344385 h 344385"/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10700 w 9149938"/>
              <a:gd name="connsiteY7" fmla="*/ 300625 h 344385"/>
              <a:gd name="connsiteX8" fmla="*/ 0 w 9149938"/>
              <a:gd name="connsiteY8" fmla="*/ 344385 h 344385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25019 w 9139238"/>
              <a:gd name="connsiteY0" fmla="*/ 399154 h 399154"/>
              <a:gd name="connsiteX1" fmla="*/ 8230776 w 9139238"/>
              <a:gd name="connsiteY1" fmla="*/ 338447 h 399154"/>
              <a:gd name="connsiteX2" fmla="*/ 8771103 w 9139238"/>
              <a:gd name="connsiteY2" fmla="*/ 296883 h 399154"/>
              <a:gd name="connsiteX3" fmla="*/ 9139238 w 9139238"/>
              <a:gd name="connsiteY3" fmla="*/ 231569 h 399154"/>
              <a:gd name="connsiteX4" fmla="*/ 9139238 w 9139238"/>
              <a:gd name="connsiteY4" fmla="*/ 0 h 399154"/>
              <a:gd name="connsiteX5" fmla="*/ 8747352 w 9139238"/>
              <a:gd name="connsiteY5" fmla="*/ 201881 h 399154"/>
              <a:gd name="connsiteX6" fmla="*/ 8135773 w 9139238"/>
              <a:gd name="connsiteY6" fmla="*/ 302821 h 399154"/>
              <a:gd name="connsiteX7" fmla="*/ 0 w 9139238"/>
              <a:gd name="connsiteY7" fmla="*/ 300625 h 399154"/>
              <a:gd name="connsiteX8" fmla="*/ 25019 w 9139238"/>
              <a:gd name="connsiteY8" fmla="*/ 399154 h 39915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5937 w 9145175"/>
              <a:gd name="connsiteY7" fmla="*/ 300625 h 342004"/>
              <a:gd name="connsiteX8" fmla="*/ 0 w 9145175"/>
              <a:gd name="connsiteY8" fmla="*/ 342004 h 34200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120237 w 9145175"/>
              <a:gd name="connsiteY7" fmla="*/ 255381 h 342004"/>
              <a:gd name="connsiteX8" fmla="*/ 0 w 9145175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142917 w 9146382"/>
              <a:gd name="connsiteY6" fmla="*/ 302821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55 w 9145230"/>
              <a:gd name="connsiteY0" fmla="*/ 342004 h 342004"/>
              <a:gd name="connsiteX1" fmla="*/ 8236768 w 9145230"/>
              <a:gd name="connsiteY1" fmla="*/ 338447 h 342004"/>
              <a:gd name="connsiteX2" fmla="*/ 8777095 w 9145230"/>
              <a:gd name="connsiteY2" fmla="*/ 296883 h 342004"/>
              <a:gd name="connsiteX3" fmla="*/ 9145230 w 9145230"/>
              <a:gd name="connsiteY3" fmla="*/ 231569 h 342004"/>
              <a:gd name="connsiteX4" fmla="*/ 9145230 w 9145230"/>
              <a:gd name="connsiteY4" fmla="*/ 0 h 342004"/>
              <a:gd name="connsiteX5" fmla="*/ 8039370 w 9145230"/>
              <a:gd name="connsiteY5" fmla="*/ 302822 h 342004"/>
              <a:gd name="connsiteX6" fmla="*/ 1230 w 9145230"/>
              <a:gd name="connsiteY6" fmla="*/ 307768 h 342004"/>
              <a:gd name="connsiteX7" fmla="*/ 55 w 9145230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5387 h 342004"/>
              <a:gd name="connsiteX7" fmla="*/ 1207 w 9146382"/>
              <a:gd name="connsiteY7" fmla="*/ 342004 h 342004"/>
              <a:gd name="connsiteX0" fmla="*/ 1207 w 9146382"/>
              <a:gd name="connsiteY0" fmla="*/ 339622 h 339622"/>
              <a:gd name="connsiteX1" fmla="*/ 8237920 w 9146382"/>
              <a:gd name="connsiteY1" fmla="*/ 338447 h 339622"/>
              <a:gd name="connsiteX2" fmla="*/ 8778247 w 9146382"/>
              <a:gd name="connsiteY2" fmla="*/ 296883 h 339622"/>
              <a:gd name="connsiteX3" fmla="*/ 9146382 w 9146382"/>
              <a:gd name="connsiteY3" fmla="*/ 231569 h 339622"/>
              <a:gd name="connsiteX4" fmla="*/ 9146382 w 9146382"/>
              <a:gd name="connsiteY4" fmla="*/ 0 h 339622"/>
              <a:gd name="connsiteX5" fmla="*/ 8040522 w 9146382"/>
              <a:gd name="connsiteY5" fmla="*/ 302822 h 339622"/>
              <a:gd name="connsiteX6" fmla="*/ 0 w 9146382"/>
              <a:gd name="connsiteY6" fmla="*/ 305387 h 339622"/>
              <a:gd name="connsiteX7" fmla="*/ 1207 w 9146382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2822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3685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4860 h 334860"/>
              <a:gd name="connsiteX1" fmla="*/ 8236768 w 9145230"/>
              <a:gd name="connsiteY1" fmla="*/ 333685 h 334860"/>
              <a:gd name="connsiteX2" fmla="*/ 8777095 w 9145230"/>
              <a:gd name="connsiteY2" fmla="*/ 296883 h 334860"/>
              <a:gd name="connsiteX3" fmla="*/ 9145230 w 9145230"/>
              <a:gd name="connsiteY3" fmla="*/ 231569 h 334860"/>
              <a:gd name="connsiteX4" fmla="*/ 9145230 w 9145230"/>
              <a:gd name="connsiteY4" fmla="*/ 0 h 334860"/>
              <a:gd name="connsiteX5" fmla="*/ 8039370 w 9145230"/>
              <a:gd name="connsiteY5" fmla="*/ 305204 h 334860"/>
              <a:gd name="connsiteX6" fmla="*/ 1230 w 9145230"/>
              <a:gd name="connsiteY6" fmla="*/ 305387 h 334860"/>
              <a:gd name="connsiteX7" fmla="*/ 55 w 9145230"/>
              <a:gd name="connsiteY7" fmla="*/ 334860 h 3348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9145230" h="334860">
                <a:moveTo>
                  <a:pt x="55" y="334860"/>
                </a:moveTo>
                <a:lnTo>
                  <a:pt x="8236768" y="333685"/>
                </a:lnTo>
                <a:cubicBezTo>
                  <a:pt x="8424021" y="326974"/>
                  <a:pt x="8625685" y="313902"/>
                  <a:pt x="8777095" y="296883"/>
                </a:cubicBezTo>
                <a:cubicBezTo>
                  <a:pt x="8928505" y="279864"/>
                  <a:pt x="9017756" y="262865"/>
                  <a:pt x="9145230" y="231569"/>
                </a:cubicBezTo>
                <a:lnTo>
                  <a:pt x="9145230" y="0"/>
                </a:lnTo>
                <a:cubicBezTo>
                  <a:pt x="8875194" y="176182"/>
                  <a:pt x="8573165" y="285660"/>
                  <a:pt x="8039370" y="305204"/>
                </a:cubicBezTo>
                <a:lnTo>
                  <a:pt x="1230" y="305387"/>
                </a:lnTo>
                <a:cubicBezTo>
                  <a:pt x="1632" y="318386"/>
                  <a:pt x="-347" y="321861"/>
                  <a:pt x="55" y="334860"/>
                </a:cubicBezTo>
                <a:close/>
              </a:path>
            </a:pathLst>
          </a:cu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254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正方形/長方形 13"/>
          <p:cNvSpPr/>
          <p:nvPr/>
        </p:nvSpPr>
        <p:spPr>
          <a:xfrm>
            <a:off x="0" y="6321600"/>
            <a:ext cx="9144000" cy="25200"/>
          </a:xfrm>
          <a:prstGeom prst="rect">
            <a:avLst/>
          </a:pr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12700" dir="16200000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014414"/>
            <a:ext cx="4038600" cy="5111750"/>
          </a:xfrm>
        </p:spPr>
        <p:txBody>
          <a:bodyPr>
            <a:normAutofit/>
          </a:bodyPr>
          <a:lstStyle>
            <a:lvl1pPr>
              <a:defRPr sz="2400" baseline="0"/>
            </a:lvl1pPr>
            <a:lvl2pPr>
              <a:defRPr sz="2000" baseline="0"/>
            </a:lvl2pPr>
            <a:lvl3pPr>
              <a:defRPr sz="1800" baseline="0"/>
            </a:lvl3pPr>
            <a:lvl4pPr>
              <a:defRPr sz="1600" baseline="0"/>
            </a:lvl4pPr>
            <a:lvl5pPr>
              <a:defRPr sz="1600" baseline="0"/>
            </a:lvl5pPr>
            <a:lvl6pPr>
              <a:defRPr sz="1400"/>
            </a:lvl6pPr>
            <a:lvl7pPr marL="2297113" indent="-228600">
              <a:defRPr sz="1400"/>
            </a:lvl7pPr>
            <a:lvl8pPr marL="2601913" indent="-228600">
              <a:defRPr sz="1400"/>
            </a:lvl8pPr>
            <a:lvl9pPr marL="2874963" indent="-228600">
              <a:defRPr sz="14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en-US" altLang="ja-JP" dirty="0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014414"/>
            <a:ext cx="4038600" cy="5111749"/>
          </a:xfrm>
        </p:spPr>
        <p:txBody>
          <a:bodyPr>
            <a:normAutofit/>
          </a:bodyPr>
          <a:lstStyle>
            <a:lvl1pPr>
              <a:defRPr sz="2400" baseline="0"/>
            </a:lvl1pPr>
            <a:lvl2pPr>
              <a:defRPr sz="2000" baseline="0"/>
            </a:lvl2pPr>
            <a:lvl3pPr>
              <a:defRPr sz="1800" baseline="0"/>
            </a:lvl3pPr>
            <a:lvl4pPr>
              <a:defRPr sz="1600" baseline="0"/>
            </a:lvl4pPr>
            <a:lvl5pPr>
              <a:defRPr sz="1600" baseline="0"/>
            </a:lvl5pPr>
            <a:lvl6pPr>
              <a:defRPr sz="1400"/>
            </a:lvl6pPr>
            <a:lvl7pPr marL="2297113" indent="-228600">
              <a:defRPr sz="1400"/>
            </a:lvl7pPr>
            <a:lvl8pPr marL="2601913" indent="-228600">
              <a:defRPr sz="1400"/>
            </a:lvl8pPr>
            <a:lvl9pPr marL="2874963" indent="-228600">
              <a:defRPr sz="14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en-US" altLang="ja-JP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8211641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TxTwoObj" preserve="1">
  <p:cSld name="Comparison: 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図 1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35380" y="76966"/>
            <a:ext cx="856731" cy="594588"/>
          </a:xfrm>
          <a:prstGeom prst="rect">
            <a:avLst/>
          </a:prstGeom>
        </p:spPr>
      </p:pic>
      <p:sp>
        <p:nvSpPr>
          <p:cNvPr id="15" name="フリーフォーム 14"/>
          <p:cNvSpPr/>
          <p:nvPr/>
        </p:nvSpPr>
        <p:spPr>
          <a:xfrm>
            <a:off x="-1231" y="451262"/>
            <a:ext cx="9145230" cy="334860"/>
          </a:xfrm>
          <a:custGeom>
            <a:avLst/>
            <a:gdLst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5938 w 9149938"/>
              <a:gd name="connsiteY7" fmla="*/ 231569 h 344385"/>
              <a:gd name="connsiteX8" fmla="*/ 0 w 9149938"/>
              <a:gd name="connsiteY8" fmla="*/ 344385 h 344385"/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10700 w 9149938"/>
              <a:gd name="connsiteY7" fmla="*/ 300625 h 344385"/>
              <a:gd name="connsiteX8" fmla="*/ 0 w 9149938"/>
              <a:gd name="connsiteY8" fmla="*/ 344385 h 344385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25019 w 9139238"/>
              <a:gd name="connsiteY0" fmla="*/ 399154 h 399154"/>
              <a:gd name="connsiteX1" fmla="*/ 8230776 w 9139238"/>
              <a:gd name="connsiteY1" fmla="*/ 338447 h 399154"/>
              <a:gd name="connsiteX2" fmla="*/ 8771103 w 9139238"/>
              <a:gd name="connsiteY2" fmla="*/ 296883 h 399154"/>
              <a:gd name="connsiteX3" fmla="*/ 9139238 w 9139238"/>
              <a:gd name="connsiteY3" fmla="*/ 231569 h 399154"/>
              <a:gd name="connsiteX4" fmla="*/ 9139238 w 9139238"/>
              <a:gd name="connsiteY4" fmla="*/ 0 h 399154"/>
              <a:gd name="connsiteX5" fmla="*/ 8747352 w 9139238"/>
              <a:gd name="connsiteY5" fmla="*/ 201881 h 399154"/>
              <a:gd name="connsiteX6" fmla="*/ 8135773 w 9139238"/>
              <a:gd name="connsiteY6" fmla="*/ 302821 h 399154"/>
              <a:gd name="connsiteX7" fmla="*/ 0 w 9139238"/>
              <a:gd name="connsiteY7" fmla="*/ 300625 h 399154"/>
              <a:gd name="connsiteX8" fmla="*/ 25019 w 9139238"/>
              <a:gd name="connsiteY8" fmla="*/ 399154 h 39915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5937 w 9145175"/>
              <a:gd name="connsiteY7" fmla="*/ 300625 h 342004"/>
              <a:gd name="connsiteX8" fmla="*/ 0 w 9145175"/>
              <a:gd name="connsiteY8" fmla="*/ 342004 h 34200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120237 w 9145175"/>
              <a:gd name="connsiteY7" fmla="*/ 255381 h 342004"/>
              <a:gd name="connsiteX8" fmla="*/ 0 w 9145175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142917 w 9146382"/>
              <a:gd name="connsiteY6" fmla="*/ 302821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55 w 9145230"/>
              <a:gd name="connsiteY0" fmla="*/ 342004 h 342004"/>
              <a:gd name="connsiteX1" fmla="*/ 8236768 w 9145230"/>
              <a:gd name="connsiteY1" fmla="*/ 338447 h 342004"/>
              <a:gd name="connsiteX2" fmla="*/ 8777095 w 9145230"/>
              <a:gd name="connsiteY2" fmla="*/ 296883 h 342004"/>
              <a:gd name="connsiteX3" fmla="*/ 9145230 w 9145230"/>
              <a:gd name="connsiteY3" fmla="*/ 231569 h 342004"/>
              <a:gd name="connsiteX4" fmla="*/ 9145230 w 9145230"/>
              <a:gd name="connsiteY4" fmla="*/ 0 h 342004"/>
              <a:gd name="connsiteX5" fmla="*/ 8039370 w 9145230"/>
              <a:gd name="connsiteY5" fmla="*/ 302822 h 342004"/>
              <a:gd name="connsiteX6" fmla="*/ 1230 w 9145230"/>
              <a:gd name="connsiteY6" fmla="*/ 307768 h 342004"/>
              <a:gd name="connsiteX7" fmla="*/ 55 w 9145230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5387 h 342004"/>
              <a:gd name="connsiteX7" fmla="*/ 1207 w 9146382"/>
              <a:gd name="connsiteY7" fmla="*/ 342004 h 342004"/>
              <a:gd name="connsiteX0" fmla="*/ 1207 w 9146382"/>
              <a:gd name="connsiteY0" fmla="*/ 339622 h 339622"/>
              <a:gd name="connsiteX1" fmla="*/ 8237920 w 9146382"/>
              <a:gd name="connsiteY1" fmla="*/ 338447 h 339622"/>
              <a:gd name="connsiteX2" fmla="*/ 8778247 w 9146382"/>
              <a:gd name="connsiteY2" fmla="*/ 296883 h 339622"/>
              <a:gd name="connsiteX3" fmla="*/ 9146382 w 9146382"/>
              <a:gd name="connsiteY3" fmla="*/ 231569 h 339622"/>
              <a:gd name="connsiteX4" fmla="*/ 9146382 w 9146382"/>
              <a:gd name="connsiteY4" fmla="*/ 0 h 339622"/>
              <a:gd name="connsiteX5" fmla="*/ 8040522 w 9146382"/>
              <a:gd name="connsiteY5" fmla="*/ 302822 h 339622"/>
              <a:gd name="connsiteX6" fmla="*/ 0 w 9146382"/>
              <a:gd name="connsiteY6" fmla="*/ 305387 h 339622"/>
              <a:gd name="connsiteX7" fmla="*/ 1207 w 9146382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2822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3685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4860 h 334860"/>
              <a:gd name="connsiteX1" fmla="*/ 8236768 w 9145230"/>
              <a:gd name="connsiteY1" fmla="*/ 333685 h 334860"/>
              <a:gd name="connsiteX2" fmla="*/ 8777095 w 9145230"/>
              <a:gd name="connsiteY2" fmla="*/ 296883 h 334860"/>
              <a:gd name="connsiteX3" fmla="*/ 9145230 w 9145230"/>
              <a:gd name="connsiteY3" fmla="*/ 231569 h 334860"/>
              <a:gd name="connsiteX4" fmla="*/ 9145230 w 9145230"/>
              <a:gd name="connsiteY4" fmla="*/ 0 h 334860"/>
              <a:gd name="connsiteX5" fmla="*/ 8039370 w 9145230"/>
              <a:gd name="connsiteY5" fmla="*/ 305204 h 334860"/>
              <a:gd name="connsiteX6" fmla="*/ 1230 w 9145230"/>
              <a:gd name="connsiteY6" fmla="*/ 305387 h 334860"/>
              <a:gd name="connsiteX7" fmla="*/ 55 w 9145230"/>
              <a:gd name="connsiteY7" fmla="*/ 334860 h 3348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9145230" h="334860">
                <a:moveTo>
                  <a:pt x="55" y="334860"/>
                </a:moveTo>
                <a:lnTo>
                  <a:pt x="8236768" y="333685"/>
                </a:lnTo>
                <a:cubicBezTo>
                  <a:pt x="8424021" y="326974"/>
                  <a:pt x="8625685" y="313902"/>
                  <a:pt x="8777095" y="296883"/>
                </a:cubicBezTo>
                <a:cubicBezTo>
                  <a:pt x="8928505" y="279864"/>
                  <a:pt x="9017756" y="262865"/>
                  <a:pt x="9145230" y="231569"/>
                </a:cubicBezTo>
                <a:lnTo>
                  <a:pt x="9145230" y="0"/>
                </a:lnTo>
                <a:cubicBezTo>
                  <a:pt x="8875194" y="176182"/>
                  <a:pt x="8573165" y="285660"/>
                  <a:pt x="8039370" y="305204"/>
                </a:cubicBezTo>
                <a:lnTo>
                  <a:pt x="1230" y="305387"/>
                </a:lnTo>
                <a:cubicBezTo>
                  <a:pt x="1632" y="318386"/>
                  <a:pt x="-347" y="321861"/>
                  <a:pt x="55" y="334860"/>
                </a:cubicBezTo>
                <a:close/>
              </a:path>
            </a:pathLst>
          </a:cu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254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正方形/長方形 15"/>
          <p:cNvSpPr/>
          <p:nvPr/>
        </p:nvSpPr>
        <p:spPr>
          <a:xfrm>
            <a:off x="0" y="6321600"/>
            <a:ext cx="9144000" cy="25200"/>
          </a:xfrm>
          <a:prstGeom prst="rect">
            <a:avLst/>
          </a:pr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12700" dir="16200000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014413"/>
            <a:ext cx="4040188" cy="685800"/>
          </a:xfrm>
        </p:spPr>
        <p:txBody>
          <a:bodyPr anchor="ctr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1700213"/>
            <a:ext cx="4040188" cy="442595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 marL="1976438" indent="-228600">
              <a:defRPr sz="1200"/>
            </a:lvl6pPr>
            <a:lvl7pPr marL="2297113" indent="-228600">
              <a:defRPr sz="1200"/>
            </a:lvl7pPr>
            <a:lvl8pPr marL="2601913" indent="-228600">
              <a:defRPr sz="1200"/>
            </a:lvl8pPr>
            <a:lvl9pPr marL="2874963" indent="-228600">
              <a:defRPr sz="12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en-US" altLang="ja-JP" dirty="0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014413"/>
            <a:ext cx="4041775" cy="685800"/>
          </a:xfrm>
        </p:spPr>
        <p:txBody>
          <a:bodyPr anchor="ctr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1700213"/>
            <a:ext cx="4041775" cy="442595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 marL="1887538" indent="-228600">
              <a:defRPr sz="1200"/>
            </a:lvl6pPr>
            <a:lvl7pPr marL="2297113" indent="-228600">
              <a:defRPr sz="1200"/>
            </a:lvl7pPr>
            <a:lvl8pPr marL="2601913" indent="-228600">
              <a:defRPr sz="1200"/>
            </a:lvl8pPr>
            <a:lvl9pPr marL="2874963" indent="-228600">
              <a:defRPr sz="12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en-US" altLang="ja-JP" dirty="0"/>
          </a:p>
        </p:txBody>
      </p:sp>
      <p:sp>
        <p:nvSpPr>
          <p:cNvPr id="7" name="フッター プレースホルダー 6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0001916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Title Only: 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35380" y="76966"/>
            <a:ext cx="856731" cy="594588"/>
          </a:xfrm>
          <a:prstGeom prst="rect">
            <a:avLst/>
          </a:prstGeom>
        </p:spPr>
      </p:pic>
      <p:sp>
        <p:nvSpPr>
          <p:cNvPr id="11" name="フリーフォーム 10"/>
          <p:cNvSpPr/>
          <p:nvPr/>
        </p:nvSpPr>
        <p:spPr>
          <a:xfrm>
            <a:off x="-1231" y="451262"/>
            <a:ext cx="9145230" cy="334860"/>
          </a:xfrm>
          <a:custGeom>
            <a:avLst/>
            <a:gdLst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5938 w 9149938"/>
              <a:gd name="connsiteY7" fmla="*/ 231569 h 344385"/>
              <a:gd name="connsiteX8" fmla="*/ 0 w 9149938"/>
              <a:gd name="connsiteY8" fmla="*/ 344385 h 344385"/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10700 w 9149938"/>
              <a:gd name="connsiteY7" fmla="*/ 300625 h 344385"/>
              <a:gd name="connsiteX8" fmla="*/ 0 w 9149938"/>
              <a:gd name="connsiteY8" fmla="*/ 344385 h 344385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25019 w 9139238"/>
              <a:gd name="connsiteY0" fmla="*/ 399154 h 399154"/>
              <a:gd name="connsiteX1" fmla="*/ 8230776 w 9139238"/>
              <a:gd name="connsiteY1" fmla="*/ 338447 h 399154"/>
              <a:gd name="connsiteX2" fmla="*/ 8771103 w 9139238"/>
              <a:gd name="connsiteY2" fmla="*/ 296883 h 399154"/>
              <a:gd name="connsiteX3" fmla="*/ 9139238 w 9139238"/>
              <a:gd name="connsiteY3" fmla="*/ 231569 h 399154"/>
              <a:gd name="connsiteX4" fmla="*/ 9139238 w 9139238"/>
              <a:gd name="connsiteY4" fmla="*/ 0 h 399154"/>
              <a:gd name="connsiteX5" fmla="*/ 8747352 w 9139238"/>
              <a:gd name="connsiteY5" fmla="*/ 201881 h 399154"/>
              <a:gd name="connsiteX6" fmla="*/ 8135773 w 9139238"/>
              <a:gd name="connsiteY6" fmla="*/ 302821 h 399154"/>
              <a:gd name="connsiteX7" fmla="*/ 0 w 9139238"/>
              <a:gd name="connsiteY7" fmla="*/ 300625 h 399154"/>
              <a:gd name="connsiteX8" fmla="*/ 25019 w 9139238"/>
              <a:gd name="connsiteY8" fmla="*/ 399154 h 39915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5937 w 9145175"/>
              <a:gd name="connsiteY7" fmla="*/ 300625 h 342004"/>
              <a:gd name="connsiteX8" fmla="*/ 0 w 9145175"/>
              <a:gd name="connsiteY8" fmla="*/ 342004 h 34200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120237 w 9145175"/>
              <a:gd name="connsiteY7" fmla="*/ 255381 h 342004"/>
              <a:gd name="connsiteX8" fmla="*/ 0 w 9145175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142917 w 9146382"/>
              <a:gd name="connsiteY6" fmla="*/ 302821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55 w 9145230"/>
              <a:gd name="connsiteY0" fmla="*/ 342004 h 342004"/>
              <a:gd name="connsiteX1" fmla="*/ 8236768 w 9145230"/>
              <a:gd name="connsiteY1" fmla="*/ 338447 h 342004"/>
              <a:gd name="connsiteX2" fmla="*/ 8777095 w 9145230"/>
              <a:gd name="connsiteY2" fmla="*/ 296883 h 342004"/>
              <a:gd name="connsiteX3" fmla="*/ 9145230 w 9145230"/>
              <a:gd name="connsiteY3" fmla="*/ 231569 h 342004"/>
              <a:gd name="connsiteX4" fmla="*/ 9145230 w 9145230"/>
              <a:gd name="connsiteY4" fmla="*/ 0 h 342004"/>
              <a:gd name="connsiteX5" fmla="*/ 8039370 w 9145230"/>
              <a:gd name="connsiteY5" fmla="*/ 302822 h 342004"/>
              <a:gd name="connsiteX6" fmla="*/ 1230 w 9145230"/>
              <a:gd name="connsiteY6" fmla="*/ 307768 h 342004"/>
              <a:gd name="connsiteX7" fmla="*/ 55 w 9145230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5387 h 342004"/>
              <a:gd name="connsiteX7" fmla="*/ 1207 w 9146382"/>
              <a:gd name="connsiteY7" fmla="*/ 342004 h 342004"/>
              <a:gd name="connsiteX0" fmla="*/ 1207 w 9146382"/>
              <a:gd name="connsiteY0" fmla="*/ 339622 h 339622"/>
              <a:gd name="connsiteX1" fmla="*/ 8237920 w 9146382"/>
              <a:gd name="connsiteY1" fmla="*/ 338447 h 339622"/>
              <a:gd name="connsiteX2" fmla="*/ 8778247 w 9146382"/>
              <a:gd name="connsiteY2" fmla="*/ 296883 h 339622"/>
              <a:gd name="connsiteX3" fmla="*/ 9146382 w 9146382"/>
              <a:gd name="connsiteY3" fmla="*/ 231569 h 339622"/>
              <a:gd name="connsiteX4" fmla="*/ 9146382 w 9146382"/>
              <a:gd name="connsiteY4" fmla="*/ 0 h 339622"/>
              <a:gd name="connsiteX5" fmla="*/ 8040522 w 9146382"/>
              <a:gd name="connsiteY5" fmla="*/ 302822 h 339622"/>
              <a:gd name="connsiteX6" fmla="*/ 0 w 9146382"/>
              <a:gd name="connsiteY6" fmla="*/ 305387 h 339622"/>
              <a:gd name="connsiteX7" fmla="*/ 1207 w 9146382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2822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3685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4860 h 334860"/>
              <a:gd name="connsiteX1" fmla="*/ 8236768 w 9145230"/>
              <a:gd name="connsiteY1" fmla="*/ 333685 h 334860"/>
              <a:gd name="connsiteX2" fmla="*/ 8777095 w 9145230"/>
              <a:gd name="connsiteY2" fmla="*/ 296883 h 334860"/>
              <a:gd name="connsiteX3" fmla="*/ 9145230 w 9145230"/>
              <a:gd name="connsiteY3" fmla="*/ 231569 h 334860"/>
              <a:gd name="connsiteX4" fmla="*/ 9145230 w 9145230"/>
              <a:gd name="connsiteY4" fmla="*/ 0 h 334860"/>
              <a:gd name="connsiteX5" fmla="*/ 8039370 w 9145230"/>
              <a:gd name="connsiteY5" fmla="*/ 305204 h 334860"/>
              <a:gd name="connsiteX6" fmla="*/ 1230 w 9145230"/>
              <a:gd name="connsiteY6" fmla="*/ 305387 h 334860"/>
              <a:gd name="connsiteX7" fmla="*/ 55 w 9145230"/>
              <a:gd name="connsiteY7" fmla="*/ 334860 h 3348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9145230" h="334860">
                <a:moveTo>
                  <a:pt x="55" y="334860"/>
                </a:moveTo>
                <a:lnTo>
                  <a:pt x="8236768" y="333685"/>
                </a:lnTo>
                <a:cubicBezTo>
                  <a:pt x="8424021" y="326974"/>
                  <a:pt x="8625685" y="313902"/>
                  <a:pt x="8777095" y="296883"/>
                </a:cubicBezTo>
                <a:cubicBezTo>
                  <a:pt x="8928505" y="279864"/>
                  <a:pt x="9017756" y="262865"/>
                  <a:pt x="9145230" y="231569"/>
                </a:cubicBezTo>
                <a:lnTo>
                  <a:pt x="9145230" y="0"/>
                </a:lnTo>
                <a:cubicBezTo>
                  <a:pt x="8875194" y="176182"/>
                  <a:pt x="8573165" y="285660"/>
                  <a:pt x="8039370" y="305204"/>
                </a:cubicBezTo>
                <a:lnTo>
                  <a:pt x="1230" y="305387"/>
                </a:lnTo>
                <a:cubicBezTo>
                  <a:pt x="1632" y="318386"/>
                  <a:pt x="-347" y="321861"/>
                  <a:pt x="55" y="334860"/>
                </a:cubicBezTo>
                <a:close/>
              </a:path>
            </a:pathLst>
          </a:cu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254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正方形/長方形 11"/>
          <p:cNvSpPr/>
          <p:nvPr/>
        </p:nvSpPr>
        <p:spPr>
          <a:xfrm>
            <a:off x="0" y="6321600"/>
            <a:ext cx="9144000" cy="25200"/>
          </a:xfrm>
          <a:prstGeom prst="rect">
            <a:avLst/>
          </a:pr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12700" dir="16200000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7728304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: 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フッター プレースホルダー 1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95856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ED6A891-268E-435C-A725-07EB6DD7A938}" type="datetime1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Segoe UI"/>
                <a:ea typeface="Meiryo UI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/7/2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2DABCC2-1EEF-4DDF-B308-B50BC011052B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Segoe UI"/>
                <a:ea typeface="Meiryo UI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65847636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Content with Caption: タイトル付きの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図 1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35380" y="76966"/>
            <a:ext cx="856731" cy="594588"/>
          </a:xfrm>
          <a:prstGeom prst="rect">
            <a:avLst/>
          </a:prstGeom>
        </p:spPr>
      </p:pic>
      <p:sp>
        <p:nvSpPr>
          <p:cNvPr id="15" name="フリーフォーム 14"/>
          <p:cNvSpPr/>
          <p:nvPr/>
        </p:nvSpPr>
        <p:spPr>
          <a:xfrm>
            <a:off x="-1231" y="451262"/>
            <a:ext cx="9145230" cy="334860"/>
          </a:xfrm>
          <a:custGeom>
            <a:avLst/>
            <a:gdLst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5938 w 9149938"/>
              <a:gd name="connsiteY7" fmla="*/ 231569 h 344385"/>
              <a:gd name="connsiteX8" fmla="*/ 0 w 9149938"/>
              <a:gd name="connsiteY8" fmla="*/ 344385 h 344385"/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10700 w 9149938"/>
              <a:gd name="connsiteY7" fmla="*/ 300625 h 344385"/>
              <a:gd name="connsiteX8" fmla="*/ 0 w 9149938"/>
              <a:gd name="connsiteY8" fmla="*/ 344385 h 344385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25019 w 9139238"/>
              <a:gd name="connsiteY0" fmla="*/ 399154 h 399154"/>
              <a:gd name="connsiteX1" fmla="*/ 8230776 w 9139238"/>
              <a:gd name="connsiteY1" fmla="*/ 338447 h 399154"/>
              <a:gd name="connsiteX2" fmla="*/ 8771103 w 9139238"/>
              <a:gd name="connsiteY2" fmla="*/ 296883 h 399154"/>
              <a:gd name="connsiteX3" fmla="*/ 9139238 w 9139238"/>
              <a:gd name="connsiteY3" fmla="*/ 231569 h 399154"/>
              <a:gd name="connsiteX4" fmla="*/ 9139238 w 9139238"/>
              <a:gd name="connsiteY4" fmla="*/ 0 h 399154"/>
              <a:gd name="connsiteX5" fmla="*/ 8747352 w 9139238"/>
              <a:gd name="connsiteY5" fmla="*/ 201881 h 399154"/>
              <a:gd name="connsiteX6" fmla="*/ 8135773 w 9139238"/>
              <a:gd name="connsiteY6" fmla="*/ 302821 h 399154"/>
              <a:gd name="connsiteX7" fmla="*/ 0 w 9139238"/>
              <a:gd name="connsiteY7" fmla="*/ 300625 h 399154"/>
              <a:gd name="connsiteX8" fmla="*/ 25019 w 9139238"/>
              <a:gd name="connsiteY8" fmla="*/ 399154 h 39915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5937 w 9145175"/>
              <a:gd name="connsiteY7" fmla="*/ 300625 h 342004"/>
              <a:gd name="connsiteX8" fmla="*/ 0 w 9145175"/>
              <a:gd name="connsiteY8" fmla="*/ 342004 h 34200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120237 w 9145175"/>
              <a:gd name="connsiteY7" fmla="*/ 255381 h 342004"/>
              <a:gd name="connsiteX8" fmla="*/ 0 w 9145175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142917 w 9146382"/>
              <a:gd name="connsiteY6" fmla="*/ 302821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55 w 9145230"/>
              <a:gd name="connsiteY0" fmla="*/ 342004 h 342004"/>
              <a:gd name="connsiteX1" fmla="*/ 8236768 w 9145230"/>
              <a:gd name="connsiteY1" fmla="*/ 338447 h 342004"/>
              <a:gd name="connsiteX2" fmla="*/ 8777095 w 9145230"/>
              <a:gd name="connsiteY2" fmla="*/ 296883 h 342004"/>
              <a:gd name="connsiteX3" fmla="*/ 9145230 w 9145230"/>
              <a:gd name="connsiteY3" fmla="*/ 231569 h 342004"/>
              <a:gd name="connsiteX4" fmla="*/ 9145230 w 9145230"/>
              <a:gd name="connsiteY4" fmla="*/ 0 h 342004"/>
              <a:gd name="connsiteX5" fmla="*/ 8039370 w 9145230"/>
              <a:gd name="connsiteY5" fmla="*/ 302822 h 342004"/>
              <a:gd name="connsiteX6" fmla="*/ 1230 w 9145230"/>
              <a:gd name="connsiteY6" fmla="*/ 307768 h 342004"/>
              <a:gd name="connsiteX7" fmla="*/ 55 w 9145230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5387 h 342004"/>
              <a:gd name="connsiteX7" fmla="*/ 1207 w 9146382"/>
              <a:gd name="connsiteY7" fmla="*/ 342004 h 342004"/>
              <a:gd name="connsiteX0" fmla="*/ 1207 w 9146382"/>
              <a:gd name="connsiteY0" fmla="*/ 339622 h 339622"/>
              <a:gd name="connsiteX1" fmla="*/ 8237920 w 9146382"/>
              <a:gd name="connsiteY1" fmla="*/ 338447 h 339622"/>
              <a:gd name="connsiteX2" fmla="*/ 8778247 w 9146382"/>
              <a:gd name="connsiteY2" fmla="*/ 296883 h 339622"/>
              <a:gd name="connsiteX3" fmla="*/ 9146382 w 9146382"/>
              <a:gd name="connsiteY3" fmla="*/ 231569 h 339622"/>
              <a:gd name="connsiteX4" fmla="*/ 9146382 w 9146382"/>
              <a:gd name="connsiteY4" fmla="*/ 0 h 339622"/>
              <a:gd name="connsiteX5" fmla="*/ 8040522 w 9146382"/>
              <a:gd name="connsiteY5" fmla="*/ 302822 h 339622"/>
              <a:gd name="connsiteX6" fmla="*/ 0 w 9146382"/>
              <a:gd name="connsiteY6" fmla="*/ 305387 h 339622"/>
              <a:gd name="connsiteX7" fmla="*/ 1207 w 9146382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2822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3685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4860 h 334860"/>
              <a:gd name="connsiteX1" fmla="*/ 8236768 w 9145230"/>
              <a:gd name="connsiteY1" fmla="*/ 333685 h 334860"/>
              <a:gd name="connsiteX2" fmla="*/ 8777095 w 9145230"/>
              <a:gd name="connsiteY2" fmla="*/ 296883 h 334860"/>
              <a:gd name="connsiteX3" fmla="*/ 9145230 w 9145230"/>
              <a:gd name="connsiteY3" fmla="*/ 231569 h 334860"/>
              <a:gd name="connsiteX4" fmla="*/ 9145230 w 9145230"/>
              <a:gd name="connsiteY4" fmla="*/ 0 h 334860"/>
              <a:gd name="connsiteX5" fmla="*/ 8039370 w 9145230"/>
              <a:gd name="connsiteY5" fmla="*/ 305204 h 334860"/>
              <a:gd name="connsiteX6" fmla="*/ 1230 w 9145230"/>
              <a:gd name="connsiteY6" fmla="*/ 305387 h 334860"/>
              <a:gd name="connsiteX7" fmla="*/ 55 w 9145230"/>
              <a:gd name="connsiteY7" fmla="*/ 334860 h 3348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9145230" h="334860">
                <a:moveTo>
                  <a:pt x="55" y="334860"/>
                </a:moveTo>
                <a:lnTo>
                  <a:pt x="8236768" y="333685"/>
                </a:lnTo>
                <a:cubicBezTo>
                  <a:pt x="8424021" y="326974"/>
                  <a:pt x="8625685" y="313902"/>
                  <a:pt x="8777095" y="296883"/>
                </a:cubicBezTo>
                <a:cubicBezTo>
                  <a:pt x="8928505" y="279864"/>
                  <a:pt x="9017756" y="262865"/>
                  <a:pt x="9145230" y="231569"/>
                </a:cubicBezTo>
                <a:lnTo>
                  <a:pt x="9145230" y="0"/>
                </a:lnTo>
                <a:cubicBezTo>
                  <a:pt x="8875194" y="176182"/>
                  <a:pt x="8573165" y="285660"/>
                  <a:pt x="8039370" y="305204"/>
                </a:cubicBezTo>
                <a:lnTo>
                  <a:pt x="1230" y="305387"/>
                </a:lnTo>
                <a:cubicBezTo>
                  <a:pt x="1632" y="318386"/>
                  <a:pt x="-347" y="321861"/>
                  <a:pt x="55" y="334860"/>
                </a:cubicBezTo>
                <a:close/>
              </a:path>
            </a:pathLst>
          </a:cu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254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正方形/長方形 15"/>
          <p:cNvSpPr/>
          <p:nvPr/>
        </p:nvSpPr>
        <p:spPr>
          <a:xfrm>
            <a:off x="0" y="6321600"/>
            <a:ext cx="9144000" cy="25200"/>
          </a:xfrm>
          <a:prstGeom prst="rect">
            <a:avLst/>
          </a:pr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12700" dir="16200000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187325"/>
            <a:ext cx="7355159" cy="544513"/>
          </a:xfrm>
        </p:spPr>
        <p:txBody>
          <a:bodyPr anchor="ctr">
            <a:normAutofit/>
          </a:bodyPr>
          <a:lstStyle>
            <a:lvl1pPr algn="l">
              <a:defRPr sz="3200" b="1" baseline="0"/>
            </a:lvl1pPr>
          </a:lstStyle>
          <a:p>
            <a:r>
              <a:rPr kumimoji="1" lang="ja-JP" altLang="en-US"/>
              <a:t>マスター タイトルの書式設定</a:t>
            </a:r>
            <a:endParaRPr kumimoji="1" lang="ja-JP" altLang="en-US" dirty="0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1014413"/>
            <a:ext cx="5111750" cy="5111750"/>
          </a:xfrm>
        </p:spPr>
        <p:txBody>
          <a:bodyPr>
            <a:normAutofit/>
          </a:bodyPr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JP" altLang="en-US" dirty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700213"/>
            <a:ext cx="3008313" cy="44259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8" name="テキスト プレースホルダー 7"/>
          <p:cNvSpPr>
            <a:spLocks noGrp="1"/>
          </p:cNvSpPr>
          <p:nvPr>
            <p:ph type="body" sz="quarter" idx="11"/>
          </p:nvPr>
        </p:nvSpPr>
        <p:spPr>
          <a:xfrm>
            <a:off x="457199" y="1014413"/>
            <a:ext cx="3008314" cy="685799"/>
          </a:xfrm>
        </p:spPr>
        <p:txBody>
          <a:bodyPr vert="horz" lIns="91440" tIns="45720" rIns="91440" bIns="45720" rtlCol="0" anchor="ctr">
            <a:normAutofit lnSpcReduction="10000"/>
          </a:bodyPr>
          <a:lstStyle>
            <a:lvl1pPr marL="0" indent="0">
              <a:buNone/>
              <a:defRPr lang="ja-JP" altLang="en-US" sz="2000" b="1" baseline="0" dirty="0" smtClean="0">
                <a:latin typeface="+mn-lt"/>
                <a:ea typeface="+mn-ea"/>
                <a:cs typeface="+mj-cs"/>
              </a:defRPr>
            </a:lvl1pPr>
            <a:lvl2pPr marL="171450" indent="0">
              <a:buNone/>
              <a:defRPr lang="ja-JP" altLang="en-US" sz="1800" dirty="0" smtClean="0"/>
            </a:lvl2pPr>
            <a:lvl3pPr marL="685800" indent="0">
              <a:buNone/>
              <a:defRPr lang="ja-JP" altLang="en-US" sz="1800" dirty="0" smtClean="0"/>
            </a:lvl3pPr>
            <a:lvl4pPr marL="1143000" indent="0">
              <a:buNone/>
              <a:defRPr lang="ja-JP" altLang="en-US" dirty="0" smtClean="0"/>
            </a:lvl4pPr>
            <a:lvl5pPr marL="1600200" indent="0">
              <a:buNone/>
              <a:defRPr lang="ja-JP" altLang="en-US" dirty="0"/>
            </a:lvl5pPr>
          </a:lstStyle>
          <a:p>
            <a:pPr marL="0" lvl="0">
              <a:lnSpc>
                <a:spcPct val="100000"/>
              </a:lnSpc>
              <a:spcBef>
                <a:spcPct val="0"/>
              </a:spcBef>
            </a:pPr>
            <a:r>
              <a:rPr kumimoji="1" lang="ja-JP" altLang="en-US"/>
              <a:t>マスター テキスト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3411235427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Picture with Caption: 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図 1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35380" y="76966"/>
            <a:ext cx="856731" cy="594588"/>
          </a:xfrm>
          <a:prstGeom prst="rect">
            <a:avLst/>
          </a:prstGeom>
        </p:spPr>
      </p:pic>
      <p:sp>
        <p:nvSpPr>
          <p:cNvPr id="15" name="フリーフォーム 14"/>
          <p:cNvSpPr/>
          <p:nvPr/>
        </p:nvSpPr>
        <p:spPr>
          <a:xfrm>
            <a:off x="-1231" y="451262"/>
            <a:ext cx="9145230" cy="334860"/>
          </a:xfrm>
          <a:custGeom>
            <a:avLst/>
            <a:gdLst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5938 w 9149938"/>
              <a:gd name="connsiteY7" fmla="*/ 231569 h 344385"/>
              <a:gd name="connsiteX8" fmla="*/ 0 w 9149938"/>
              <a:gd name="connsiteY8" fmla="*/ 344385 h 344385"/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10700 w 9149938"/>
              <a:gd name="connsiteY7" fmla="*/ 300625 h 344385"/>
              <a:gd name="connsiteX8" fmla="*/ 0 w 9149938"/>
              <a:gd name="connsiteY8" fmla="*/ 344385 h 344385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25019 w 9139238"/>
              <a:gd name="connsiteY0" fmla="*/ 399154 h 399154"/>
              <a:gd name="connsiteX1" fmla="*/ 8230776 w 9139238"/>
              <a:gd name="connsiteY1" fmla="*/ 338447 h 399154"/>
              <a:gd name="connsiteX2" fmla="*/ 8771103 w 9139238"/>
              <a:gd name="connsiteY2" fmla="*/ 296883 h 399154"/>
              <a:gd name="connsiteX3" fmla="*/ 9139238 w 9139238"/>
              <a:gd name="connsiteY3" fmla="*/ 231569 h 399154"/>
              <a:gd name="connsiteX4" fmla="*/ 9139238 w 9139238"/>
              <a:gd name="connsiteY4" fmla="*/ 0 h 399154"/>
              <a:gd name="connsiteX5" fmla="*/ 8747352 w 9139238"/>
              <a:gd name="connsiteY5" fmla="*/ 201881 h 399154"/>
              <a:gd name="connsiteX6" fmla="*/ 8135773 w 9139238"/>
              <a:gd name="connsiteY6" fmla="*/ 302821 h 399154"/>
              <a:gd name="connsiteX7" fmla="*/ 0 w 9139238"/>
              <a:gd name="connsiteY7" fmla="*/ 300625 h 399154"/>
              <a:gd name="connsiteX8" fmla="*/ 25019 w 9139238"/>
              <a:gd name="connsiteY8" fmla="*/ 399154 h 39915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5937 w 9145175"/>
              <a:gd name="connsiteY7" fmla="*/ 300625 h 342004"/>
              <a:gd name="connsiteX8" fmla="*/ 0 w 9145175"/>
              <a:gd name="connsiteY8" fmla="*/ 342004 h 34200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120237 w 9145175"/>
              <a:gd name="connsiteY7" fmla="*/ 255381 h 342004"/>
              <a:gd name="connsiteX8" fmla="*/ 0 w 9145175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142917 w 9146382"/>
              <a:gd name="connsiteY6" fmla="*/ 302821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55 w 9145230"/>
              <a:gd name="connsiteY0" fmla="*/ 342004 h 342004"/>
              <a:gd name="connsiteX1" fmla="*/ 8236768 w 9145230"/>
              <a:gd name="connsiteY1" fmla="*/ 338447 h 342004"/>
              <a:gd name="connsiteX2" fmla="*/ 8777095 w 9145230"/>
              <a:gd name="connsiteY2" fmla="*/ 296883 h 342004"/>
              <a:gd name="connsiteX3" fmla="*/ 9145230 w 9145230"/>
              <a:gd name="connsiteY3" fmla="*/ 231569 h 342004"/>
              <a:gd name="connsiteX4" fmla="*/ 9145230 w 9145230"/>
              <a:gd name="connsiteY4" fmla="*/ 0 h 342004"/>
              <a:gd name="connsiteX5" fmla="*/ 8039370 w 9145230"/>
              <a:gd name="connsiteY5" fmla="*/ 302822 h 342004"/>
              <a:gd name="connsiteX6" fmla="*/ 1230 w 9145230"/>
              <a:gd name="connsiteY6" fmla="*/ 307768 h 342004"/>
              <a:gd name="connsiteX7" fmla="*/ 55 w 9145230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5387 h 342004"/>
              <a:gd name="connsiteX7" fmla="*/ 1207 w 9146382"/>
              <a:gd name="connsiteY7" fmla="*/ 342004 h 342004"/>
              <a:gd name="connsiteX0" fmla="*/ 1207 w 9146382"/>
              <a:gd name="connsiteY0" fmla="*/ 339622 h 339622"/>
              <a:gd name="connsiteX1" fmla="*/ 8237920 w 9146382"/>
              <a:gd name="connsiteY1" fmla="*/ 338447 h 339622"/>
              <a:gd name="connsiteX2" fmla="*/ 8778247 w 9146382"/>
              <a:gd name="connsiteY2" fmla="*/ 296883 h 339622"/>
              <a:gd name="connsiteX3" fmla="*/ 9146382 w 9146382"/>
              <a:gd name="connsiteY3" fmla="*/ 231569 h 339622"/>
              <a:gd name="connsiteX4" fmla="*/ 9146382 w 9146382"/>
              <a:gd name="connsiteY4" fmla="*/ 0 h 339622"/>
              <a:gd name="connsiteX5" fmla="*/ 8040522 w 9146382"/>
              <a:gd name="connsiteY5" fmla="*/ 302822 h 339622"/>
              <a:gd name="connsiteX6" fmla="*/ 0 w 9146382"/>
              <a:gd name="connsiteY6" fmla="*/ 305387 h 339622"/>
              <a:gd name="connsiteX7" fmla="*/ 1207 w 9146382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2822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3685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4860 h 334860"/>
              <a:gd name="connsiteX1" fmla="*/ 8236768 w 9145230"/>
              <a:gd name="connsiteY1" fmla="*/ 333685 h 334860"/>
              <a:gd name="connsiteX2" fmla="*/ 8777095 w 9145230"/>
              <a:gd name="connsiteY2" fmla="*/ 296883 h 334860"/>
              <a:gd name="connsiteX3" fmla="*/ 9145230 w 9145230"/>
              <a:gd name="connsiteY3" fmla="*/ 231569 h 334860"/>
              <a:gd name="connsiteX4" fmla="*/ 9145230 w 9145230"/>
              <a:gd name="connsiteY4" fmla="*/ 0 h 334860"/>
              <a:gd name="connsiteX5" fmla="*/ 8039370 w 9145230"/>
              <a:gd name="connsiteY5" fmla="*/ 305204 h 334860"/>
              <a:gd name="connsiteX6" fmla="*/ 1230 w 9145230"/>
              <a:gd name="connsiteY6" fmla="*/ 305387 h 334860"/>
              <a:gd name="connsiteX7" fmla="*/ 55 w 9145230"/>
              <a:gd name="connsiteY7" fmla="*/ 334860 h 3348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9145230" h="334860">
                <a:moveTo>
                  <a:pt x="55" y="334860"/>
                </a:moveTo>
                <a:lnTo>
                  <a:pt x="8236768" y="333685"/>
                </a:lnTo>
                <a:cubicBezTo>
                  <a:pt x="8424021" y="326974"/>
                  <a:pt x="8625685" y="313902"/>
                  <a:pt x="8777095" y="296883"/>
                </a:cubicBezTo>
                <a:cubicBezTo>
                  <a:pt x="8928505" y="279864"/>
                  <a:pt x="9017756" y="262865"/>
                  <a:pt x="9145230" y="231569"/>
                </a:cubicBezTo>
                <a:lnTo>
                  <a:pt x="9145230" y="0"/>
                </a:lnTo>
                <a:cubicBezTo>
                  <a:pt x="8875194" y="176182"/>
                  <a:pt x="8573165" y="285660"/>
                  <a:pt x="8039370" y="305204"/>
                </a:cubicBezTo>
                <a:lnTo>
                  <a:pt x="1230" y="305387"/>
                </a:lnTo>
                <a:cubicBezTo>
                  <a:pt x="1632" y="318386"/>
                  <a:pt x="-347" y="321861"/>
                  <a:pt x="55" y="334860"/>
                </a:cubicBezTo>
                <a:close/>
              </a:path>
            </a:pathLst>
          </a:cu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254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正方形/長方形 15"/>
          <p:cNvSpPr/>
          <p:nvPr/>
        </p:nvSpPr>
        <p:spPr>
          <a:xfrm>
            <a:off x="0" y="6321600"/>
            <a:ext cx="9144000" cy="25200"/>
          </a:xfrm>
          <a:prstGeom prst="rect">
            <a:avLst/>
          </a:pr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12700" dir="16200000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187325"/>
            <a:ext cx="7355160" cy="544513"/>
          </a:xfrm>
        </p:spPr>
        <p:txBody>
          <a:bodyPr anchor="ctr">
            <a:normAutofit/>
          </a:bodyPr>
          <a:lstStyle>
            <a:lvl1pPr algn="l">
              <a:defRPr sz="3200" b="1"/>
            </a:lvl1pPr>
          </a:lstStyle>
          <a:p>
            <a:r>
              <a:rPr kumimoji="1" lang="ja-JP" altLang="en-US"/>
              <a:t>マスター タイトルの書式設定</a:t>
            </a:r>
            <a:endParaRPr kumimoji="1" lang="ja-JP" altLang="en-US" dirty="0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1014412"/>
            <a:ext cx="5486400" cy="3709987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kumimoji="1" lang="ja-JP" altLang="en-US"/>
              <a:t>アイコンをクリックして図を追加</a:t>
            </a:r>
            <a:endParaRPr kumimoji="1" lang="ja-JP" altLang="en-US" dirty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771525"/>
          </a:xfrm>
        </p:spPr>
        <p:txBody>
          <a:bodyPr/>
          <a:lstStyle>
            <a:lvl1pPr marL="0" indent="0">
              <a:buNone/>
              <a:defRPr sz="1400" baseline="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テキスト プレースホルダー 6"/>
          <p:cNvSpPr>
            <a:spLocks noGrp="1"/>
          </p:cNvSpPr>
          <p:nvPr>
            <p:ph type="body" sz="quarter" idx="11"/>
          </p:nvPr>
        </p:nvSpPr>
        <p:spPr>
          <a:xfrm>
            <a:off x="1792288" y="4791338"/>
            <a:ext cx="5486400" cy="576000"/>
          </a:xfrm>
        </p:spPr>
        <p:txBody>
          <a:bodyPr vert="horz" lIns="91440" tIns="45720" rIns="91440" bIns="45720" rtlCol="0" anchor="ctr">
            <a:normAutofit/>
          </a:bodyPr>
          <a:lstStyle>
            <a:lvl1pPr marL="342900" indent="-342900">
              <a:buNone/>
              <a:defRPr lang="ja-JP" altLang="en-US" sz="2000" b="1" smtClean="0"/>
            </a:lvl1pPr>
            <a:lvl2pPr>
              <a:defRPr lang="ja-JP" altLang="en-US" sz="1200" smtClean="0"/>
            </a:lvl2pPr>
            <a:lvl3pPr>
              <a:defRPr lang="ja-JP" altLang="en-US" sz="1000" smtClean="0"/>
            </a:lvl3pPr>
            <a:lvl4pPr>
              <a:defRPr lang="ja-JP" altLang="en-US" sz="900" smtClean="0"/>
            </a:lvl4pPr>
            <a:lvl5pPr>
              <a:defRPr lang="ja-JP" altLang="en-US" sz="900"/>
            </a:lvl5pPr>
          </a:lstStyle>
          <a:p>
            <a:pPr marL="0" lvl="0" indent="0"/>
            <a:r>
              <a:rPr kumimoji="1" lang="ja-JP" altLang="en-US"/>
              <a:t>マスター テキスト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3149592997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35380" y="76966"/>
            <a:ext cx="856731" cy="594588"/>
          </a:xfrm>
          <a:prstGeom prst="rect">
            <a:avLst/>
          </a:prstGeom>
        </p:spPr>
      </p:pic>
      <p:sp>
        <p:nvSpPr>
          <p:cNvPr id="12" name="フリーフォーム 11"/>
          <p:cNvSpPr/>
          <p:nvPr/>
        </p:nvSpPr>
        <p:spPr>
          <a:xfrm>
            <a:off x="-1231" y="451262"/>
            <a:ext cx="9145230" cy="334860"/>
          </a:xfrm>
          <a:custGeom>
            <a:avLst/>
            <a:gdLst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5938 w 9149938"/>
              <a:gd name="connsiteY7" fmla="*/ 231569 h 344385"/>
              <a:gd name="connsiteX8" fmla="*/ 0 w 9149938"/>
              <a:gd name="connsiteY8" fmla="*/ 344385 h 344385"/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10700 w 9149938"/>
              <a:gd name="connsiteY7" fmla="*/ 300625 h 344385"/>
              <a:gd name="connsiteX8" fmla="*/ 0 w 9149938"/>
              <a:gd name="connsiteY8" fmla="*/ 344385 h 344385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25019 w 9139238"/>
              <a:gd name="connsiteY0" fmla="*/ 399154 h 399154"/>
              <a:gd name="connsiteX1" fmla="*/ 8230776 w 9139238"/>
              <a:gd name="connsiteY1" fmla="*/ 338447 h 399154"/>
              <a:gd name="connsiteX2" fmla="*/ 8771103 w 9139238"/>
              <a:gd name="connsiteY2" fmla="*/ 296883 h 399154"/>
              <a:gd name="connsiteX3" fmla="*/ 9139238 w 9139238"/>
              <a:gd name="connsiteY3" fmla="*/ 231569 h 399154"/>
              <a:gd name="connsiteX4" fmla="*/ 9139238 w 9139238"/>
              <a:gd name="connsiteY4" fmla="*/ 0 h 399154"/>
              <a:gd name="connsiteX5" fmla="*/ 8747352 w 9139238"/>
              <a:gd name="connsiteY5" fmla="*/ 201881 h 399154"/>
              <a:gd name="connsiteX6" fmla="*/ 8135773 w 9139238"/>
              <a:gd name="connsiteY6" fmla="*/ 302821 h 399154"/>
              <a:gd name="connsiteX7" fmla="*/ 0 w 9139238"/>
              <a:gd name="connsiteY7" fmla="*/ 300625 h 399154"/>
              <a:gd name="connsiteX8" fmla="*/ 25019 w 9139238"/>
              <a:gd name="connsiteY8" fmla="*/ 399154 h 39915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5937 w 9145175"/>
              <a:gd name="connsiteY7" fmla="*/ 300625 h 342004"/>
              <a:gd name="connsiteX8" fmla="*/ 0 w 9145175"/>
              <a:gd name="connsiteY8" fmla="*/ 342004 h 34200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120237 w 9145175"/>
              <a:gd name="connsiteY7" fmla="*/ 255381 h 342004"/>
              <a:gd name="connsiteX8" fmla="*/ 0 w 9145175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142917 w 9146382"/>
              <a:gd name="connsiteY6" fmla="*/ 302821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55 w 9145230"/>
              <a:gd name="connsiteY0" fmla="*/ 342004 h 342004"/>
              <a:gd name="connsiteX1" fmla="*/ 8236768 w 9145230"/>
              <a:gd name="connsiteY1" fmla="*/ 338447 h 342004"/>
              <a:gd name="connsiteX2" fmla="*/ 8777095 w 9145230"/>
              <a:gd name="connsiteY2" fmla="*/ 296883 h 342004"/>
              <a:gd name="connsiteX3" fmla="*/ 9145230 w 9145230"/>
              <a:gd name="connsiteY3" fmla="*/ 231569 h 342004"/>
              <a:gd name="connsiteX4" fmla="*/ 9145230 w 9145230"/>
              <a:gd name="connsiteY4" fmla="*/ 0 h 342004"/>
              <a:gd name="connsiteX5" fmla="*/ 8039370 w 9145230"/>
              <a:gd name="connsiteY5" fmla="*/ 302822 h 342004"/>
              <a:gd name="connsiteX6" fmla="*/ 1230 w 9145230"/>
              <a:gd name="connsiteY6" fmla="*/ 307768 h 342004"/>
              <a:gd name="connsiteX7" fmla="*/ 55 w 9145230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5387 h 342004"/>
              <a:gd name="connsiteX7" fmla="*/ 1207 w 9146382"/>
              <a:gd name="connsiteY7" fmla="*/ 342004 h 342004"/>
              <a:gd name="connsiteX0" fmla="*/ 1207 w 9146382"/>
              <a:gd name="connsiteY0" fmla="*/ 339622 h 339622"/>
              <a:gd name="connsiteX1" fmla="*/ 8237920 w 9146382"/>
              <a:gd name="connsiteY1" fmla="*/ 338447 h 339622"/>
              <a:gd name="connsiteX2" fmla="*/ 8778247 w 9146382"/>
              <a:gd name="connsiteY2" fmla="*/ 296883 h 339622"/>
              <a:gd name="connsiteX3" fmla="*/ 9146382 w 9146382"/>
              <a:gd name="connsiteY3" fmla="*/ 231569 h 339622"/>
              <a:gd name="connsiteX4" fmla="*/ 9146382 w 9146382"/>
              <a:gd name="connsiteY4" fmla="*/ 0 h 339622"/>
              <a:gd name="connsiteX5" fmla="*/ 8040522 w 9146382"/>
              <a:gd name="connsiteY5" fmla="*/ 302822 h 339622"/>
              <a:gd name="connsiteX6" fmla="*/ 0 w 9146382"/>
              <a:gd name="connsiteY6" fmla="*/ 305387 h 339622"/>
              <a:gd name="connsiteX7" fmla="*/ 1207 w 9146382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2822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3685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4860 h 334860"/>
              <a:gd name="connsiteX1" fmla="*/ 8236768 w 9145230"/>
              <a:gd name="connsiteY1" fmla="*/ 333685 h 334860"/>
              <a:gd name="connsiteX2" fmla="*/ 8777095 w 9145230"/>
              <a:gd name="connsiteY2" fmla="*/ 296883 h 334860"/>
              <a:gd name="connsiteX3" fmla="*/ 9145230 w 9145230"/>
              <a:gd name="connsiteY3" fmla="*/ 231569 h 334860"/>
              <a:gd name="connsiteX4" fmla="*/ 9145230 w 9145230"/>
              <a:gd name="connsiteY4" fmla="*/ 0 h 334860"/>
              <a:gd name="connsiteX5" fmla="*/ 8039370 w 9145230"/>
              <a:gd name="connsiteY5" fmla="*/ 305204 h 334860"/>
              <a:gd name="connsiteX6" fmla="*/ 1230 w 9145230"/>
              <a:gd name="connsiteY6" fmla="*/ 305387 h 334860"/>
              <a:gd name="connsiteX7" fmla="*/ 55 w 9145230"/>
              <a:gd name="connsiteY7" fmla="*/ 334860 h 3348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9145230" h="334860">
                <a:moveTo>
                  <a:pt x="55" y="334860"/>
                </a:moveTo>
                <a:lnTo>
                  <a:pt x="8236768" y="333685"/>
                </a:lnTo>
                <a:cubicBezTo>
                  <a:pt x="8424021" y="326974"/>
                  <a:pt x="8625685" y="313902"/>
                  <a:pt x="8777095" y="296883"/>
                </a:cubicBezTo>
                <a:cubicBezTo>
                  <a:pt x="8928505" y="279864"/>
                  <a:pt x="9017756" y="262865"/>
                  <a:pt x="9145230" y="231569"/>
                </a:cubicBezTo>
                <a:lnTo>
                  <a:pt x="9145230" y="0"/>
                </a:lnTo>
                <a:cubicBezTo>
                  <a:pt x="8875194" y="176182"/>
                  <a:pt x="8573165" y="285660"/>
                  <a:pt x="8039370" y="305204"/>
                </a:cubicBezTo>
                <a:lnTo>
                  <a:pt x="1230" y="305387"/>
                </a:lnTo>
                <a:cubicBezTo>
                  <a:pt x="1632" y="318386"/>
                  <a:pt x="-347" y="321861"/>
                  <a:pt x="55" y="334860"/>
                </a:cubicBezTo>
                <a:close/>
              </a:path>
            </a:pathLst>
          </a:cu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254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正方形/長方形 12"/>
          <p:cNvSpPr/>
          <p:nvPr/>
        </p:nvSpPr>
        <p:spPr>
          <a:xfrm>
            <a:off x="0" y="6321600"/>
            <a:ext cx="9144000" cy="25200"/>
          </a:xfrm>
          <a:prstGeom prst="rect">
            <a:avLst/>
          </a:pr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12700" dir="16200000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>
            <a:lvl1pPr>
              <a:defRPr baseline="0">
                <a:latin typeface="メイリオ" panose="020B0604030504040204" pitchFamily="50" charset="-128"/>
                <a:ea typeface="メイリオ" panose="020B0604030504040204" pitchFamily="50" charset="-128"/>
              </a:defRPr>
            </a:lvl1pPr>
            <a:lvl2pPr>
              <a:defRPr baseline="0">
                <a:latin typeface="メイリオ" panose="020B0604030504040204" pitchFamily="50" charset="-128"/>
                <a:ea typeface="メイリオ" panose="020B0604030504040204" pitchFamily="50" charset="-128"/>
              </a:defRPr>
            </a:lvl2pPr>
            <a:lvl3pPr>
              <a:defRPr baseline="0">
                <a:latin typeface="メイリオ" panose="020B0604030504040204" pitchFamily="50" charset="-128"/>
                <a:ea typeface="メイリオ" panose="020B0604030504040204" pitchFamily="50" charset="-128"/>
              </a:defRPr>
            </a:lvl3pPr>
            <a:lvl4pPr>
              <a:defRPr baseline="0">
                <a:latin typeface="メイリオ" panose="020B0604030504040204" pitchFamily="50" charset="-128"/>
                <a:ea typeface="メイリオ" panose="020B0604030504040204" pitchFamily="50" charset="-128"/>
              </a:defRPr>
            </a:lvl4pPr>
            <a:lvl5pPr>
              <a:defRPr baseline="0">
                <a:latin typeface="メイリオ" panose="020B0604030504040204" pitchFamily="50" charset="-128"/>
                <a:ea typeface="メイリオ" panose="020B0604030504040204" pitchFamily="50" charset="-128"/>
              </a:defRPr>
            </a:lvl5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JP" alt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3081450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図 1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35380" y="76966"/>
            <a:ext cx="856731" cy="594588"/>
          </a:xfrm>
          <a:prstGeom prst="rect">
            <a:avLst/>
          </a:prstGeom>
        </p:spPr>
      </p:pic>
      <p:sp>
        <p:nvSpPr>
          <p:cNvPr id="14" name="フリーフォーム 13"/>
          <p:cNvSpPr/>
          <p:nvPr/>
        </p:nvSpPr>
        <p:spPr>
          <a:xfrm>
            <a:off x="-1231" y="451262"/>
            <a:ext cx="9145230" cy="334860"/>
          </a:xfrm>
          <a:custGeom>
            <a:avLst/>
            <a:gdLst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5938 w 9149938"/>
              <a:gd name="connsiteY7" fmla="*/ 231569 h 344385"/>
              <a:gd name="connsiteX8" fmla="*/ 0 w 9149938"/>
              <a:gd name="connsiteY8" fmla="*/ 344385 h 344385"/>
              <a:gd name="connsiteX0" fmla="*/ 0 w 9149938"/>
              <a:gd name="connsiteY0" fmla="*/ 344385 h 344385"/>
              <a:gd name="connsiteX1" fmla="*/ 8241476 w 9149938"/>
              <a:gd name="connsiteY1" fmla="*/ 338447 h 344385"/>
              <a:gd name="connsiteX2" fmla="*/ 8781803 w 9149938"/>
              <a:gd name="connsiteY2" fmla="*/ 296883 h 344385"/>
              <a:gd name="connsiteX3" fmla="*/ 9149938 w 9149938"/>
              <a:gd name="connsiteY3" fmla="*/ 231569 h 344385"/>
              <a:gd name="connsiteX4" fmla="*/ 9149938 w 9149938"/>
              <a:gd name="connsiteY4" fmla="*/ 0 h 344385"/>
              <a:gd name="connsiteX5" fmla="*/ 8758052 w 9149938"/>
              <a:gd name="connsiteY5" fmla="*/ 201881 h 344385"/>
              <a:gd name="connsiteX6" fmla="*/ 8146473 w 9149938"/>
              <a:gd name="connsiteY6" fmla="*/ 302821 h 344385"/>
              <a:gd name="connsiteX7" fmla="*/ 10700 w 9149938"/>
              <a:gd name="connsiteY7" fmla="*/ 300625 h 344385"/>
              <a:gd name="connsiteX8" fmla="*/ 0 w 9149938"/>
              <a:gd name="connsiteY8" fmla="*/ 344385 h 344385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3588 w 9139238"/>
              <a:gd name="connsiteY0" fmla="*/ 342004 h 342004"/>
              <a:gd name="connsiteX1" fmla="*/ 8230776 w 9139238"/>
              <a:gd name="connsiteY1" fmla="*/ 338447 h 342004"/>
              <a:gd name="connsiteX2" fmla="*/ 8771103 w 9139238"/>
              <a:gd name="connsiteY2" fmla="*/ 296883 h 342004"/>
              <a:gd name="connsiteX3" fmla="*/ 9139238 w 9139238"/>
              <a:gd name="connsiteY3" fmla="*/ 231569 h 342004"/>
              <a:gd name="connsiteX4" fmla="*/ 9139238 w 9139238"/>
              <a:gd name="connsiteY4" fmla="*/ 0 h 342004"/>
              <a:gd name="connsiteX5" fmla="*/ 8747352 w 9139238"/>
              <a:gd name="connsiteY5" fmla="*/ 201881 h 342004"/>
              <a:gd name="connsiteX6" fmla="*/ 8135773 w 9139238"/>
              <a:gd name="connsiteY6" fmla="*/ 302821 h 342004"/>
              <a:gd name="connsiteX7" fmla="*/ 0 w 9139238"/>
              <a:gd name="connsiteY7" fmla="*/ 300625 h 342004"/>
              <a:gd name="connsiteX8" fmla="*/ 3588 w 9139238"/>
              <a:gd name="connsiteY8" fmla="*/ 342004 h 342004"/>
              <a:gd name="connsiteX0" fmla="*/ 25019 w 9139238"/>
              <a:gd name="connsiteY0" fmla="*/ 399154 h 399154"/>
              <a:gd name="connsiteX1" fmla="*/ 8230776 w 9139238"/>
              <a:gd name="connsiteY1" fmla="*/ 338447 h 399154"/>
              <a:gd name="connsiteX2" fmla="*/ 8771103 w 9139238"/>
              <a:gd name="connsiteY2" fmla="*/ 296883 h 399154"/>
              <a:gd name="connsiteX3" fmla="*/ 9139238 w 9139238"/>
              <a:gd name="connsiteY3" fmla="*/ 231569 h 399154"/>
              <a:gd name="connsiteX4" fmla="*/ 9139238 w 9139238"/>
              <a:gd name="connsiteY4" fmla="*/ 0 h 399154"/>
              <a:gd name="connsiteX5" fmla="*/ 8747352 w 9139238"/>
              <a:gd name="connsiteY5" fmla="*/ 201881 h 399154"/>
              <a:gd name="connsiteX6" fmla="*/ 8135773 w 9139238"/>
              <a:gd name="connsiteY6" fmla="*/ 302821 h 399154"/>
              <a:gd name="connsiteX7" fmla="*/ 0 w 9139238"/>
              <a:gd name="connsiteY7" fmla="*/ 300625 h 399154"/>
              <a:gd name="connsiteX8" fmla="*/ 25019 w 9139238"/>
              <a:gd name="connsiteY8" fmla="*/ 399154 h 39915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5937 w 9145175"/>
              <a:gd name="connsiteY7" fmla="*/ 300625 h 342004"/>
              <a:gd name="connsiteX8" fmla="*/ 0 w 9145175"/>
              <a:gd name="connsiteY8" fmla="*/ 342004 h 342004"/>
              <a:gd name="connsiteX0" fmla="*/ 0 w 9145175"/>
              <a:gd name="connsiteY0" fmla="*/ 342004 h 342004"/>
              <a:gd name="connsiteX1" fmla="*/ 8236713 w 9145175"/>
              <a:gd name="connsiteY1" fmla="*/ 338447 h 342004"/>
              <a:gd name="connsiteX2" fmla="*/ 8777040 w 9145175"/>
              <a:gd name="connsiteY2" fmla="*/ 296883 h 342004"/>
              <a:gd name="connsiteX3" fmla="*/ 9145175 w 9145175"/>
              <a:gd name="connsiteY3" fmla="*/ 231569 h 342004"/>
              <a:gd name="connsiteX4" fmla="*/ 9145175 w 9145175"/>
              <a:gd name="connsiteY4" fmla="*/ 0 h 342004"/>
              <a:gd name="connsiteX5" fmla="*/ 8753289 w 9145175"/>
              <a:gd name="connsiteY5" fmla="*/ 201881 h 342004"/>
              <a:gd name="connsiteX6" fmla="*/ 8141710 w 9145175"/>
              <a:gd name="connsiteY6" fmla="*/ 302821 h 342004"/>
              <a:gd name="connsiteX7" fmla="*/ 120237 w 9145175"/>
              <a:gd name="connsiteY7" fmla="*/ 255381 h 342004"/>
              <a:gd name="connsiteX8" fmla="*/ 0 w 9145175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142917 w 9146382"/>
              <a:gd name="connsiteY6" fmla="*/ 302821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54496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64335 w 9146382"/>
              <a:gd name="connsiteY6" fmla="*/ 305203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1881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723540 w 9146382"/>
              <a:gd name="connsiteY5" fmla="*/ 204263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675915 w 9146382"/>
              <a:gd name="connsiteY5" fmla="*/ 213788 h 342004"/>
              <a:gd name="connsiteX6" fmla="*/ 8040522 w 9146382"/>
              <a:gd name="connsiteY6" fmla="*/ 302822 h 342004"/>
              <a:gd name="connsiteX7" fmla="*/ 0 w 9146382"/>
              <a:gd name="connsiteY7" fmla="*/ 303006 h 342004"/>
              <a:gd name="connsiteX8" fmla="*/ 1207 w 9146382"/>
              <a:gd name="connsiteY8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3006 h 342004"/>
              <a:gd name="connsiteX7" fmla="*/ 1207 w 9146382"/>
              <a:gd name="connsiteY7" fmla="*/ 342004 h 342004"/>
              <a:gd name="connsiteX0" fmla="*/ 55 w 9145230"/>
              <a:gd name="connsiteY0" fmla="*/ 342004 h 342004"/>
              <a:gd name="connsiteX1" fmla="*/ 8236768 w 9145230"/>
              <a:gd name="connsiteY1" fmla="*/ 338447 h 342004"/>
              <a:gd name="connsiteX2" fmla="*/ 8777095 w 9145230"/>
              <a:gd name="connsiteY2" fmla="*/ 296883 h 342004"/>
              <a:gd name="connsiteX3" fmla="*/ 9145230 w 9145230"/>
              <a:gd name="connsiteY3" fmla="*/ 231569 h 342004"/>
              <a:gd name="connsiteX4" fmla="*/ 9145230 w 9145230"/>
              <a:gd name="connsiteY4" fmla="*/ 0 h 342004"/>
              <a:gd name="connsiteX5" fmla="*/ 8039370 w 9145230"/>
              <a:gd name="connsiteY5" fmla="*/ 302822 h 342004"/>
              <a:gd name="connsiteX6" fmla="*/ 1230 w 9145230"/>
              <a:gd name="connsiteY6" fmla="*/ 307768 h 342004"/>
              <a:gd name="connsiteX7" fmla="*/ 55 w 9145230"/>
              <a:gd name="connsiteY7" fmla="*/ 342004 h 342004"/>
              <a:gd name="connsiteX0" fmla="*/ 1207 w 9146382"/>
              <a:gd name="connsiteY0" fmla="*/ 342004 h 342004"/>
              <a:gd name="connsiteX1" fmla="*/ 8237920 w 9146382"/>
              <a:gd name="connsiteY1" fmla="*/ 338447 h 342004"/>
              <a:gd name="connsiteX2" fmla="*/ 8778247 w 9146382"/>
              <a:gd name="connsiteY2" fmla="*/ 296883 h 342004"/>
              <a:gd name="connsiteX3" fmla="*/ 9146382 w 9146382"/>
              <a:gd name="connsiteY3" fmla="*/ 231569 h 342004"/>
              <a:gd name="connsiteX4" fmla="*/ 9146382 w 9146382"/>
              <a:gd name="connsiteY4" fmla="*/ 0 h 342004"/>
              <a:gd name="connsiteX5" fmla="*/ 8040522 w 9146382"/>
              <a:gd name="connsiteY5" fmla="*/ 302822 h 342004"/>
              <a:gd name="connsiteX6" fmla="*/ 0 w 9146382"/>
              <a:gd name="connsiteY6" fmla="*/ 305387 h 342004"/>
              <a:gd name="connsiteX7" fmla="*/ 1207 w 9146382"/>
              <a:gd name="connsiteY7" fmla="*/ 342004 h 342004"/>
              <a:gd name="connsiteX0" fmla="*/ 1207 w 9146382"/>
              <a:gd name="connsiteY0" fmla="*/ 339622 h 339622"/>
              <a:gd name="connsiteX1" fmla="*/ 8237920 w 9146382"/>
              <a:gd name="connsiteY1" fmla="*/ 338447 h 339622"/>
              <a:gd name="connsiteX2" fmla="*/ 8778247 w 9146382"/>
              <a:gd name="connsiteY2" fmla="*/ 296883 h 339622"/>
              <a:gd name="connsiteX3" fmla="*/ 9146382 w 9146382"/>
              <a:gd name="connsiteY3" fmla="*/ 231569 h 339622"/>
              <a:gd name="connsiteX4" fmla="*/ 9146382 w 9146382"/>
              <a:gd name="connsiteY4" fmla="*/ 0 h 339622"/>
              <a:gd name="connsiteX5" fmla="*/ 8040522 w 9146382"/>
              <a:gd name="connsiteY5" fmla="*/ 302822 h 339622"/>
              <a:gd name="connsiteX6" fmla="*/ 0 w 9146382"/>
              <a:gd name="connsiteY6" fmla="*/ 305387 h 339622"/>
              <a:gd name="connsiteX7" fmla="*/ 1207 w 9146382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2822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8447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9149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6066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9622 h 339622"/>
              <a:gd name="connsiteX1" fmla="*/ 8236768 w 9145230"/>
              <a:gd name="connsiteY1" fmla="*/ 333685 h 339622"/>
              <a:gd name="connsiteX2" fmla="*/ 8777095 w 9145230"/>
              <a:gd name="connsiteY2" fmla="*/ 296883 h 339622"/>
              <a:gd name="connsiteX3" fmla="*/ 9145230 w 9145230"/>
              <a:gd name="connsiteY3" fmla="*/ 231569 h 339622"/>
              <a:gd name="connsiteX4" fmla="*/ 9145230 w 9145230"/>
              <a:gd name="connsiteY4" fmla="*/ 0 h 339622"/>
              <a:gd name="connsiteX5" fmla="*/ 8039370 w 9145230"/>
              <a:gd name="connsiteY5" fmla="*/ 305204 h 339622"/>
              <a:gd name="connsiteX6" fmla="*/ 1230 w 9145230"/>
              <a:gd name="connsiteY6" fmla="*/ 305387 h 339622"/>
              <a:gd name="connsiteX7" fmla="*/ 55 w 9145230"/>
              <a:gd name="connsiteY7" fmla="*/ 339622 h 339622"/>
              <a:gd name="connsiteX0" fmla="*/ 55 w 9145230"/>
              <a:gd name="connsiteY0" fmla="*/ 334860 h 334860"/>
              <a:gd name="connsiteX1" fmla="*/ 8236768 w 9145230"/>
              <a:gd name="connsiteY1" fmla="*/ 333685 h 334860"/>
              <a:gd name="connsiteX2" fmla="*/ 8777095 w 9145230"/>
              <a:gd name="connsiteY2" fmla="*/ 296883 h 334860"/>
              <a:gd name="connsiteX3" fmla="*/ 9145230 w 9145230"/>
              <a:gd name="connsiteY3" fmla="*/ 231569 h 334860"/>
              <a:gd name="connsiteX4" fmla="*/ 9145230 w 9145230"/>
              <a:gd name="connsiteY4" fmla="*/ 0 h 334860"/>
              <a:gd name="connsiteX5" fmla="*/ 8039370 w 9145230"/>
              <a:gd name="connsiteY5" fmla="*/ 305204 h 334860"/>
              <a:gd name="connsiteX6" fmla="*/ 1230 w 9145230"/>
              <a:gd name="connsiteY6" fmla="*/ 305387 h 334860"/>
              <a:gd name="connsiteX7" fmla="*/ 55 w 9145230"/>
              <a:gd name="connsiteY7" fmla="*/ 334860 h 3348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9145230" h="334860">
                <a:moveTo>
                  <a:pt x="55" y="334860"/>
                </a:moveTo>
                <a:lnTo>
                  <a:pt x="8236768" y="333685"/>
                </a:lnTo>
                <a:cubicBezTo>
                  <a:pt x="8424021" y="326974"/>
                  <a:pt x="8625685" y="313902"/>
                  <a:pt x="8777095" y="296883"/>
                </a:cubicBezTo>
                <a:cubicBezTo>
                  <a:pt x="8928505" y="279864"/>
                  <a:pt x="9017756" y="262865"/>
                  <a:pt x="9145230" y="231569"/>
                </a:cubicBezTo>
                <a:lnTo>
                  <a:pt x="9145230" y="0"/>
                </a:lnTo>
                <a:cubicBezTo>
                  <a:pt x="8875194" y="176182"/>
                  <a:pt x="8573165" y="285660"/>
                  <a:pt x="8039370" y="305204"/>
                </a:cubicBezTo>
                <a:lnTo>
                  <a:pt x="1230" y="305387"/>
                </a:lnTo>
                <a:cubicBezTo>
                  <a:pt x="1632" y="318386"/>
                  <a:pt x="-347" y="321861"/>
                  <a:pt x="55" y="334860"/>
                </a:cubicBezTo>
                <a:close/>
              </a:path>
            </a:pathLst>
          </a:cu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254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正方形/長方形 14"/>
          <p:cNvSpPr/>
          <p:nvPr/>
        </p:nvSpPr>
        <p:spPr>
          <a:xfrm>
            <a:off x="0" y="6321600"/>
            <a:ext cx="9144000" cy="25200"/>
          </a:xfrm>
          <a:prstGeom prst="rect">
            <a:avLst/>
          </a:prstGeom>
          <a:solidFill>
            <a:schemeClr val="accent1"/>
          </a:solidFill>
          <a:ln w="3175">
            <a:solidFill>
              <a:schemeClr val="accent1"/>
            </a:solidFill>
          </a:ln>
          <a:effectLst>
            <a:outerShdw blurRad="50800" dist="12700" dir="16200000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57200" y="187325"/>
            <a:ext cx="7355160" cy="544514"/>
          </a:xfrm>
        </p:spPr>
        <p:txBody>
          <a:bodyPr vert="horz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199" y="1014413"/>
            <a:ext cx="6930189" cy="5111750"/>
          </a:xfrm>
        </p:spPr>
        <p:txBody>
          <a:bodyPr vert="eaVert"/>
          <a:lstStyle>
            <a:lvl1pPr>
              <a:defRPr baseline="0">
                <a:latin typeface="メイリオ" panose="020B0604030504040204" pitchFamily="50" charset="-128"/>
                <a:ea typeface="メイリオ" panose="020B0604030504040204" pitchFamily="50" charset="-128"/>
              </a:defRPr>
            </a:lvl1pPr>
            <a:lvl2pPr>
              <a:defRPr baseline="0">
                <a:latin typeface="メイリオ" panose="020B0604030504040204" pitchFamily="50" charset="-128"/>
                <a:ea typeface="メイリオ" panose="020B0604030504040204" pitchFamily="50" charset="-128"/>
              </a:defRPr>
            </a:lvl2pPr>
            <a:lvl3pPr>
              <a:defRPr baseline="0">
                <a:latin typeface="メイリオ" panose="020B0604030504040204" pitchFamily="50" charset="-128"/>
                <a:ea typeface="メイリオ" panose="020B0604030504040204" pitchFamily="50" charset="-128"/>
              </a:defRPr>
            </a:lvl3pPr>
            <a:lvl4pPr>
              <a:defRPr baseline="0">
                <a:latin typeface="メイリオ" panose="020B0604030504040204" pitchFamily="50" charset="-128"/>
                <a:ea typeface="メイリオ" panose="020B0604030504040204" pitchFamily="50" charset="-128"/>
              </a:defRPr>
            </a:lvl4pPr>
            <a:lvl5pPr>
              <a:defRPr baseline="0">
                <a:latin typeface="メイリオ" panose="020B0604030504040204" pitchFamily="50" charset="-128"/>
                <a:ea typeface="メイリオ" panose="020B0604030504040204" pitchFamily="50" charset="-128"/>
              </a:defRPr>
            </a:lvl5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縦書きテキスト プレースホルダー 6"/>
          <p:cNvSpPr>
            <a:spLocks noGrp="1"/>
          </p:cNvSpPr>
          <p:nvPr>
            <p:ph type="body" orient="vert" sz="quarter" idx="11"/>
          </p:nvPr>
        </p:nvSpPr>
        <p:spPr>
          <a:xfrm>
            <a:off x="7452320" y="1014413"/>
            <a:ext cx="1240830" cy="5111750"/>
          </a:xfrm>
        </p:spPr>
        <p:txBody>
          <a:bodyPr vert="eaVert" lIns="91440" tIns="45720" rIns="91440" bIns="45720" rtlCol="0" anchor="ctr">
            <a:noAutofit/>
          </a:bodyPr>
          <a:lstStyle>
            <a:lvl1pPr marL="0" indent="0">
              <a:buNone/>
              <a:defRPr lang="ja-JP" altLang="en-US" sz="3200" b="1" baseline="0" smtClean="0">
                <a:latin typeface="メイリオ" panose="020B0604030504040204" pitchFamily="50" charset="-128"/>
                <a:ea typeface="メイリオ" panose="020B0604030504040204" pitchFamily="50" charset="-128"/>
                <a:cs typeface="+mj-cs"/>
              </a:defRPr>
            </a:lvl1pPr>
            <a:lvl2pPr marL="171450" indent="0">
              <a:buNone/>
              <a:defRPr lang="ja-JP" altLang="en-US" sz="1800" smtClean="0"/>
            </a:lvl2pPr>
            <a:lvl3pPr marL="685800" indent="0">
              <a:buNone/>
              <a:defRPr lang="ja-JP" altLang="en-US" sz="1800" smtClean="0"/>
            </a:lvl3pPr>
            <a:lvl4pPr marL="1143000" indent="0">
              <a:buNone/>
              <a:defRPr lang="ja-JP" altLang="en-US" smtClean="0"/>
            </a:lvl4pPr>
            <a:lvl5pPr marL="1600200" indent="0">
              <a:buNone/>
              <a:defRPr lang="ja-JP" altLang="en-US"/>
            </a:lvl5pPr>
          </a:lstStyle>
          <a:p>
            <a:pPr marL="0" lvl="0">
              <a:lnSpc>
                <a:spcPct val="100000"/>
              </a:lnSpc>
              <a:spcBef>
                <a:spcPct val="0"/>
              </a:spcBef>
            </a:pPr>
            <a:r>
              <a:rPr kumimoji="1" lang="ja-JP" altLang="en-US"/>
              <a:t>マスター テキスト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8945410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0819334-A749-43FC-A2C1-919B6FD13D50}" type="datetime1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Segoe UI"/>
                <a:ea typeface="Meiryo UI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/7/2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2DABCC2-1EEF-4DDF-B308-B50BC011052B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Segoe UI"/>
                <a:ea typeface="Meiryo UI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2136112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2371E4E4-7A91-4712-B406-A494B5ED2AE0}" type="datetime1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Segoe UI"/>
                <a:ea typeface="Meiryo UI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/7/2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2DABCC2-1EEF-4DDF-B308-B50BC011052B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Segoe UI"/>
                <a:ea typeface="Meiryo UI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742600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0FAEA93-9899-4640-85B2-DE73BB0DEC15}" type="datetime1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Segoe UI"/>
                <a:ea typeface="Meiryo UI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/7/2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2DABCC2-1EEF-4DDF-B308-B50BC011052B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Segoe UI"/>
                <a:ea typeface="Meiryo UI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2426258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3C5C0E9-5EEE-460A-988A-9C3F6AAA524B}" type="datetime1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Segoe UI"/>
                <a:ea typeface="Meiryo UI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/7/2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2DABCC2-1EEF-4DDF-B308-B50BC011052B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Segoe UI"/>
                <a:ea typeface="Meiryo UI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9375209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2DCC90D-9657-4AAE-8663-70C0328A6566}" type="datetime1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Segoe UI"/>
                <a:ea typeface="Meiryo UI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/7/2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2DABCC2-1EEF-4DDF-B308-B50BC011052B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Segoe UI"/>
                <a:ea typeface="Meiryo UI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9367483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01EC908-EA25-4F33-8DA4-AD0411EB8BA7}" type="datetime1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Segoe UI"/>
                <a:ea typeface="Meiryo UI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/7/2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2DABCC2-1EEF-4DDF-B308-B50BC011052B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Segoe UI"/>
                <a:ea typeface="Meiryo UI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0800259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image" Target="../media/image1.png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0.xml"/><Relationship Id="rId13" Type="http://schemas.openxmlformats.org/officeDocument/2006/relationships/image" Target="../media/image1.png"/><Relationship Id="rId3" Type="http://schemas.openxmlformats.org/officeDocument/2006/relationships/slideLayout" Target="../slideLayouts/slideLayout25.xml"/><Relationship Id="rId7" Type="http://schemas.openxmlformats.org/officeDocument/2006/relationships/slideLayout" Target="../slideLayouts/slideLayout29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4.xml"/><Relationship Id="rId1" Type="http://schemas.openxmlformats.org/officeDocument/2006/relationships/slideLayout" Target="../slideLayouts/slideLayout23.xml"/><Relationship Id="rId6" Type="http://schemas.openxmlformats.org/officeDocument/2006/relationships/slideLayout" Target="../slideLayouts/slideLayout28.xml"/><Relationship Id="rId11" Type="http://schemas.openxmlformats.org/officeDocument/2006/relationships/slideLayout" Target="../slideLayouts/slideLayout33.xml"/><Relationship Id="rId5" Type="http://schemas.openxmlformats.org/officeDocument/2006/relationships/slideLayout" Target="../slideLayouts/slideLayout27.xml"/><Relationship Id="rId10" Type="http://schemas.openxmlformats.org/officeDocument/2006/relationships/slideLayout" Target="../slideLayouts/slideLayout32.xml"/><Relationship Id="rId4" Type="http://schemas.openxmlformats.org/officeDocument/2006/relationships/slideLayout" Target="../slideLayouts/slideLayout26.xml"/><Relationship Id="rId9" Type="http://schemas.openxmlformats.org/officeDocument/2006/relationships/slideLayout" Target="../slideLayouts/slideLayout3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DACFC5C6-8D9E-46CF-B709-95DD2D1A0F3E}" type="datetime1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Segoe UI"/>
                <a:ea typeface="Meiryo UI"/>
                <a:cs typeface="+mn-cs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/7/2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2DABCC2-1EEF-4DDF-B308-B50BC011052B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Segoe UI"/>
                <a:ea typeface="Meiryo UI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1295573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 bwMode="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187326"/>
            <a:ext cx="7355160" cy="54451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68314" y="1014413"/>
            <a:ext cx="8224836" cy="51244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  <a:endParaRPr kumimoji="1" lang="en-US" altLang="ja-JP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7885013" y="6424358"/>
            <a:ext cx="113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1A87B33B-7959-486E-ACDB-21B2725ABE16}" type="slidenum">
              <a:rPr kumimoji="1" lang="ja-JP" altLang="en-US" smtClean="0"/>
              <a:pPr algn="r"/>
              <a:t>‹#›</a:t>
            </a:fld>
            <a:endParaRPr kumimoji="1" lang="ja-JP" alt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3"/>
          </p:nvPr>
        </p:nvSpPr>
        <p:spPr>
          <a:xfrm>
            <a:off x="2358189" y="6689558"/>
            <a:ext cx="4427622" cy="1684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lumMod val="50000"/>
                    <a:lumOff val="50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pic>
        <p:nvPicPr>
          <p:cNvPr id="6" name="図 5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767" y="6478651"/>
            <a:ext cx="1270800" cy="2421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2408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85000"/>
        </a:lnSpc>
        <a:spcBef>
          <a:spcPct val="0"/>
        </a:spcBef>
        <a:buNone/>
        <a:defRPr kumimoji="1" sz="3200" b="1" kern="1200" baseline="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800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677863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400" kern="1200" baseline="0">
          <a:solidFill>
            <a:schemeClr val="tx1"/>
          </a:solidFill>
          <a:latin typeface="+mn-lt"/>
          <a:ea typeface="+mn-ea"/>
          <a:cs typeface="+mn-cs"/>
        </a:defRPr>
      </a:lvl2pPr>
      <a:lvl3pPr marL="998538" indent="-228600" algn="l" defTabSz="914400" rtl="0" eaLnBrk="1" latinLnBrk="0" hangingPunct="1">
        <a:spcBef>
          <a:spcPct val="20000"/>
        </a:spcBef>
        <a:buFont typeface="Segoe UI" panose="020B0502040204020203" pitchFamily="34" charset="0"/>
        <a:buChar char="&gt;"/>
        <a:defRPr kumimoji="1" sz="2000" kern="1200" baseline="0">
          <a:solidFill>
            <a:schemeClr val="tx1"/>
          </a:solidFill>
          <a:latin typeface="+mn-lt"/>
          <a:ea typeface="+mn-ea"/>
          <a:cs typeface="+mn-cs"/>
        </a:defRPr>
      </a:lvl3pPr>
      <a:lvl4pPr marL="132715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="/>
        <a:defRPr kumimoji="1" sz="1800" kern="1200" baseline="0">
          <a:solidFill>
            <a:schemeClr val="tx1"/>
          </a:solidFill>
          <a:latin typeface="+mn-lt"/>
          <a:ea typeface="+mn-ea"/>
          <a:cs typeface="+mn-cs"/>
        </a:defRPr>
      </a:lvl4pPr>
      <a:lvl5pPr marL="16637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1800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1976438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336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690813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051175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 bwMode="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187326"/>
            <a:ext cx="7355160" cy="54451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68314" y="1014413"/>
            <a:ext cx="8224836" cy="51244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  <a:endParaRPr kumimoji="1" lang="en-US" altLang="ja-JP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7885013" y="6424358"/>
            <a:ext cx="113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1A87B33B-7959-486E-ACDB-21B2725ABE16}" type="slidenum">
              <a:rPr kumimoji="1" lang="ja-JP" altLang="en-US" smtClean="0"/>
              <a:pPr algn="r"/>
              <a:t>‹#›</a:t>
            </a:fld>
            <a:endParaRPr kumimoji="1" lang="ja-JP" alt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3"/>
          </p:nvPr>
        </p:nvSpPr>
        <p:spPr>
          <a:xfrm>
            <a:off x="2358189" y="6689558"/>
            <a:ext cx="4427622" cy="1684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lumMod val="50000"/>
                    <a:lumOff val="50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pic>
        <p:nvPicPr>
          <p:cNvPr id="6" name="図 5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767" y="6478651"/>
            <a:ext cx="1270800" cy="2421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840545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hf hdr="0" ftr="0" dt="0"/>
  <p:txStyles>
    <p:titleStyle>
      <a:lvl1pPr algn="l" defTabSz="914400" rtl="0" eaLnBrk="1" latinLnBrk="0" hangingPunct="1">
        <a:lnSpc>
          <a:spcPct val="85000"/>
        </a:lnSpc>
        <a:spcBef>
          <a:spcPct val="0"/>
        </a:spcBef>
        <a:buNone/>
        <a:defRPr kumimoji="1" sz="3200" b="1" kern="1200" baseline="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800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677863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400" kern="1200" baseline="0">
          <a:solidFill>
            <a:schemeClr val="tx1"/>
          </a:solidFill>
          <a:latin typeface="+mn-lt"/>
          <a:ea typeface="+mn-ea"/>
          <a:cs typeface="+mn-cs"/>
        </a:defRPr>
      </a:lvl2pPr>
      <a:lvl3pPr marL="998538" indent="-228600" algn="l" defTabSz="914400" rtl="0" eaLnBrk="1" latinLnBrk="0" hangingPunct="1">
        <a:spcBef>
          <a:spcPct val="20000"/>
        </a:spcBef>
        <a:buFont typeface="Segoe UI" panose="020B0502040204020203" pitchFamily="34" charset="0"/>
        <a:buChar char="&gt;"/>
        <a:defRPr kumimoji="1" sz="2000" kern="1200" baseline="0">
          <a:solidFill>
            <a:schemeClr val="tx1"/>
          </a:solidFill>
          <a:latin typeface="+mn-lt"/>
          <a:ea typeface="+mn-ea"/>
          <a:cs typeface="+mn-cs"/>
        </a:defRPr>
      </a:lvl3pPr>
      <a:lvl4pPr marL="132715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="/>
        <a:defRPr kumimoji="1" sz="1800" kern="1200" baseline="0">
          <a:solidFill>
            <a:schemeClr val="tx1"/>
          </a:solidFill>
          <a:latin typeface="+mn-lt"/>
          <a:ea typeface="+mn-ea"/>
          <a:cs typeface="+mn-cs"/>
        </a:defRPr>
      </a:lvl4pPr>
      <a:lvl5pPr marL="16637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1800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1976438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336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690813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051175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9.png"/><Relationship Id="rId4" Type="http://schemas.openxmlformats.org/officeDocument/2006/relationships/image" Target="../media/image6.png"/><Relationship Id="rId9" Type="http://schemas.microsoft.com/office/2007/relationships/hdphoto" Target="../media/hdphoto4.wdp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" name="テキスト ボックス 169">
            <a:extLst>
              <a:ext uri="{FF2B5EF4-FFF2-40B4-BE49-F238E27FC236}">
                <a16:creationId xmlns:a16="http://schemas.microsoft.com/office/drawing/2014/main" id="{8AF044F9-D934-4DFF-B4CE-7375033CDA6A}"/>
              </a:ext>
            </a:extLst>
          </p:cNvPr>
          <p:cNvSpPr txBox="1"/>
          <p:nvPr/>
        </p:nvSpPr>
        <p:spPr>
          <a:xfrm>
            <a:off x="5712851" y="185232"/>
            <a:ext cx="9532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/>
                <a:ea typeface="Meiryo UI"/>
                <a:cs typeface="+mn-cs"/>
              </a:rPr>
              <a:t>Placebo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8DDC896B-A1E8-4AE8-A10C-8E0DB81EAB41}"/>
              </a:ext>
            </a:extLst>
          </p:cNvPr>
          <p:cNvSpPr txBox="1"/>
          <p:nvPr/>
        </p:nvSpPr>
        <p:spPr>
          <a:xfrm>
            <a:off x="2826452" y="185232"/>
            <a:ext cx="11766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/>
                <a:ea typeface="Meiryo UI"/>
                <a:cs typeface="+mn-cs"/>
              </a:rPr>
              <a:t>Pirfenidone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Segoe UI"/>
              <a:ea typeface="Meiryo UI"/>
              <a:cs typeface="+mn-cs"/>
            </a:endParaRPr>
          </a:p>
        </p:txBody>
      </p:sp>
      <p:sp>
        <p:nvSpPr>
          <p:cNvPr id="167" name="正方形/長方形 166">
            <a:extLst>
              <a:ext uri="{FF2B5EF4-FFF2-40B4-BE49-F238E27FC236}">
                <a16:creationId xmlns:a16="http://schemas.microsoft.com/office/drawing/2014/main" id="{99151296-D333-4E5D-9FEF-5C0CFC8E3B88}"/>
              </a:ext>
            </a:extLst>
          </p:cNvPr>
          <p:cNvSpPr/>
          <p:nvPr/>
        </p:nvSpPr>
        <p:spPr>
          <a:xfrm>
            <a:off x="2033151" y="393946"/>
            <a:ext cx="84646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/>
                <a:ea typeface="Meiryo UI"/>
                <a:cs typeface="+mn-cs"/>
              </a:rPr>
              <a:t>A) SP-D</a:t>
            </a:r>
          </a:p>
        </p:txBody>
      </p:sp>
      <p:sp>
        <p:nvSpPr>
          <p:cNvPr id="203" name="テキスト ボックス 202">
            <a:extLst>
              <a:ext uri="{FF2B5EF4-FFF2-40B4-BE49-F238E27FC236}">
                <a16:creationId xmlns:a16="http://schemas.microsoft.com/office/drawing/2014/main" id="{63D6F9CC-0489-4B92-BBB8-4DAE9410EB49}"/>
              </a:ext>
            </a:extLst>
          </p:cNvPr>
          <p:cNvSpPr txBox="1"/>
          <p:nvPr/>
        </p:nvSpPr>
        <p:spPr>
          <a:xfrm>
            <a:off x="1870388" y="2151013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 panose="020B0502040204020203" pitchFamily="34" charset="0"/>
                <a:ea typeface="Meiryo UI"/>
                <a:cs typeface="Segoe UI" panose="020B0502040204020203" pitchFamily="34" charset="0"/>
              </a:rPr>
              <a:t>0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Segoe UI" panose="020B0502040204020203" pitchFamily="34" charset="0"/>
              <a:ea typeface="Meiryo UI"/>
              <a:cs typeface="Segoe UI" panose="020B0502040204020203" pitchFamily="34" charset="0"/>
            </a:endParaRPr>
          </a:p>
        </p:txBody>
      </p:sp>
      <p:grpSp>
        <p:nvGrpSpPr>
          <p:cNvPr id="14" name="グループ化 13"/>
          <p:cNvGrpSpPr/>
          <p:nvPr/>
        </p:nvGrpSpPr>
        <p:grpSpPr>
          <a:xfrm>
            <a:off x="1753368" y="580729"/>
            <a:ext cx="5735570" cy="1771820"/>
            <a:chOff x="1753368" y="580729"/>
            <a:chExt cx="5735570" cy="1771820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410276E1-A8ED-4E48-A315-1174A5A09B8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7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891817" y="676004"/>
              <a:ext cx="2597121" cy="1676545"/>
            </a:xfrm>
            <a:prstGeom prst="rect">
              <a:avLst/>
            </a:prstGeom>
          </p:spPr>
        </p:pic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E86F3C0D-9D38-4066-BAB3-46C6E115B09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7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126535" y="651953"/>
              <a:ext cx="2603218" cy="1694835"/>
            </a:xfrm>
            <a:prstGeom prst="rect">
              <a:avLst/>
            </a:prstGeom>
          </p:spPr>
        </p:pic>
        <p:sp>
          <p:nvSpPr>
            <p:cNvPr id="198" name="テキスト ボックス 197">
              <a:extLst>
                <a:ext uri="{FF2B5EF4-FFF2-40B4-BE49-F238E27FC236}">
                  <a16:creationId xmlns:a16="http://schemas.microsoft.com/office/drawing/2014/main" id="{DE450542-0620-46A1-9807-C19A5260BF86}"/>
                </a:ext>
              </a:extLst>
            </p:cNvPr>
            <p:cNvSpPr txBox="1"/>
            <p:nvPr/>
          </p:nvSpPr>
          <p:spPr>
            <a:xfrm>
              <a:off x="1753368" y="580729"/>
              <a:ext cx="3850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 panose="020B0502040204020203" pitchFamily="34" charset="0"/>
                  <a:ea typeface="Meiryo UI"/>
                  <a:cs typeface="Segoe UI" panose="020B0502040204020203" pitchFamily="34" charset="0"/>
                </a:rPr>
                <a:t>1.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 panose="020B0502040204020203" pitchFamily="34" charset="0"/>
                <a:ea typeface="Meiryo UI"/>
                <a:cs typeface="Segoe UI" panose="020B0502040204020203" pitchFamily="34" charset="0"/>
              </a:endParaRPr>
            </a:p>
          </p:txBody>
        </p:sp>
        <p:sp>
          <p:nvSpPr>
            <p:cNvPr id="199" name="テキスト ボックス 198">
              <a:extLst>
                <a:ext uri="{FF2B5EF4-FFF2-40B4-BE49-F238E27FC236}">
                  <a16:creationId xmlns:a16="http://schemas.microsoft.com/office/drawing/2014/main" id="{F469E0C6-0DE9-4DF5-9D9F-585934A998A0}"/>
                </a:ext>
              </a:extLst>
            </p:cNvPr>
            <p:cNvSpPr txBox="1"/>
            <p:nvPr/>
          </p:nvSpPr>
          <p:spPr>
            <a:xfrm>
              <a:off x="1753368" y="894786"/>
              <a:ext cx="3850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 panose="020B0502040204020203" pitchFamily="34" charset="0"/>
                  <a:ea typeface="Meiryo UI"/>
                  <a:cs typeface="Segoe UI" panose="020B0502040204020203" pitchFamily="34" charset="0"/>
                </a:rPr>
                <a:t>0.8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 panose="020B0502040204020203" pitchFamily="34" charset="0"/>
                <a:ea typeface="Meiryo UI"/>
                <a:cs typeface="Segoe UI" panose="020B0502040204020203" pitchFamily="34" charset="0"/>
              </a:endParaRPr>
            </a:p>
          </p:txBody>
        </p:sp>
        <p:sp>
          <p:nvSpPr>
            <p:cNvPr id="200" name="テキスト ボックス 199">
              <a:extLst>
                <a:ext uri="{FF2B5EF4-FFF2-40B4-BE49-F238E27FC236}">
                  <a16:creationId xmlns:a16="http://schemas.microsoft.com/office/drawing/2014/main" id="{403E8AA9-F8E4-41C9-B664-F18A2CA77144}"/>
                </a:ext>
              </a:extLst>
            </p:cNvPr>
            <p:cNvSpPr txBox="1"/>
            <p:nvPr/>
          </p:nvSpPr>
          <p:spPr>
            <a:xfrm>
              <a:off x="1753368" y="1208843"/>
              <a:ext cx="3850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 panose="020B0502040204020203" pitchFamily="34" charset="0"/>
                  <a:ea typeface="Meiryo UI"/>
                  <a:cs typeface="Segoe UI" panose="020B0502040204020203" pitchFamily="34" charset="0"/>
                </a:rPr>
                <a:t>0.6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 panose="020B0502040204020203" pitchFamily="34" charset="0"/>
                <a:ea typeface="Meiryo UI"/>
                <a:cs typeface="Segoe UI" panose="020B0502040204020203" pitchFamily="34" charset="0"/>
              </a:endParaRPr>
            </a:p>
          </p:txBody>
        </p:sp>
        <p:sp>
          <p:nvSpPr>
            <p:cNvPr id="201" name="テキスト ボックス 200">
              <a:extLst>
                <a:ext uri="{FF2B5EF4-FFF2-40B4-BE49-F238E27FC236}">
                  <a16:creationId xmlns:a16="http://schemas.microsoft.com/office/drawing/2014/main" id="{6CED8D33-2D64-4FDE-9AA4-6EB1E0EB8A3F}"/>
                </a:ext>
              </a:extLst>
            </p:cNvPr>
            <p:cNvSpPr txBox="1"/>
            <p:nvPr/>
          </p:nvSpPr>
          <p:spPr>
            <a:xfrm>
              <a:off x="1753368" y="1522900"/>
              <a:ext cx="3850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 panose="020B0502040204020203" pitchFamily="34" charset="0"/>
                  <a:ea typeface="Meiryo UI"/>
                  <a:cs typeface="Segoe UI" panose="020B0502040204020203" pitchFamily="34" charset="0"/>
                </a:rPr>
                <a:t>0.4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 panose="020B0502040204020203" pitchFamily="34" charset="0"/>
                <a:ea typeface="Meiryo UI"/>
                <a:cs typeface="Segoe UI" panose="020B0502040204020203" pitchFamily="34" charset="0"/>
              </a:endParaRPr>
            </a:p>
          </p:txBody>
        </p:sp>
        <p:sp>
          <p:nvSpPr>
            <p:cNvPr id="202" name="テキスト ボックス 201">
              <a:extLst>
                <a:ext uri="{FF2B5EF4-FFF2-40B4-BE49-F238E27FC236}">
                  <a16:creationId xmlns:a16="http://schemas.microsoft.com/office/drawing/2014/main" id="{196F9F4C-5A2E-46F4-88E9-EF4A131F64FE}"/>
                </a:ext>
              </a:extLst>
            </p:cNvPr>
            <p:cNvSpPr txBox="1"/>
            <p:nvPr/>
          </p:nvSpPr>
          <p:spPr>
            <a:xfrm>
              <a:off x="1753368" y="1836957"/>
              <a:ext cx="3850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 panose="020B0502040204020203" pitchFamily="34" charset="0"/>
                  <a:ea typeface="Meiryo UI"/>
                  <a:cs typeface="Segoe UI" panose="020B0502040204020203" pitchFamily="34" charset="0"/>
                </a:rPr>
                <a:t>0.2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 panose="020B0502040204020203" pitchFamily="34" charset="0"/>
                <a:ea typeface="Meiryo UI"/>
                <a:cs typeface="Segoe UI" panose="020B0502040204020203" pitchFamily="34" charset="0"/>
              </a:endParaRPr>
            </a:p>
          </p:txBody>
        </p:sp>
        <p:sp>
          <p:nvSpPr>
            <p:cNvPr id="74" name="テキスト ボックス 73">
              <a:extLst>
                <a:ext uri="{FF2B5EF4-FFF2-40B4-BE49-F238E27FC236}">
                  <a16:creationId xmlns:a16="http://schemas.microsoft.com/office/drawing/2014/main" id="{48FA91E0-3E88-43F1-A89F-F7B9DE664330}"/>
                </a:ext>
              </a:extLst>
            </p:cNvPr>
            <p:cNvSpPr txBox="1"/>
            <p:nvPr/>
          </p:nvSpPr>
          <p:spPr>
            <a:xfrm>
              <a:off x="2224821" y="1930468"/>
              <a:ext cx="10023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 panose="020B0502040204020203" pitchFamily="34" charset="0"/>
                  <a:ea typeface="Meiryo UI"/>
                  <a:cs typeface="Segoe UI" panose="020B0502040204020203" pitchFamily="34" charset="0"/>
                </a:rPr>
                <a:t>P=0.9926</a:t>
              </a:r>
            </a:p>
          </p:txBody>
        </p:sp>
        <p:sp>
          <p:nvSpPr>
            <p:cNvPr id="75" name="テキスト ボックス 74">
              <a:extLst>
                <a:ext uri="{FF2B5EF4-FFF2-40B4-BE49-F238E27FC236}">
                  <a16:creationId xmlns:a16="http://schemas.microsoft.com/office/drawing/2014/main" id="{49A30759-177D-4A15-8038-61D72479AA1C}"/>
                </a:ext>
              </a:extLst>
            </p:cNvPr>
            <p:cNvSpPr txBox="1"/>
            <p:nvPr/>
          </p:nvSpPr>
          <p:spPr>
            <a:xfrm>
              <a:off x="4994702" y="1925799"/>
              <a:ext cx="932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 panose="020B0502040204020203" pitchFamily="34" charset="0"/>
                  <a:ea typeface="Meiryo UI"/>
                  <a:cs typeface="Segoe UI" panose="020B0502040204020203" pitchFamily="34" charset="0"/>
                </a:rPr>
                <a:t>P=0.6282</a:t>
              </a:r>
            </a:p>
          </p:txBody>
        </p:sp>
      </p:grpSp>
      <p:sp>
        <p:nvSpPr>
          <p:cNvPr id="168" name="正方形/長方形 167">
            <a:extLst>
              <a:ext uri="{FF2B5EF4-FFF2-40B4-BE49-F238E27FC236}">
                <a16:creationId xmlns:a16="http://schemas.microsoft.com/office/drawing/2014/main" id="{84CFCCBC-928C-4385-82C7-B3FD75768A47}"/>
              </a:ext>
            </a:extLst>
          </p:cNvPr>
          <p:cNvSpPr/>
          <p:nvPr/>
        </p:nvSpPr>
        <p:spPr>
          <a:xfrm>
            <a:off x="2033151" y="2316303"/>
            <a:ext cx="93594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/>
                <a:ea typeface="Meiryo UI"/>
                <a:cs typeface="+mn-cs"/>
              </a:rPr>
              <a:t>B) SP-A</a:t>
            </a:r>
          </a:p>
        </p:txBody>
      </p:sp>
      <p:grpSp>
        <p:nvGrpSpPr>
          <p:cNvPr id="10" name="グループ化 9"/>
          <p:cNvGrpSpPr/>
          <p:nvPr/>
        </p:nvGrpSpPr>
        <p:grpSpPr>
          <a:xfrm>
            <a:off x="1753369" y="2507560"/>
            <a:ext cx="5744839" cy="1837799"/>
            <a:chOff x="1753369" y="2507560"/>
            <a:chExt cx="5744839" cy="1837799"/>
          </a:xfrm>
        </p:grpSpPr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7B83028F-7CD4-4326-A940-362584D9B76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70000"/>
                      </a14:imgEffect>
                    </a14:imgLayer>
                  </a14:imgProps>
                </a:ext>
              </a:extLst>
            </a:blip>
            <a:srcRect l="466" t="1" b="1079"/>
            <a:stretch/>
          </p:blipFill>
          <p:spPr>
            <a:xfrm>
              <a:off x="4894990" y="2586119"/>
              <a:ext cx="2603218" cy="1676545"/>
            </a:xfrm>
            <a:prstGeom prst="rect">
              <a:avLst/>
            </a:prstGeom>
          </p:spPr>
        </p:pic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2DE36F8C-472D-4031-BEC1-6B3309B02D6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harpenSoften amount="70000"/>
                      </a14:imgEffect>
                    </a14:imgLayer>
                  </a14:imgProps>
                </a:ext>
              </a:extLst>
            </a:blip>
            <a:srcRect l="466" b="1260"/>
            <a:stretch/>
          </p:blipFill>
          <p:spPr>
            <a:xfrm>
              <a:off x="2131466" y="2582877"/>
              <a:ext cx="2603218" cy="1673468"/>
            </a:xfrm>
            <a:prstGeom prst="rect">
              <a:avLst/>
            </a:prstGeom>
          </p:spPr>
        </p:pic>
        <p:sp>
          <p:nvSpPr>
            <p:cNvPr id="192" name="テキスト ボックス 191">
              <a:extLst>
                <a:ext uri="{FF2B5EF4-FFF2-40B4-BE49-F238E27FC236}">
                  <a16:creationId xmlns:a16="http://schemas.microsoft.com/office/drawing/2014/main" id="{EF9EC5DD-9866-4890-8E4E-1C47E592A3DE}"/>
                </a:ext>
              </a:extLst>
            </p:cNvPr>
            <p:cNvSpPr txBox="1"/>
            <p:nvPr/>
          </p:nvSpPr>
          <p:spPr>
            <a:xfrm>
              <a:off x="1753369" y="2507560"/>
              <a:ext cx="385042" cy="2690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 panose="020B0502040204020203" pitchFamily="34" charset="0"/>
                  <a:ea typeface="Meiryo UI"/>
                  <a:cs typeface="Segoe UI" panose="020B0502040204020203" pitchFamily="34" charset="0"/>
                </a:rPr>
                <a:t>1.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 panose="020B0502040204020203" pitchFamily="34" charset="0"/>
                <a:ea typeface="Meiryo UI"/>
                <a:cs typeface="Segoe UI" panose="020B0502040204020203" pitchFamily="34" charset="0"/>
              </a:endParaRPr>
            </a:p>
          </p:txBody>
        </p:sp>
        <p:sp>
          <p:nvSpPr>
            <p:cNvPr id="193" name="テキスト ボックス 192">
              <a:extLst>
                <a:ext uri="{FF2B5EF4-FFF2-40B4-BE49-F238E27FC236}">
                  <a16:creationId xmlns:a16="http://schemas.microsoft.com/office/drawing/2014/main" id="{C724BCF2-61A1-4CAB-BAF4-7666D3224B2C}"/>
                </a:ext>
              </a:extLst>
            </p:cNvPr>
            <p:cNvSpPr txBox="1"/>
            <p:nvPr/>
          </p:nvSpPr>
          <p:spPr>
            <a:xfrm>
              <a:off x="1753369" y="2821309"/>
              <a:ext cx="385042" cy="2690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 panose="020B0502040204020203" pitchFamily="34" charset="0"/>
                  <a:ea typeface="Meiryo UI"/>
                  <a:cs typeface="Segoe UI" panose="020B0502040204020203" pitchFamily="34" charset="0"/>
                </a:rPr>
                <a:t>0.8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 panose="020B0502040204020203" pitchFamily="34" charset="0"/>
                <a:ea typeface="Meiryo UI"/>
                <a:cs typeface="Segoe UI" panose="020B0502040204020203" pitchFamily="34" charset="0"/>
              </a:endParaRPr>
            </a:p>
          </p:txBody>
        </p:sp>
        <p:sp>
          <p:nvSpPr>
            <p:cNvPr id="194" name="テキスト ボックス 193">
              <a:extLst>
                <a:ext uri="{FF2B5EF4-FFF2-40B4-BE49-F238E27FC236}">
                  <a16:creationId xmlns:a16="http://schemas.microsoft.com/office/drawing/2014/main" id="{0B01DBAA-DC97-4C6B-A0E4-EFA10F3E266C}"/>
                </a:ext>
              </a:extLst>
            </p:cNvPr>
            <p:cNvSpPr txBox="1"/>
            <p:nvPr/>
          </p:nvSpPr>
          <p:spPr>
            <a:xfrm>
              <a:off x="1753369" y="3135058"/>
              <a:ext cx="385042" cy="2690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 panose="020B0502040204020203" pitchFamily="34" charset="0"/>
                  <a:ea typeface="Meiryo UI"/>
                  <a:cs typeface="Segoe UI" panose="020B0502040204020203" pitchFamily="34" charset="0"/>
                </a:rPr>
                <a:t>0.6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 panose="020B0502040204020203" pitchFamily="34" charset="0"/>
                <a:ea typeface="Meiryo UI"/>
                <a:cs typeface="Segoe UI" panose="020B0502040204020203" pitchFamily="34" charset="0"/>
              </a:endParaRPr>
            </a:p>
          </p:txBody>
        </p:sp>
        <p:sp>
          <p:nvSpPr>
            <p:cNvPr id="195" name="テキスト ボックス 194">
              <a:extLst>
                <a:ext uri="{FF2B5EF4-FFF2-40B4-BE49-F238E27FC236}">
                  <a16:creationId xmlns:a16="http://schemas.microsoft.com/office/drawing/2014/main" id="{43F08FF5-879A-4500-9291-9CBEFED023B3}"/>
                </a:ext>
              </a:extLst>
            </p:cNvPr>
            <p:cNvSpPr txBox="1"/>
            <p:nvPr/>
          </p:nvSpPr>
          <p:spPr>
            <a:xfrm>
              <a:off x="1753369" y="3448807"/>
              <a:ext cx="385042" cy="2690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 panose="020B0502040204020203" pitchFamily="34" charset="0"/>
                  <a:ea typeface="Meiryo UI"/>
                  <a:cs typeface="Segoe UI" panose="020B0502040204020203" pitchFamily="34" charset="0"/>
                </a:rPr>
                <a:t>0.4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 panose="020B0502040204020203" pitchFamily="34" charset="0"/>
                <a:ea typeface="Meiryo UI"/>
                <a:cs typeface="Segoe UI" panose="020B0502040204020203" pitchFamily="34" charset="0"/>
              </a:endParaRPr>
            </a:p>
          </p:txBody>
        </p:sp>
        <p:sp>
          <p:nvSpPr>
            <p:cNvPr id="196" name="テキスト ボックス 195">
              <a:extLst>
                <a:ext uri="{FF2B5EF4-FFF2-40B4-BE49-F238E27FC236}">
                  <a16:creationId xmlns:a16="http://schemas.microsoft.com/office/drawing/2014/main" id="{257BED91-A737-4BDD-AFC4-21482D304DB6}"/>
                </a:ext>
              </a:extLst>
            </p:cNvPr>
            <p:cNvSpPr txBox="1"/>
            <p:nvPr/>
          </p:nvSpPr>
          <p:spPr>
            <a:xfrm>
              <a:off x="1753369" y="3762556"/>
              <a:ext cx="385042" cy="2690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 panose="020B0502040204020203" pitchFamily="34" charset="0"/>
                  <a:ea typeface="Meiryo UI"/>
                  <a:cs typeface="Segoe UI" panose="020B0502040204020203" pitchFamily="34" charset="0"/>
                </a:rPr>
                <a:t>0.2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 panose="020B0502040204020203" pitchFamily="34" charset="0"/>
                <a:ea typeface="Meiryo UI"/>
                <a:cs typeface="Segoe UI" panose="020B0502040204020203" pitchFamily="34" charset="0"/>
              </a:endParaRPr>
            </a:p>
          </p:txBody>
        </p:sp>
        <p:sp>
          <p:nvSpPr>
            <p:cNvPr id="197" name="テキスト ボックス 196">
              <a:extLst>
                <a:ext uri="{FF2B5EF4-FFF2-40B4-BE49-F238E27FC236}">
                  <a16:creationId xmlns:a16="http://schemas.microsoft.com/office/drawing/2014/main" id="{D18CFDA3-BCC7-41BF-BB4A-D74E47300982}"/>
                </a:ext>
              </a:extLst>
            </p:cNvPr>
            <p:cNvSpPr txBox="1"/>
            <p:nvPr/>
          </p:nvSpPr>
          <p:spPr>
            <a:xfrm>
              <a:off x="1870389" y="4076306"/>
              <a:ext cx="268022" cy="2690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 panose="020B0502040204020203" pitchFamily="34" charset="0"/>
                  <a:ea typeface="Meiryo UI"/>
                  <a:cs typeface="Segoe UI" panose="020B0502040204020203" pitchFamily="34" charset="0"/>
                </a:rPr>
                <a:t>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 panose="020B0502040204020203" pitchFamily="34" charset="0"/>
                <a:ea typeface="Meiryo UI"/>
                <a:cs typeface="Segoe UI" panose="020B0502040204020203" pitchFamily="34" charset="0"/>
              </a:endParaRPr>
            </a:p>
          </p:txBody>
        </p:sp>
        <p:sp>
          <p:nvSpPr>
            <p:cNvPr id="76" name="テキスト ボックス 75">
              <a:extLst>
                <a:ext uri="{FF2B5EF4-FFF2-40B4-BE49-F238E27FC236}">
                  <a16:creationId xmlns:a16="http://schemas.microsoft.com/office/drawing/2014/main" id="{38705C49-F632-4CD1-8915-158D06911E4C}"/>
                </a:ext>
              </a:extLst>
            </p:cNvPr>
            <p:cNvSpPr txBox="1"/>
            <p:nvPr/>
          </p:nvSpPr>
          <p:spPr>
            <a:xfrm>
              <a:off x="2224822" y="3860711"/>
              <a:ext cx="932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 panose="020B0502040204020203" pitchFamily="34" charset="0"/>
                  <a:ea typeface="Meiryo UI"/>
                  <a:cs typeface="Segoe UI" panose="020B0502040204020203" pitchFamily="34" charset="0"/>
                </a:rPr>
                <a:t>P=</a:t>
              </a: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/>
                  <a:ea typeface="Meiryo UI"/>
                </a:rPr>
                <a:t>0.5516</a:t>
              </a:r>
              <a:endParaRPr kumimoji="1" lang="ja-JP" alt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/>
                <a:ea typeface="Meiryo UI"/>
                <a:cs typeface="+mn-cs"/>
              </a:endParaRPr>
            </a:p>
          </p:txBody>
        </p:sp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id="{CA453B2E-C7EB-42AE-8DBB-514820E85746}"/>
                </a:ext>
              </a:extLst>
            </p:cNvPr>
            <p:cNvSpPr txBox="1"/>
            <p:nvPr/>
          </p:nvSpPr>
          <p:spPr>
            <a:xfrm>
              <a:off x="4994702" y="3875725"/>
              <a:ext cx="932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 panose="020B0502040204020203" pitchFamily="34" charset="0"/>
                  <a:ea typeface="Meiryo UI"/>
                  <a:cs typeface="Segoe UI" panose="020B0502040204020203" pitchFamily="34" charset="0"/>
                </a:rPr>
                <a:t>P=</a:t>
              </a: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/>
                  <a:ea typeface="Meiryo UI"/>
                </a:rPr>
                <a:t>0.1381</a:t>
              </a:r>
              <a:endParaRPr kumimoji="1" lang="ja-JP" alt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/>
                <a:ea typeface="Meiryo UI"/>
                <a:cs typeface="+mn-cs"/>
              </a:endParaRPr>
            </a:p>
          </p:txBody>
        </p:sp>
      </p:grpSp>
      <p:sp>
        <p:nvSpPr>
          <p:cNvPr id="169" name="正方形/長方形 168">
            <a:extLst>
              <a:ext uri="{FF2B5EF4-FFF2-40B4-BE49-F238E27FC236}">
                <a16:creationId xmlns:a16="http://schemas.microsoft.com/office/drawing/2014/main" id="{663C7477-BEB4-4491-B49C-3DE614E8805F}"/>
              </a:ext>
            </a:extLst>
          </p:cNvPr>
          <p:cNvSpPr/>
          <p:nvPr/>
        </p:nvSpPr>
        <p:spPr>
          <a:xfrm>
            <a:off x="2033151" y="4250974"/>
            <a:ext cx="86149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/>
                <a:ea typeface="Meiryo UI"/>
                <a:cs typeface="+mn-cs"/>
              </a:rPr>
              <a:t>C) KL-6</a:t>
            </a:r>
          </a:p>
        </p:txBody>
      </p:sp>
      <p:grpSp>
        <p:nvGrpSpPr>
          <p:cNvPr id="19" name="グループ化 18"/>
          <p:cNvGrpSpPr/>
          <p:nvPr/>
        </p:nvGrpSpPr>
        <p:grpSpPr>
          <a:xfrm>
            <a:off x="4976952" y="767072"/>
            <a:ext cx="874381" cy="424803"/>
            <a:chOff x="6614557" y="284025"/>
            <a:chExt cx="874381" cy="424803"/>
          </a:xfrm>
        </p:grpSpPr>
        <p:cxnSp>
          <p:nvCxnSpPr>
            <p:cNvPr id="68" name="直線コネクタ 67">
              <a:extLst>
                <a:ext uri="{FF2B5EF4-FFF2-40B4-BE49-F238E27FC236}">
                  <a16:creationId xmlns:a16="http://schemas.microsoft.com/office/drawing/2014/main" id="{19A987E2-7C89-4858-BD0F-74199C154441}"/>
                </a:ext>
              </a:extLst>
            </p:cNvPr>
            <p:cNvCxnSpPr>
              <a:cxnSpLocks/>
            </p:cNvCxnSpPr>
            <p:nvPr/>
          </p:nvCxnSpPr>
          <p:spPr>
            <a:xfrm>
              <a:off x="6614557" y="430582"/>
              <a:ext cx="19442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直線コネクタ 68">
              <a:extLst>
                <a:ext uri="{FF2B5EF4-FFF2-40B4-BE49-F238E27FC236}">
                  <a16:creationId xmlns:a16="http://schemas.microsoft.com/office/drawing/2014/main" id="{AEDAF890-26D5-4A8A-A53A-734586C0C559}"/>
                </a:ext>
              </a:extLst>
            </p:cNvPr>
            <p:cNvCxnSpPr>
              <a:cxnSpLocks/>
            </p:cNvCxnSpPr>
            <p:nvPr/>
          </p:nvCxnSpPr>
          <p:spPr>
            <a:xfrm>
              <a:off x="6614557" y="574273"/>
              <a:ext cx="194424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739525AF-4027-4C28-8F12-03A1845CF049}"/>
                </a:ext>
              </a:extLst>
            </p:cNvPr>
            <p:cNvSpPr txBox="1"/>
            <p:nvPr/>
          </p:nvSpPr>
          <p:spPr>
            <a:xfrm>
              <a:off x="6750081" y="284025"/>
              <a:ext cx="5997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 panose="020B0502040204020203" pitchFamily="34" charset="0"/>
                  <a:ea typeface="Meiryo UI"/>
                  <a:cs typeface="Segoe UI" panose="020B0502040204020203" pitchFamily="34" charset="0"/>
                </a:rPr>
                <a:t>Stable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 panose="020B0502040204020203" pitchFamily="34" charset="0"/>
                <a:ea typeface="Meiryo UI"/>
                <a:cs typeface="Segoe UI" panose="020B0502040204020203" pitchFamily="34" charset="0"/>
              </a:endParaRPr>
            </a:p>
          </p:txBody>
        </p: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3F51540C-4FA2-40C4-8C66-358E5B07091F}"/>
                </a:ext>
              </a:extLst>
            </p:cNvPr>
            <p:cNvSpPr txBox="1"/>
            <p:nvPr/>
          </p:nvSpPr>
          <p:spPr>
            <a:xfrm>
              <a:off x="6750081" y="431829"/>
              <a:ext cx="7388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 panose="020B0502040204020203" pitchFamily="34" charset="0"/>
                  <a:ea typeface="Meiryo UI"/>
                  <a:cs typeface="Segoe UI" panose="020B0502040204020203" pitchFamily="34" charset="0"/>
                </a:rPr>
                <a:t>Increase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 panose="020B0502040204020203" pitchFamily="34" charset="0"/>
                <a:ea typeface="Meiryo UI"/>
                <a:cs typeface="Segoe UI" panose="020B0502040204020203" pitchFamily="34" charset="0"/>
              </a:endParaRPr>
            </a:p>
          </p:txBody>
        </p:sp>
      </p:grpSp>
      <p:grpSp>
        <p:nvGrpSpPr>
          <p:cNvPr id="20" name="グループ化 19"/>
          <p:cNvGrpSpPr/>
          <p:nvPr/>
        </p:nvGrpSpPr>
        <p:grpSpPr>
          <a:xfrm>
            <a:off x="2237864" y="770221"/>
            <a:ext cx="874381" cy="424803"/>
            <a:chOff x="3850530" y="287174"/>
            <a:chExt cx="874381" cy="424803"/>
          </a:xfrm>
        </p:grpSpPr>
        <p:cxnSp>
          <p:nvCxnSpPr>
            <p:cNvPr id="81" name="直線コネクタ 80">
              <a:extLst>
                <a:ext uri="{FF2B5EF4-FFF2-40B4-BE49-F238E27FC236}">
                  <a16:creationId xmlns:a16="http://schemas.microsoft.com/office/drawing/2014/main" id="{19A987E2-7C89-4858-BD0F-74199C154441}"/>
                </a:ext>
              </a:extLst>
            </p:cNvPr>
            <p:cNvCxnSpPr>
              <a:cxnSpLocks/>
            </p:cNvCxnSpPr>
            <p:nvPr/>
          </p:nvCxnSpPr>
          <p:spPr>
            <a:xfrm>
              <a:off x="3850530" y="433731"/>
              <a:ext cx="194424" cy="0"/>
            </a:xfrm>
            <a:prstGeom prst="line">
              <a:avLst/>
            </a:prstGeom>
            <a:ln w="19050">
              <a:solidFill>
                <a:schemeClr val="accent5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直線コネクタ 81">
              <a:extLst>
                <a:ext uri="{FF2B5EF4-FFF2-40B4-BE49-F238E27FC236}">
                  <a16:creationId xmlns:a16="http://schemas.microsoft.com/office/drawing/2014/main" id="{AEDAF890-26D5-4A8A-A53A-734586C0C559}"/>
                </a:ext>
              </a:extLst>
            </p:cNvPr>
            <p:cNvCxnSpPr>
              <a:cxnSpLocks/>
            </p:cNvCxnSpPr>
            <p:nvPr/>
          </p:nvCxnSpPr>
          <p:spPr>
            <a:xfrm>
              <a:off x="3850530" y="577422"/>
              <a:ext cx="194424" cy="0"/>
            </a:xfrm>
            <a:prstGeom prst="line">
              <a:avLst/>
            </a:prstGeom>
            <a:ln w="19050">
              <a:solidFill>
                <a:schemeClr val="accent5">
                  <a:lumMod val="7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id="{739525AF-4027-4C28-8F12-03A1845CF049}"/>
                </a:ext>
              </a:extLst>
            </p:cNvPr>
            <p:cNvSpPr txBox="1"/>
            <p:nvPr/>
          </p:nvSpPr>
          <p:spPr>
            <a:xfrm>
              <a:off x="3986054" y="287174"/>
              <a:ext cx="5997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 panose="020B0502040204020203" pitchFamily="34" charset="0"/>
                  <a:ea typeface="Meiryo UI"/>
                  <a:cs typeface="Segoe UI" panose="020B0502040204020203" pitchFamily="34" charset="0"/>
                </a:rPr>
                <a:t>Stable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 panose="020B0502040204020203" pitchFamily="34" charset="0"/>
                <a:ea typeface="Meiryo UI"/>
                <a:cs typeface="Segoe UI" panose="020B0502040204020203" pitchFamily="34" charset="0"/>
              </a:endParaRPr>
            </a:p>
          </p:txBody>
        </p: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3F51540C-4FA2-40C4-8C66-358E5B07091F}"/>
                </a:ext>
              </a:extLst>
            </p:cNvPr>
            <p:cNvSpPr txBox="1"/>
            <p:nvPr/>
          </p:nvSpPr>
          <p:spPr>
            <a:xfrm>
              <a:off x="3986054" y="434978"/>
              <a:ext cx="7388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 panose="020B0502040204020203" pitchFamily="34" charset="0"/>
                  <a:ea typeface="Meiryo UI"/>
                  <a:cs typeface="Segoe UI" panose="020B0502040204020203" pitchFamily="34" charset="0"/>
                </a:rPr>
                <a:t>Increase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 panose="020B0502040204020203" pitchFamily="34" charset="0"/>
                <a:ea typeface="Meiryo UI"/>
                <a:cs typeface="Segoe UI" panose="020B0502040204020203" pitchFamily="34" charset="0"/>
              </a:endParaRPr>
            </a:p>
          </p:txBody>
        </p:sp>
      </p:grp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CA3F4485-D287-4FEA-BBD2-E09E0C79793D}"/>
              </a:ext>
            </a:extLst>
          </p:cNvPr>
          <p:cNvSpPr txBox="1"/>
          <p:nvPr/>
        </p:nvSpPr>
        <p:spPr>
          <a:xfrm>
            <a:off x="4026982" y="6418966"/>
            <a:ext cx="15004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 panose="020B0502040204020203" pitchFamily="34" charset="0"/>
                <a:ea typeface="Meiryo UI"/>
                <a:cs typeface="Segoe UI" panose="020B0502040204020203" pitchFamily="34" charset="0"/>
              </a:rPr>
              <a:t>Treatment (days)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Segoe UI" panose="020B0502040204020203" pitchFamily="34" charset="0"/>
              <a:ea typeface="Meiryo UI"/>
              <a:cs typeface="Segoe UI" panose="020B0502040204020203" pitchFamily="34" charset="0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1450145" y="2311281"/>
            <a:ext cx="400110" cy="216227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kumimoji="1" lang="en-US" altLang="ja-JP" sz="1400" dirty="0">
                <a:latin typeface="Segoe UI" panose="020B0502040204020203" pitchFamily="34" charset="0"/>
                <a:cs typeface="Segoe UI" panose="020B0502040204020203" pitchFamily="34" charset="0"/>
              </a:rPr>
              <a:t>Progression-free survival</a:t>
            </a: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14489BEF-6D76-4B1C-B6AC-D5DB32525AF2}"/>
              </a:ext>
            </a:extLst>
          </p:cNvPr>
          <p:cNvSpPr txBox="1"/>
          <p:nvPr/>
        </p:nvSpPr>
        <p:spPr>
          <a:xfrm>
            <a:off x="278327" y="492893"/>
            <a:ext cx="14308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>
                <a:solidFill>
                  <a:prstClr val="black"/>
                </a:solidFill>
                <a:latin typeface="Arial" panose="020B0604020202020204" pitchFamily="34" charset="0"/>
                <a:ea typeface="Meiryo UI"/>
                <a:cs typeface="Arial" panose="020B0604020202020204" pitchFamily="34" charset="0"/>
              </a:rPr>
              <a:t>Figure S1</a:t>
            </a:r>
            <a:endParaRPr kumimoji="1" lang="en-US" altLang="ja-JP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eiryo UI"/>
              <a:cs typeface="Arial" panose="020B0604020202020204" pitchFamily="34" charset="0"/>
            </a:endParaRPr>
          </a:p>
        </p:txBody>
      </p:sp>
      <p:grpSp>
        <p:nvGrpSpPr>
          <p:cNvPr id="9" name="グループ化 8"/>
          <p:cNvGrpSpPr/>
          <p:nvPr/>
        </p:nvGrpSpPr>
        <p:grpSpPr>
          <a:xfrm>
            <a:off x="1753372" y="4446602"/>
            <a:ext cx="5902195" cy="2008884"/>
            <a:chOff x="1753372" y="4446602"/>
            <a:chExt cx="5902195" cy="2008884"/>
          </a:xfrm>
        </p:grpSpPr>
        <p:pic>
          <p:nvPicPr>
            <p:cNvPr id="7" name="図 6">
              <a:extLst>
                <a:ext uri="{FF2B5EF4-FFF2-40B4-BE49-F238E27FC236}">
                  <a16:creationId xmlns:a16="http://schemas.microsoft.com/office/drawing/2014/main" id="{64DB6BF3-578A-4A7F-BF14-54A0E29991F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harpenSoften amount="70000"/>
                      </a14:imgEffect>
                    </a14:imgLayer>
                  </a14:imgProps>
                </a:ext>
              </a:extLst>
            </a:blip>
            <a:srcRect l="-494"/>
            <a:stretch/>
          </p:blipFill>
          <p:spPr>
            <a:xfrm>
              <a:off x="2124092" y="4507267"/>
              <a:ext cx="2603813" cy="1707028"/>
            </a:xfrm>
            <a:prstGeom prst="rect">
              <a:avLst/>
            </a:prstGeom>
          </p:spPr>
        </p:pic>
        <p:pic>
          <p:nvPicPr>
            <p:cNvPr id="8" name="図 7">
              <a:extLst>
                <a:ext uri="{FF2B5EF4-FFF2-40B4-BE49-F238E27FC236}">
                  <a16:creationId xmlns:a16="http://schemas.microsoft.com/office/drawing/2014/main" id="{F771290D-77F9-4ADD-8B3C-8CCEAE22882C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sharpenSoften amount="7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897530" y="4518208"/>
              <a:ext cx="2645893" cy="1694835"/>
            </a:xfrm>
            <a:prstGeom prst="rect">
              <a:avLst/>
            </a:prstGeom>
          </p:spPr>
        </p:pic>
        <p:sp>
          <p:nvSpPr>
            <p:cNvPr id="186" name="テキスト ボックス 185">
              <a:extLst>
                <a:ext uri="{FF2B5EF4-FFF2-40B4-BE49-F238E27FC236}">
                  <a16:creationId xmlns:a16="http://schemas.microsoft.com/office/drawing/2014/main" id="{4537041C-2CA7-45AA-996F-CF6D5D79363F}"/>
                </a:ext>
              </a:extLst>
            </p:cNvPr>
            <p:cNvSpPr txBox="1"/>
            <p:nvPr/>
          </p:nvSpPr>
          <p:spPr>
            <a:xfrm>
              <a:off x="1753372" y="4446602"/>
              <a:ext cx="3850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 panose="020B0502040204020203" pitchFamily="34" charset="0"/>
                  <a:ea typeface="Meiryo UI"/>
                  <a:cs typeface="Segoe UI" panose="020B0502040204020203" pitchFamily="34" charset="0"/>
                </a:rPr>
                <a:t>1.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 panose="020B0502040204020203" pitchFamily="34" charset="0"/>
                <a:ea typeface="Meiryo UI"/>
                <a:cs typeface="Segoe UI" panose="020B0502040204020203" pitchFamily="34" charset="0"/>
              </a:endParaRPr>
            </a:p>
          </p:txBody>
        </p:sp>
        <p:sp>
          <p:nvSpPr>
            <p:cNvPr id="187" name="テキスト ボックス 186">
              <a:extLst>
                <a:ext uri="{FF2B5EF4-FFF2-40B4-BE49-F238E27FC236}">
                  <a16:creationId xmlns:a16="http://schemas.microsoft.com/office/drawing/2014/main" id="{C2467141-12E8-4AAD-90C4-79170066C70B}"/>
                </a:ext>
              </a:extLst>
            </p:cNvPr>
            <p:cNvSpPr txBox="1"/>
            <p:nvPr/>
          </p:nvSpPr>
          <p:spPr>
            <a:xfrm>
              <a:off x="1753372" y="4760659"/>
              <a:ext cx="3850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 panose="020B0502040204020203" pitchFamily="34" charset="0"/>
                  <a:ea typeface="Meiryo UI"/>
                  <a:cs typeface="Segoe UI" panose="020B0502040204020203" pitchFamily="34" charset="0"/>
                </a:rPr>
                <a:t>0.8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 panose="020B0502040204020203" pitchFamily="34" charset="0"/>
                <a:ea typeface="Meiryo UI"/>
                <a:cs typeface="Segoe UI" panose="020B0502040204020203" pitchFamily="34" charset="0"/>
              </a:endParaRPr>
            </a:p>
          </p:txBody>
        </p:sp>
        <p:sp>
          <p:nvSpPr>
            <p:cNvPr id="188" name="テキスト ボックス 187">
              <a:extLst>
                <a:ext uri="{FF2B5EF4-FFF2-40B4-BE49-F238E27FC236}">
                  <a16:creationId xmlns:a16="http://schemas.microsoft.com/office/drawing/2014/main" id="{C23B478F-98F7-46D7-B9A4-251129D0E1AA}"/>
                </a:ext>
              </a:extLst>
            </p:cNvPr>
            <p:cNvSpPr txBox="1"/>
            <p:nvPr/>
          </p:nvSpPr>
          <p:spPr>
            <a:xfrm>
              <a:off x="1753372" y="5074716"/>
              <a:ext cx="3850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 panose="020B0502040204020203" pitchFamily="34" charset="0"/>
                  <a:ea typeface="Meiryo UI"/>
                  <a:cs typeface="Segoe UI" panose="020B0502040204020203" pitchFamily="34" charset="0"/>
                </a:rPr>
                <a:t>0.6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 panose="020B0502040204020203" pitchFamily="34" charset="0"/>
                <a:ea typeface="Meiryo UI"/>
                <a:cs typeface="Segoe UI" panose="020B0502040204020203" pitchFamily="34" charset="0"/>
              </a:endParaRPr>
            </a:p>
          </p:txBody>
        </p:sp>
        <p:sp>
          <p:nvSpPr>
            <p:cNvPr id="189" name="テキスト ボックス 188">
              <a:extLst>
                <a:ext uri="{FF2B5EF4-FFF2-40B4-BE49-F238E27FC236}">
                  <a16:creationId xmlns:a16="http://schemas.microsoft.com/office/drawing/2014/main" id="{9F3D1BAC-A542-4E3C-BF08-5082F739BD44}"/>
                </a:ext>
              </a:extLst>
            </p:cNvPr>
            <p:cNvSpPr txBox="1"/>
            <p:nvPr/>
          </p:nvSpPr>
          <p:spPr>
            <a:xfrm>
              <a:off x="1753372" y="5388773"/>
              <a:ext cx="3850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 panose="020B0502040204020203" pitchFamily="34" charset="0"/>
                  <a:ea typeface="Meiryo UI"/>
                  <a:cs typeface="Segoe UI" panose="020B0502040204020203" pitchFamily="34" charset="0"/>
                </a:rPr>
                <a:t>0.4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 panose="020B0502040204020203" pitchFamily="34" charset="0"/>
                <a:ea typeface="Meiryo UI"/>
                <a:cs typeface="Segoe UI" panose="020B0502040204020203" pitchFamily="34" charset="0"/>
              </a:endParaRPr>
            </a:p>
          </p:txBody>
        </p:sp>
        <p:sp>
          <p:nvSpPr>
            <p:cNvPr id="190" name="テキスト ボックス 189">
              <a:extLst>
                <a:ext uri="{FF2B5EF4-FFF2-40B4-BE49-F238E27FC236}">
                  <a16:creationId xmlns:a16="http://schemas.microsoft.com/office/drawing/2014/main" id="{9A84E15F-DFC3-414D-9410-FA1632487CC0}"/>
                </a:ext>
              </a:extLst>
            </p:cNvPr>
            <p:cNvSpPr txBox="1"/>
            <p:nvPr/>
          </p:nvSpPr>
          <p:spPr>
            <a:xfrm>
              <a:off x="1753372" y="5702830"/>
              <a:ext cx="3850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 panose="020B0502040204020203" pitchFamily="34" charset="0"/>
                  <a:ea typeface="Meiryo UI"/>
                  <a:cs typeface="Segoe UI" panose="020B0502040204020203" pitchFamily="34" charset="0"/>
                </a:rPr>
                <a:t>0.2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 panose="020B0502040204020203" pitchFamily="34" charset="0"/>
                <a:ea typeface="Meiryo UI"/>
                <a:cs typeface="Segoe UI" panose="020B0502040204020203" pitchFamily="34" charset="0"/>
              </a:endParaRPr>
            </a:p>
          </p:txBody>
        </p:sp>
        <p:sp>
          <p:nvSpPr>
            <p:cNvPr id="191" name="テキスト ボックス 190">
              <a:extLst>
                <a:ext uri="{FF2B5EF4-FFF2-40B4-BE49-F238E27FC236}">
                  <a16:creationId xmlns:a16="http://schemas.microsoft.com/office/drawing/2014/main" id="{E63E8035-4B1F-4DC6-AA1B-0611C9FB0823}"/>
                </a:ext>
              </a:extLst>
            </p:cNvPr>
            <p:cNvSpPr txBox="1"/>
            <p:nvPr/>
          </p:nvSpPr>
          <p:spPr>
            <a:xfrm>
              <a:off x="1870392" y="6016886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 panose="020B0502040204020203" pitchFamily="34" charset="0"/>
                  <a:ea typeface="Meiryo UI"/>
                  <a:cs typeface="Segoe UI" panose="020B0502040204020203" pitchFamily="34" charset="0"/>
                </a:rPr>
                <a:t>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 panose="020B0502040204020203" pitchFamily="34" charset="0"/>
                <a:ea typeface="Meiryo UI"/>
                <a:cs typeface="Segoe UI" panose="020B0502040204020203" pitchFamily="34" charset="0"/>
              </a:endParaRPr>
            </a:p>
          </p:txBody>
        </p: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728C07C0-6D4A-44FC-A3AD-5BBC47483CAC}"/>
                </a:ext>
              </a:extLst>
            </p:cNvPr>
            <p:cNvSpPr txBox="1"/>
            <p:nvPr/>
          </p:nvSpPr>
          <p:spPr>
            <a:xfrm>
              <a:off x="2224822" y="5785809"/>
              <a:ext cx="10023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 panose="020B0502040204020203" pitchFamily="34" charset="0"/>
                  <a:ea typeface="Meiryo UI"/>
                  <a:cs typeface="Segoe UI" panose="020B0502040204020203" pitchFamily="34" charset="0"/>
                </a:rPr>
                <a:t>P=</a:t>
              </a: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/>
                  <a:ea typeface="Meiryo UI"/>
                </a:rPr>
                <a:t>0.1896</a:t>
              </a:r>
              <a:endParaRPr kumimoji="1" lang="ja-JP" alt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/>
                <a:ea typeface="Meiryo UI"/>
                <a:cs typeface="+mn-cs"/>
              </a:endParaRPr>
            </a:p>
          </p:txBody>
        </p:sp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id="{148AEB6A-981F-4AF9-8EA8-F2D7BC963B2F}"/>
                </a:ext>
              </a:extLst>
            </p:cNvPr>
            <p:cNvSpPr txBox="1"/>
            <p:nvPr/>
          </p:nvSpPr>
          <p:spPr>
            <a:xfrm>
              <a:off x="4996082" y="5785809"/>
              <a:ext cx="9300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 panose="020B0502040204020203" pitchFamily="34" charset="0"/>
                  <a:ea typeface="Meiryo UI"/>
                  <a:cs typeface="Segoe UI" panose="020B0502040204020203" pitchFamily="34" charset="0"/>
                </a:rPr>
                <a:t>P=</a:t>
              </a: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/>
                  <a:ea typeface="Meiryo UI"/>
                </a:rPr>
                <a:t>0.0093</a:t>
              </a:r>
              <a:endParaRPr kumimoji="1" lang="ja-JP" alt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/>
                <a:ea typeface="Meiryo UI"/>
                <a:cs typeface="+mn-cs"/>
              </a:endParaRPr>
            </a:p>
          </p:txBody>
        </p:sp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3D4BB63B-2FBB-4F08-8AE9-E0DF75E2B777}"/>
                </a:ext>
              </a:extLst>
            </p:cNvPr>
            <p:cNvSpPr txBox="1"/>
            <p:nvPr/>
          </p:nvSpPr>
          <p:spPr>
            <a:xfrm>
              <a:off x="2026175" y="6178487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/>
                  <a:ea typeface="Meiryo UI"/>
                  <a:cs typeface="+mn-cs"/>
                </a:rPr>
                <a:t>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/>
                <a:ea typeface="Meiryo UI"/>
                <a:cs typeface="+mn-cs"/>
              </a:endParaRPr>
            </a:p>
          </p:txBody>
        </p:sp>
        <p:sp>
          <p:nvSpPr>
            <p:cNvPr id="71" name="テキスト ボックス 70">
              <a:extLst>
                <a:ext uri="{FF2B5EF4-FFF2-40B4-BE49-F238E27FC236}">
                  <a16:creationId xmlns:a16="http://schemas.microsoft.com/office/drawing/2014/main" id="{3D4BB63B-2FBB-4F08-8AE9-E0DF75E2B777}"/>
                </a:ext>
              </a:extLst>
            </p:cNvPr>
            <p:cNvSpPr txBox="1"/>
            <p:nvPr/>
          </p:nvSpPr>
          <p:spPr>
            <a:xfrm>
              <a:off x="4454391" y="6178487"/>
              <a:ext cx="4347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/>
                  <a:ea typeface="Meiryo UI"/>
                  <a:cs typeface="+mn-cs"/>
                </a:rPr>
                <a:t>40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/>
                <a:ea typeface="Meiryo UI"/>
                <a:cs typeface="+mn-cs"/>
              </a:endParaRPr>
            </a:p>
          </p:txBody>
        </p:sp>
        <p:sp>
          <p:nvSpPr>
            <p:cNvPr id="72" name="テキスト ボックス 71">
              <a:extLst>
                <a:ext uri="{FF2B5EF4-FFF2-40B4-BE49-F238E27FC236}">
                  <a16:creationId xmlns:a16="http://schemas.microsoft.com/office/drawing/2014/main" id="{3D4BB63B-2FBB-4F08-8AE9-E0DF75E2B777}"/>
                </a:ext>
              </a:extLst>
            </p:cNvPr>
            <p:cNvSpPr txBox="1"/>
            <p:nvPr/>
          </p:nvSpPr>
          <p:spPr>
            <a:xfrm>
              <a:off x="2571989" y="6178487"/>
              <a:ext cx="4347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dirty="0">
                  <a:solidFill>
                    <a:prstClr val="black"/>
                  </a:solidFill>
                  <a:latin typeface="Segoe UI"/>
                  <a:ea typeface="Meiryo UI"/>
                </a:rPr>
                <a:t>1</a:t>
              </a: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/>
                  <a:ea typeface="Meiryo UI"/>
                </a:rPr>
                <a:t>0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/>
                <a:ea typeface="Meiryo UI"/>
              </a:endParaRPr>
            </a:p>
          </p:txBody>
        </p:sp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3D4BB63B-2FBB-4F08-8AE9-E0DF75E2B777}"/>
                </a:ext>
              </a:extLst>
            </p:cNvPr>
            <p:cNvSpPr txBox="1"/>
            <p:nvPr/>
          </p:nvSpPr>
          <p:spPr>
            <a:xfrm>
              <a:off x="3198940" y="6178487"/>
              <a:ext cx="4347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noProof="0" dirty="0">
                  <a:solidFill>
                    <a:prstClr val="black"/>
                  </a:solidFill>
                  <a:latin typeface="Segoe UI"/>
                  <a:ea typeface="Meiryo UI"/>
                </a:rPr>
                <a:t>2</a:t>
              </a: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/>
                  <a:ea typeface="Meiryo UI"/>
                </a:rPr>
                <a:t>0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/>
                <a:ea typeface="Meiryo UI"/>
              </a:endParaRPr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3D4BB63B-2FBB-4F08-8AE9-E0DF75E2B777}"/>
                </a:ext>
              </a:extLst>
            </p:cNvPr>
            <p:cNvSpPr txBox="1"/>
            <p:nvPr/>
          </p:nvSpPr>
          <p:spPr>
            <a:xfrm>
              <a:off x="3825829" y="6178487"/>
              <a:ext cx="4347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noProof="0" dirty="0">
                  <a:solidFill>
                    <a:prstClr val="black"/>
                  </a:solidFill>
                  <a:latin typeface="Segoe UI"/>
                  <a:ea typeface="Meiryo UI"/>
                </a:rPr>
                <a:t>3</a:t>
              </a: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/>
                  <a:ea typeface="Meiryo UI"/>
                </a:rPr>
                <a:t>0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/>
                <a:ea typeface="Meiryo UI"/>
              </a:endParaRPr>
            </a:p>
          </p:txBody>
        </p:sp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3D4BB63B-2FBB-4F08-8AE9-E0DF75E2B777}"/>
                </a:ext>
              </a:extLst>
            </p:cNvPr>
            <p:cNvSpPr txBox="1"/>
            <p:nvPr/>
          </p:nvSpPr>
          <p:spPr>
            <a:xfrm>
              <a:off x="4792617" y="6178487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/>
                  <a:ea typeface="Meiryo UI"/>
                  <a:cs typeface="+mn-cs"/>
                </a:rPr>
                <a:t>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/>
                <a:ea typeface="Meiryo UI"/>
                <a:cs typeface="+mn-cs"/>
              </a:endParaRPr>
            </a:p>
          </p:txBody>
        </p:sp>
        <p:sp>
          <p:nvSpPr>
            <p:cNvPr id="87" name="テキスト ボックス 86">
              <a:extLst>
                <a:ext uri="{FF2B5EF4-FFF2-40B4-BE49-F238E27FC236}">
                  <a16:creationId xmlns:a16="http://schemas.microsoft.com/office/drawing/2014/main" id="{3D4BB63B-2FBB-4F08-8AE9-E0DF75E2B777}"/>
                </a:ext>
              </a:extLst>
            </p:cNvPr>
            <p:cNvSpPr txBox="1"/>
            <p:nvPr/>
          </p:nvSpPr>
          <p:spPr>
            <a:xfrm>
              <a:off x="7220833" y="6178487"/>
              <a:ext cx="4347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/>
                  <a:ea typeface="Meiryo UI"/>
                  <a:cs typeface="+mn-cs"/>
                </a:rPr>
                <a:t>40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/>
                <a:ea typeface="Meiryo UI"/>
                <a:cs typeface="+mn-cs"/>
              </a:endParaRPr>
            </a:p>
          </p:txBody>
        </p: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3D4BB63B-2FBB-4F08-8AE9-E0DF75E2B777}"/>
                </a:ext>
              </a:extLst>
            </p:cNvPr>
            <p:cNvSpPr txBox="1"/>
            <p:nvPr/>
          </p:nvSpPr>
          <p:spPr>
            <a:xfrm>
              <a:off x="5338431" y="6178487"/>
              <a:ext cx="4347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dirty="0">
                  <a:solidFill>
                    <a:prstClr val="black"/>
                  </a:solidFill>
                  <a:latin typeface="Segoe UI"/>
                  <a:ea typeface="Meiryo UI"/>
                </a:rPr>
                <a:t>1</a:t>
              </a: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/>
                  <a:ea typeface="Meiryo UI"/>
                </a:rPr>
                <a:t>0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/>
                <a:ea typeface="Meiryo UI"/>
              </a:endParaRPr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id="{3D4BB63B-2FBB-4F08-8AE9-E0DF75E2B777}"/>
                </a:ext>
              </a:extLst>
            </p:cNvPr>
            <p:cNvSpPr txBox="1"/>
            <p:nvPr/>
          </p:nvSpPr>
          <p:spPr>
            <a:xfrm>
              <a:off x="5965382" y="6178487"/>
              <a:ext cx="4347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noProof="0" dirty="0">
                  <a:solidFill>
                    <a:prstClr val="black"/>
                  </a:solidFill>
                  <a:latin typeface="Segoe UI"/>
                  <a:ea typeface="Meiryo UI"/>
                </a:rPr>
                <a:t>2</a:t>
              </a: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/>
                  <a:ea typeface="Meiryo UI"/>
                </a:rPr>
                <a:t>0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/>
                <a:ea typeface="Meiryo UI"/>
              </a:endParaRPr>
            </a:p>
          </p:txBody>
        </p: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3D4BB63B-2FBB-4F08-8AE9-E0DF75E2B777}"/>
                </a:ext>
              </a:extLst>
            </p:cNvPr>
            <p:cNvSpPr txBox="1"/>
            <p:nvPr/>
          </p:nvSpPr>
          <p:spPr>
            <a:xfrm>
              <a:off x="6597161" y="6178487"/>
              <a:ext cx="4347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noProof="0" dirty="0">
                  <a:solidFill>
                    <a:prstClr val="black"/>
                  </a:solidFill>
                  <a:latin typeface="Segoe UI"/>
                  <a:ea typeface="Meiryo UI"/>
                </a:rPr>
                <a:t>3</a:t>
              </a: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egoe UI"/>
                  <a:ea typeface="Meiryo UI"/>
                </a:rPr>
                <a:t>0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egoe UI"/>
                <a:ea typeface="Meiryo UI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206530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A708D09-C259-4DE8-9740-4008150C89B2}"/>
              </a:ext>
            </a:extLst>
          </p:cNvPr>
          <p:cNvSpPr txBox="1"/>
          <p:nvPr/>
        </p:nvSpPr>
        <p:spPr>
          <a:xfrm>
            <a:off x="1583082" y="526486"/>
            <a:ext cx="5987300" cy="12234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 Relationship between changes in serum concentration of biomarkers at week 16 and the efficacy of pirfenidone on progression-free survival. </a:t>
            </a:r>
          </a:p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 patients were dichotomized by the change in concentration of (A) SP-D, (B) SP-A and (C) KL-6 at week 16 from baseline to the increase and stable (equal and decrease) biomarker subgroups. Solid lines, stable biomarker; dotted lines, increasing biomarker. The disease progression was defined by a &gt;10% decline in vital capacity from baseline and/or death. Progression-free survival was estimated using the Kaplan-Meier method and compared using the log-rank test.</a:t>
            </a:r>
          </a:p>
        </p:txBody>
      </p:sp>
    </p:spTree>
    <p:extLst>
      <p:ext uri="{BB962C8B-B14F-4D97-AF65-F5344CB8AC3E}">
        <p14:creationId xmlns:p14="http://schemas.microsoft.com/office/powerpoint/2010/main" val="454087440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メイリオ+Segou UI 最強">
      <a:majorFont>
        <a:latin typeface="Segoe UI"/>
        <a:ea typeface="Meiryo UI"/>
        <a:cs typeface=""/>
      </a:majorFont>
      <a:minorFont>
        <a:latin typeface="Segoe UI"/>
        <a:ea typeface="Meiryo UI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Shionogi">
  <a:themeElements>
    <a:clrScheme name="Shionogi_Yasuda">
      <a:dk1>
        <a:sysClr val="windowText" lastClr="000000"/>
      </a:dk1>
      <a:lt1>
        <a:sysClr val="window" lastClr="FFFFFF"/>
      </a:lt1>
      <a:dk2>
        <a:srgbClr val="002859"/>
      </a:dk2>
      <a:lt2>
        <a:srgbClr val="E9F7FD"/>
      </a:lt2>
      <a:accent1>
        <a:srgbClr val="DA0000"/>
      </a:accent1>
      <a:accent2>
        <a:srgbClr val="0051BA"/>
      </a:accent2>
      <a:accent3>
        <a:srgbClr val="82EBB9"/>
      </a:accent3>
      <a:accent4>
        <a:srgbClr val="B9EB5A"/>
      </a:accent4>
      <a:accent5>
        <a:srgbClr val="FF9682"/>
      </a:accent5>
      <a:accent6>
        <a:srgbClr val="FFD73C"/>
      </a:accent6>
      <a:hlink>
        <a:srgbClr val="3333FF"/>
      </a:hlink>
      <a:folHlink>
        <a:srgbClr val="CC00CC"/>
      </a:folHlink>
    </a:clrScheme>
    <a:fontScheme name="Shionogi">
      <a:majorFont>
        <a:latin typeface="Segoe UI"/>
        <a:ea typeface="Meiryo UI"/>
        <a:cs typeface=""/>
      </a:majorFont>
      <a:minorFont>
        <a:latin typeface="Segoe UI"/>
        <a:ea typeface="Meiryo UI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Shionogi">
  <a:themeElements>
    <a:clrScheme name="Shionogi_Yasuda">
      <a:dk1>
        <a:sysClr val="windowText" lastClr="000000"/>
      </a:dk1>
      <a:lt1>
        <a:sysClr val="window" lastClr="FFFFFF"/>
      </a:lt1>
      <a:dk2>
        <a:srgbClr val="002859"/>
      </a:dk2>
      <a:lt2>
        <a:srgbClr val="E9F7FD"/>
      </a:lt2>
      <a:accent1>
        <a:srgbClr val="DA0000"/>
      </a:accent1>
      <a:accent2>
        <a:srgbClr val="0051BA"/>
      </a:accent2>
      <a:accent3>
        <a:srgbClr val="82EBB9"/>
      </a:accent3>
      <a:accent4>
        <a:srgbClr val="B9EB5A"/>
      </a:accent4>
      <a:accent5>
        <a:srgbClr val="FF9682"/>
      </a:accent5>
      <a:accent6>
        <a:srgbClr val="FFD73C"/>
      </a:accent6>
      <a:hlink>
        <a:srgbClr val="3333FF"/>
      </a:hlink>
      <a:folHlink>
        <a:srgbClr val="CC00CC"/>
      </a:folHlink>
    </a:clrScheme>
    <a:fontScheme name="Shionogi">
      <a:majorFont>
        <a:latin typeface="Segoe UI"/>
        <a:ea typeface="Meiryo UI"/>
        <a:cs typeface=""/>
      </a:majorFont>
      <a:minorFont>
        <a:latin typeface="Segoe UI"/>
        <a:ea typeface="Meiryo UI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5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38</TotalTime>
  <Words>182</Words>
  <Application>Microsoft Office PowerPoint</Application>
  <PresentationFormat>画面に合わせる (4:3)</PresentationFormat>
  <Paragraphs>48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3</vt:i4>
      </vt:variant>
      <vt:variant>
        <vt:lpstr>スライド タイトル</vt:lpstr>
      </vt:variant>
      <vt:variant>
        <vt:i4>2</vt:i4>
      </vt:variant>
    </vt:vector>
  </HeadingPairs>
  <TitlesOfParts>
    <vt:vector size="11" baseType="lpstr">
      <vt:lpstr>メイリオ</vt:lpstr>
      <vt:lpstr>游ゴシック</vt:lpstr>
      <vt:lpstr>Arial</vt:lpstr>
      <vt:lpstr>Calibri</vt:lpstr>
      <vt:lpstr>Segoe UI</vt:lpstr>
      <vt:lpstr>Times New Roman</vt:lpstr>
      <vt:lpstr>1_Office ​​テーマ</vt:lpstr>
      <vt:lpstr>Shionogi</vt:lpstr>
      <vt:lpstr>1_Shionogi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UROFUMI CHIBA</dc:creator>
  <cp:lastModifiedBy>池田 貴美之</cp:lastModifiedBy>
  <cp:revision>302</cp:revision>
  <cp:lastPrinted>2020-06-24T03:59:53Z</cp:lastPrinted>
  <dcterms:created xsi:type="dcterms:W3CDTF">2019-08-01T14:43:03Z</dcterms:created>
  <dcterms:modified xsi:type="dcterms:W3CDTF">2020-07-20T21:22:12Z</dcterms:modified>
</cp:coreProperties>
</file>